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drawings/drawing1.xml" ContentType="application/vnd.openxmlformats-officedocument.drawingml.chartshapes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6" r:id="rId3"/>
    <p:sldId id="257" r:id="rId4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8566" autoAdjust="0"/>
  </p:normalViewPr>
  <p:slideViewPr>
    <p:cSldViewPr>
      <p:cViewPr varScale="1">
        <p:scale>
          <a:sx n="46" d="100"/>
          <a:sy n="46" d="100"/>
        </p:scale>
        <p:origin x="1373" y="4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Miami\research%20plan\diatom\T.%20pseudonana\tp_final%20data\profile\NUE\tp_NUE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Miami\research%20plan\diatom\P.%20tricornutum\pt_final_data\profile\NUE\pt_NUE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Miami\research%20plan\Tetrahymena_thermophila\profile\profile_Tt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D:\Miami\research%20plan\Ostreococcus%20lucimarinus\profile\Ol_profile.xlsx" TargetMode="Externa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D:\Miami\research%20plan\red_alga\profile\profile_Cy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D:\Miami\research%20plan\Selaginella%20moellendorffii\profile\NUE\Sela_NUE_profile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D:\Miami\research%20plan\moss\moss_diatom_final\profile\NUE\moss_NUE_35_13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4.2401259374756611E-2"/>
          <c:y val="3.1154032854444506E-2"/>
          <c:w val="0.95759874062524297"/>
          <c:h val="0.33730509158803107"/>
        </c:manualLayout>
      </c:layout>
      <c:lineChart>
        <c:grouping val="standard"/>
        <c:varyColors val="0"/>
        <c:ser>
          <c:idx val="0"/>
          <c:order val="0"/>
          <c:tx>
            <c:strRef>
              <c:f>'3nt'!$A$564</c:f>
              <c:strCache>
                <c:ptCount val="1"/>
                <c:pt idx="0">
                  <c:v>UAA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564:$T$564</c:f>
              <c:numCache>
                <c:formatCode>General</c:formatCode>
                <c:ptCount val="19"/>
                <c:pt idx="0">
                  <c:v>0.98538905878355398</c:v>
                </c:pt>
                <c:pt idx="1">
                  <c:v>0.95141012572204176</c:v>
                </c:pt>
                <c:pt idx="2">
                  <c:v>1.5290519877675839</c:v>
                </c:pt>
                <c:pt idx="3">
                  <c:v>2.3105674481821272</c:v>
                </c:pt>
                <c:pt idx="4">
                  <c:v>2.2086306489976639</c:v>
                </c:pt>
                <c:pt idx="5">
                  <c:v>2.6163778457356441</c:v>
                </c:pt>
                <c:pt idx="6">
                  <c:v>3.7716615698267071</c:v>
                </c:pt>
                <c:pt idx="7">
                  <c:v>3.533809038396194</c:v>
                </c:pt>
                <c:pt idx="8">
                  <c:v>4.3153244988107371</c:v>
                </c:pt>
                <c:pt idx="9">
                  <c:v>4.5531770302412475</c:v>
                </c:pt>
                <c:pt idx="10">
                  <c:v>4.9269452939177709</c:v>
                </c:pt>
                <c:pt idx="11">
                  <c:v>6.3540604825008504</c:v>
                </c:pt>
                <c:pt idx="12">
                  <c:v>6.8977234114848924</c:v>
                </c:pt>
                <c:pt idx="13">
                  <c:v>7.5093442065919076</c:v>
                </c:pt>
                <c:pt idx="14">
                  <c:v>9.5480801902820183</c:v>
                </c:pt>
                <c:pt idx="15">
                  <c:v>9.0723751274209992</c:v>
                </c:pt>
                <c:pt idx="16">
                  <c:v>7.6452599388379197</c:v>
                </c:pt>
                <c:pt idx="17">
                  <c:v>5.0628610261637785</c:v>
                </c:pt>
                <c:pt idx="18">
                  <c:v>2.718314644920150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182-4396-A787-9A90C1232515}"/>
            </c:ext>
          </c:extLst>
        </c:ser>
        <c:ser>
          <c:idx val="1"/>
          <c:order val="1"/>
          <c:tx>
            <c:strRef>
              <c:f>'3nt'!$A$565</c:f>
              <c:strCache>
                <c:ptCount val="1"/>
                <c:pt idx="0">
                  <c:v>AAU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565:$T$565</c:f>
              <c:numCache>
                <c:formatCode>General</c:formatCode>
                <c:ptCount val="19"/>
                <c:pt idx="0">
                  <c:v>1.3931362555215758</c:v>
                </c:pt>
                <c:pt idx="1">
                  <c:v>1.5970098538905879</c:v>
                </c:pt>
                <c:pt idx="2">
                  <c:v>1.3931362555215758</c:v>
                </c:pt>
                <c:pt idx="3">
                  <c:v>1.3591573224600761</c:v>
                </c:pt>
                <c:pt idx="4">
                  <c:v>2.1066938498131162</c:v>
                </c:pt>
                <c:pt idx="5">
                  <c:v>1.8008834522595978</c:v>
                </c:pt>
                <c:pt idx="6">
                  <c:v>2.3445463812436267</c:v>
                </c:pt>
                <c:pt idx="7">
                  <c:v>3.1260618416581742</c:v>
                </c:pt>
                <c:pt idx="8">
                  <c:v>3.0581039755351678</c:v>
                </c:pt>
                <c:pt idx="9">
                  <c:v>3.4998301053346927</c:v>
                </c:pt>
                <c:pt idx="10">
                  <c:v>3.6017669045191978</c:v>
                </c:pt>
                <c:pt idx="11">
                  <c:v>3.7716615698267071</c:v>
                </c:pt>
                <c:pt idx="12">
                  <c:v>3.9755351681957181</c:v>
                </c:pt>
                <c:pt idx="13">
                  <c:v>4.9609242269792109</c:v>
                </c:pt>
                <c:pt idx="14">
                  <c:v>4.6551138294256713</c:v>
                </c:pt>
                <c:pt idx="15">
                  <c:v>5.0628610261637785</c:v>
                </c:pt>
                <c:pt idx="16">
                  <c:v>4.9609242269792109</c:v>
                </c:pt>
                <c:pt idx="17">
                  <c:v>4.3832823649337413</c:v>
                </c:pt>
                <c:pt idx="18">
                  <c:v>3.737682636765202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182-4396-A787-9A90C1232515}"/>
            </c:ext>
          </c:extLst>
        </c:ser>
        <c:ser>
          <c:idx val="2"/>
          <c:order val="2"/>
          <c:tx>
            <c:strRef>
              <c:f>'3nt'!$A$566</c:f>
              <c:strCache>
                <c:ptCount val="1"/>
                <c:pt idx="0">
                  <c:v>AUA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566:$T$566</c:f>
              <c:numCache>
                <c:formatCode>General</c:formatCode>
                <c:ptCount val="19"/>
                <c:pt idx="0">
                  <c:v>1.5290519877675839</c:v>
                </c:pt>
                <c:pt idx="1">
                  <c:v>1.3591573224600761</c:v>
                </c:pt>
                <c:pt idx="2">
                  <c:v>1.7329255861365971</c:v>
                </c:pt>
                <c:pt idx="3">
                  <c:v>1.3251783893985731</c:v>
                </c:pt>
                <c:pt idx="4">
                  <c:v>1.7329255861365971</c:v>
                </c:pt>
                <c:pt idx="5">
                  <c:v>2.0727149167516141</c:v>
                </c:pt>
                <c:pt idx="6">
                  <c:v>2.2086306489976639</c:v>
                </c:pt>
                <c:pt idx="7">
                  <c:v>2.6843357118586684</c:v>
                </c:pt>
                <c:pt idx="8">
                  <c:v>3.7037037037037042</c:v>
                </c:pt>
                <c:pt idx="9">
                  <c:v>3.1260618416581742</c:v>
                </c:pt>
                <c:pt idx="10">
                  <c:v>3.2279986408427068</c:v>
                </c:pt>
                <c:pt idx="11">
                  <c:v>3.7376826367652027</c:v>
                </c:pt>
                <c:pt idx="12">
                  <c:v>4.4512402310567474</c:v>
                </c:pt>
                <c:pt idx="13">
                  <c:v>4.6211348963641941</c:v>
                </c:pt>
                <c:pt idx="14">
                  <c:v>4.8589874277947667</c:v>
                </c:pt>
                <c:pt idx="15">
                  <c:v>4.3153244988107371</c:v>
                </c:pt>
                <c:pt idx="16">
                  <c:v>3.6017669045191978</c:v>
                </c:pt>
                <c:pt idx="17">
                  <c:v>3.4658511722731777</c:v>
                </c:pt>
                <c:pt idx="18">
                  <c:v>3.058103975535167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1182-4396-A787-9A90C1232515}"/>
            </c:ext>
          </c:extLst>
        </c:ser>
        <c:ser>
          <c:idx val="3"/>
          <c:order val="3"/>
          <c:tx>
            <c:strRef>
              <c:f>'3nt'!$A$567</c:f>
              <c:strCache>
                <c:ptCount val="1"/>
                <c:pt idx="0">
                  <c:v>AAA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567:$T$567</c:f>
              <c:numCache>
                <c:formatCode>General</c:formatCode>
                <c:ptCount val="19"/>
                <c:pt idx="0">
                  <c:v>1.1213047910295517</c:v>
                </c:pt>
                <c:pt idx="1">
                  <c:v>1.0873258579680598</c:v>
                </c:pt>
                <c:pt idx="2">
                  <c:v>1.1213047910295517</c:v>
                </c:pt>
                <c:pt idx="3">
                  <c:v>1.6649677200136013</c:v>
                </c:pt>
                <c:pt idx="4">
                  <c:v>1.4610941216445799</c:v>
                </c:pt>
                <c:pt idx="5">
                  <c:v>1.63098878695209</c:v>
                </c:pt>
                <c:pt idx="6">
                  <c:v>1.7329255861365971</c:v>
                </c:pt>
                <c:pt idx="7">
                  <c:v>2.6503567787971707</c:v>
                </c:pt>
                <c:pt idx="8">
                  <c:v>2.9221882432891597</c:v>
                </c:pt>
                <c:pt idx="9">
                  <c:v>2.4464831804281126</c:v>
                </c:pt>
                <c:pt idx="10">
                  <c:v>3.1600407747196742</c:v>
                </c:pt>
                <c:pt idx="11">
                  <c:v>3.6357458375806977</c:v>
                </c:pt>
                <c:pt idx="12">
                  <c:v>3.5677879714577236</c:v>
                </c:pt>
                <c:pt idx="13">
                  <c:v>3.4658511722731777</c:v>
                </c:pt>
                <c:pt idx="14">
                  <c:v>3.7716615698267071</c:v>
                </c:pt>
                <c:pt idx="15">
                  <c:v>4.077471967380224</c:v>
                </c:pt>
                <c:pt idx="16">
                  <c:v>4.3493034318722534</c:v>
                </c:pt>
                <c:pt idx="17">
                  <c:v>4.519198097179749</c:v>
                </c:pt>
                <c:pt idx="18">
                  <c:v>4.960924226979210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1182-4396-A787-9A90C1232515}"/>
            </c:ext>
          </c:extLst>
        </c:ser>
        <c:ser>
          <c:idx val="4"/>
          <c:order val="4"/>
          <c:tx>
            <c:strRef>
              <c:f>'3nt'!$A$568</c:f>
              <c:strCache>
                <c:ptCount val="1"/>
                <c:pt idx="0">
                  <c:v>UUA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568:$T$568</c:f>
              <c:numCache>
                <c:formatCode>General</c:formatCode>
                <c:ptCount val="19"/>
                <c:pt idx="0">
                  <c:v>1.1213047910295517</c:v>
                </c:pt>
                <c:pt idx="1">
                  <c:v>1.3931362555215758</c:v>
                </c:pt>
                <c:pt idx="2">
                  <c:v>1.3591573224600761</c:v>
                </c:pt>
                <c:pt idx="3">
                  <c:v>1.8008834522595978</c:v>
                </c:pt>
                <c:pt idx="4">
                  <c:v>2.0047570506286112</c:v>
                </c:pt>
                <c:pt idx="5">
                  <c:v>2.3445463812436267</c:v>
                </c:pt>
                <c:pt idx="6">
                  <c:v>2.3445463812436267</c:v>
                </c:pt>
                <c:pt idx="7">
                  <c:v>2.4804621134896063</c:v>
                </c:pt>
                <c:pt idx="8">
                  <c:v>2.242609582059123</c:v>
                </c:pt>
                <c:pt idx="9">
                  <c:v>3.1260618416581742</c:v>
                </c:pt>
                <c:pt idx="10">
                  <c:v>3.4998301053346927</c:v>
                </c:pt>
                <c:pt idx="11">
                  <c:v>3.5677879714577236</c:v>
                </c:pt>
                <c:pt idx="12">
                  <c:v>4.1454298335032282</c:v>
                </c:pt>
                <c:pt idx="13">
                  <c:v>5.3007135575942836</c:v>
                </c:pt>
                <c:pt idx="14">
                  <c:v>4.7570506286102336</c:v>
                </c:pt>
                <c:pt idx="15">
                  <c:v>3.7037037037037042</c:v>
                </c:pt>
                <c:pt idx="16">
                  <c:v>2.8202514441046547</c:v>
                </c:pt>
                <c:pt idx="17">
                  <c:v>1.698946653075093</c:v>
                </c:pt>
                <c:pt idx="18">
                  <c:v>2.03873598369011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1182-4396-A787-9A90C1232515}"/>
            </c:ext>
          </c:extLst>
        </c:ser>
        <c:ser>
          <c:idx val="5"/>
          <c:order val="5"/>
          <c:tx>
            <c:strRef>
              <c:f>'3nt'!$A$569</c:f>
              <c:strCache>
                <c:ptCount val="1"/>
                <c:pt idx="0">
                  <c:v>GUA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569:$T$569</c:f>
              <c:numCache>
                <c:formatCode>General</c:formatCode>
                <c:ptCount val="19"/>
                <c:pt idx="0">
                  <c:v>1.6649677200136013</c:v>
                </c:pt>
                <c:pt idx="1">
                  <c:v>1.9707781175671071</c:v>
                </c:pt>
                <c:pt idx="2">
                  <c:v>1.63098878695209</c:v>
                </c:pt>
                <c:pt idx="3">
                  <c:v>2.1406727828746202</c:v>
                </c:pt>
                <c:pt idx="4">
                  <c:v>1.9707781175671071</c:v>
                </c:pt>
                <c:pt idx="5">
                  <c:v>2.5484199796126399</c:v>
                </c:pt>
                <c:pt idx="6">
                  <c:v>2.2086306489976639</c:v>
                </c:pt>
                <c:pt idx="7">
                  <c:v>2.1406727828746202</c:v>
                </c:pt>
                <c:pt idx="8">
                  <c:v>2.8542303771661572</c:v>
                </c:pt>
                <c:pt idx="9">
                  <c:v>2.4804621134896063</c:v>
                </c:pt>
                <c:pt idx="10">
                  <c:v>2.8202514441046547</c:v>
                </c:pt>
                <c:pt idx="11">
                  <c:v>3.1260618416581742</c:v>
                </c:pt>
                <c:pt idx="12">
                  <c:v>3.0581039755351678</c:v>
                </c:pt>
                <c:pt idx="13">
                  <c:v>3.2959565069656809</c:v>
                </c:pt>
                <c:pt idx="14">
                  <c:v>3.9755351681957181</c:v>
                </c:pt>
                <c:pt idx="15">
                  <c:v>3.2619775739041801</c:v>
                </c:pt>
                <c:pt idx="16">
                  <c:v>2.3445463812436267</c:v>
                </c:pt>
                <c:pt idx="17">
                  <c:v>2.0727149167516141</c:v>
                </c:pt>
                <c:pt idx="18">
                  <c:v>1.766904519198097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1182-4396-A787-9A90C1232515}"/>
            </c:ext>
          </c:extLst>
        </c:ser>
        <c:ser>
          <c:idx val="6"/>
          <c:order val="6"/>
          <c:tx>
            <c:strRef>
              <c:f>'3nt'!$A$570</c:f>
              <c:strCache>
                <c:ptCount val="1"/>
                <c:pt idx="0">
                  <c:v>AAG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570:$T$570</c:f>
              <c:numCache>
                <c:formatCode>General</c:formatCode>
                <c:ptCount val="19"/>
                <c:pt idx="0">
                  <c:v>0.88345225959904894</c:v>
                </c:pt>
                <c:pt idx="1">
                  <c:v>1.2911994563370597</c:v>
                </c:pt>
                <c:pt idx="2">
                  <c:v>1.3591573224600761</c:v>
                </c:pt>
                <c:pt idx="3">
                  <c:v>1.3591573224600761</c:v>
                </c:pt>
                <c:pt idx="4">
                  <c:v>1.5290519877675839</c:v>
                </c:pt>
                <c:pt idx="5">
                  <c:v>1.8688413183826018</c:v>
                </c:pt>
                <c:pt idx="6">
                  <c:v>1.698946653075093</c:v>
                </c:pt>
                <c:pt idx="7">
                  <c:v>1.8688413183826018</c:v>
                </c:pt>
                <c:pt idx="8">
                  <c:v>2.3105674481821272</c:v>
                </c:pt>
                <c:pt idx="9">
                  <c:v>2.4804621134896063</c:v>
                </c:pt>
                <c:pt idx="10">
                  <c:v>2.2765885151206247</c:v>
                </c:pt>
                <c:pt idx="11">
                  <c:v>2.8202514441046547</c:v>
                </c:pt>
                <c:pt idx="12">
                  <c:v>2.6843357118586684</c:v>
                </c:pt>
                <c:pt idx="13">
                  <c:v>3.1260618416581742</c:v>
                </c:pt>
                <c:pt idx="14">
                  <c:v>3.0581039755351678</c:v>
                </c:pt>
                <c:pt idx="15">
                  <c:v>4.1454298335032282</c:v>
                </c:pt>
                <c:pt idx="16">
                  <c:v>3.8056405028881977</c:v>
                </c:pt>
                <c:pt idx="17">
                  <c:v>3.6697247706422407</c:v>
                </c:pt>
                <c:pt idx="18">
                  <c:v>4.213387699626231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1182-4396-A787-9A90C1232515}"/>
            </c:ext>
          </c:extLst>
        </c:ser>
        <c:ser>
          <c:idx val="7"/>
          <c:order val="7"/>
          <c:tx>
            <c:strRef>
              <c:f>'3nt'!$A$571</c:f>
              <c:strCache>
                <c:ptCount val="1"/>
                <c:pt idx="0">
                  <c:v>AAC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571:$T$571</c:f>
              <c:numCache>
                <c:formatCode>General</c:formatCode>
                <c:ptCount val="19"/>
                <c:pt idx="0">
                  <c:v>1.0533469249065754</c:v>
                </c:pt>
                <c:pt idx="1">
                  <c:v>1.1552837240910763</c:v>
                </c:pt>
                <c:pt idx="2">
                  <c:v>1.3931362555215758</c:v>
                </c:pt>
                <c:pt idx="3">
                  <c:v>1.495073054706082</c:v>
                </c:pt>
                <c:pt idx="4">
                  <c:v>2.0727149167516141</c:v>
                </c:pt>
                <c:pt idx="5">
                  <c:v>1.698946653075093</c:v>
                </c:pt>
                <c:pt idx="6">
                  <c:v>2.038735983690112</c:v>
                </c:pt>
                <c:pt idx="7">
                  <c:v>2.4125042473666412</c:v>
                </c:pt>
                <c:pt idx="8">
                  <c:v>2.7183146449201505</c:v>
                </c:pt>
                <c:pt idx="9">
                  <c:v>2.5144410465511382</c:v>
                </c:pt>
                <c:pt idx="10">
                  <c:v>2.9561671763506627</c:v>
                </c:pt>
                <c:pt idx="11">
                  <c:v>2.9221882432891597</c:v>
                </c:pt>
                <c:pt idx="12">
                  <c:v>2.9561671763506627</c:v>
                </c:pt>
                <c:pt idx="13">
                  <c:v>1.9707781175671071</c:v>
                </c:pt>
                <c:pt idx="14">
                  <c:v>2.8542303771661572</c:v>
                </c:pt>
                <c:pt idx="15">
                  <c:v>2.7522935779816602</c:v>
                </c:pt>
                <c:pt idx="16">
                  <c:v>4.1454298335032282</c:v>
                </c:pt>
                <c:pt idx="17">
                  <c:v>3.533809038396194</c:v>
                </c:pt>
                <c:pt idx="18">
                  <c:v>3.295956506965680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1182-4396-A787-9A90C1232515}"/>
            </c:ext>
          </c:extLst>
        </c:ser>
        <c:ser>
          <c:idx val="8"/>
          <c:order val="8"/>
          <c:tx>
            <c:strRef>
              <c:f>'3nt'!$A$572</c:f>
              <c:strCache>
                <c:ptCount val="1"/>
                <c:pt idx="0">
                  <c:v>UAG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572:$T$572</c:f>
              <c:numCache>
                <c:formatCode>General</c:formatCode>
                <c:ptCount val="19"/>
                <c:pt idx="0">
                  <c:v>1.563030920829086</c:v>
                </c:pt>
                <c:pt idx="1">
                  <c:v>1.427115188583078</c:v>
                </c:pt>
                <c:pt idx="2">
                  <c:v>1.0873258579680598</c:v>
                </c:pt>
                <c:pt idx="3">
                  <c:v>1.019367991845056</c:v>
                </c:pt>
                <c:pt idx="4">
                  <c:v>0.78151546041454301</c:v>
                </c:pt>
                <c:pt idx="5">
                  <c:v>0.98538905878355398</c:v>
                </c:pt>
                <c:pt idx="6">
                  <c:v>1.0533469249065754</c:v>
                </c:pt>
                <c:pt idx="7">
                  <c:v>0.81549439347604502</c:v>
                </c:pt>
                <c:pt idx="8">
                  <c:v>0.84947332653754704</c:v>
                </c:pt>
                <c:pt idx="9">
                  <c:v>1.1552837240910763</c:v>
                </c:pt>
                <c:pt idx="10">
                  <c:v>1.495073054706082</c:v>
                </c:pt>
                <c:pt idx="11">
                  <c:v>1.698946653075093</c:v>
                </c:pt>
                <c:pt idx="12">
                  <c:v>3.6357458375806977</c:v>
                </c:pt>
                <c:pt idx="13">
                  <c:v>5.1308188922867766</c:v>
                </c:pt>
                <c:pt idx="14">
                  <c:v>5.6744818212707591</c:v>
                </c:pt>
                <c:pt idx="15">
                  <c:v>5.6744818212707591</c:v>
                </c:pt>
                <c:pt idx="16">
                  <c:v>4.2133876996262316</c:v>
                </c:pt>
                <c:pt idx="17">
                  <c:v>2.9901461094121577</c:v>
                </c:pt>
                <c:pt idx="18">
                  <c:v>1.970778117567107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1182-4396-A787-9A90C1232515}"/>
            </c:ext>
          </c:extLst>
        </c:ser>
        <c:ser>
          <c:idx val="9"/>
          <c:order val="9"/>
          <c:tx>
            <c:strRef>
              <c:f>'3nt'!$A$573</c:f>
              <c:strCache>
                <c:ptCount val="1"/>
                <c:pt idx="0">
                  <c:v>AGU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573:$T$573</c:f>
              <c:numCache>
                <c:formatCode>General</c:formatCode>
                <c:ptCount val="19"/>
                <c:pt idx="0">
                  <c:v>1.4610941216445799</c:v>
                </c:pt>
                <c:pt idx="1">
                  <c:v>1.6649677200136013</c:v>
                </c:pt>
                <c:pt idx="2">
                  <c:v>1.7329255861365971</c:v>
                </c:pt>
                <c:pt idx="3">
                  <c:v>1.3251783893985731</c:v>
                </c:pt>
                <c:pt idx="4">
                  <c:v>1.5290519877675839</c:v>
                </c:pt>
                <c:pt idx="5">
                  <c:v>1.6649677200136013</c:v>
                </c:pt>
                <c:pt idx="6">
                  <c:v>1.7669045191980979</c:v>
                </c:pt>
                <c:pt idx="7">
                  <c:v>1.8008834522595978</c:v>
                </c:pt>
                <c:pt idx="8">
                  <c:v>1.8008834522595978</c:v>
                </c:pt>
                <c:pt idx="9">
                  <c:v>2.0047570506286112</c:v>
                </c:pt>
                <c:pt idx="10">
                  <c:v>2.6503567787971707</c:v>
                </c:pt>
                <c:pt idx="11">
                  <c:v>2.2086306489976639</c:v>
                </c:pt>
                <c:pt idx="12">
                  <c:v>2.7522935779816602</c:v>
                </c:pt>
                <c:pt idx="13">
                  <c:v>3.0241250424736705</c:v>
                </c:pt>
                <c:pt idx="14">
                  <c:v>3.5677879714577236</c:v>
                </c:pt>
                <c:pt idx="15">
                  <c:v>2.9561671763506627</c:v>
                </c:pt>
                <c:pt idx="16">
                  <c:v>3.4318722392116556</c:v>
                </c:pt>
                <c:pt idx="17">
                  <c:v>2.3105674481821272</c:v>
                </c:pt>
                <c:pt idx="18">
                  <c:v>2.344546381243626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1182-4396-A787-9A90C1232515}"/>
            </c:ext>
          </c:extLst>
        </c:ser>
        <c:ser>
          <c:idx val="10"/>
          <c:order val="10"/>
          <c:tx>
            <c:strRef>
              <c:f>'3nt'!$A$574</c:f>
              <c:strCache>
                <c:ptCount val="1"/>
                <c:pt idx="0">
                  <c:v>AUU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574:$T$574</c:f>
              <c:numCache>
                <c:formatCode>General</c:formatCode>
                <c:ptCount val="19"/>
                <c:pt idx="0">
                  <c:v>1.2911994563370597</c:v>
                </c:pt>
                <c:pt idx="1">
                  <c:v>1.5970098538905879</c:v>
                </c:pt>
                <c:pt idx="2">
                  <c:v>1.6649677200136013</c:v>
                </c:pt>
                <c:pt idx="3">
                  <c:v>1.9367991845056061</c:v>
                </c:pt>
                <c:pt idx="4">
                  <c:v>1.9707781175671071</c:v>
                </c:pt>
                <c:pt idx="5">
                  <c:v>1.7669045191980979</c:v>
                </c:pt>
                <c:pt idx="6">
                  <c:v>2.4464831804281126</c:v>
                </c:pt>
                <c:pt idx="7">
                  <c:v>1.63098878695209</c:v>
                </c:pt>
                <c:pt idx="8">
                  <c:v>2.7183146449201505</c:v>
                </c:pt>
                <c:pt idx="9">
                  <c:v>1.9367991845056061</c:v>
                </c:pt>
                <c:pt idx="10">
                  <c:v>2.5484199796126399</c:v>
                </c:pt>
                <c:pt idx="11">
                  <c:v>3.0581039755351678</c:v>
                </c:pt>
                <c:pt idx="12">
                  <c:v>3.2959565069656809</c:v>
                </c:pt>
                <c:pt idx="13">
                  <c:v>2.7522935779816602</c:v>
                </c:pt>
                <c:pt idx="14">
                  <c:v>2.786272511043153</c:v>
                </c:pt>
                <c:pt idx="15">
                  <c:v>1.7669045191980979</c:v>
                </c:pt>
                <c:pt idx="16">
                  <c:v>1.834862385321101</c:v>
                </c:pt>
                <c:pt idx="17">
                  <c:v>2.7522935779816602</c:v>
                </c:pt>
                <c:pt idx="18">
                  <c:v>2.14067278287462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1182-4396-A787-9A90C1232515}"/>
            </c:ext>
          </c:extLst>
        </c:ser>
        <c:ser>
          <c:idx val="11"/>
          <c:order val="11"/>
          <c:tx>
            <c:strRef>
              <c:f>'3nt'!$A$575</c:f>
              <c:strCache>
                <c:ptCount val="1"/>
                <c:pt idx="0">
                  <c:v>AGA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575:$T$575</c:f>
              <c:numCache>
                <c:formatCode>General</c:formatCode>
                <c:ptCount val="19"/>
                <c:pt idx="0">
                  <c:v>1.6649677200136013</c:v>
                </c:pt>
                <c:pt idx="1">
                  <c:v>1.2911994563370597</c:v>
                </c:pt>
                <c:pt idx="2">
                  <c:v>2.0727149167516141</c:v>
                </c:pt>
                <c:pt idx="3">
                  <c:v>1.495073054706082</c:v>
                </c:pt>
                <c:pt idx="4">
                  <c:v>1.3931362555215758</c:v>
                </c:pt>
                <c:pt idx="5">
                  <c:v>1.1552837240910763</c:v>
                </c:pt>
                <c:pt idx="6">
                  <c:v>1.563030920829086</c:v>
                </c:pt>
                <c:pt idx="7">
                  <c:v>1.4610941216445799</c:v>
                </c:pt>
                <c:pt idx="8">
                  <c:v>1.2232415902140548</c:v>
                </c:pt>
                <c:pt idx="9">
                  <c:v>1.3591573224600761</c:v>
                </c:pt>
                <c:pt idx="10">
                  <c:v>1.3931362555215758</c:v>
                </c:pt>
                <c:pt idx="11">
                  <c:v>1.63098878695209</c:v>
                </c:pt>
                <c:pt idx="12">
                  <c:v>1.5970098538905879</c:v>
                </c:pt>
                <c:pt idx="13">
                  <c:v>2.1746517159361201</c:v>
                </c:pt>
                <c:pt idx="14">
                  <c:v>3.329935440027183</c:v>
                </c:pt>
                <c:pt idx="15">
                  <c:v>4.1454298335032282</c:v>
                </c:pt>
                <c:pt idx="16">
                  <c:v>4.5871559633027346</c:v>
                </c:pt>
                <c:pt idx="17">
                  <c:v>4.3153244988107371</c:v>
                </c:pt>
                <c:pt idx="18">
                  <c:v>3.737682636765202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1182-4396-A787-9A90C1232515}"/>
            </c:ext>
          </c:extLst>
        </c:ser>
        <c:ser>
          <c:idx val="12"/>
          <c:order val="12"/>
          <c:tx>
            <c:strRef>
              <c:f>'3nt'!$A$576</c:f>
              <c:strCache>
                <c:ptCount val="1"/>
                <c:pt idx="0">
                  <c:v>CUA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576:$T$576</c:f>
              <c:numCache>
                <c:formatCode>General</c:formatCode>
                <c:ptCount val="19"/>
                <c:pt idx="0">
                  <c:v>0.71355759429153898</c:v>
                </c:pt>
                <c:pt idx="1">
                  <c:v>0.78151546041454301</c:v>
                </c:pt>
                <c:pt idx="2">
                  <c:v>1.0533469249065754</c:v>
                </c:pt>
                <c:pt idx="3">
                  <c:v>1.0533469249065754</c:v>
                </c:pt>
                <c:pt idx="4">
                  <c:v>1.25722052327557</c:v>
                </c:pt>
                <c:pt idx="5">
                  <c:v>1.3591573224600761</c:v>
                </c:pt>
                <c:pt idx="6">
                  <c:v>2.038735983690112</c:v>
                </c:pt>
                <c:pt idx="7">
                  <c:v>1.63098878695209</c:v>
                </c:pt>
                <c:pt idx="8">
                  <c:v>1.698946653075093</c:v>
                </c:pt>
                <c:pt idx="9">
                  <c:v>2.4804621134896063</c:v>
                </c:pt>
                <c:pt idx="10">
                  <c:v>2.7183146449201505</c:v>
                </c:pt>
                <c:pt idx="11">
                  <c:v>3.0581039755351678</c:v>
                </c:pt>
                <c:pt idx="12">
                  <c:v>3.2959565069656809</c:v>
                </c:pt>
                <c:pt idx="13">
                  <c:v>3.7037037037037042</c:v>
                </c:pt>
                <c:pt idx="14">
                  <c:v>3.2279986408427068</c:v>
                </c:pt>
                <c:pt idx="15">
                  <c:v>2.5484199796126399</c:v>
                </c:pt>
                <c:pt idx="16">
                  <c:v>2.038735983690112</c:v>
                </c:pt>
                <c:pt idx="17">
                  <c:v>1.2232415902140548</c:v>
                </c:pt>
                <c:pt idx="18">
                  <c:v>1.325178389398573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C-1182-4396-A787-9A90C1232515}"/>
            </c:ext>
          </c:extLst>
        </c:ser>
        <c:ser>
          <c:idx val="13"/>
          <c:order val="13"/>
          <c:tx>
            <c:strRef>
              <c:f>'3nt'!$A$577</c:f>
              <c:strCache>
                <c:ptCount val="1"/>
                <c:pt idx="0">
                  <c:v>UAU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577:$T$577</c:f>
              <c:numCache>
                <c:formatCode>General</c:formatCode>
                <c:ptCount val="19"/>
                <c:pt idx="0">
                  <c:v>1.1213047910295517</c:v>
                </c:pt>
                <c:pt idx="1">
                  <c:v>1.563030920829086</c:v>
                </c:pt>
                <c:pt idx="2">
                  <c:v>1.563030920829086</c:v>
                </c:pt>
                <c:pt idx="3">
                  <c:v>1.427115188583078</c:v>
                </c:pt>
                <c:pt idx="4">
                  <c:v>1.4610941216445799</c:v>
                </c:pt>
                <c:pt idx="5">
                  <c:v>1.3251783893985731</c:v>
                </c:pt>
                <c:pt idx="6">
                  <c:v>1.0873258579680598</c:v>
                </c:pt>
                <c:pt idx="7">
                  <c:v>2.3445463812436267</c:v>
                </c:pt>
                <c:pt idx="8">
                  <c:v>2.0727149167516141</c:v>
                </c:pt>
                <c:pt idx="9">
                  <c:v>2.4804621134896063</c:v>
                </c:pt>
                <c:pt idx="10">
                  <c:v>2.4125042473666412</c:v>
                </c:pt>
                <c:pt idx="11">
                  <c:v>3.0581039755351678</c:v>
                </c:pt>
                <c:pt idx="12">
                  <c:v>2.4804621134896063</c:v>
                </c:pt>
                <c:pt idx="13">
                  <c:v>2.1406727828746202</c:v>
                </c:pt>
                <c:pt idx="14">
                  <c:v>2.038735983690112</c:v>
                </c:pt>
                <c:pt idx="15">
                  <c:v>1.563030920829086</c:v>
                </c:pt>
                <c:pt idx="16">
                  <c:v>1.7669045191980979</c:v>
                </c:pt>
                <c:pt idx="17">
                  <c:v>1.6649677200136013</c:v>
                </c:pt>
                <c:pt idx="18">
                  <c:v>2.24260958205912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D-1182-4396-A787-9A90C1232515}"/>
            </c:ext>
          </c:extLst>
        </c:ser>
        <c:ser>
          <c:idx val="14"/>
          <c:order val="14"/>
          <c:tx>
            <c:strRef>
              <c:f>'3nt'!$A$578</c:f>
              <c:strCache>
                <c:ptCount val="1"/>
                <c:pt idx="0">
                  <c:v>GAU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578:$T$578</c:f>
              <c:numCache>
                <c:formatCode>General</c:formatCode>
                <c:ptCount val="19"/>
                <c:pt idx="0">
                  <c:v>1.9367991845056061</c:v>
                </c:pt>
                <c:pt idx="1">
                  <c:v>1.7329255861365971</c:v>
                </c:pt>
                <c:pt idx="2">
                  <c:v>1.5290519877675839</c:v>
                </c:pt>
                <c:pt idx="3">
                  <c:v>1.834862385321101</c:v>
                </c:pt>
                <c:pt idx="4">
                  <c:v>1.5290519877675839</c:v>
                </c:pt>
                <c:pt idx="5">
                  <c:v>1.8688413183826018</c:v>
                </c:pt>
                <c:pt idx="6">
                  <c:v>1.3931362555215758</c:v>
                </c:pt>
                <c:pt idx="7">
                  <c:v>2.4125042473666412</c:v>
                </c:pt>
                <c:pt idx="8">
                  <c:v>1.5970098538905879</c:v>
                </c:pt>
                <c:pt idx="9">
                  <c:v>1.6649677200136013</c:v>
                </c:pt>
                <c:pt idx="10">
                  <c:v>1.3591573224600761</c:v>
                </c:pt>
                <c:pt idx="11">
                  <c:v>1.9707781175671071</c:v>
                </c:pt>
                <c:pt idx="12">
                  <c:v>1.5970098538905879</c:v>
                </c:pt>
                <c:pt idx="13">
                  <c:v>1.5970098538905879</c:v>
                </c:pt>
                <c:pt idx="14">
                  <c:v>1.63098878695209</c:v>
                </c:pt>
                <c:pt idx="15">
                  <c:v>1.6649677200136013</c:v>
                </c:pt>
                <c:pt idx="16">
                  <c:v>2.4804621134896063</c:v>
                </c:pt>
                <c:pt idx="17">
                  <c:v>2.2765885151206247</c:v>
                </c:pt>
                <c:pt idx="18">
                  <c:v>3.058103975535167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E-1182-4396-A787-9A90C1232515}"/>
            </c:ext>
          </c:extLst>
        </c:ser>
        <c:ser>
          <c:idx val="15"/>
          <c:order val="15"/>
          <c:tx>
            <c:strRef>
              <c:f>'3nt'!$A$579</c:f>
              <c:strCache>
                <c:ptCount val="1"/>
                <c:pt idx="0">
                  <c:v>ACU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579:$T$579</c:f>
              <c:numCache>
                <c:formatCode>General</c:formatCode>
                <c:ptCount val="19"/>
                <c:pt idx="0">
                  <c:v>1.0533469249065754</c:v>
                </c:pt>
                <c:pt idx="1">
                  <c:v>1.0873258579680598</c:v>
                </c:pt>
                <c:pt idx="2">
                  <c:v>1.2911994563370597</c:v>
                </c:pt>
                <c:pt idx="3">
                  <c:v>1.427115188583078</c:v>
                </c:pt>
                <c:pt idx="4">
                  <c:v>1.5290519877675839</c:v>
                </c:pt>
                <c:pt idx="5">
                  <c:v>1.8008834522595978</c:v>
                </c:pt>
                <c:pt idx="6">
                  <c:v>1.5970098538905879</c:v>
                </c:pt>
                <c:pt idx="7">
                  <c:v>1.9707781175671071</c:v>
                </c:pt>
                <c:pt idx="8">
                  <c:v>2.038735983690112</c:v>
                </c:pt>
                <c:pt idx="9">
                  <c:v>2.0727149167516141</c:v>
                </c:pt>
                <c:pt idx="10">
                  <c:v>2.3105674481821272</c:v>
                </c:pt>
                <c:pt idx="11">
                  <c:v>2.6503567787971707</c:v>
                </c:pt>
                <c:pt idx="12">
                  <c:v>2.582398912674142</c:v>
                </c:pt>
                <c:pt idx="13">
                  <c:v>2.5144410465511382</c:v>
                </c:pt>
                <c:pt idx="14">
                  <c:v>1.7329255861365971</c:v>
                </c:pt>
                <c:pt idx="15">
                  <c:v>1.8688413183826018</c:v>
                </c:pt>
                <c:pt idx="16">
                  <c:v>1.5290519877675839</c:v>
                </c:pt>
                <c:pt idx="17">
                  <c:v>2.1746517159361201</c:v>
                </c:pt>
                <c:pt idx="18">
                  <c:v>1.56303092082908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F-1182-4396-A787-9A90C1232515}"/>
            </c:ext>
          </c:extLst>
        </c:ser>
        <c:ser>
          <c:idx val="16"/>
          <c:order val="16"/>
          <c:tx>
            <c:strRef>
              <c:f>'3nt'!$A$580</c:f>
              <c:strCache>
                <c:ptCount val="1"/>
                <c:pt idx="0">
                  <c:v>UGU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580:$T$580</c:f>
              <c:numCache>
                <c:formatCode>General</c:formatCode>
                <c:ptCount val="19"/>
                <c:pt idx="0">
                  <c:v>1.9367991845056061</c:v>
                </c:pt>
                <c:pt idx="1">
                  <c:v>1.7329255861365971</c:v>
                </c:pt>
                <c:pt idx="2">
                  <c:v>2.2086306489976639</c:v>
                </c:pt>
                <c:pt idx="3">
                  <c:v>2.0727149167516141</c:v>
                </c:pt>
                <c:pt idx="4">
                  <c:v>2.4464831804281126</c:v>
                </c:pt>
                <c:pt idx="5">
                  <c:v>2.2765885151206247</c:v>
                </c:pt>
                <c:pt idx="6">
                  <c:v>1.427115188583078</c:v>
                </c:pt>
                <c:pt idx="7">
                  <c:v>2.242609582059123</c:v>
                </c:pt>
                <c:pt idx="8">
                  <c:v>2.1066938498131162</c:v>
                </c:pt>
                <c:pt idx="9">
                  <c:v>1.7329255861365971</c:v>
                </c:pt>
                <c:pt idx="10">
                  <c:v>2.0047570506286112</c:v>
                </c:pt>
                <c:pt idx="11">
                  <c:v>1.563030920829086</c:v>
                </c:pt>
                <c:pt idx="12">
                  <c:v>1.63098878695209</c:v>
                </c:pt>
                <c:pt idx="13">
                  <c:v>1.9367991845056061</c:v>
                </c:pt>
                <c:pt idx="14">
                  <c:v>1.427115188583078</c:v>
                </c:pt>
                <c:pt idx="15">
                  <c:v>1.3251783893985731</c:v>
                </c:pt>
                <c:pt idx="16">
                  <c:v>1.2232415902140548</c:v>
                </c:pt>
                <c:pt idx="17">
                  <c:v>1.7329255861365971</c:v>
                </c:pt>
                <c:pt idx="18">
                  <c:v>1.56303092082908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0-1182-4396-A787-9A90C1232515}"/>
            </c:ext>
          </c:extLst>
        </c:ser>
        <c:ser>
          <c:idx val="17"/>
          <c:order val="17"/>
          <c:tx>
            <c:strRef>
              <c:f>'3nt'!$A$581</c:f>
              <c:strCache>
                <c:ptCount val="1"/>
                <c:pt idx="0">
                  <c:v>GAA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581:$T$581</c:f>
              <c:numCache>
                <c:formatCode>General</c:formatCode>
                <c:ptCount val="19"/>
                <c:pt idx="0">
                  <c:v>1.5290519877675839</c:v>
                </c:pt>
                <c:pt idx="1">
                  <c:v>1.6649677200136013</c:v>
                </c:pt>
                <c:pt idx="2">
                  <c:v>1.4610941216445799</c:v>
                </c:pt>
                <c:pt idx="3">
                  <c:v>1.495073054706082</c:v>
                </c:pt>
                <c:pt idx="4">
                  <c:v>1.9028202514440928</c:v>
                </c:pt>
                <c:pt idx="5">
                  <c:v>1.25722052327557</c:v>
                </c:pt>
                <c:pt idx="6">
                  <c:v>1.495073054706082</c:v>
                </c:pt>
                <c:pt idx="7">
                  <c:v>1.834862385321101</c:v>
                </c:pt>
                <c:pt idx="8">
                  <c:v>1.3591573224600761</c:v>
                </c:pt>
                <c:pt idx="9">
                  <c:v>1.427115188583078</c:v>
                </c:pt>
                <c:pt idx="10">
                  <c:v>1.2232415902140548</c:v>
                </c:pt>
                <c:pt idx="11">
                  <c:v>1.563030920829086</c:v>
                </c:pt>
                <c:pt idx="12">
                  <c:v>1.1892626571525557</c:v>
                </c:pt>
                <c:pt idx="13">
                  <c:v>1.6649677200136013</c:v>
                </c:pt>
                <c:pt idx="14">
                  <c:v>1.834862385321101</c:v>
                </c:pt>
                <c:pt idx="15">
                  <c:v>2.2086306489976639</c:v>
                </c:pt>
                <c:pt idx="16">
                  <c:v>2.786272511043153</c:v>
                </c:pt>
                <c:pt idx="17">
                  <c:v>3.2619775739041801</c:v>
                </c:pt>
                <c:pt idx="18">
                  <c:v>2.990146109412157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1-1182-4396-A787-9A90C1232515}"/>
            </c:ext>
          </c:extLst>
        </c:ser>
        <c:ser>
          <c:idx val="18"/>
          <c:order val="18"/>
          <c:tx>
            <c:strRef>
              <c:f>'3nt'!$A$582</c:f>
              <c:strCache>
                <c:ptCount val="1"/>
                <c:pt idx="0">
                  <c:v>ACA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582:$T$582</c:f>
              <c:numCache>
                <c:formatCode>General</c:formatCode>
                <c:ptCount val="19"/>
                <c:pt idx="0">
                  <c:v>1.3251783893985731</c:v>
                </c:pt>
                <c:pt idx="1">
                  <c:v>1.8688413183826018</c:v>
                </c:pt>
                <c:pt idx="2">
                  <c:v>1.698946653075093</c:v>
                </c:pt>
                <c:pt idx="3">
                  <c:v>1.63098878695209</c:v>
                </c:pt>
                <c:pt idx="4">
                  <c:v>1.63098878695209</c:v>
                </c:pt>
                <c:pt idx="5">
                  <c:v>1.698946653075093</c:v>
                </c:pt>
                <c:pt idx="6">
                  <c:v>2.0047570506286112</c:v>
                </c:pt>
                <c:pt idx="7">
                  <c:v>1.7329255861365971</c:v>
                </c:pt>
                <c:pt idx="8">
                  <c:v>1.3931362555215758</c:v>
                </c:pt>
                <c:pt idx="9">
                  <c:v>1.834862385321101</c:v>
                </c:pt>
                <c:pt idx="10">
                  <c:v>1.63098878695209</c:v>
                </c:pt>
                <c:pt idx="11">
                  <c:v>1.563030920829086</c:v>
                </c:pt>
                <c:pt idx="12">
                  <c:v>1.563030920829086</c:v>
                </c:pt>
                <c:pt idx="13">
                  <c:v>1.7669045191980979</c:v>
                </c:pt>
                <c:pt idx="14">
                  <c:v>1.3251783893985731</c:v>
                </c:pt>
                <c:pt idx="15">
                  <c:v>1.7329255861365971</c:v>
                </c:pt>
                <c:pt idx="16">
                  <c:v>2.0047570506286112</c:v>
                </c:pt>
                <c:pt idx="17">
                  <c:v>2.242609582059123</c:v>
                </c:pt>
                <c:pt idx="18">
                  <c:v>2.854230377166157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2-1182-4396-A787-9A90C1232515}"/>
            </c:ext>
          </c:extLst>
        </c:ser>
        <c:ser>
          <c:idx val="19"/>
          <c:order val="19"/>
          <c:tx>
            <c:strRef>
              <c:f>'3nt'!$A$583</c:f>
              <c:strCache>
                <c:ptCount val="1"/>
                <c:pt idx="0">
                  <c:v>AUG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583:$T$583</c:f>
              <c:numCache>
                <c:formatCode>General</c:formatCode>
                <c:ptCount val="19"/>
                <c:pt idx="0">
                  <c:v>1.5970098538905879</c:v>
                </c:pt>
                <c:pt idx="1">
                  <c:v>1.2911994563370597</c:v>
                </c:pt>
                <c:pt idx="2">
                  <c:v>1.563030920829086</c:v>
                </c:pt>
                <c:pt idx="3">
                  <c:v>1.9028202514440928</c:v>
                </c:pt>
                <c:pt idx="4">
                  <c:v>1.7329255861365971</c:v>
                </c:pt>
                <c:pt idx="5">
                  <c:v>1.7329255861365971</c:v>
                </c:pt>
                <c:pt idx="6">
                  <c:v>1.6649677200136013</c:v>
                </c:pt>
                <c:pt idx="7">
                  <c:v>1.5970098538905879</c:v>
                </c:pt>
                <c:pt idx="8">
                  <c:v>1.698946653075093</c:v>
                </c:pt>
                <c:pt idx="9">
                  <c:v>1.495073054706082</c:v>
                </c:pt>
                <c:pt idx="10">
                  <c:v>1.6649677200136013</c:v>
                </c:pt>
                <c:pt idx="11">
                  <c:v>1.1892626571525557</c:v>
                </c:pt>
                <c:pt idx="12">
                  <c:v>1.8008834522595978</c:v>
                </c:pt>
                <c:pt idx="13">
                  <c:v>1.1892626571525557</c:v>
                </c:pt>
                <c:pt idx="14">
                  <c:v>1.563030920829086</c:v>
                </c:pt>
                <c:pt idx="15">
                  <c:v>1.834862385321101</c:v>
                </c:pt>
                <c:pt idx="16">
                  <c:v>2.3445463812436267</c:v>
                </c:pt>
                <c:pt idx="17">
                  <c:v>2.9221882432891597</c:v>
                </c:pt>
                <c:pt idx="18">
                  <c:v>2.684335711858668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3-1182-4396-A787-9A90C1232515}"/>
            </c:ext>
          </c:extLst>
        </c:ser>
        <c:ser>
          <c:idx val="20"/>
          <c:order val="20"/>
          <c:tx>
            <c:strRef>
              <c:f>'3nt'!$A$584</c:f>
              <c:strCache>
                <c:ptCount val="1"/>
                <c:pt idx="0">
                  <c:v>GUU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584:$T$584</c:f>
              <c:numCache>
                <c:formatCode>General</c:formatCode>
                <c:ptCount val="19"/>
                <c:pt idx="0">
                  <c:v>1.8688413183826018</c:v>
                </c:pt>
                <c:pt idx="1">
                  <c:v>1.5290519877675839</c:v>
                </c:pt>
                <c:pt idx="2">
                  <c:v>1.5970098538905879</c:v>
                </c:pt>
                <c:pt idx="3">
                  <c:v>1.63098878695209</c:v>
                </c:pt>
                <c:pt idx="4">
                  <c:v>1.8008834522595978</c:v>
                </c:pt>
                <c:pt idx="5">
                  <c:v>1.7329255861365971</c:v>
                </c:pt>
                <c:pt idx="6">
                  <c:v>1.6649677200136013</c:v>
                </c:pt>
                <c:pt idx="7">
                  <c:v>1.427115188583078</c:v>
                </c:pt>
                <c:pt idx="8">
                  <c:v>1.9028202514440928</c:v>
                </c:pt>
                <c:pt idx="9">
                  <c:v>1.698946653075093</c:v>
                </c:pt>
                <c:pt idx="10">
                  <c:v>1.4610941216445799</c:v>
                </c:pt>
                <c:pt idx="11">
                  <c:v>1.563030920829086</c:v>
                </c:pt>
                <c:pt idx="12">
                  <c:v>1.2232415902140548</c:v>
                </c:pt>
                <c:pt idx="13">
                  <c:v>1.5970098538905879</c:v>
                </c:pt>
                <c:pt idx="14">
                  <c:v>1.5970098538905879</c:v>
                </c:pt>
                <c:pt idx="15">
                  <c:v>1.1892626571525557</c:v>
                </c:pt>
                <c:pt idx="16">
                  <c:v>1.3931362555215758</c:v>
                </c:pt>
                <c:pt idx="17">
                  <c:v>2.1746517159361201</c:v>
                </c:pt>
                <c:pt idx="18">
                  <c:v>1.6309887869520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4-1182-4396-A787-9A90C1232515}"/>
            </c:ext>
          </c:extLst>
        </c:ser>
        <c:ser>
          <c:idx val="21"/>
          <c:order val="21"/>
          <c:tx>
            <c:strRef>
              <c:f>'3nt'!$A$585</c:f>
              <c:strCache>
                <c:ptCount val="1"/>
                <c:pt idx="0">
                  <c:v>UGA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585:$T$585</c:f>
              <c:numCache>
                <c:formatCode>General</c:formatCode>
                <c:ptCount val="19"/>
                <c:pt idx="0">
                  <c:v>1.698946653075093</c:v>
                </c:pt>
                <c:pt idx="1">
                  <c:v>1.5970098538905879</c:v>
                </c:pt>
                <c:pt idx="2">
                  <c:v>1.5970098538905879</c:v>
                </c:pt>
                <c:pt idx="3">
                  <c:v>1.6649677200136013</c:v>
                </c:pt>
                <c:pt idx="4">
                  <c:v>1.7329255861365971</c:v>
                </c:pt>
                <c:pt idx="5">
                  <c:v>1.563030920829086</c:v>
                </c:pt>
                <c:pt idx="6">
                  <c:v>1.9707781175671071</c:v>
                </c:pt>
                <c:pt idx="7">
                  <c:v>1.3251783893985731</c:v>
                </c:pt>
                <c:pt idx="8">
                  <c:v>1.5970098538905879</c:v>
                </c:pt>
                <c:pt idx="9">
                  <c:v>1.2232415902140548</c:v>
                </c:pt>
                <c:pt idx="10">
                  <c:v>1.9707781175671071</c:v>
                </c:pt>
                <c:pt idx="11">
                  <c:v>1.563030920829086</c:v>
                </c:pt>
                <c:pt idx="12">
                  <c:v>1.3591573224600761</c:v>
                </c:pt>
                <c:pt idx="13">
                  <c:v>1.427115188583078</c:v>
                </c:pt>
                <c:pt idx="14">
                  <c:v>0.95141012572204176</c:v>
                </c:pt>
                <c:pt idx="15">
                  <c:v>1.3931362555215758</c:v>
                </c:pt>
                <c:pt idx="16">
                  <c:v>1.698946653075093</c:v>
                </c:pt>
                <c:pt idx="17">
                  <c:v>1.8688413183826018</c:v>
                </c:pt>
                <c:pt idx="18">
                  <c:v>2.106693849813116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5-1182-4396-A787-9A90C1232515}"/>
            </c:ext>
          </c:extLst>
        </c:ser>
        <c:ser>
          <c:idx val="22"/>
          <c:order val="22"/>
          <c:tx>
            <c:strRef>
              <c:f>'3nt'!$A$586</c:f>
              <c:strCache>
                <c:ptCount val="1"/>
                <c:pt idx="0">
                  <c:v>CAA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586:$T$586</c:f>
              <c:numCache>
                <c:formatCode>General</c:formatCode>
                <c:ptCount val="19"/>
                <c:pt idx="0">
                  <c:v>1.63098878695209</c:v>
                </c:pt>
                <c:pt idx="1">
                  <c:v>1.3931362555215758</c:v>
                </c:pt>
                <c:pt idx="2">
                  <c:v>1.8688413183826018</c:v>
                </c:pt>
                <c:pt idx="3">
                  <c:v>1.2232415902140548</c:v>
                </c:pt>
                <c:pt idx="4">
                  <c:v>1.2911994563370597</c:v>
                </c:pt>
                <c:pt idx="5">
                  <c:v>1.1892626571525557</c:v>
                </c:pt>
                <c:pt idx="6">
                  <c:v>1.834862385321101</c:v>
                </c:pt>
                <c:pt idx="7">
                  <c:v>1.6649677200136013</c:v>
                </c:pt>
                <c:pt idx="8">
                  <c:v>1.4610941216445799</c:v>
                </c:pt>
                <c:pt idx="9">
                  <c:v>2.0727149167516141</c:v>
                </c:pt>
                <c:pt idx="10">
                  <c:v>1.7669045191980979</c:v>
                </c:pt>
                <c:pt idx="11">
                  <c:v>1.25722052327557</c:v>
                </c:pt>
                <c:pt idx="12">
                  <c:v>1.1552837240910763</c:v>
                </c:pt>
                <c:pt idx="13">
                  <c:v>1.1892626571525557</c:v>
                </c:pt>
                <c:pt idx="14">
                  <c:v>1.1552837240910763</c:v>
                </c:pt>
                <c:pt idx="15">
                  <c:v>1.4610941216445799</c:v>
                </c:pt>
                <c:pt idx="16">
                  <c:v>1.4610941216445799</c:v>
                </c:pt>
                <c:pt idx="17">
                  <c:v>1.8008834522595978</c:v>
                </c:pt>
                <c:pt idx="18">
                  <c:v>1.868841318382601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6-1182-4396-A787-9A90C1232515}"/>
            </c:ext>
          </c:extLst>
        </c:ser>
        <c:ser>
          <c:idx val="23"/>
          <c:order val="23"/>
          <c:tx>
            <c:strRef>
              <c:f>'3nt'!$A$587</c:f>
              <c:strCache>
                <c:ptCount val="1"/>
                <c:pt idx="0">
                  <c:v>CAU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587:$T$587</c:f>
              <c:numCache>
                <c:formatCode>General</c:formatCode>
                <c:ptCount val="19"/>
                <c:pt idx="0">
                  <c:v>1.1552837240910763</c:v>
                </c:pt>
                <c:pt idx="1">
                  <c:v>1.6649677200136013</c:v>
                </c:pt>
                <c:pt idx="2">
                  <c:v>1.698946653075093</c:v>
                </c:pt>
                <c:pt idx="3">
                  <c:v>1.63098878695209</c:v>
                </c:pt>
                <c:pt idx="4">
                  <c:v>1.495073054706082</c:v>
                </c:pt>
                <c:pt idx="5">
                  <c:v>2.0727149167516141</c:v>
                </c:pt>
                <c:pt idx="6">
                  <c:v>1.1892626571525557</c:v>
                </c:pt>
                <c:pt idx="7">
                  <c:v>2.0047570506286112</c:v>
                </c:pt>
                <c:pt idx="8">
                  <c:v>1.63098878695209</c:v>
                </c:pt>
                <c:pt idx="9">
                  <c:v>1.563030920829086</c:v>
                </c:pt>
                <c:pt idx="10">
                  <c:v>1.2911994563370597</c:v>
                </c:pt>
                <c:pt idx="11">
                  <c:v>1.7669045191980979</c:v>
                </c:pt>
                <c:pt idx="12">
                  <c:v>1.7329255861365971</c:v>
                </c:pt>
                <c:pt idx="13">
                  <c:v>1.3251783893985731</c:v>
                </c:pt>
                <c:pt idx="14">
                  <c:v>1.1552837240910763</c:v>
                </c:pt>
                <c:pt idx="15">
                  <c:v>0.88345225959904894</c:v>
                </c:pt>
                <c:pt idx="16">
                  <c:v>1.3591573224600761</c:v>
                </c:pt>
                <c:pt idx="17">
                  <c:v>1.2911994563370597</c:v>
                </c:pt>
                <c:pt idx="18">
                  <c:v>1.732925586136597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7-1182-4396-A787-9A90C1232515}"/>
            </c:ext>
          </c:extLst>
        </c:ser>
        <c:ser>
          <c:idx val="24"/>
          <c:order val="24"/>
          <c:tx>
            <c:strRef>
              <c:f>'3nt'!$A$588</c:f>
              <c:strCache>
                <c:ptCount val="1"/>
                <c:pt idx="0">
                  <c:v>UUG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588:$T$588</c:f>
              <c:numCache>
                <c:formatCode>General</c:formatCode>
                <c:ptCount val="19"/>
                <c:pt idx="0">
                  <c:v>1.8688413183826018</c:v>
                </c:pt>
                <c:pt idx="1">
                  <c:v>2.0727149167516141</c:v>
                </c:pt>
                <c:pt idx="2">
                  <c:v>2.3445463812436267</c:v>
                </c:pt>
                <c:pt idx="3">
                  <c:v>1.9028202514440928</c:v>
                </c:pt>
                <c:pt idx="4">
                  <c:v>1.9028202514440928</c:v>
                </c:pt>
                <c:pt idx="5">
                  <c:v>1.6649677200136013</c:v>
                </c:pt>
                <c:pt idx="6">
                  <c:v>1.5970098538905879</c:v>
                </c:pt>
                <c:pt idx="7">
                  <c:v>1.4610941216445799</c:v>
                </c:pt>
                <c:pt idx="8">
                  <c:v>1.2232415902140548</c:v>
                </c:pt>
                <c:pt idx="9">
                  <c:v>1.698946653075093</c:v>
                </c:pt>
                <c:pt idx="10">
                  <c:v>0.74753652735304099</c:v>
                </c:pt>
                <c:pt idx="11">
                  <c:v>1.1213047910295517</c:v>
                </c:pt>
                <c:pt idx="12">
                  <c:v>0.95141012572204176</c:v>
                </c:pt>
                <c:pt idx="13">
                  <c:v>0.71355759429153898</c:v>
                </c:pt>
                <c:pt idx="14">
                  <c:v>0.74753652735304099</c:v>
                </c:pt>
                <c:pt idx="15">
                  <c:v>0.95141012572204176</c:v>
                </c:pt>
                <c:pt idx="16">
                  <c:v>1.3591573224600761</c:v>
                </c:pt>
                <c:pt idx="17">
                  <c:v>1.2232415902140548</c:v>
                </c:pt>
                <c:pt idx="18">
                  <c:v>1.970778117567107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8-1182-4396-A787-9A90C1232515}"/>
            </c:ext>
          </c:extLst>
        </c:ser>
        <c:ser>
          <c:idx val="25"/>
          <c:order val="25"/>
          <c:tx>
            <c:strRef>
              <c:f>'3nt'!$A$589</c:f>
              <c:strCache>
                <c:ptCount val="1"/>
                <c:pt idx="0">
                  <c:v>UUU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589:$T$589</c:f>
              <c:numCache>
                <c:formatCode>General</c:formatCode>
                <c:ptCount val="19"/>
                <c:pt idx="0">
                  <c:v>1.495073054706082</c:v>
                </c:pt>
                <c:pt idx="1">
                  <c:v>1.2911994563370597</c:v>
                </c:pt>
                <c:pt idx="2">
                  <c:v>1.4610941216445799</c:v>
                </c:pt>
                <c:pt idx="3">
                  <c:v>1.3251783893985731</c:v>
                </c:pt>
                <c:pt idx="4">
                  <c:v>1.698946653075093</c:v>
                </c:pt>
                <c:pt idx="5">
                  <c:v>1.3251783893985731</c:v>
                </c:pt>
                <c:pt idx="6">
                  <c:v>1.2232415902140548</c:v>
                </c:pt>
                <c:pt idx="7">
                  <c:v>1.4610941216445799</c:v>
                </c:pt>
                <c:pt idx="8">
                  <c:v>1.4610941216445799</c:v>
                </c:pt>
                <c:pt idx="9">
                  <c:v>1.25722052327557</c:v>
                </c:pt>
                <c:pt idx="10">
                  <c:v>1.427115188583078</c:v>
                </c:pt>
                <c:pt idx="11">
                  <c:v>1.1552837240910763</c:v>
                </c:pt>
                <c:pt idx="12">
                  <c:v>1.3591573224600761</c:v>
                </c:pt>
                <c:pt idx="13">
                  <c:v>1.698946653075093</c:v>
                </c:pt>
                <c:pt idx="14">
                  <c:v>1.019367991845056</c:v>
                </c:pt>
                <c:pt idx="15">
                  <c:v>1.427115188583078</c:v>
                </c:pt>
                <c:pt idx="16">
                  <c:v>0.61162079510703404</c:v>
                </c:pt>
                <c:pt idx="17">
                  <c:v>1.0873258579680598</c:v>
                </c:pt>
                <c:pt idx="18">
                  <c:v>1.8348623853211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9-1182-4396-A787-9A90C1232515}"/>
            </c:ext>
          </c:extLst>
        </c:ser>
        <c:ser>
          <c:idx val="26"/>
          <c:order val="26"/>
          <c:tx>
            <c:strRef>
              <c:f>'3nt'!$A$590</c:f>
              <c:strCache>
                <c:ptCount val="1"/>
                <c:pt idx="0">
                  <c:v>UCU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590:$T$590</c:f>
              <c:numCache>
                <c:formatCode>General</c:formatCode>
                <c:ptCount val="19"/>
                <c:pt idx="0">
                  <c:v>1.019367991845056</c:v>
                </c:pt>
                <c:pt idx="1">
                  <c:v>1.0533469249065754</c:v>
                </c:pt>
                <c:pt idx="2">
                  <c:v>1.2911994563370597</c:v>
                </c:pt>
                <c:pt idx="3">
                  <c:v>1.2232415902140548</c:v>
                </c:pt>
                <c:pt idx="4">
                  <c:v>1.3591573224600761</c:v>
                </c:pt>
                <c:pt idx="5">
                  <c:v>1.4610941216445799</c:v>
                </c:pt>
                <c:pt idx="6">
                  <c:v>1.495073054706082</c:v>
                </c:pt>
                <c:pt idx="7">
                  <c:v>1.1213047910295517</c:v>
                </c:pt>
                <c:pt idx="8">
                  <c:v>1.563030920829086</c:v>
                </c:pt>
                <c:pt idx="9">
                  <c:v>1.8688413183826018</c:v>
                </c:pt>
                <c:pt idx="10">
                  <c:v>1.7669045191980979</c:v>
                </c:pt>
                <c:pt idx="11">
                  <c:v>1.8008834522595978</c:v>
                </c:pt>
                <c:pt idx="12">
                  <c:v>1.4610941216445799</c:v>
                </c:pt>
                <c:pt idx="13">
                  <c:v>1.6649677200136013</c:v>
                </c:pt>
                <c:pt idx="14">
                  <c:v>1.0533469249065754</c:v>
                </c:pt>
                <c:pt idx="15">
                  <c:v>0.84947332653754704</c:v>
                </c:pt>
                <c:pt idx="16">
                  <c:v>0.91743119266055106</c:v>
                </c:pt>
                <c:pt idx="17">
                  <c:v>0.81549439347604502</c:v>
                </c:pt>
                <c:pt idx="18">
                  <c:v>1.49507305470608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A-1182-4396-A787-9A90C1232515}"/>
            </c:ext>
          </c:extLst>
        </c:ser>
        <c:ser>
          <c:idx val="27"/>
          <c:order val="27"/>
          <c:tx>
            <c:strRef>
              <c:f>'3nt'!$A$591</c:f>
              <c:strCache>
                <c:ptCount val="1"/>
                <c:pt idx="0">
                  <c:v>AUC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591:$T$591</c:f>
              <c:numCache>
                <c:formatCode>General</c:formatCode>
                <c:ptCount val="19"/>
                <c:pt idx="0">
                  <c:v>1.1552837240910763</c:v>
                </c:pt>
                <c:pt idx="1">
                  <c:v>1.427115188583078</c:v>
                </c:pt>
                <c:pt idx="2">
                  <c:v>1.1892626571525557</c:v>
                </c:pt>
                <c:pt idx="3">
                  <c:v>1.0533469249065754</c:v>
                </c:pt>
                <c:pt idx="4">
                  <c:v>1.1213047910295517</c:v>
                </c:pt>
                <c:pt idx="5">
                  <c:v>1.2232415902140548</c:v>
                </c:pt>
                <c:pt idx="6">
                  <c:v>0.78151546041454301</c:v>
                </c:pt>
                <c:pt idx="7">
                  <c:v>1.1552837240910763</c:v>
                </c:pt>
                <c:pt idx="8">
                  <c:v>1.7329255861365971</c:v>
                </c:pt>
                <c:pt idx="9">
                  <c:v>1.5970098538905879</c:v>
                </c:pt>
                <c:pt idx="10">
                  <c:v>1.3931362555215758</c:v>
                </c:pt>
                <c:pt idx="11">
                  <c:v>0.98538905878355398</c:v>
                </c:pt>
                <c:pt idx="12">
                  <c:v>1.25722052327557</c:v>
                </c:pt>
                <c:pt idx="13">
                  <c:v>1.1213047910295517</c:v>
                </c:pt>
                <c:pt idx="14">
                  <c:v>1.0873258579680598</c:v>
                </c:pt>
                <c:pt idx="15">
                  <c:v>1.5290519877675839</c:v>
                </c:pt>
                <c:pt idx="16">
                  <c:v>1.563030920829086</c:v>
                </c:pt>
                <c:pt idx="17">
                  <c:v>1.63098878695209</c:v>
                </c:pt>
                <c:pt idx="18">
                  <c:v>1.732925586136597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B-1182-4396-A787-9A90C1232515}"/>
            </c:ext>
          </c:extLst>
        </c:ser>
        <c:ser>
          <c:idx val="28"/>
          <c:order val="28"/>
          <c:tx>
            <c:strRef>
              <c:f>'3nt'!$A$592</c:f>
              <c:strCache>
                <c:ptCount val="1"/>
                <c:pt idx="0">
                  <c:v>CUU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592:$T$592</c:f>
              <c:numCache>
                <c:formatCode>General</c:formatCode>
                <c:ptCount val="19"/>
                <c:pt idx="0">
                  <c:v>1.1552837240910763</c:v>
                </c:pt>
                <c:pt idx="1">
                  <c:v>1.1213047910295517</c:v>
                </c:pt>
                <c:pt idx="2">
                  <c:v>0.84947332653754704</c:v>
                </c:pt>
                <c:pt idx="3">
                  <c:v>1.2232415902140548</c:v>
                </c:pt>
                <c:pt idx="4">
                  <c:v>1.7669045191980979</c:v>
                </c:pt>
                <c:pt idx="5">
                  <c:v>1.698946653075093</c:v>
                </c:pt>
                <c:pt idx="6">
                  <c:v>1.5970098538905879</c:v>
                </c:pt>
                <c:pt idx="7">
                  <c:v>1.0533469249065754</c:v>
                </c:pt>
                <c:pt idx="8">
                  <c:v>1.1892626571525557</c:v>
                </c:pt>
                <c:pt idx="9">
                  <c:v>1.563030920829086</c:v>
                </c:pt>
                <c:pt idx="10">
                  <c:v>1.3931362555215758</c:v>
                </c:pt>
                <c:pt idx="11">
                  <c:v>1.2232415902140548</c:v>
                </c:pt>
                <c:pt idx="12">
                  <c:v>1.5970098538905879</c:v>
                </c:pt>
                <c:pt idx="13">
                  <c:v>0.98538905878355398</c:v>
                </c:pt>
                <c:pt idx="14">
                  <c:v>1.1213047910295517</c:v>
                </c:pt>
                <c:pt idx="15">
                  <c:v>1.1213047910295517</c:v>
                </c:pt>
                <c:pt idx="16">
                  <c:v>1.1892626571525557</c:v>
                </c:pt>
                <c:pt idx="17">
                  <c:v>1.0533469249065754</c:v>
                </c:pt>
                <c:pt idx="18">
                  <c:v>1.121304791029551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C-1182-4396-A787-9A90C1232515}"/>
            </c:ext>
          </c:extLst>
        </c:ser>
        <c:ser>
          <c:idx val="29"/>
          <c:order val="29"/>
          <c:tx>
            <c:strRef>
              <c:f>'3nt'!$A$593</c:f>
              <c:strCache>
                <c:ptCount val="1"/>
                <c:pt idx="0">
                  <c:v>UAC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593:$T$593</c:f>
              <c:numCache>
                <c:formatCode>General</c:formatCode>
                <c:ptCount val="19"/>
                <c:pt idx="0">
                  <c:v>1.2911994563370597</c:v>
                </c:pt>
                <c:pt idx="1">
                  <c:v>1.3251783893985731</c:v>
                </c:pt>
                <c:pt idx="2">
                  <c:v>1.3591573224600761</c:v>
                </c:pt>
                <c:pt idx="3">
                  <c:v>1.0533469249065754</c:v>
                </c:pt>
                <c:pt idx="4">
                  <c:v>1.2911994563370597</c:v>
                </c:pt>
                <c:pt idx="5">
                  <c:v>1.2232415902140548</c:v>
                </c:pt>
                <c:pt idx="6">
                  <c:v>1.3931362555215758</c:v>
                </c:pt>
                <c:pt idx="7">
                  <c:v>1.1213047910295517</c:v>
                </c:pt>
                <c:pt idx="8">
                  <c:v>1.563030920829086</c:v>
                </c:pt>
                <c:pt idx="9">
                  <c:v>1.3931362555215758</c:v>
                </c:pt>
                <c:pt idx="10">
                  <c:v>1.495073054706082</c:v>
                </c:pt>
                <c:pt idx="11">
                  <c:v>1.2911994563370597</c:v>
                </c:pt>
                <c:pt idx="12">
                  <c:v>1.2232415902140548</c:v>
                </c:pt>
                <c:pt idx="13">
                  <c:v>1.1213047910295517</c:v>
                </c:pt>
                <c:pt idx="14">
                  <c:v>0.84947332653754704</c:v>
                </c:pt>
                <c:pt idx="15">
                  <c:v>0.91743119266055106</c:v>
                </c:pt>
                <c:pt idx="16">
                  <c:v>0.95141012572204176</c:v>
                </c:pt>
                <c:pt idx="17">
                  <c:v>1.2232415902140548</c:v>
                </c:pt>
                <c:pt idx="18">
                  <c:v>1.529051987767583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D-1182-4396-A787-9A90C1232515}"/>
            </c:ext>
          </c:extLst>
        </c:ser>
        <c:ser>
          <c:idx val="30"/>
          <c:order val="30"/>
          <c:tx>
            <c:strRef>
              <c:f>'3nt'!$A$594</c:f>
              <c:strCache>
                <c:ptCount val="1"/>
                <c:pt idx="0">
                  <c:v>UCA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594:$T$594</c:f>
              <c:numCache>
                <c:formatCode>General</c:formatCode>
                <c:ptCount val="19"/>
                <c:pt idx="0">
                  <c:v>1.3251783893985731</c:v>
                </c:pt>
                <c:pt idx="1">
                  <c:v>1.6649677200136013</c:v>
                </c:pt>
                <c:pt idx="2">
                  <c:v>1.4610941216445799</c:v>
                </c:pt>
                <c:pt idx="3">
                  <c:v>1.63098878695209</c:v>
                </c:pt>
                <c:pt idx="4">
                  <c:v>1.2232415902140548</c:v>
                </c:pt>
                <c:pt idx="5">
                  <c:v>1.25722052327557</c:v>
                </c:pt>
                <c:pt idx="6">
                  <c:v>1.0873258579680598</c:v>
                </c:pt>
                <c:pt idx="7">
                  <c:v>0.98538905878355398</c:v>
                </c:pt>
                <c:pt idx="8">
                  <c:v>1.3251783893985731</c:v>
                </c:pt>
                <c:pt idx="9">
                  <c:v>1.25722052327557</c:v>
                </c:pt>
                <c:pt idx="10">
                  <c:v>0.95141012572204176</c:v>
                </c:pt>
                <c:pt idx="11">
                  <c:v>0.95141012572204176</c:v>
                </c:pt>
                <c:pt idx="12">
                  <c:v>0.91743119266055106</c:v>
                </c:pt>
                <c:pt idx="13">
                  <c:v>0.71355759429153898</c:v>
                </c:pt>
                <c:pt idx="14">
                  <c:v>0.78151546041454301</c:v>
                </c:pt>
                <c:pt idx="15">
                  <c:v>1.1552837240910763</c:v>
                </c:pt>
                <c:pt idx="16">
                  <c:v>1.2232415902140548</c:v>
                </c:pt>
                <c:pt idx="17">
                  <c:v>1.4610941216445799</c:v>
                </c:pt>
                <c:pt idx="18">
                  <c:v>1.49507305470608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E-1182-4396-A787-9A90C1232515}"/>
            </c:ext>
          </c:extLst>
        </c:ser>
        <c:ser>
          <c:idx val="31"/>
          <c:order val="31"/>
          <c:tx>
            <c:strRef>
              <c:f>'3nt'!$A$595</c:f>
              <c:strCache>
                <c:ptCount val="1"/>
                <c:pt idx="0">
                  <c:v>AGC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595:$T$595</c:f>
              <c:numCache>
                <c:formatCode>General</c:formatCode>
                <c:ptCount val="19"/>
                <c:pt idx="0">
                  <c:v>0.78151546041454301</c:v>
                </c:pt>
                <c:pt idx="1">
                  <c:v>0.74753652735304099</c:v>
                </c:pt>
                <c:pt idx="2">
                  <c:v>1.2232415902140548</c:v>
                </c:pt>
                <c:pt idx="3">
                  <c:v>0.98538905878355398</c:v>
                </c:pt>
                <c:pt idx="4">
                  <c:v>0.78151546041454301</c:v>
                </c:pt>
                <c:pt idx="5">
                  <c:v>0.5436629289840299</c:v>
                </c:pt>
                <c:pt idx="6">
                  <c:v>0.95141012572204176</c:v>
                </c:pt>
                <c:pt idx="7">
                  <c:v>0.84947332653754704</c:v>
                </c:pt>
                <c:pt idx="8">
                  <c:v>0.61162079510703404</c:v>
                </c:pt>
                <c:pt idx="9">
                  <c:v>0.57764186204554224</c:v>
                </c:pt>
                <c:pt idx="10">
                  <c:v>0.74753652735304099</c:v>
                </c:pt>
                <c:pt idx="11">
                  <c:v>0.71355759429153898</c:v>
                </c:pt>
                <c:pt idx="12">
                  <c:v>0.91743119266055106</c:v>
                </c:pt>
                <c:pt idx="13">
                  <c:v>1.2911994563370597</c:v>
                </c:pt>
                <c:pt idx="14">
                  <c:v>1.3591573224600761</c:v>
                </c:pt>
                <c:pt idx="15">
                  <c:v>1.25722052327557</c:v>
                </c:pt>
                <c:pt idx="16">
                  <c:v>2.2086306489976639</c:v>
                </c:pt>
                <c:pt idx="17">
                  <c:v>1.3591573224600761</c:v>
                </c:pt>
                <c:pt idx="18">
                  <c:v>1.325178389398573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F-1182-4396-A787-9A90C1232515}"/>
            </c:ext>
          </c:extLst>
        </c:ser>
        <c:ser>
          <c:idx val="32"/>
          <c:order val="32"/>
          <c:tx>
            <c:strRef>
              <c:f>'3nt'!$A$596</c:f>
              <c:strCache>
                <c:ptCount val="1"/>
                <c:pt idx="0">
                  <c:v>GAG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596:$T$596</c:f>
              <c:numCache>
                <c:formatCode>General</c:formatCode>
                <c:ptCount val="19"/>
                <c:pt idx="0">
                  <c:v>1.427115188583078</c:v>
                </c:pt>
                <c:pt idx="1">
                  <c:v>1.495073054706082</c:v>
                </c:pt>
                <c:pt idx="2">
                  <c:v>0.95141012572204176</c:v>
                </c:pt>
                <c:pt idx="3">
                  <c:v>0.95141012572204176</c:v>
                </c:pt>
                <c:pt idx="4">
                  <c:v>0.88345225959904894</c:v>
                </c:pt>
                <c:pt idx="5">
                  <c:v>1.1552837240910763</c:v>
                </c:pt>
                <c:pt idx="6">
                  <c:v>1.0873258579680598</c:v>
                </c:pt>
                <c:pt idx="7">
                  <c:v>0.88345225959904894</c:v>
                </c:pt>
                <c:pt idx="8">
                  <c:v>0.67957866123003807</c:v>
                </c:pt>
                <c:pt idx="9">
                  <c:v>0.47570506286102598</c:v>
                </c:pt>
                <c:pt idx="10">
                  <c:v>0.40774719673802196</c:v>
                </c:pt>
                <c:pt idx="11">
                  <c:v>0.64559972816854216</c:v>
                </c:pt>
                <c:pt idx="12">
                  <c:v>0.5436629289840299</c:v>
                </c:pt>
                <c:pt idx="13">
                  <c:v>0.71355759429153898</c:v>
                </c:pt>
                <c:pt idx="14">
                  <c:v>1.0533469249065754</c:v>
                </c:pt>
                <c:pt idx="15">
                  <c:v>1.0533469249065754</c:v>
                </c:pt>
                <c:pt idx="16">
                  <c:v>0.98538905878355398</c:v>
                </c:pt>
                <c:pt idx="17">
                  <c:v>1.427115188583078</c:v>
                </c:pt>
                <c:pt idx="18">
                  <c:v>1.325178389398573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0-1182-4396-A787-9A90C1232515}"/>
            </c:ext>
          </c:extLst>
        </c:ser>
        <c:ser>
          <c:idx val="33"/>
          <c:order val="33"/>
          <c:tx>
            <c:strRef>
              <c:f>'3nt'!$A$597</c:f>
              <c:strCache>
                <c:ptCount val="1"/>
                <c:pt idx="0">
                  <c:v>UUC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597:$T$597</c:f>
              <c:numCache>
                <c:formatCode>General</c:formatCode>
                <c:ptCount val="19"/>
                <c:pt idx="0">
                  <c:v>1.019367991845056</c:v>
                </c:pt>
                <c:pt idx="1">
                  <c:v>0.98538905878355398</c:v>
                </c:pt>
                <c:pt idx="2">
                  <c:v>1.019367991845056</c:v>
                </c:pt>
                <c:pt idx="3">
                  <c:v>0.95141012572204176</c:v>
                </c:pt>
                <c:pt idx="4">
                  <c:v>0.95141012572204176</c:v>
                </c:pt>
                <c:pt idx="5">
                  <c:v>1.2232415902140548</c:v>
                </c:pt>
                <c:pt idx="6">
                  <c:v>1.1552837240910763</c:v>
                </c:pt>
                <c:pt idx="7">
                  <c:v>1.25722052327557</c:v>
                </c:pt>
                <c:pt idx="8">
                  <c:v>0.98538905878355398</c:v>
                </c:pt>
                <c:pt idx="9">
                  <c:v>1.0873258579680598</c:v>
                </c:pt>
                <c:pt idx="10">
                  <c:v>0.91743119266055106</c:v>
                </c:pt>
                <c:pt idx="11">
                  <c:v>0.84947332653754704</c:v>
                </c:pt>
                <c:pt idx="12">
                  <c:v>0.64559972816854216</c:v>
                </c:pt>
                <c:pt idx="13">
                  <c:v>0.50968399592252789</c:v>
                </c:pt>
                <c:pt idx="14">
                  <c:v>0.71355759429153898</c:v>
                </c:pt>
                <c:pt idx="15">
                  <c:v>0.50968399592252789</c:v>
                </c:pt>
                <c:pt idx="16">
                  <c:v>0.67957866123003807</c:v>
                </c:pt>
                <c:pt idx="17">
                  <c:v>1.0533469249065754</c:v>
                </c:pt>
                <c:pt idx="18">
                  <c:v>1.46109412164457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1-1182-4396-A787-9A90C1232515}"/>
            </c:ext>
          </c:extLst>
        </c:ser>
        <c:ser>
          <c:idx val="34"/>
          <c:order val="34"/>
          <c:tx>
            <c:strRef>
              <c:f>'3nt'!$A$598</c:f>
              <c:strCache>
                <c:ptCount val="1"/>
                <c:pt idx="0">
                  <c:v>GCA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598:$T$598</c:f>
              <c:numCache>
                <c:formatCode>General</c:formatCode>
                <c:ptCount val="19"/>
                <c:pt idx="0">
                  <c:v>1.25722052327557</c:v>
                </c:pt>
                <c:pt idx="1">
                  <c:v>1.1552837240910763</c:v>
                </c:pt>
                <c:pt idx="2">
                  <c:v>1.2232415902140548</c:v>
                </c:pt>
                <c:pt idx="3">
                  <c:v>0.64559972816854216</c:v>
                </c:pt>
                <c:pt idx="4">
                  <c:v>1.4610941216445799</c:v>
                </c:pt>
                <c:pt idx="5">
                  <c:v>0.95141012572204176</c:v>
                </c:pt>
                <c:pt idx="6">
                  <c:v>0.61162079510703404</c:v>
                </c:pt>
                <c:pt idx="7">
                  <c:v>0.95141012572204176</c:v>
                </c:pt>
                <c:pt idx="8">
                  <c:v>1.0873258579680598</c:v>
                </c:pt>
                <c:pt idx="9">
                  <c:v>0.61162079510703404</c:v>
                </c:pt>
                <c:pt idx="10">
                  <c:v>0.71355759429153898</c:v>
                </c:pt>
                <c:pt idx="11">
                  <c:v>0.61162079510703404</c:v>
                </c:pt>
                <c:pt idx="12">
                  <c:v>0.44172612979952502</c:v>
                </c:pt>
                <c:pt idx="13">
                  <c:v>0.37376826367652105</c:v>
                </c:pt>
                <c:pt idx="14">
                  <c:v>1.019367991845056</c:v>
                </c:pt>
                <c:pt idx="15">
                  <c:v>0.67957866123003807</c:v>
                </c:pt>
                <c:pt idx="16">
                  <c:v>0.71355759429153898</c:v>
                </c:pt>
                <c:pt idx="17">
                  <c:v>1.563030920829086</c:v>
                </c:pt>
                <c:pt idx="18">
                  <c:v>1.2572205232755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2-1182-4396-A787-9A90C1232515}"/>
            </c:ext>
          </c:extLst>
        </c:ser>
        <c:ser>
          <c:idx val="35"/>
          <c:order val="35"/>
          <c:tx>
            <c:strRef>
              <c:f>'3nt'!$A$599</c:f>
              <c:strCache>
                <c:ptCount val="1"/>
                <c:pt idx="0">
                  <c:v>AGG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599:$T$599</c:f>
              <c:numCache>
                <c:formatCode>General</c:formatCode>
                <c:ptCount val="19"/>
                <c:pt idx="0">
                  <c:v>0.98538905878355398</c:v>
                </c:pt>
                <c:pt idx="1">
                  <c:v>0.67957866123003807</c:v>
                </c:pt>
                <c:pt idx="2">
                  <c:v>0.95141012572204176</c:v>
                </c:pt>
                <c:pt idx="3">
                  <c:v>0.81549439347604502</c:v>
                </c:pt>
                <c:pt idx="4">
                  <c:v>0.5436629289840299</c:v>
                </c:pt>
                <c:pt idx="5">
                  <c:v>0.71355759429153898</c:v>
                </c:pt>
                <c:pt idx="6">
                  <c:v>0.71355759429153898</c:v>
                </c:pt>
                <c:pt idx="7">
                  <c:v>0.40774719673802196</c:v>
                </c:pt>
                <c:pt idx="8">
                  <c:v>0.47570506286102598</c:v>
                </c:pt>
                <c:pt idx="9">
                  <c:v>0.50968399592252789</c:v>
                </c:pt>
                <c:pt idx="10">
                  <c:v>0.47570506286102598</c:v>
                </c:pt>
                <c:pt idx="11">
                  <c:v>0.57764186204554224</c:v>
                </c:pt>
                <c:pt idx="12">
                  <c:v>0.78151546041454301</c:v>
                </c:pt>
                <c:pt idx="13">
                  <c:v>0.71355759429153898</c:v>
                </c:pt>
                <c:pt idx="14">
                  <c:v>1.1213047910295517</c:v>
                </c:pt>
                <c:pt idx="15">
                  <c:v>1.834862385321101</c:v>
                </c:pt>
                <c:pt idx="16">
                  <c:v>1.4610941216445799</c:v>
                </c:pt>
                <c:pt idx="17">
                  <c:v>1.698946653075093</c:v>
                </c:pt>
                <c:pt idx="18">
                  <c:v>1.359157322460076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3-1182-4396-A787-9A90C1232515}"/>
            </c:ext>
          </c:extLst>
        </c:ser>
        <c:ser>
          <c:idx val="36"/>
          <c:order val="36"/>
          <c:tx>
            <c:strRef>
              <c:f>'3nt'!$A$600</c:f>
              <c:strCache>
                <c:ptCount val="1"/>
                <c:pt idx="0">
                  <c:v>GUG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600:$T$600</c:f>
              <c:numCache>
                <c:formatCode>General</c:formatCode>
                <c:ptCount val="19"/>
                <c:pt idx="0">
                  <c:v>1.25722052327557</c:v>
                </c:pt>
                <c:pt idx="1">
                  <c:v>1.2232415902140548</c:v>
                </c:pt>
                <c:pt idx="2">
                  <c:v>1.0873258579680598</c:v>
                </c:pt>
                <c:pt idx="3">
                  <c:v>1.1213047910295517</c:v>
                </c:pt>
                <c:pt idx="4">
                  <c:v>1.0873258579680598</c:v>
                </c:pt>
                <c:pt idx="5">
                  <c:v>1.019367991845056</c:v>
                </c:pt>
                <c:pt idx="6">
                  <c:v>0.88345225959904894</c:v>
                </c:pt>
                <c:pt idx="7">
                  <c:v>0.88345225959904894</c:v>
                </c:pt>
                <c:pt idx="8">
                  <c:v>0.57764186204554224</c:v>
                </c:pt>
                <c:pt idx="9">
                  <c:v>0.81549439347604502</c:v>
                </c:pt>
                <c:pt idx="10">
                  <c:v>0.74753652735304099</c:v>
                </c:pt>
                <c:pt idx="11">
                  <c:v>0.81549439347604502</c:v>
                </c:pt>
                <c:pt idx="12">
                  <c:v>0.67957866123003807</c:v>
                </c:pt>
                <c:pt idx="13">
                  <c:v>0.71355759429153898</c:v>
                </c:pt>
                <c:pt idx="14">
                  <c:v>0.30581039755352007</c:v>
                </c:pt>
                <c:pt idx="15">
                  <c:v>0.74753652735304099</c:v>
                </c:pt>
                <c:pt idx="16">
                  <c:v>0.81549439347604502</c:v>
                </c:pt>
                <c:pt idx="17">
                  <c:v>0.95141012572204176</c:v>
                </c:pt>
                <c:pt idx="18">
                  <c:v>0.9174311926605510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4-1182-4396-A787-9A90C1232515}"/>
            </c:ext>
          </c:extLst>
        </c:ser>
        <c:ser>
          <c:idx val="37"/>
          <c:order val="37"/>
          <c:tx>
            <c:strRef>
              <c:f>'3nt'!$A$601</c:f>
              <c:strCache>
                <c:ptCount val="1"/>
                <c:pt idx="0">
                  <c:v>GCU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601:$T$601</c:f>
              <c:numCache>
                <c:formatCode>General</c:formatCode>
                <c:ptCount val="19"/>
                <c:pt idx="0">
                  <c:v>0.81549439347604502</c:v>
                </c:pt>
                <c:pt idx="1">
                  <c:v>1.019367991845056</c:v>
                </c:pt>
                <c:pt idx="2">
                  <c:v>0.95141012572204176</c:v>
                </c:pt>
                <c:pt idx="3">
                  <c:v>1.2232415902140548</c:v>
                </c:pt>
                <c:pt idx="4">
                  <c:v>0.71355759429153898</c:v>
                </c:pt>
                <c:pt idx="5">
                  <c:v>0.91743119266055106</c:v>
                </c:pt>
                <c:pt idx="6">
                  <c:v>0.50968399592252789</c:v>
                </c:pt>
                <c:pt idx="7">
                  <c:v>0.5436629289840299</c:v>
                </c:pt>
                <c:pt idx="8">
                  <c:v>0.78151546041454301</c:v>
                </c:pt>
                <c:pt idx="9">
                  <c:v>0.78151546041454301</c:v>
                </c:pt>
                <c:pt idx="10">
                  <c:v>0.81549439347604502</c:v>
                </c:pt>
                <c:pt idx="11">
                  <c:v>0.74753652735304099</c:v>
                </c:pt>
                <c:pt idx="12">
                  <c:v>0.64559972816854216</c:v>
                </c:pt>
                <c:pt idx="13">
                  <c:v>0.81549439347604502</c:v>
                </c:pt>
                <c:pt idx="14">
                  <c:v>1.1213047910295517</c:v>
                </c:pt>
                <c:pt idx="15">
                  <c:v>0.61162079510703404</c:v>
                </c:pt>
                <c:pt idx="16">
                  <c:v>0.67957866123003807</c:v>
                </c:pt>
                <c:pt idx="17">
                  <c:v>0.88345225959904894</c:v>
                </c:pt>
                <c:pt idx="18">
                  <c:v>1.01936799184505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5-1182-4396-A787-9A90C1232515}"/>
            </c:ext>
          </c:extLst>
        </c:ser>
        <c:ser>
          <c:idx val="38"/>
          <c:order val="38"/>
          <c:tx>
            <c:strRef>
              <c:f>'3nt'!$A$602</c:f>
              <c:strCache>
                <c:ptCount val="1"/>
                <c:pt idx="0">
                  <c:v>ACG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602:$T$602</c:f>
              <c:numCache>
                <c:formatCode>General</c:formatCode>
                <c:ptCount val="19"/>
                <c:pt idx="0">
                  <c:v>1.019367991845056</c:v>
                </c:pt>
                <c:pt idx="1">
                  <c:v>0.81549439347604502</c:v>
                </c:pt>
                <c:pt idx="2">
                  <c:v>0.88345225959904894</c:v>
                </c:pt>
                <c:pt idx="3">
                  <c:v>0.98538905878355398</c:v>
                </c:pt>
                <c:pt idx="4">
                  <c:v>0.5436629289840299</c:v>
                </c:pt>
                <c:pt idx="5">
                  <c:v>0.71355759429153898</c:v>
                </c:pt>
                <c:pt idx="6">
                  <c:v>0.40774719673802196</c:v>
                </c:pt>
                <c:pt idx="7">
                  <c:v>0.71355759429153898</c:v>
                </c:pt>
                <c:pt idx="8">
                  <c:v>0.64559972816854216</c:v>
                </c:pt>
                <c:pt idx="9">
                  <c:v>0.5436629289840299</c:v>
                </c:pt>
                <c:pt idx="10">
                  <c:v>0.5436629289840299</c:v>
                </c:pt>
                <c:pt idx="11">
                  <c:v>0.95141012572204176</c:v>
                </c:pt>
                <c:pt idx="12">
                  <c:v>0.71355759429153898</c:v>
                </c:pt>
                <c:pt idx="13">
                  <c:v>0.40774719673802196</c:v>
                </c:pt>
                <c:pt idx="14">
                  <c:v>0.61162079510703404</c:v>
                </c:pt>
                <c:pt idx="15">
                  <c:v>0.67957866123003807</c:v>
                </c:pt>
                <c:pt idx="16">
                  <c:v>1.0873258579680598</c:v>
                </c:pt>
                <c:pt idx="17">
                  <c:v>1.427115188583078</c:v>
                </c:pt>
                <c:pt idx="18">
                  <c:v>1.49507305470608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6-1182-4396-A787-9A90C1232515}"/>
            </c:ext>
          </c:extLst>
        </c:ser>
        <c:ser>
          <c:idx val="39"/>
          <c:order val="39"/>
          <c:tx>
            <c:strRef>
              <c:f>'3nt'!$A$603</c:f>
              <c:strCache>
                <c:ptCount val="1"/>
                <c:pt idx="0">
                  <c:v>UGC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603:$T$603</c:f>
              <c:numCache>
                <c:formatCode>General</c:formatCode>
                <c:ptCount val="19"/>
                <c:pt idx="0">
                  <c:v>0.74753652735304099</c:v>
                </c:pt>
                <c:pt idx="1">
                  <c:v>1.019367991845056</c:v>
                </c:pt>
                <c:pt idx="2">
                  <c:v>1.0533469249065754</c:v>
                </c:pt>
                <c:pt idx="3">
                  <c:v>0.98538905878355398</c:v>
                </c:pt>
                <c:pt idx="4">
                  <c:v>1.495073054706082</c:v>
                </c:pt>
                <c:pt idx="5">
                  <c:v>0.71355759429153898</c:v>
                </c:pt>
                <c:pt idx="6">
                  <c:v>0.67957866123003807</c:v>
                </c:pt>
                <c:pt idx="7">
                  <c:v>1.0873258579680598</c:v>
                </c:pt>
                <c:pt idx="8">
                  <c:v>0.61162079510703404</c:v>
                </c:pt>
                <c:pt idx="9">
                  <c:v>0.81549439347604502</c:v>
                </c:pt>
                <c:pt idx="10">
                  <c:v>0.61162079510703404</c:v>
                </c:pt>
                <c:pt idx="11">
                  <c:v>0.37376826367652105</c:v>
                </c:pt>
                <c:pt idx="12">
                  <c:v>0.40774719673802196</c:v>
                </c:pt>
                <c:pt idx="13">
                  <c:v>0.57764186204554224</c:v>
                </c:pt>
                <c:pt idx="14">
                  <c:v>0.33978933061501904</c:v>
                </c:pt>
                <c:pt idx="15">
                  <c:v>0.30581039755352007</c:v>
                </c:pt>
                <c:pt idx="16">
                  <c:v>0.71355759429153898</c:v>
                </c:pt>
                <c:pt idx="17">
                  <c:v>0.91743119266055106</c:v>
                </c:pt>
                <c:pt idx="18">
                  <c:v>1.359157322460076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7-1182-4396-A787-9A90C1232515}"/>
            </c:ext>
          </c:extLst>
        </c:ser>
        <c:ser>
          <c:idx val="40"/>
          <c:order val="40"/>
          <c:tx>
            <c:strRef>
              <c:f>'3nt'!$A$604</c:f>
              <c:strCache>
                <c:ptCount val="1"/>
                <c:pt idx="0">
                  <c:v>GGA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604:$T$604</c:f>
              <c:numCache>
                <c:formatCode>General</c:formatCode>
                <c:ptCount val="19"/>
                <c:pt idx="0">
                  <c:v>1.25722052327557</c:v>
                </c:pt>
                <c:pt idx="1">
                  <c:v>0.71355759429153898</c:v>
                </c:pt>
                <c:pt idx="2">
                  <c:v>0.71355759429153898</c:v>
                </c:pt>
                <c:pt idx="3">
                  <c:v>0.81549439347604502</c:v>
                </c:pt>
                <c:pt idx="4">
                  <c:v>0.64559972816854216</c:v>
                </c:pt>
                <c:pt idx="5">
                  <c:v>0.61162079510703404</c:v>
                </c:pt>
                <c:pt idx="6">
                  <c:v>1.019367991845056</c:v>
                </c:pt>
                <c:pt idx="7">
                  <c:v>0.84947332653754704</c:v>
                </c:pt>
                <c:pt idx="8">
                  <c:v>0.27183146449201501</c:v>
                </c:pt>
                <c:pt idx="9">
                  <c:v>0.27183146449201501</c:v>
                </c:pt>
                <c:pt idx="10">
                  <c:v>0.57764186204554224</c:v>
                </c:pt>
                <c:pt idx="11">
                  <c:v>0.27183146449201501</c:v>
                </c:pt>
                <c:pt idx="12">
                  <c:v>0.40774719673802196</c:v>
                </c:pt>
                <c:pt idx="13">
                  <c:v>0.33978933061501904</c:v>
                </c:pt>
                <c:pt idx="14">
                  <c:v>0.44172612979952502</c:v>
                </c:pt>
                <c:pt idx="15">
                  <c:v>0.67957866123003807</c:v>
                </c:pt>
                <c:pt idx="16">
                  <c:v>1.0533469249065754</c:v>
                </c:pt>
                <c:pt idx="17">
                  <c:v>1.3591573224600761</c:v>
                </c:pt>
                <c:pt idx="18">
                  <c:v>1.29119945633705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8-1182-4396-A787-9A90C1232515}"/>
            </c:ext>
          </c:extLst>
        </c:ser>
        <c:ser>
          <c:idx val="41"/>
          <c:order val="41"/>
          <c:tx>
            <c:strRef>
              <c:f>'3nt'!$A$605</c:f>
              <c:strCache>
                <c:ptCount val="1"/>
                <c:pt idx="0">
                  <c:v>CUG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605:$T$605</c:f>
              <c:numCache>
                <c:formatCode>General</c:formatCode>
                <c:ptCount val="19"/>
                <c:pt idx="0">
                  <c:v>0.57764186204554224</c:v>
                </c:pt>
                <c:pt idx="1">
                  <c:v>0.91743119266055106</c:v>
                </c:pt>
                <c:pt idx="2">
                  <c:v>0.74753652735304099</c:v>
                </c:pt>
                <c:pt idx="3">
                  <c:v>1.1213047910295517</c:v>
                </c:pt>
                <c:pt idx="4">
                  <c:v>0.98538905878355398</c:v>
                </c:pt>
                <c:pt idx="5">
                  <c:v>0.78151546041454301</c:v>
                </c:pt>
                <c:pt idx="6">
                  <c:v>0.57764186204554224</c:v>
                </c:pt>
                <c:pt idx="7">
                  <c:v>0.67957866123003807</c:v>
                </c:pt>
                <c:pt idx="8">
                  <c:v>0.78151546041454301</c:v>
                </c:pt>
                <c:pt idx="9">
                  <c:v>0.84947332653754704</c:v>
                </c:pt>
                <c:pt idx="10">
                  <c:v>0.67957866123003807</c:v>
                </c:pt>
                <c:pt idx="11">
                  <c:v>0.37376826367652105</c:v>
                </c:pt>
                <c:pt idx="12">
                  <c:v>0.5436629289840299</c:v>
                </c:pt>
                <c:pt idx="13">
                  <c:v>0.40774719673802196</c:v>
                </c:pt>
                <c:pt idx="14">
                  <c:v>0.50968399592252789</c:v>
                </c:pt>
                <c:pt idx="15">
                  <c:v>0.44172612979952502</c:v>
                </c:pt>
                <c:pt idx="16">
                  <c:v>0.47570506286102598</c:v>
                </c:pt>
                <c:pt idx="17">
                  <c:v>0.81549439347604502</c:v>
                </c:pt>
                <c:pt idx="18">
                  <c:v>0.8834522595990489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9-1182-4396-A787-9A90C1232515}"/>
            </c:ext>
          </c:extLst>
        </c:ser>
        <c:ser>
          <c:idx val="42"/>
          <c:order val="42"/>
          <c:tx>
            <c:strRef>
              <c:f>'3nt'!$A$606</c:f>
              <c:strCache>
                <c:ptCount val="1"/>
                <c:pt idx="0">
                  <c:v>CGU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606:$T$606</c:f>
              <c:numCache>
                <c:formatCode>General</c:formatCode>
                <c:ptCount val="19"/>
                <c:pt idx="0">
                  <c:v>1.019367991845056</c:v>
                </c:pt>
                <c:pt idx="1">
                  <c:v>0.67957866123003807</c:v>
                </c:pt>
                <c:pt idx="2">
                  <c:v>0.67957866123003807</c:v>
                </c:pt>
                <c:pt idx="3">
                  <c:v>0.67957866123003807</c:v>
                </c:pt>
                <c:pt idx="4">
                  <c:v>0.88345225959904894</c:v>
                </c:pt>
                <c:pt idx="5">
                  <c:v>0.44172612979952502</c:v>
                </c:pt>
                <c:pt idx="6">
                  <c:v>0.84947332653754704</c:v>
                </c:pt>
                <c:pt idx="7">
                  <c:v>0.5436629289840299</c:v>
                </c:pt>
                <c:pt idx="8">
                  <c:v>0.78151546041454301</c:v>
                </c:pt>
                <c:pt idx="9">
                  <c:v>0.84947332653754704</c:v>
                </c:pt>
                <c:pt idx="10">
                  <c:v>0.5436629289840299</c:v>
                </c:pt>
                <c:pt idx="11">
                  <c:v>0.78151546041454301</c:v>
                </c:pt>
                <c:pt idx="12">
                  <c:v>0.81549439347604502</c:v>
                </c:pt>
                <c:pt idx="13">
                  <c:v>0.47570506286102598</c:v>
                </c:pt>
                <c:pt idx="14">
                  <c:v>0.30581039755352007</c:v>
                </c:pt>
                <c:pt idx="15">
                  <c:v>0.40774719673802196</c:v>
                </c:pt>
                <c:pt idx="16">
                  <c:v>0.5436629289840299</c:v>
                </c:pt>
                <c:pt idx="17">
                  <c:v>0.47570506286102598</c:v>
                </c:pt>
                <c:pt idx="18">
                  <c:v>1.01936799184505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A-1182-4396-A787-9A90C1232515}"/>
            </c:ext>
          </c:extLst>
        </c:ser>
        <c:ser>
          <c:idx val="43"/>
          <c:order val="43"/>
          <c:tx>
            <c:strRef>
              <c:f>'3nt'!$A$607</c:f>
              <c:strCache>
                <c:ptCount val="1"/>
                <c:pt idx="0">
                  <c:v>GAC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607:$T$607</c:f>
              <c:numCache>
                <c:formatCode>General</c:formatCode>
                <c:ptCount val="19"/>
                <c:pt idx="0">
                  <c:v>0.98538905878355398</c:v>
                </c:pt>
                <c:pt idx="1">
                  <c:v>0.91743119266055106</c:v>
                </c:pt>
                <c:pt idx="2">
                  <c:v>0.91743119266055106</c:v>
                </c:pt>
                <c:pt idx="3">
                  <c:v>0.64559972816854216</c:v>
                </c:pt>
                <c:pt idx="4">
                  <c:v>0.64559972816854216</c:v>
                </c:pt>
                <c:pt idx="5">
                  <c:v>1.0533469249065754</c:v>
                </c:pt>
                <c:pt idx="6">
                  <c:v>0.67957866123003807</c:v>
                </c:pt>
                <c:pt idx="7">
                  <c:v>0.57764186204554224</c:v>
                </c:pt>
                <c:pt idx="8">
                  <c:v>0.33978933061501904</c:v>
                </c:pt>
                <c:pt idx="9">
                  <c:v>0.27183146449201501</c:v>
                </c:pt>
                <c:pt idx="10">
                  <c:v>0.40774719673802196</c:v>
                </c:pt>
                <c:pt idx="11">
                  <c:v>0.20387359836901098</c:v>
                </c:pt>
                <c:pt idx="12">
                  <c:v>0.27183146449201501</c:v>
                </c:pt>
                <c:pt idx="13">
                  <c:v>0.40774719673802196</c:v>
                </c:pt>
                <c:pt idx="14">
                  <c:v>0.44172612979952502</c:v>
                </c:pt>
                <c:pt idx="15">
                  <c:v>0.61162079510703404</c:v>
                </c:pt>
                <c:pt idx="16">
                  <c:v>1.0533469249065754</c:v>
                </c:pt>
                <c:pt idx="17">
                  <c:v>1.2232415902140548</c:v>
                </c:pt>
                <c:pt idx="18">
                  <c:v>0.985389058783553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B-1182-4396-A787-9A90C1232515}"/>
            </c:ext>
          </c:extLst>
        </c:ser>
        <c:ser>
          <c:idx val="44"/>
          <c:order val="44"/>
          <c:tx>
            <c:strRef>
              <c:f>'3nt'!$A$608</c:f>
              <c:strCache>
                <c:ptCount val="1"/>
                <c:pt idx="0">
                  <c:v>CAG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608:$T$608</c:f>
              <c:numCache>
                <c:formatCode>General</c:formatCode>
                <c:ptCount val="19"/>
                <c:pt idx="0">
                  <c:v>0.64559972816854216</c:v>
                </c:pt>
                <c:pt idx="1">
                  <c:v>0.98538905878355398</c:v>
                </c:pt>
                <c:pt idx="2">
                  <c:v>0.84947332653754704</c:v>
                </c:pt>
                <c:pt idx="3">
                  <c:v>0.78151546041454301</c:v>
                </c:pt>
                <c:pt idx="4">
                  <c:v>0.67957866123003807</c:v>
                </c:pt>
                <c:pt idx="5">
                  <c:v>0.91743119266055106</c:v>
                </c:pt>
                <c:pt idx="6">
                  <c:v>0.57764186204554224</c:v>
                </c:pt>
                <c:pt idx="7">
                  <c:v>0.5436629289840299</c:v>
                </c:pt>
                <c:pt idx="8">
                  <c:v>0.47570506286102598</c:v>
                </c:pt>
                <c:pt idx="9">
                  <c:v>0.50968399592252789</c:v>
                </c:pt>
                <c:pt idx="10">
                  <c:v>0.67957866123003807</c:v>
                </c:pt>
                <c:pt idx="11">
                  <c:v>0.47570506286102598</c:v>
                </c:pt>
                <c:pt idx="12">
                  <c:v>0.50968399592252789</c:v>
                </c:pt>
                <c:pt idx="13">
                  <c:v>0.57764186204554224</c:v>
                </c:pt>
                <c:pt idx="14">
                  <c:v>0.40774719673802196</c:v>
                </c:pt>
                <c:pt idx="15">
                  <c:v>0.57764186204554224</c:v>
                </c:pt>
                <c:pt idx="16">
                  <c:v>0.61162079510703404</c:v>
                </c:pt>
                <c:pt idx="17">
                  <c:v>0.67957866123003807</c:v>
                </c:pt>
                <c:pt idx="18">
                  <c:v>0.985389058783553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C-1182-4396-A787-9A90C1232515}"/>
            </c:ext>
          </c:extLst>
        </c:ser>
        <c:ser>
          <c:idx val="45"/>
          <c:order val="45"/>
          <c:tx>
            <c:strRef>
              <c:f>'3nt'!$A$609</c:f>
              <c:strCache>
                <c:ptCount val="1"/>
                <c:pt idx="0">
                  <c:v>GGU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609:$T$609</c:f>
              <c:numCache>
                <c:formatCode>General</c:formatCode>
                <c:ptCount val="19"/>
                <c:pt idx="0">
                  <c:v>0.91743119266055106</c:v>
                </c:pt>
                <c:pt idx="1">
                  <c:v>0.71355759429153898</c:v>
                </c:pt>
                <c:pt idx="2">
                  <c:v>0.78151546041454301</c:v>
                </c:pt>
                <c:pt idx="3">
                  <c:v>0.98538905878355398</c:v>
                </c:pt>
                <c:pt idx="4">
                  <c:v>0.84947332653754704</c:v>
                </c:pt>
                <c:pt idx="5">
                  <c:v>0.81549439347604502</c:v>
                </c:pt>
                <c:pt idx="6">
                  <c:v>0.57764186204554224</c:v>
                </c:pt>
                <c:pt idx="7">
                  <c:v>0.71355759429153898</c:v>
                </c:pt>
                <c:pt idx="8">
                  <c:v>0.50968399592252789</c:v>
                </c:pt>
                <c:pt idx="9">
                  <c:v>0.61162079510703404</c:v>
                </c:pt>
                <c:pt idx="10">
                  <c:v>0.5436629289840299</c:v>
                </c:pt>
                <c:pt idx="11">
                  <c:v>0.47570506286102598</c:v>
                </c:pt>
                <c:pt idx="12">
                  <c:v>0.57764186204554224</c:v>
                </c:pt>
                <c:pt idx="13">
                  <c:v>0.47570506286102598</c:v>
                </c:pt>
                <c:pt idx="14">
                  <c:v>0.40774719673802196</c:v>
                </c:pt>
                <c:pt idx="15">
                  <c:v>0.61162079510703404</c:v>
                </c:pt>
                <c:pt idx="16">
                  <c:v>0.61162079510703404</c:v>
                </c:pt>
                <c:pt idx="17">
                  <c:v>0.44172612979952502</c:v>
                </c:pt>
                <c:pt idx="18">
                  <c:v>0.713557594291538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D-1182-4396-A787-9A90C1232515}"/>
            </c:ext>
          </c:extLst>
        </c:ser>
        <c:ser>
          <c:idx val="46"/>
          <c:order val="46"/>
          <c:tx>
            <c:strRef>
              <c:f>'3nt'!$A$610</c:f>
              <c:strCache>
                <c:ptCount val="1"/>
                <c:pt idx="0">
                  <c:v>CGA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610:$T$610</c:f>
              <c:numCache>
                <c:formatCode>General</c:formatCode>
                <c:ptCount val="19"/>
                <c:pt idx="0">
                  <c:v>0.91743119266055106</c:v>
                </c:pt>
                <c:pt idx="1">
                  <c:v>0.71355759429153898</c:v>
                </c:pt>
                <c:pt idx="2">
                  <c:v>0.67957866123003807</c:v>
                </c:pt>
                <c:pt idx="3">
                  <c:v>0.88345225959904894</c:v>
                </c:pt>
                <c:pt idx="4">
                  <c:v>0.98538905878355398</c:v>
                </c:pt>
                <c:pt idx="5">
                  <c:v>0.98538905878355398</c:v>
                </c:pt>
                <c:pt idx="6">
                  <c:v>0.57764186204554224</c:v>
                </c:pt>
                <c:pt idx="7">
                  <c:v>0.30581039755352007</c:v>
                </c:pt>
                <c:pt idx="8">
                  <c:v>0.61162079510703404</c:v>
                </c:pt>
                <c:pt idx="9">
                  <c:v>0.33978933061501904</c:v>
                </c:pt>
                <c:pt idx="10">
                  <c:v>0.40774719673802196</c:v>
                </c:pt>
                <c:pt idx="11">
                  <c:v>0.30581039755352007</c:v>
                </c:pt>
                <c:pt idx="12">
                  <c:v>0.5436629289840299</c:v>
                </c:pt>
                <c:pt idx="13">
                  <c:v>0.37376826367652105</c:v>
                </c:pt>
                <c:pt idx="14">
                  <c:v>0.44172612979952502</c:v>
                </c:pt>
                <c:pt idx="15">
                  <c:v>0.67957866123003807</c:v>
                </c:pt>
                <c:pt idx="16">
                  <c:v>0.50968399592252789</c:v>
                </c:pt>
                <c:pt idx="17">
                  <c:v>0.81549439347604502</c:v>
                </c:pt>
                <c:pt idx="18">
                  <c:v>0.985389058783553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E-1182-4396-A787-9A90C1232515}"/>
            </c:ext>
          </c:extLst>
        </c:ser>
        <c:ser>
          <c:idx val="47"/>
          <c:order val="47"/>
          <c:tx>
            <c:strRef>
              <c:f>'3nt'!$A$611</c:f>
              <c:strCache>
                <c:ptCount val="1"/>
                <c:pt idx="0">
                  <c:v>GUC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611:$T$611</c:f>
              <c:numCache>
                <c:formatCode>General</c:formatCode>
                <c:ptCount val="19"/>
                <c:pt idx="0">
                  <c:v>1.2232415902140548</c:v>
                </c:pt>
                <c:pt idx="1">
                  <c:v>0.84947332653754704</c:v>
                </c:pt>
                <c:pt idx="2">
                  <c:v>0.64559972816854216</c:v>
                </c:pt>
                <c:pt idx="3">
                  <c:v>0.88345225959904894</c:v>
                </c:pt>
                <c:pt idx="4">
                  <c:v>0.74753652735304099</c:v>
                </c:pt>
                <c:pt idx="5">
                  <c:v>0.44172612979952502</c:v>
                </c:pt>
                <c:pt idx="6">
                  <c:v>0.5436629289840299</c:v>
                </c:pt>
                <c:pt idx="7">
                  <c:v>0.67957866123003807</c:v>
                </c:pt>
                <c:pt idx="8">
                  <c:v>0.33978933061501904</c:v>
                </c:pt>
                <c:pt idx="9">
                  <c:v>0.40774719673802196</c:v>
                </c:pt>
                <c:pt idx="10">
                  <c:v>0.78151546041454301</c:v>
                </c:pt>
                <c:pt idx="11">
                  <c:v>0.44172612979952502</c:v>
                </c:pt>
                <c:pt idx="12">
                  <c:v>0.23785253143051299</c:v>
                </c:pt>
                <c:pt idx="13">
                  <c:v>0.37376826367652105</c:v>
                </c:pt>
                <c:pt idx="14">
                  <c:v>0.33978933061501904</c:v>
                </c:pt>
                <c:pt idx="15">
                  <c:v>0.5436629289840299</c:v>
                </c:pt>
                <c:pt idx="16">
                  <c:v>0.81549439347604502</c:v>
                </c:pt>
                <c:pt idx="17">
                  <c:v>0.64559972816854216</c:v>
                </c:pt>
                <c:pt idx="18">
                  <c:v>0.6455997281685421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F-1182-4396-A787-9A90C1232515}"/>
            </c:ext>
          </c:extLst>
        </c:ser>
        <c:ser>
          <c:idx val="48"/>
          <c:order val="48"/>
          <c:tx>
            <c:strRef>
              <c:f>'3nt'!$A$612</c:f>
              <c:strCache>
                <c:ptCount val="1"/>
                <c:pt idx="0">
                  <c:v>CAC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612:$T$612</c:f>
              <c:numCache>
                <c:formatCode>General</c:formatCode>
                <c:ptCount val="19"/>
                <c:pt idx="0">
                  <c:v>0.91743119266055106</c:v>
                </c:pt>
                <c:pt idx="1">
                  <c:v>0.84947332653754704</c:v>
                </c:pt>
                <c:pt idx="2">
                  <c:v>0.71355759429153898</c:v>
                </c:pt>
                <c:pt idx="3">
                  <c:v>0.98538905878355398</c:v>
                </c:pt>
                <c:pt idx="4">
                  <c:v>0.81549439347604502</c:v>
                </c:pt>
                <c:pt idx="5">
                  <c:v>0.47570506286102598</c:v>
                </c:pt>
                <c:pt idx="6">
                  <c:v>0.88345225959904894</c:v>
                </c:pt>
                <c:pt idx="7">
                  <c:v>0.44172612979952502</c:v>
                </c:pt>
                <c:pt idx="8">
                  <c:v>0.44172612979952502</c:v>
                </c:pt>
                <c:pt idx="9">
                  <c:v>0.64559972816854216</c:v>
                </c:pt>
                <c:pt idx="10">
                  <c:v>0.50968399592252789</c:v>
                </c:pt>
                <c:pt idx="11">
                  <c:v>0.33978933061501904</c:v>
                </c:pt>
                <c:pt idx="12">
                  <c:v>0.23785253143051299</c:v>
                </c:pt>
                <c:pt idx="13">
                  <c:v>0.16989466530750899</c:v>
                </c:pt>
                <c:pt idx="14">
                  <c:v>0.44172612979952502</c:v>
                </c:pt>
                <c:pt idx="15">
                  <c:v>0.64559972816854216</c:v>
                </c:pt>
                <c:pt idx="16">
                  <c:v>0.30581039755352007</c:v>
                </c:pt>
                <c:pt idx="17">
                  <c:v>0.64559972816854216</c:v>
                </c:pt>
                <c:pt idx="18">
                  <c:v>0.985389058783553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0-1182-4396-A787-9A90C1232515}"/>
            </c:ext>
          </c:extLst>
        </c:ser>
        <c:ser>
          <c:idx val="49"/>
          <c:order val="49"/>
          <c:tx>
            <c:strRef>
              <c:f>'3nt'!$A$613</c:f>
              <c:strCache>
                <c:ptCount val="1"/>
                <c:pt idx="0">
                  <c:v>CUC</c:v>
                </c:pt>
              </c:strCache>
            </c:strRef>
          </c:tx>
          <c:marker>
            <c:symbol val="none"/>
          </c:marker>
          <c:cat>
            <c:numRef>
              <c:f>'3nt'!$B$563:$T$563</c:f>
              <c:numCache>
                <c:formatCode>General</c:formatCode>
                <c:ptCount val="19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  <c:pt idx="18">
                  <c:v>-17</c:v>
                </c:pt>
              </c:numCache>
            </c:numRef>
          </c:cat>
          <c:val>
            <c:numRef>
              <c:f>'3nt'!$B$613:$T$613</c:f>
              <c:numCache>
                <c:formatCode>General</c:formatCode>
                <c:ptCount val="19"/>
                <c:pt idx="0">
                  <c:v>0.50968399592252789</c:v>
                </c:pt>
                <c:pt idx="1">
                  <c:v>0.71355759429153898</c:v>
                </c:pt>
                <c:pt idx="2">
                  <c:v>0.98538905878355398</c:v>
                </c:pt>
                <c:pt idx="3">
                  <c:v>0.64559972816854216</c:v>
                </c:pt>
                <c:pt idx="4">
                  <c:v>0.81549439347604502</c:v>
                </c:pt>
                <c:pt idx="5">
                  <c:v>0.61162079510703404</c:v>
                </c:pt>
                <c:pt idx="6">
                  <c:v>0.47570506286102598</c:v>
                </c:pt>
                <c:pt idx="7">
                  <c:v>0.81549439347604502</c:v>
                </c:pt>
                <c:pt idx="8">
                  <c:v>0.67957866123003807</c:v>
                </c:pt>
                <c:pt idx="9">
                  <c:v>0.44172612979952502</c:v>
                </c:pt>
                <c:pt idx="10">
                  <c:v>0.44172612979952502</c:v>
                </c:pt>
                <c:pt idx="11">
                  <c:v>0.61162079510703404</c:v>
                </c:pt>
                <c:pt idx="12">
                  <c:v>0.5436629289840299</c:v>
                </c:pt>
                <c:pt idx="13">
                  <c:v>0.37376826367652105</c:v>
                </c:pt>
                <c:pt idx="14">
                  <c:v>0.30581039755352007</c:v>
                </c:pt>
                <c:pt idx="15">
                  <c:v>0.30581039755352007</c:v>
                </c:pt>
                <c:pt idx="16">
                  <c:v>0.101936799184506</c:v>
                </c:pt>
                <c:pt idx="17">
                  <c:v>0.44172612979952502</c:v>
                </c:pt>
                <c:pt idx="18">
                  <c:v>0.9514101257220417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1-1182-4396-A787-9A90C123251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78256000"/>
        <c:axId val="78257536"/>
      </c:lineChart>
      <c:catAx>
        <c:axId val="782560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zh-CN"/>
            </a:pPr>
            <a:endParaRPr lang="en-US"/>
          </a:p>
        </c:txPr>
        <c:crossAx val="78257536"/>
        <c:crosses val="autoZero"/>
        <c:auto val="1"/>
        <c:lblAlgn val="ctr"/>
        <c:lblOffset val="100"/>
        <c:noMultiLvlLbl val="0"/>
      </c:catAx>
      <c:valAx>
        <c:axId val="782575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zh-CN"/>
            </a:pPr>
            <a:endParaRPr lang="en-US"/>
          </a:p>
        </c:txPr>
        <c:crossAx val="7825600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"/>
          <c:y val="0.58257272796084081"/>
          <c:w val="0.99574851754642313"/>
          <c:h val="0.41607269011454812"/>
        </c:manualLayout>
      </c:layout>
      <c:overlay val="0"/>
      <c:txPr>
        <a:bodyPr/>
        <a:lstStyle/>
        <a:p>
          <a:pPr>
            <a:defRPr lang="zh-CN" sz="600" baseline="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6867668814125919E-2"/>
          <c:y val="3.4996121938658413E-2"/>
          <c:w val="0.96041107134335502"/>
          <c:h val="0.37010908792650904"/>
        </c:manualLayout>
      </c:layout>
      <c:lineChart>
        <c:grouping val="standard"/>
        <c:varyColors val="0"/>
        <c:ser>
          <c:idx val="0"/>
          <c:order val="0"/>
          <c:tx>
            <c:strRef>
              <c:f>'3nt'!$A$451</c:f>
              <c:strCache>
                <c:ptCount val="1"/>
                <c:pt idx="0">
                  <c:v>UAA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51:$Y$451</c:f>
              <c:numCache>
                <c:formatCode>General</c:formatCode>
                <c:ptCount val="24"/>
                <c:pt idx="0">
                  <c:v>2.1306818181818201</c:v>
                </c:pt>
                <c:pt idx="1">
                  <c:v>2.982954545454545</c:v>
                </c:pt>
                <c:pt idx="2">
                  <c:v>2.9545454545454537</c:v>
                </c:pt>
                <c:pt idx="3">
                  <c:v>2.9545454545454537</c:v>
                </c:pt>
                <c:pt idx="4">
                  <c:v>3.7784090909090899</c:v>
                </c:pt>
                <c:pt idx="5">
                  <c:v>3.9772727272727271</c:v>
                </c:pt>
                <c:pt idx="6">
                  <c:v>4.0624999999999956</c:v>
                </c:pt>
                <c:pt idx="7">
                  <c:v>4.8579545454545237</c:v>
                </c:pt>
                <c:pt idx="8">
                  <c:v>4.6306818181818157</c:v>
                </c:pt>
                <c:pt idx="9">
                  <c:v>5.5113636363636909</c:v>
                </c:pt>
                <c:pt idx="10">
                  <c:v>5.795454545454545</c:v>
                </c:pt>
                <c:pt idx="11">
                  <c:v>5.4261363636363615</c:v>
                </c:pt>
                <c:pt idx="12">
                  <c:v>6.0227272727272636</c:v>
                </c:pt>
                <c:pt idx="13">
                  <c:v>6.0227272727272636</c:v>
                </c:pt>
                <c:pt idx="14">
                  <c:v>6.1647727272727266</c:v>
                </c:pt>
                <c:pt idx="15">
                  <c:v>5.3124999999999956</c:v>
                </c:pt>
                <c:pt idx="16">
                  <c:v>6.0795454545454541</c:v>
                </c:pt>
                <c:pt idx="17">
                  <c:v>6.6761363636363606</c:v>
                </c:pt>
                <c:pt idx="18">
                  <c:v>8.6363636363636349</c:v>
                </c:pt>
                <c:pt idx="19">
                  <c:v>7.5568181818181834</c:v>
                </c:pt>
                <c:pt idx="20">
                  <c:v>7.1306818181818166</c:v>
                </c:pt>
                <c:pt idx="21">
                  <c:v>5.170454545454545</c:v>
                </c:pt>
                <c:pt idx="22">
                  <c:v>2.6988636363636327</c:v>
                </c:pt>
                <c:pt idx="23">
                  <c:v>2.04545454545454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784-405B-8F91-AE3CBDDEDCBB}"/>
            </c:ext>
          </c:extLst>
        </c:ser>
        <c:ser>
          <c:idx val="1"/>
          <c:order val="1"/>
          <c:tx>
            <c:strRef>
              <c:f>'3nt'!$A$452</c:f>
              <c:strCache>
                <c:ptCount val="1"/>
                <c:pt idx="0">
                  <c:v>AAU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52:$Y$452</c:f>
              <c:numCache>
                <c:formatCode>General</c:formatCode>
                <c:ptCount val="24"/>
                <c:pt idx="0">
                  <c:v>2.6988636363636327</c:v>
                </c:pt>
                <c:pt idx="1">
                  <c:v>2.357954545454545</c:v>
                </c:pt>
                <c:pt idx="2">
                  <c:v>3.2670454545454541</c:v>
                </c:pt>
                <c:pt idx="3">
                  <c:v>3.1534090909090908</c:v>
                </c:pt>
                <c:pt idx="4">
                  <c:v>2.9261363636363642</c:v>
                </c:pt>
                <c:pt idx="5">
                  <c:v>3.4659090909090908</c:v>
                </c:pt>
                <c:pt idx="6">
                  <c:v>3.806818181818139</c:v>
                </c:pt>
                <c:pt idx="7">
                  <c:v>3.6363636363636327</c:v>
                </c:pt>
                <c:pt idx="8">
                  <c:v>4.3465909090909056</c:v>
                </c:pt>
                <c:pt idx="9">
                  <c:v>4.0056818181818166</c:v>
                </c:pt>
                <c:pt idx="10">
                  <c:v>4.6874999999999947</c:v>
                </c:pt>
                <c:pt idx="11">
                  <c:v>4.4034090909091512</c:v>
                </c:pt>
                <c:pt idx="12">
                  <c:v>4.7443181818181834</c:v>
                </c:pt>
                <c:pt idx="13">
                  <c:v>4.545454545454545</c:v>
                </c:pt>
                <c:pt idx="14">
                  <c:v>5.1136363636363615</c:v>
                </c:pt>
                <c:pt idx="15">
                  <c:v>4.7727272727272716</c:v>
                </c:pt>
                <c:pt idx="16">
                  <c:v>4.9147727272727284</c:v>
                </c:pt>
                <c:pt idx="17">
                  <c:v>4.7727272727272716</c:v>
                </c:pt>
                <c:pt idx="18">
                  <c:v>5.1136363636363615</c:v>
                </c:pt>
                <c:pt idx="19">
                  <c:v>4.7727272727272716</c:v>
                </c:pt>
                <c:pt idx="20">
                  <c:v>4.4602272727272716</c:v>
                </c:pt>
                <c:pt idx="21">
                  <c:v>4.232954545454545</c:v>
                </c:pt>
                <c:pt idx="22">
                  <c:v>4.4318181818182394</c:v>
                </c:pt>
                <c:pt idx="23">
                  <c:v>3.664772727272750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784-405B-8F91-AE3CBDDEDCBB}"/>
            </c:ext>
          </c:extLst>
        </c:ser>
        <c:ser>
          <c:idx val="2"/>
          <c:order val="2"/>
          <c:tx>
            <c:strRef>
              <c:f>'3nt'!$A$453</c:f>
              <c:strCache>
                <c:ptCount val="1"/>
                <c:pt idx="0">
                  <c:v>AAA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53:$Y$453</c:f>
              <c:numCache>
                <c:formatCode>General</c:formatCode>
                <c:ptCount val="24"/>
                <c:pt idx="0">
                  <c:v>2.1022727272727271</c:v>
                </c:pt>
                <c:pt idx="1">
                  <c:v>2.9261363636363642</c:v>
                </c:pt>
                <c:pt idx="2">
                  <c:v>3.4090909090909087</c:v>
                </c:pt>
                <c:pt idx="3">
                  <c:v>2.357954545454545</c:v>
                </c:pt>
                <c:pt idx="4">
                  <c:v>2.7272727272727506</c:v>
                </c:pt>
                <c:pt idx="5">
                  <c:v>4.4318181818182394</c:v>
                </c:pt>
                <c:pt idx="6">
                  <c:v>2.8409090909090908</c:v>
                </c:pt>
                <c:pt idx="7">
                  <c:v>3.2102272727273009</c:v>
                </c:pt>
                <c:pt idx="8">
                  <c:v>5.0284090909090908</c:v>
                </c:pt>
                <c:pt idx="9">
                  <c:v>2.8124999999999716</c:v>
                </c:pt>
                <c:pt idx="10">
                  <c:v>3.1818181818181777</c:v>
                </c:pt>
                <c:pt idx="11">
                  <c:v>5.1420454545454346</c:v>
                </c:pt>
                <c:pt idx="12">
                  <c:v>3.295454545454545</c:v>
                </c:pt>
                <c:pt idx="13">
                  <c:v>3.5795454545454537</c:v>
                </c:pt>
                <c:pt idx="14">
                  <c:v>5.5681818181817553</c:v>
                </c:pt>
                <c:pt idx="15">
                  <c:v>3.6363636363636327</c:v>
                </c:pt>
                <c:pt idx="16">
                  <c:v>3.3522727272727177</c:v>
                </c:pt>
                <c:pt idx="17">
                  <c:v>5.2272727272727284</c:v>
                </c:pt>
                <c:pt idx="18">
                  <c:v>3.3806818181818201</c:v>
                </c:pt>
                <c:pt idx="19">
                  <c:v>4.6306818181818157</c:v>
                </c:pt>
                <c:pt idx="20">
                  <c:v>8.3238636363636367</c:v>
                </c:pt>
                <c:pt idx="21">
                  <c:v>5.0284090909090908</c:v>
                </c:pt>
                <c:pt idx="22">
                  <c:v>4.4034090909091512</c:v>
                </c:pt>
                <c:pt idx="23">
                  <c:v>5.880681818181816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1784-405B-8F91-AE3CBDDEDCBB}"/>
            </c:ext>
          </c:extLst>
        </c:ser>
        <c:ser>
          <c:idx val="3"/>
          <c:order val="3"/>
          <c:tx>
            <c:strRef>
              <c:f>'3nt'!$A$454</c:f>
              <c:strCache>
                <c:ptCount val="1"/>
                <c:pt idx="0">
                  <c:v>AUA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54:$Y$454</c:f>
              <c:numCache>
                <c:formatCode>General</c:formatCode>
                <c:ptCount val="24"/>
                <c:pt idx="0">
                  <c:v>2.3295454545454537</c:v>
                </c:pt>
                <c:pt idx="1">
                  <c:v>2.556818181818139</c:v>
                </c:pt>
                <c:pt idx="2">
                  <c:v>2.2727272727273009</c:v>
                </c:pt>
                <c:pt idx="3">
                  <c:v>2.8693181818181777</c:v>
                </c:pt>
                <c:pt idx="4">
                  <c:v>2.8409090909090908</c:v>
                </c:pt>
                <c:pt idx="5">
                  <c:v>2.8409090909090908</c:v>
                </c:pt>
                <c:pt idx="6">
                  <c:v>3.3238636363636327</c:v>
                </c:pt>
                <c:pt idx="7">
                  <c:v>2.6988636363636327</c:v>
                </c:pt>
                <c:pt idx="8">
                  <c:v>3.5511363636363642</c:v>
                </c:pt>
                <c:pt idx="9">
                  <c:v>3.2102272727273009</c:v>
                </c:pt>
                <c:pt idx="10">
                  <c:v>4.1761363636363615</c:v>
                </c:pt>
                <c:pt idx="11">
                  <c:v>4.1761363636363615</c:v>
                </c:pt>
                <c:pt idx="12">
                  <c:v>3.3238636363636327</c:v>
                </c:pt>
                <c:pt idx="13">
                  <c:v>4.5738636363636909</c:v>
                </c:pt>
                <c:pt idx="14">
                  <c:v>4.8579545454545237</c:v>
                </c:pt>
                <c:pt idx="15">
                  <c:v>5.4261363636363615</c:v>
                </c:pt>
                <c:pt idx="16">
                  <c:v>5.62499999999996</c:v>
                </c:pt>
                <c:pt idx="17">
                  <c:v>6.3636363636363606</c:v>
                </c:pt>
                <c:pt idx="18">
                  <c:v>5.4261363636363615</c:v>
                </c:pt>
                <c:pt idx="19">
                  <c:v>6.25</c:v>
                </c:pt>
                <c:pt idx="20">
                  <c:v>3.75</c:v>
                </c:pt>
                <c:pt idx="21">
                  <c:v>2.4715909090909087</c:v>
                </c:pt>
                <c:pt idx="22">
                  <c:v>2.3011363636363642</c:v>
                </c:pt>
                <c:pt idx="23">
                  <c:v>2.13068181818182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1784-405B-8F91-AE3CBDDEDCBB}"/>
            </c:ext>
          </c:extLst>
        </c:ser>
        <c:ser>
          <c:idx val="4"/>
          <c:order val="4"/>
          <c:tx>
            <c:strRef>
              <c:f>'3nt'!$A$455</c:f>
              <c:strCache>
                <c:ptCount val="1"/>
                <c:pt idx="0">
                  <c:v>UUA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55:$Y$455</c:f>
              <c:numCache>
                <c:formatCode>General</c:formatCode>
                <c:ptCount val="24"/>
                <c:pt idx="0">
                  <c:v>2.1022727272727271</c:v>
                </c:pt>
                <c:pt idx="1">
                  <c:v>2.5</c:v>
                </c:pt>
                <c:pt idx="2">
                  <c:v>2.0170454545454537</c:v>
                </c:pt>
                <c:pt idx="3">
                  <c:v>2.5852272727273009</c:v>
                </c:pt>
                <c:pt idx="4">
                  <c:v>2.7840909090909105</c:v>
                </c:pt>
                <c:pt idx="5">
                  <c:v>2.2727272727273009</c:v>
                </c:pt>
                <c:pt idx="6">
                  <c:v>2.8977272727273009</c:v>
                </c:pt>
                <c:pt idx="7">
                  <c:v>2.4147727272727271</c:v>
                </c:pt>
                <c:pt idx="8">
                  <c:v>3.5227272727273009</c:v>
                </c:pt>
                <c:pt idx="9">
                  <c:v>3.0397727272727271</c:v>
                </c:pt>
                <c:pt idx="10">
                  <c:v>3.3806818181818201</c:v>
                </c:pt>
                <c:pt idx="11">
                  <c:v>2.9261363636363642</c:v>
                </c:pt>
                <c:pt idx="12">
                  <c:v>4.0624999999999956</c:v>
                </c:pt>
                <c:pt idx="13">
                  <c:v>3.7215909090909105</c:v>
                </c:pt>
                <c:pt idx="14">
                  <c:v>3.6931818181818454</c:v>
                </c:pt>
                <c:pt idx="15">
                  <c:v>3.8352272727272751</c:v>
                </c:pt>
                <c:pt idx="16">
                  <c:v>4.2897727272727524</c:v>
                </c:pt>
                <c:pt idx="17">
                  <c:v>5.3124999999999956</c:v>
                </c:pt>
                <c:pt idx="18">
                  <c:v>4.3465909090909056</c:v>
                </c:pt>
                <c:pt idx="19">
                  <c:v>3.8920454545454164</c:v>
                </c:pt>
                <c:pt idx="20">
                  <c:v>3.0113636363636327</c:v>
                </c:pt>
                <c:pt idx="21">
                  <c:v>2.357954545454545</c:v>
                </c:pt>
                <c:pt idx="22">
                  <c:v>1.5625</c:v>
                </c:pt>
                <c:pt idx="23">
                  <c:v>1.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1784-405B-8F91-AE3CBDDEDCBB}"/>
            </c:ext>
          </c:extLst>
        </c:ser>
        <c:ser>
          <c:idx val="5"/>
          <c:order val="5"/>
          <c:tx>
            <c:strRef>
              <c:f>'3nt'!$A$456</c:f>
              <c:strCache>
                <c:ptCount val="1"/>
                <c:pt idx="0">
                  <c:v>AUU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56:$Y$456</c:f>
              <c:numCache>
                <c:formatCode>General</c:formatCode>
                <c:ptCount val="24"/>
                <c:pt idx="0">
                  <c:v>2.2443181818181821</c:v>
                </c:pt>
                <c:pt idx="1">
                  <c:v>2.8409090909090908</c:v>
                </c:pt>
                <c:pt idx="2">
                  <c:v>2.6988636363636327</c:v>
                </c:pt>
                <c:pt idx="3">
                  <c:v>2.5852272727273009</c:v>
                </c:pt>
                <c:pt idx="4">
                  <c:v>2.2443181818181821</c:v>
                </c:pt>
                <c:pt idx="5">
                  <c:v>2.4431818181818454</c:v>
                </c:pt>
                <c:pt idx="6">
                  <c:v>2.8693181818181777</c:v>
                </c:pt>
                <c:pt idx="7">
                  <c:v>3.0113636363636327</c:v>
                </c:pt>
                <c:pt idx="8">
                  <c:v>2.8124999999999716</c:v>
                </c:pt>
                <c:pt idx="9">
                  <c:v>3.1534090909090908</c:v>
                </c:pt>
                <c:pt idx="10">
                  <c:v>2.8693181818181777</c:v>
                </c:pt>
                <c:pt idx="11">
                  <c:v>3.6363636363636327</c:v>
                </c:pt>
                <c:pt idx="12">
                  <c:v>3.5227272727273009</c:v>
                </c:pt>
                <c:pt idx="13">
                  <c:v>3.2670454545454541</c:v>
                </c:pt>
                <c:pt idx="14">
                  <c:v>3.3522727272727177</c:v>
                </c:pt>
                <c:pt idx="15">
                  <c:v>3.5227272727273009</c:v>
                </c:pt>
                <c:pt idx="16">
                  <c:v>3.4659090909090908</c:v>
                </c:pt>
                <c:pt idx="17">
                  <c:v>2.982954545454545</c:v>
                </c:pt>
                <c:pt idx="18">
                  <c:v>3.0397727272727271</c:v>
                </c:pt>
                <c:pt idx="19">
                  <c:v>2.670454545454545</c:v>
                </c:pt>
                <c:pt idx="20">
                  <c:v>2.7272727272727506</c:v>
                </c:pt>
                <c:pt idx="21">
                  <c:v>2.5852272727273009</c:v>
                </c:pt>
                <c:pt idx="22">
                  <c:v>2.8977272727273009</c:v>
                </c:pt>
                <c:pt idx="23">
                  <c:v>2.98295454545454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1784-405B-8F91-AE3CBDDEDCBB}"/>
            </c:ext>
          </c:extLst>
        </c:ser>
        <c:ser>
          <c:idx val="6"/>
          <c:order val="6"/>
          <c:tx>
            <c:strRef>
              <c:f>'3nt'!$A$457</c:f>
              <c:strCache>
                <c:ptCount val="1"/>
                <c:pt idx="0">
                  <c:v>UAG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57:$Y$457</c:f>
              <c:numCache>
                <c:formatCode>General</c:formatCode>
                <c:ptCount val="24"/>
                <c:pt idx="0">
                  <c:v>2.8124999999999716</c:v>
                </c:pt>
                <c:pt idx="1">
                  <c:v>2.3011363636363642</c:v>
                </c:pt>
                <c:pt idx="2">
                  <c:v>2.4431818181818454</c:v>
                </c:pt>
                <c:pt idx="3">
                  <c:v>1.8181818181818181</c:v>
                </c:pt>
                <c:pt idx="4">
                  <c:v>2.3863636363636327</c:v>
                </c:pt>
                <c:pt idx="5">
                  <c:v>1.9886363636363742</c:v>
                </c:pt>
                <c:pt idx="6">
                  <c:v>1.4772727272727271</c:v>
                </c:pt>
                <c:pt idx="7">
                  <c:v>1.9034090909090808</c:v>
                </c:pt>
                <c:pt idx="8">
                  <c:v>1.420454545454545</c:v>
                </c:pt>
                <c:pt idx="9">
                  <c:v>1.6193181818181821</c:v>
                </c:pt>
                <c:pt idx="10">
                  <c:v>1.4488636363636358</c:v>
                </c:pt>
                <c:pt idx="11">
                  <c:v>1.3920454545454561</c:v>
                </c:pt>
                <c:pt idx="12">
                  <c:v>1.4772727272727271</c:v>
                </c:pt>
                <c:pt idx="13">
                  <c:v>1.9034090909090808</c:v>
                </c:pt>
                <c:pt idx="14">
                  <c:v>1.8181818181818181</c:v>
                </c:pt>
                <c:pt idx="15">
                  <c:v>2.670454545454545</c:v>
                </c:pt>
                <c:pt idx="16">
                  <c:v>4.0909090909090908</c:v>
                </c:pt>
                <c:pt idx="17">
                  <c:v>4.0909090909090908</c:v>
                </c:pt>
                <c:pt idx="18">
                  <c:v>5.6818181818181834</c:v>
                </c:pt>
                <c:pt idx="19">
                  <c:v>5.3977272727272636</c:v>
                </c:pt>
                <c:pt idx="20">
                  <c:v>5.5397727272727524</c:v>
                </c:pt>
                <c:pt idx="21">
                  <c:v>3.8352272727272751</c:v>
                </c:pt>
                <c:pt idx="22">
                  <c:v>1.9318181818181821</c:v>
                </c:pt>
                <c:pt idx="23">
                  <c:v>1.505681818181817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1784-405B-8F91-AE3CBDDEDCBB}"/>
            </c:ext>
          </c:extLst>
        </c:ser>
        <c:ser>
          <c:idx val="7"/>
          <c:order val="7"/>
          <c:tx>
            <c:strRef>
              <c:f>'3nt'!$A$458</c:f>
              <c:strCache>
                <c:ptCount val="1"/>
                <c:pt idx="0">
                  <c:v>UUU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58:$Y$458</c:f>
              <c:numCache>
                <c:formatCode>General</c:formatCode>
                <c:ptCount val="24"/>
                <c:pt idx="0">
                  <c:v>2.4147727272727271</c:v>
                </c:pt>
                <c:pt idx="1">
                  <c:v>2.0170454545454537</c:v>
                </c:pt>
                <c:pt idx="2">
                  <c:v>3.4659090909090908</c:v>
                </c:pt>
                <c:pt idx="3">
                  <c:v>2.357954545454545</c:v>
                </c:pt>
                <c:pt idx="4">
                  <c:v>2.1875000000000244</c:v>
                </c:pt>
                <c:pt idx="5">
                  <c:v>3.0965909090909087</c:v>
                </c:pt>
                <c:pt idx="6">
                  <c:v>2.4715909090909087</c:v>
                </c:pt>
                <c:pt idx="7">
                  <c:v>2.357954545454545</c:v>
                </c:pt>
                <c:pt idx="8">
                  <c:v>3.2386363636363642</c:v>
                </c:pt>
                <c:pt idx="9">
                  <c:v>2.3011363636363642</c:v>
                </c:pt>
                <c:pt idx="10">
                  <c:v>2.3863636363636327</c:v>
                </c:pt>
                <c:pt idx="11">
                  <c:v>3.5511363636363642</c:v>
                </c:pt>
                <c:pt idx="12">
                  <c:v>2.5284090909090908</c:v>
                </c:pt>
                <c:pt idx="13">
                  <c:v>2.6420454545454537</c:v>
                </c:pt>
                <c:pt idx="14">
                  <c:v>3.75</c:v>
                </c:pt>
                <c:pt idx="15">
                  <c:v>2.4147727272727271</c:v>
                </c:pt>
                <c:pt idx="16">
                  <c:v>2.8124999999999716</c:v>
                </c:pt>
                <c:pt idx="17">
                  <c:v>2.982954545454545</c:v>
                </c:pt>
                <c:pt idx="18">
                  <c:v>1.9034090909090808</c:v>
                </c:pt>
                <c:pt idx="19">
                  <c:v>1.6761363636363742</c:v>
                </c:pt>
                <c:pt idx="20">
                  <c:v>1.9034090909090808</c:v>
                </c:pt>
                <c:pt idx="21">
                  <c:v>1.5909090909090808</c:v>
                </c:pt>
                <c:pt idx="22">
                  <c:v>1.5340909090909101</c:v>
                </c:pt>
                <c:pt idx="23">
                  <c:v>3.77840909090908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1784-405B-8F91-AE3CBDDEDCBB}"/>
            </c:ext>
          </c:extLst>
        </c:ser>
        <c:ser>
          <c:idx val="8"/>
          <c:order val="8"/>
          <c:tx>
            <c:strRef>
              <c:f>'3nt'!$A$459</c:f>
              <c:strCache>
                <c:ptCount val="1"/>
                <c:pt idx="0">
                  <c:v>GUA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59:$Y$459</c:f>
              <c:numCache>
                <c:formatCode>General</c:formatCode>
                <c:ptCount val="24"/>
                <c:pt idx="0">
                  <c:v>2.4715909090909087</c:v>
                </c:pt>
                <c:pt idx="1">
                  <c:v>2.357954545454545</c:v>
                </c:pt>
                <c:pt idx="2">
                  <c:v>2.1022727272727271</c:v>
                </c:pt>
                <c:pt idx="3">
                  <c:v>2.1875000000000244</c:v>
                </c:pt>
                <c:pt idx="4">
                  <c:v>2.357954545454545</c:v>
                </c:pt>
                <c:pt idx="5">
                  <c:v>2.2443181818181821</c:v>
                </c:pt>
                <c:pt idx="6">
                  <c:v>2.8124999999999716</c:v>
                </c:pt>
                <c:pt idx="7">
                  <c:v>2.2159090909090908</c:v>
                </c:pt>
                <c:pt idx="8">
                  <c:v>2.1590909090909087</c:v>
                </c:pt>
                <c:pt idx="9">
                  <c:v>2.7272727272727506</c:v>
                </c:pt>
                <c:pt idx="10">
                  <c:v>2.1306818181818201</c:v>
                </c:pt>
                <c:pt idx="11">
                  <c:v>2.7840909090909105</c:v>
                </c:pt>
                <c:pt idx="12">
                  <c:v>2.7840909090909105</c:v>
                </c:pt>
                <c:pt idx="13">
                  <c:v>2.6988636363636327</c:v>
                </c:pt>
                <c:pt idx="14">
                  <c:v>2.5284090909090908</c:v>
                </c:pt>
                <c:pt idx="15">
                  <c:v>2.8409090909090908</c:v>
                </c:pt>
                <c:pt idx="16">
                  <c:v>2.9545454545454537</c:v>
                </c:pt>
                <c:pt idx="17">
                  <c:v>3.6931818181818454</c:v>
                </c:pt>
                <c:pt idx="18">
                  <c:v>2.982954545454545</c:v>
                </c:pt>
                <c:pt idx="19">
                  <c:v>3.0113636363636327</c:v>
                </c:pt>
                <c:pt idx="20">
                  <c:v>3.1534090909090908</c:v>
                </c:pt>
                <c:pt idx="21">
                  <c:v>1.9886363636363742</c:v>
                </c:pt>
                <c:pt idx="22">
                  <c:v>1.960227272727272</c:v>
                </c:pt>
                <c:pt idx="23">
                  <c:v>1.392045454545456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1784-405B-8F91-AE3CBDDEDCBB}"/>
            </c:ext>
          </c:extLst>
        </c:ser>
        <c:ser>
          <c:idx val="9"/>
          <c:order val="9"/>
          <c:tx>
            <c:strRef>
              <c:f>'3nt'!$A$460</c:f>
              <c:strCache>
                <c:ptCount val="1"/>
                <c:pt idx="0">
                  <c:v>AAC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60:$Y$460</c:f>
              <c:numCache>
                <c:formatCode>General</c:formatCode>
                <c:ptCount val="24"/>
                <c:pt idx="0">
                  <c:v>1.3920454545454561</c:v>
                </c:pt>
                <c:pt idx="1">
                  <c:v>1.5625</c:v>
                </c:pt>
                <c:pt idx="2">
                  <c:v>2.7556818181818201</c:v>
                </c:pt>
                <c:pt idx="3">
                  <c:v>2.0738636363636327</c:v>
                </c:pt>
                <c:pt idx="4">
                  <c:v>2.1022727272727271</c:v>
                </c:pt>
                <c:pt idx="5">
                  <c:v>2.1022727272727271</c:v>
                </c:pt>
                <c:pt idx="6">
                  <c:v>2.2443181818181821</c:v>
                </c:pt>
                <c:pt idx="7">
                  <c:v>2.5</c:v>
                </c:pt>
                <c:pt idx="8">
                  <c:v>2.6988636363636327</c:v>
                </c:pt>
                <c:pt idx="9">
                  <c:v>2.4431818181818454</c:v>
                </c:pt>
                <c:pt idx="10">
                  <c:v>2.6420454545454537</c:v>
                </c:pt>
                <c:pt idx="11">
                  <c:v>2.357954545454545</c:v>
                </c:pt>
                <c:pt idx="12">
                  <c:v>2.2443181818181821</c:v>
                </c:pt>
                <c:pt idx="13">
                  <c:v>2.556818181818139</c:v>
                </c:pt>
                <c:pt idx="14">
                  <c:v>2.4715909090909087</c:v>
                </c:pt>
                <c:pt idx="15">
                  <c:v>2.670454545454545</c:v>
                </c:pt>
                <c:pt idx="16">
                  <c:v>2.3011363636363642</c:v>
                </c:pt>
                <c:pt idx="17">
                  <c:v>2.0170454545454537</c:v>
                </c:pt>
                <c:pt idx="18">
                  <c:v>2.2727272727273009</c:v>
                </c:pt>
                <c:pt idx="19">
                  <c:v>2.2159090909090908</c:v>
                </c:pt>
                <c:pt idx="20">
                  <c:v>2.4431818181818454</c:v>
                </c:pt>
                <c:pt idx="21">
                  <c:v>3.7215909090909105</c:v>
                </c:pt>
                <c:pt idx="22">
                  <c:v>2.8977272727273009</c:v>
                </c:pt>
                <c:pt idx="23">
                  <c:v>2.67045454545454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1784-405B-8F91-AE3CBDDEDCBB}"/>
            </c:ext>
          </c:extLst>
        </c:ser>
        <c:ser>
          <c:idx val="10"/>
          <c:order val="10"/>
          <c:tx>
            <c:strRef>
              <c:f>'3nt'!$A$461</c:f>
              <c:strCache>
                <c:ptCount val="1"/>
                <c:pt idx="0">
                  <c:v>UAU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61:$Y$461</c:f>
              <c:numCache>
                <c:formatCode>General</c:formatCode>
                <c:ptCount val="24"/>
                <c:pt idx="0">
                  <c:v>1.6477272727272718</c:v>
                </c:pt>
                <c:pt idx="1">
                  <c:v>1.960227272727272</c:v>
                </c:pt>
                <c:pt idx="2">
                  <c:v>1.8181818181818181</c:v>
                </c:pt>
                <c:pt idx="3">
                  <c:v>1.5909090909090808</c:v>
                </c:pt>
                <c:pt idx="4">
                  <c:v>1.9034090909090808</c:v>
                </c:pt>
                <c:pt idx="5">
                  <c:v>2.2727272727273009</c:v>
                </c:pt>
                <c:pt idx="6">
                  <c:v>1.9034090909090808</c:v>
                </c:pt>
                <c:pt idx="7">
                  <c:v>2.556818181818139</c:v>
                </c:pt>
                <c:pt idx="8">
                  <c:v>1.7897727272727271</c:v>
                </c:pt>
                <c:pt idx="9">
                  <c:v>2.1022727272727271</c:v>
                </c:pt>
                <c:pt idx="10">
                  <c:v>2.3863636363636327</c:v>
                </c:pt>
                <c:pt idx="11">
                  <c:v>2.8693181818181777</c:v>
                </c:pt>
                <c:pt idx="12">
                  <c:v>2.5852272727273009</c:v>
                </c:pt>
                <c:pt idx="13">
                  <c:v>3.4659090909090908</c:v>
                </c:pt>
                <c:pt idx="14">
                  <c:v>3.9772727272727271</c:v>
                </c:pt>
                <c:pt idx="15">
                  <c:v>3.0965909090909087</c:v>
                </c:pt>
                <c:pt idx="16">
                  <c:v>4.0340909090909065</c:v>
                </c:pt>
                <c:pt idx="17">
                  <c:v>3.3238636363636327</c:v>
                </c:pt>
                <c:pt idx="18">
                  <c:v>2.7840909090909105</c:v>
                </c:pt>
                <c:pt idx="19">
                  <c:v>2.1306818181818201</c:v>
                </c:pt>
                <c:pt idx="20">
                  <c:v>1.8465909090909101</c:v>
                </c:pt>
                <c:pt idx="21">
                  <c:v>1.704545454545455</c:v>
                </c:pt>
                <c:pt idx="22">
                  <c:v>1.6193181818181821</c:v>
                </c:pt>
                <c:pt idx="23">
                  <c:v>1.619318181818182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1784-405B-8F91-AE3CBDDEDCBB}"/>
            </c:ext>
          </c:extLst>
        </c:ser>
        <c:ser>
          <c:idx val="11"/>
          <c:order val="11"/>
          <c:tx>
            <c:strRef>
              <c:f>'3nt'!$A$462</c:f>
              <c:strCache>
                <c:ptCount val="1"/>
                <c:pt idx="0">
                  <c:v>AAG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62:$Y$462</c:f>
              <c:numCache>
                <c:formatCode>General</c:formatCode>
                <c:ptCount val="24"/>
                <c:pt idx="0">
                  <c:v>2.3295454545454537</c:v>
                </c:pt>
                <c:pt idx="1">
                  <c:v>1.7897727272727271</c:v>
                </c:pt>
                <c:pt idx="2">
                  <c:v>2.1590909090909087</c:v>
                </c:pt>
                <c:pt idx="3">
                  <c:v>1.9886363636363742</c:v>
                </c:pt>
                <c:pt idx="4">
                  <c:v>1.9318181818181821</c:v>
                </c:pt>
                <c:pt idx="5">
                  <c:v>2.357954545454545</c:v>
                </c:pt>
                <c:pt idx="6">
                  <c:v>1.9886363636363742</c:v>
                </c:pt>
                <c:pt idx="7">
                  <c:v>1.704545454545455</c:v>
                </c:pt>
                <c:pt idx="8">
                  <c:v>1.960227272727272</c:v>
                </c:pt>
                <c:pt idx="9">
                  <c:v>2.4431818181818454</c:v>
                </c:pt>
                <c:pt idx="10">
                  <c:v>2.2443181818181821</c:v>
                </c:pt>
                <c:pt idx="11">
                  <c:v>2.5</c:v>
                </c:pt>
                <c:pt idx="12">
                  <c:v>2.357954545454545</c:v>
                </c:pt>
                <c:pt idx="13">
                  <c:v>2.3863636363636327</c:v>
                </c:pt>
                <c:pt idx="14">
                  <c:v>2.4715909090909087</c:v>
                </c:pt>
                <c:pt idx="15">
                  <c:v>2.045454545454545</c:v>
                </c:pt>
                <c:pt idx="16">
                  <c:v>1.8465909090909101</c:v>
                </c:pt>
                <c:pt idx="17">
                  <c:v>2.4715909090909087</c:v>
                </c:pt>
                <c:pt idx="18">
                  <c:v>2.2443181818181821</c:v>
                </c:pt>
                <c:pt idx="19">
                  <c:v>2.8693181818181777</c:v>
                </c:pt>
                <c:pt idx="20">
                  <c:v>3.4659090909090908</c:v>
                </c:pt>
                <c:pt idx="21">
                  <c:v>3.5511363636363642</c:v>
                </c:pt>
                <c:pt idx="22">
                  <c:v>2.8977272727273009</c:v>
                </c:pt>
                <c:pt idx="23">
                  <c:v>2.55681818181813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1784-405B-8F91-AE3CBDDEDCBB}"/>
            </c:ext>
          </c:extLst>
        </c:ser>
        <c:ser>
          <c:idx val="12"/>
          <c:order val="12"/>
          <c:tx>
            <c:strRef>
              <c:f>'3nt'!$A$463</c:f>
              <c:strCache>
                <c:ptCount val="1"/>
                <c:pt idx="0">
                  <c:v>AGU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63:$Y$463</c:f>
              <c:numCache>
                <c:formatCode>General</c:formatCode>
                <c:ptCount val="24"/>
                <c:pt idx="0">
                  <c:v>2.1022727272727271</c:v>
                </c:pt>
                <c:pt idx="1">
                  <c:v>2.2159090909090908</c:v>
                </c:pt>
                <c:pt idx="2">
                  <c:v>1.8465909090909101</c:v>
                </c:pt>
                <c:pt idx="3">
                  <c:v>2.0170454545454537</c:v>
                </c:pt>
                <c:pt idx="4">
                  <c:v>1.9886363636363742</c:v>
                </c:pt>
                <c:pt idx="5">
                  <c:v>2.357954545454545</c:v>
                </c:pt>
                <c:pt idx="6">
                  <c:v>1.8465909090909101</c:v>
                </c:pt>
                <c:pt idx="7">
                  <c:v>1.7613636363636358</c:v>
                </c:pt>
                <c:pt idx="8">
                  <c:v>2.1022727272727271</c:v>
                </c:pt>
                <c:pt idx="9">
                  <c:v>1.3636363636363631</c:v>
                </c:pt>
                <c:pt idx="10">
                  <c:v>1.7329545454545459</c:v>
                </c:pt>
                <c:pt idx="11">
                  <c:v>1.8181818181818181</c:v>
                </c:pt>
                <c:pt idx="12">
                  <c:v>2.1022727272727271</c:v>
                </c:pt>
                <c:pt idx="13">
                  <c:v>2.2443181818181821</c:v>
                </c:pt>
                <c:pt idx="14">
                  <c:v>2.2443181818181821</c:v>
                </c:pt>
                <c:pt idx="15">
                  <c:v>2.3295454545454537</c:v>
                </c:pt>
                <c:pt idx="16">
                  <c:v>2.5</c:v>
                </c:pt>
                <c:pt idx="17">
                  <c:v>2.6988636363636327</c:v>
                </c:pt>
                <c:pt idx="18">
                  <c:v>2.7840909090909105</c:v>
                </c:pt>
                <c:pt idx="19">
                  <c:v>3.4943181818181777</c:v>
                </c:pt>
                <c:pt idx="20">
                  <c:v>2.7272727272727506</c:v>
                </c:pt>
                <c:pt idx="21">
                  <c:v>3.4374999999999987</c:v>
                </c:pt>
                <c:pt idx="22">
                  <c:v>2.556818181818139</c:v>
                </c:pt>
                <c:pt idx="23">
                  <c:v>1.818181818181818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C-1784-405B-8F91-AE3CBDDEDCBB}"/>
            </c:ext>
          </c:extLst>
        </c:ser>
        <c:ser>
          <c:idx val="13"/>
          <c:order val="13"/>
          <c:tx>
            <c:strRef>
              <c:f>'3nt'!$A$464</c:f>
              <c:strCache>
                <c:ptCount val="1"/>
                <c:pt idx="0">
                  <c:v>CUA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64:$Y$464</c:f>
              <c:numCache>
                <c:formatCode>General</c:formatCode>
                <c:ptCount val="24"/>
                <c:pt idx="0">
                  <c:v>1.7897727272727271</c:v>
                </c:pt>
                <c:pt idx="1">
                  <c:v>1.7897727272727271</c:v>
                </c:pt>
                <c:pt idx="2">
                  <c:v>1.875</c:v>
                </c:pt>
                <c:pt idx="3">
                  <c:v>1.7613636363636358</c:v>
                </c:pt>
                <c:pt idx="4">
                  <c:v>1.9318181818181821</c:v>
                </c:pt>
                <c:pt idx="5">
                  <c:v>2.1590909090909087</c:v>
                </c:pt>
                <c:pt idx="6">
                  <c:v>1.9886363636363742</c:v>
                </c:pt>
                <c:pt idx="7">
                  <c:v>1.960227272727272</c:v>
                </c:pt>
                <c:pt idx="8">
                  <c:v>2.1306818181818201</c:v>
                </c:pt>
                <c:pt idx="9">
                  <c:v>2.4431818181818454</c:v>
                </c:pt>
                <c:pt idx="10">
                  <c:v>2.2443181818181821</c:v>
                </c:pt>
                <c:pt idx="11">
                  <c:v>2.1590909090909087</c:v>
                </c:pt>
                <c:pt idx="12">
                  <c:v>2.3863636363636327</c:v>
                </c:pt>
                <c:pt idx="13">
                  <c:v>2.6988636363636327</c:v>
                </c:pt>
                <c:pt idx="14">
                  <c:v>2.3295454545454537</c:v>
                </c:pt>
                <c:pt idx="15">
                  <c:v>3.2102272727273009</c:v>
                </c:pt>
                <c:pt idx="16">
                  <c:v>2.8977272727273009</c:v>
                </c:pt>
                <c:pt idx="17">
                  <c:v>3.3522727272727177</c:v>
                </c:pt>
                <c:pt idx="18">
                  <c:v>2.7556818181818201</c:v>
                </c:pt>
                <c:pt idx="19">
                  <c:v>2.6420454545454537</c:v>
                </c:pt>
                <c:pt idx="20">
                  <c:v>2.3011363636363642</c:v>
                </c:pt>
                <c:pt idx="21">
                  <c:v>0.82386363636364213</c:v>
                </c:pt>
                <c:pt idx="22">
                  <c:v>1.3068181818181821</c:v>
                </c:pt>
                <c:pt idx="23">
                  <c:v>1.164772727272737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D-1784-405B-8F91-AE3CBDDEDCBB}"/>
            </c:ext>
          </c:extLst>
        </c:ser>
        <c:ser>
          <c:idx val="14"/>
          <c:order val="14"/>
          <c:tx>
            <c:strRef>
              <c:f>'3nt'!$A$465</c:f>
              <c:strCache>
                <c:ptCount val="1"/>
                <c:pt idx="0">
                  <c:v>AGA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65:$Y$465</c:f>
              <c:numCache>
                <c:formatCode>General</c:formatCode>
                <c:ptCount val="24"/>
                <c:pt idx="0">
                  <c:v>2.1875000000000244</c:v>
                </c:pt>
                <c:pt idx="1">
                  <c:v>2.045454545454545</c:v>
                </c:pt>
                <c:pt idx="2">
                  <c:v>2.2443181818181821</c:v>
                </c:pt>
                <c:pt idx="3">
                  <c:v>1.960227272727272</c:v>
                </c:pt>
                <c:pt idx="4">
                  <c:v>1.960227272727272</c:v>
                </c:pt>
                <c:pt idx="5">
                  <c:v>1.9034090909090808</c:v>
                </c:pt>
                <c:pt idx="6">
                  <c:v>2.2159090909090908</c:v>
                </c:pt>
                <c:pt idx="7">
                  <c:v>1.8465909090909101</c:v>
                </c:pt>
                <c:pt idx="8">
                  <c:v>1.2215909090909078</c:v>
                </c:pt>
                <c:pt idx="9">
                  <c:v>1.6477272727272718</c:v>
                </c:pt>
                <c:pt idx="10">
                  <c:v>1.8465909090909101</c:v>
                </c:pt>
                <c:pt idx="11">
                  <c:v>1.420454545454545</c:v>
                </c:pt>
                <c:pt idx="12">
                  <c:v>1.3352272727272718</c:v>
                </c:pt>
                <c:pt idx="13">
                  <c:v>1.4488636363636358</c:v>
                </c:pt>
                <c:pt idx="14">
                  <c:v>1.5340909090909101</c:v>
                </c:pt>
                <c:pt idx="15">
                  <c:v>1.5056818181818179</c:v>
                </c:pt>
                <c:pt idx="16">
                  <c:v>1.875</c:v>
                </c:pt>
                <c:pt idx="17">
                  <c:v>2.4147727272727271</c:v>
                </c:pt>
                <c:pt idx="18">
                  <c:v>2.4431818181818454</c:v>
                </c:pt>
                <c:pt idx="19">
                  <c:v>2.8409090909090908</c:v>
                </c:pt>
                <c:pt idx="20">
                  <c:v>3.75</c:v>
                </c:pt>
                <c:pt idx="21">
                  <c:v>3.75</c:v>
                </c:pt>
                <c:pt idx="22">
                  <c:v>3.7215909090909105</c:v>
                </c:pt>
                <c:pt idx="23">
                  <c:v>2.102272727272727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E-1784-405B-8F91-AE3CBDDEDCBB}"/>
            </c:ext>
          </c:extLst>
        </c:ser>
        <c:ser>
          <c:idx val="15"/>
          <c:order val="15"/>
          <c:tx>
            <c:strRef>
              <c:f>'3nt'!$A$466</c:f>
              <c:strCache>
                <c:ptCount val="1"/>
                <c:pt idx="0">
                  <c:v>GAA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66:$Y$466</c:f>
              <c:numCache>
                <c:formatCode>General</c:formatCode>
                <c:ptCount val="24"/>
                <c:pt idx="0">
                  <c:v>1.875</c:v>
                </c:pt>
                <c:pt idx="1">
                  <c:v>2.357954545454545</c:v>
                </c:pt>
                <c:pt idx="2">
                  <c:v>2.0170454545454537</c:v>
                </c:pt>
                <c:pt idx="3">
                  <c:v>2.2159090909090908</c:v>
                </c:pt>
                <c:pt idx="4">
                  <c:v>2.2443181818181821</c:v>
                </c:pt>
                <c:pt idx="5">
                  <c:v>1.7329545454545459</c:v>
                </c:pt>
                <c:pt idx="6">
                  <c:v>2.2443181818181821</c:v>
                </c:pt>
                <c:pt idx="7">
                  <c:v>2.1590909090909087</c:v>
                </c:pt>
                <c:pt idx="8">
                  <c:v>1.9886363636363742</c:v>
                </c:pt>
                <c:pt idx="9">
                  <c:v>1.9318181818181821</c:v>
                </c:pt>
                <c:pt idx="10">
                  <c:v>1.7613636363636358</c:v>
                </c:pt>
                <c:pt idx="11">
                  <c:v>1.7897727272727271</c:v>
                </c:pt>
                <c:pt idx="12">
                  <c:v>2.1306818181818201</c:v>
                </c:pt>
                <c:pt idx="13">
                  <c:v>1.7613636363636358</c:v>
                </c:pt>
                <c:pt idx="14">
                  <c:v>1.5625</c:v>
                </c:pt>
                <c:pt idx="15">
                  <c:v>1.6761363636363742</c:v>
                </c:pt>
                <c:pt idx="16">
                  <c:v>1.4488636363636358</c:v>
                </c:pt>
                <c:pt idx="17">
                  <c:v>1.6477272727272718</c:v>
                </c:pt>
                <c:pt idx="18">
                  <c:v>1.8181818181818181</c:v>
                </c:pt>
                <c:pt idx="19">
                  <c:v>2.1022727272727271</c:v>
                </c:pt>
                <c:pt idx="20">
                  <c:v>2.2443181818181821</c:v>
                </c:pt>
                <c:pt idx="21">
                  <c:v>2.6420454545454537</c:v>
                </c:pt>
                <c:pt idx="22">
                  <c:v>2.8409090909090908</c:v>
                </c:pt>
                <c:pt idx="23">
                  <c:v>2.55681818181813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F-1784-405B-8F91-AE3CBDDEDCBB}"/>
            </c:ext>
          </c:extLst>
        </c:ser>
        <c:ser>
          <c:idx val="16"/>
          <c:order val="16"/>
          <c:tx>
            <c:strRef>
              <c:f>'3nt'!$A$467</c:f>
              <c:strCache>
                <c:ptCount val="1"/>
                <c:pt idx="0">
                  <c:v>CAA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67:$Y$467</c:f>
              <c:numCache>
                <c:formatCode>General</c:formatCode>
                <c:ptCount val="24"/>
                <c:pt idx="0">
                  <c:v>2.1875000000000244</c:v>
                </c:pt>
                <c:pt idx="1">
                  <c:v>2.3295454545454537</c:v>
                </c:pt>
                <c:pt idx="2">
                  <c:v>2.4147727272727271</c:v>
                </c:pt>
                <c:pt idx="3">
                  <c:v>2.2727272727273009</c:v>
                </c:pt>
                <c:pt idx="4">
                  <c:v>2.2727272727273009</c:v>
                </c:pt>
                <c:pt idx="5">
                  <c:v>2.2443181818181821</c:v>
                </c:pt>
                <c:pt idx="6">
                  <c:v>2.0170454545454537</c:v>
                </c:pt>
                <c:pt idx="7">
                  <c:v>2.1875000000000244</c:v>
                </c:pt>
                <c:pt idx="8">
                  <c:v>1.9318181818181821</c:v>
                </c:pt>
                <c:pt idx="9">
                  <c:v>2.4715909090909087</c:v>
                </c:pt>
                <c:pt idx="10">
                  <c:v>1.8181818181818181</c:v>
                </c:pt>
                <c:pt idx="11">
                  <c:v>1.875</c:v>
                </c:pt>
                <c:pt idx="12">
                  <c:v>2.1022727272727271</c:v>
                </c:pt>
                <c:pt idx="13">
                  <c:v>2.1875000000000244</c:v>
                </c:pt>
                <c:pt idx="14">
                  <c:v>1.7613636363636358</c:v>
                </c:pt>
                <c:pt idx="15">
                  <c:v>1.6761363636363742</c:v>
                </c:pt>
                <c:pt idx="16">
                  <c:v>1.7897727272727271</c:v>
                </c:pt>
                <c:pt idx="17">
                  <c:v>1.704545454545455</c:v>
                </c:pt>
                <c:pt idx="18">
                  <c:v>1.25</c:v>
                </c:pt>
                <c:pt idx="19">
                  <c:v>1.5625</c:v>
                </c:pt>
                <c:pt idx="20">
                  <c:v>1.6477272727272718</c:v>
                </c:pt>
                <c:pt idx="21">
                  <c:v>1.6477272727272718</c:v>
                </c:pt>
                <c:pt idx="22">
                  <c:v>2.1590909090909087</c:v>
                </c:pt>
                <c:pt idx="23">
                  <c:v>2.67045454545454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0-1784-405B-8F91-AE3CBDDEDCBB}"/>
            </c:ext>
          </c:extLst>
        </c:ser>
        <c:ser>
          <c:idx val="17"/>
          <c:order val="17"/>
          <c:tx>
            <c:strRef>
              <c:f>'3nt'!$A$468</c:f>
              <c:strCache>
                <c:ptCount val="1"/>
                <c:pt idx="0">
                  <c:v>ACA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68:$Y$468</c:f>
              <c:numCache>
                <c:formatCode>General</c:formatCode>
                <c:ptCount val="24"/>
                <c:pt idx="0">
                  <c:v>2.0738636363636327</c:v>
                </c:pt>
                <c:pt idx="1">
                  <c:v>2.045454545454545</c:v>
                </c:pt>
                <c:pt idx="2">
                  <c:v>1.5056818181818179</c:v>
                </c:pt>
                <c:pt idx="3">
                  <c:v>2.3011363636363642</c:v>
                </c:pt>
                <c:pt idx="4">
                  <c:v>2.2443181818181821</c:v>
                </c:pt>
                <c:pt idx="5">
                  <c:v>2.357954545454545</c:v>
                </c:pt>
                <c:pt idx="6">
                  <c:v>1.7329545454545459</c:v>
                </c:pt>
                <c:pt idx="7">
                  <c:v>1.9034090909090808</c:v>
                </c:pt>
                <c:pt idx="8">
                  <c:v>2.1875000000000244</c:v>
                </c:pt>
                <c:pt idx="9">
                  <c:v>1.8181818181818181</c:v>
                </c:pt>
                <c:pt idx="10">
                  <c:v>1.7329545454545459</c:v>
                </c:pt>
                <c:pt idx="11">
                  <c:v>2.3295454545454537</c:v>
                </c:pt>
                <c:pt idx="12">
                  <c:v>2.1590909090909087</c:v>
                </c:pt>
                <c:pt idx="13">
                  <c:v>1.9318181818181821</c:v>
                </c:pt>
                <c:pt idx="14">
                  <c:v>1.8181818181818181</c:v>
                </c:pt>
                <c:pt idx="15">
                  <c:v>1.8465909090909101</c:v>
                </c:pt>
                <c:pt idx="16">
                  <c:v>1.9318181818181821</c:v>
                </c:pt>
                <c:pt idx="17">
                  <c:v>1.9886363636363742</c:v>
                </c:pt>
                <c:pt idx="18">
                  <c:v>1.5340909090909101</c:v>
                </c:pt>
                <c:pt idx="19">
                  <c:v>1.5340909090909101</c:v>
                </c:pt>
                <c:pt idx="20">
                  <c:v>1.5340909090909101</c:v>
                </c:pt>
                <c:pt idx="21">
                  <c:v>1.7613636363636358</c:v>
                </c:pt>
                <c:pt idx="22">
                  <c:v>2.8124999999999716</c:v>
                </c:pt>
                <c:pt idx="23">
                  <c:v>2.954545454545453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1-1784-405B-8F91-AE3CBDDEDCBB}"/>
            </c:ext>
          </c:extLst>
        </c:ser>
        <c:ser>
          <c:idx val="18"/>
          <c:order val="18"/>
          <c:tx>
            <c:strRef>
              <c:f>'3nt'!$A$469</c:f>
              <c:strCache>
                <c:ptCount val="1"/>
                <c:pt idx="0">
                  <c:v>ACU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69:$Y$469</c:f>
              <c:numCache>
                <c:formatCode>General</c:formatCode>
                <c:ptCount val="24"/>
                <c:pt idx="0">
                  <c:v>1.1931818181818181</c:v>
                </c:pt>
                <c:pt idx="1">
                  <c:v>1.704545454545455</c:v>
                </c:pt>
                <c:pt idx="2">
                  <c:v>1.6193181818181821</c:v>
                </c:pt>
                <c:pt idx="3">
                  <c:v>1.9318181818181821</c:v>
                </c:pt>
                <c:pt idx="4">
                  <c:v>1.4488636363636358</c:v>
                </c:pt>
                <c:pt idx="5">
                  <c:v>1.8181818181818181</c:v>
                </c:pt>
                <c:pt idx="6">
                  <c:v>1.960227272727272</c:v>
                </c:pt>
                <c:pt idx="7">
                  <c:v>2.0738636363636327</c:v>
                </c:pt>
                <c:pt idx="8">
                  <c:v>2.3863636363636327</c:v>
                </c:pt>
                <c:pt idx="9">
                  <c:v>1.9034090909090808</c:v>
                </c:pt>
                <c:pt idx="10">
                  <c:v>2.0170454545454537</c:v>
                </c:pt>
                <c:pt idx="11">
                  <c:v>1.960227272727272</c:v>
                </c:pt>
                <c:pt idx="12">
                  <c:v>2.3863636363636327</c:v>
                </c:pt>
                <c:pt idx="13">
                  <c:v>1.7897727272727271</c:v>
                </c:pt>
                <c:pt idx="14">
                  <c:v>1.9318181818181821</c:v>
                </c:pt>
                <c:pt idx="15">
                  <c:v>2.1306818181818201</c:v>
                </c:pt>
                <c:pt idx="16">
                  <c:v>2.2727272727273009</c:v>
                </c:pt>
                <c:pt idx="17">
                  <c:v>1.9886363636363742</c:v>
                </c:pt>
                <c:pt idx="18">
                  <c:v>1.8465909090909101</c:v>
                </c:pt>
                <c:pt idx="19">
                  <c:v>1.5909090909090808</c:v>
                </c:pt>
                <c:pt idx="20">
                  <c:v>1.2215909090909078</c:v>
                </c:pt>
                <c:pt idx="21">
                  <c:v>1.4488636363636358</c:v>
                </c:pt>
                <c:pt idx="22">
                  <c:v>1.7329545454545459</c:v>
                </c:pt>
                <c:pt idx="23">
                  <c:v>1.732954545454545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2-1784-405B-8F91-AE3CBDDEDCBB}"/>
            </c:ext>
          </c:extLst>
        </c:ser>
        <c:ser>
          <c:idx val="19"/>
          <c:order val="19"/>
          <c:tx>
            <c:strRef>
              <c:f>'3nt'!$A$470</c:f>
              <c:strCache>
                <c:ptCount val="1"/>
                <c:pt idx="0">
                  <c:v>UAC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70:$Y$470</c:f>
              <c:numCache>
                <c:formatCode>General</c:formatCode>
                <c:ptCount val="24"/>
                <c:pt idx="0">
                  <c:v>2.2159090909090908</c:v>
                </c:pt>
                <c:pt idx="1">
                  <c:v>1.6477272727272718</c:v>
                </c:pt>
                <c:pt idx="2">
                  <c:v>1.9886363636363742</c:v>
                </c:pt>
                <c:pt idx="3">
                  <c:v>1.704545454545455</c:v>
                </c:pt>
                <c:pt idx="4">
                  <c:v>1.5625</c:v>
                </c:pt>
                <c:pt idx="5">
                  <c:v>1.6761363636363742</c:v>
                </c:pt>
                <c:pt idx="6">
                  <c:v>1.875</c:v>
                </c:pt>
                <c:pt idx="7">
                  <c:v>1.875</c:v>
                </c:pt>
                <c:pt idx="8">
                  <c:v>1.4488636363636358</c:v>
                </c:pt>
                <c:pt idx="9">
                  <c:v>1.7897727272727271</c:v>
                </c:pt>
                <c:pt idx="10">
                  <c:v>1.9034090909090808</c:v>
                </c:pt>
                <c:pt idx="11">
                  <c:v>2.2443181818181821</c:v>
                </c:pt>
                <c:pt idx="12">
                  <c:v>1.5625</c:v>
                </c:pt>
                <c:pt idx="13">
                  <c:v>1.8181818181818181</c:v>
                </c:pt>
                <c:pt idx="14">
                  <c:v>1.7329545454545459</c:v>
                </c:pt>
                <c:pt idx="15">
                  <c:v>1.9886363636363742</c:v>
                </c:pt>
                <c:pt idx="16">
                  <c:v>1.7897727272727271</c:v>
                </c:pt>
                <c:pt idx="17">
                  <c:v>1.6761363636363742</c:v>
                </c:pt>
                <c:pt idx="18">
                  <c:v>1.3920454545454561</c:v>
                </c:pt>
                <c:pt idx="19">
                  <c:v>0.82386363636364213</c:v>
                </c:pt>
                <c:pt idx="20">
                  <c:v>1.2784090909090808</c:v>
                </c:pt>
                <c:pt idx="21">
                  <c:v>1.3920454545454561</c:v>
                </c:pt>
                <c:pt idx="22">
                  <c:v>1.5625</c:v>
                </c:pt>
                <c:pt idx="23">
                  <c:v>1.96022727272727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3-1784-405B-8F91-AE3CBDDEDCBB}"/>
            </c:ext>
          </c:extLst>
        </c:ser>
        <c:ser>
          <c:idx val="20"/>
          <c:order val="20"/>
          <c:tx>
            <c:strRef>
              <c:f>'3nt'!$A$471</c:f>
              <c:strCache>
                <c:ptCount val="1"/>
                <c:pt idx="0">
                  <c:v>CAU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71:$Y$471</c:f>
              <c:numCache>
                <c:formatCode>General</c:formatCode>
                <c:ptCount val="24"/>
                <c:pt idx="0">
                  <c:v>1.8181818181818181</c:v>
                </c:pt>
                <c:pt idx="1">
                  <c:v>1.9318181818181821</c:v>
                </c:pt>
                <c:pt idx="2">
                  <c:v>1.704545454545455</c:v>
                </c:pt>
                <c:pt idx="3">
                  <c:v>1.7897727272727271</c:v>
                </c:pt>
                <c:pt idx="4">
                  <c:v>1.5056818181818179</c:v>
                </c:pt>
                <c:pt idx="5">
                  <c:v>2.0738636363636327</c:v>
                </c:pt>
                <c:pt idx="6">
                  <c:v>1.8181818181818181</c:v>
                </c:pt>
                <c:pt idx="7">
                  <c:v>1.7613636363636358</c:v>
                </c:pt>
                <c:pt idx="8">
                  <c:v>1.960227272727272</c:v>
                </c:pt>
                <c:pt idx="9">
                  <c:v>2.0738636363636327</c:v>
                </c:pt>
                <c:pt idx="10">
                  <c:v>2.045454545454545</c:v>
                </c:pt>
                <c:pt idx="11">
                  <c:v>1.6193181818181821</c:v>
                </c:pt>
                <c:pt idx="12">
                  <c:v>2.0738636363636327</c:v>
                </c:pt>
                <c:pt idx="13">
                  <c:v>1.5056818181818179</c:v>
                </c:pt>
                <c:pt idx="14">
                  <c:v>1.7897727272727271</c:v>
                </c:pt>
                <c:pt idx="15">
                  <c:v>1.4772727272727271</c:v>
                </c:pt>
                <c:pt idx="16">
                  <c:v>1.5909090909090808</c:v>
                </c:pt>
                <c:pt idx="17">
                  <c:v>1.6193181818181821</c:v>
                </c:pt>
                <c:pt idx="18">
                  <c:v>1.5625</c:v>
                </c:pt>
                <c:pt idx="19">
                  <c:v>1.051136363636364</c:v>
                </c:pt>
                <c:pt idx="20">
                  <c:v>0.96590909090909716</c:v>
                </c:pt>
                <c:pt idx="21">
                  <c:v>1.3068181818181821</c:v>
                </c:pt>
                <c:pt idx="22">
                  <c:v>1.2784090909090808</c:v>
                </c:pt>
                <c:pt idx="23">
                  <c:v>2.017045454545453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4-1784-405B-8F91-AE3CBDDEDCBB}"/>
            </c:ext>
          </c:extLst>
        </c:ser>
        <c:ser>
          <c:idx val="21"/>
          <c:order val="21"/>
          <c:tx>
            <c:strRef>
              <c:f>'3nt'!$A$472</c:f>
              <c:strCache>
                <c:ptCount val="1"/>
                <c:pt idx="0">
                  <c:v>UGU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72:$Y$472</c:f>
              <c:numCache>
                <c:formatCode>General</c:formatCode>
                <c:ptCount val="24"/>
                <c:pt idx="0">
                  <c:v>1.5625</c:v>
                </c:pt>
                <c:pt idx="1">
                  <c:v>1.9886363636363742</c:v>
                </c:pt>
                <c:pt idx="2">
                  <c:v>1.6761363636363742</c:v>
                </c:pt>
                <c:pt idx="3">
                  <c:v>1.6761363636363742</c:v>
                </c:pt>
                <c:pt idx="4">
                  <c:v>1.9318181818181821</c:v>
                </c:pt>
                <c:pt idx="5">
                  <c:v>2.2727272727273009</c:v>
                </c:pt>
                <c:pt idx="6">
                  <c:v>1.5340909090909101</c:v>
                </c:pt>
                <c:pt idx="7">
                  <c:v>2.1590909090909087</c:v>
                </c:pt>
                <c:pt idx="8">
                  <c:v>2.0170454545454537</c:v>
                </c:pt>
                <c:pt idx="9">
                  <c:v>1.420454545454545</c:v>
                </c:pt>
                <c:pt idx="10">
                  <c:v>2.1022727272727271</c:v>
                </c:pt>
                <c:pt idx="11">
                  <c:v>1.8181818181818181</c:v>
                </c:pt>
                <c:pt idx="12">
                  <c:v>2.0170454545454537</c:v>
                </c:pt>
                <c:pt idx="13">
                  <c:v>1.7329545454545459</c:v>
                </c:pt>
                <c:pt idx="14">
                  <c:v>1.9886363636363742</c:v>
                </c:pt>
                <c:pt idx="15">
                  <c:v>1.4772727272727271</c:v>
                </c:pt>
                <c:pt idx="16">
                  <c:v>1.875</c:v>
                </c:pt>
                <c:pt idx="17">
                  <c:v>1.4772727272727271</c:v>
                </c:pt>
                <c:pt idx="18">
                  <c:v>1.3068181818181821</c:v>
                </c:pt>
                <c:pt idx="19">
                  <c:v>1.3636363636363631</c:v>
                </c:pt>
                <c:pt idx="20">
                  <c:v>0.96590909090909716</c:v>
                </c:pt>
                <c:pt idx="21">
                  <c:v>1.136363636363636</c:v>
                </c:pt>
                <c:pt idx="22">
                  <c:v>1.051136363636364</c:v>
                </c:pt>
                <c:pt idx="23">
                  <c:v>1.590909090909080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5-1784-405B-8F91-AE3CBDDEDCBB}"/>
            </c:ext>
          </c:extLst>
        </c:ser>
        <c:ser>
          <c:idx val="22"/>
          <c:order val="22"/>
          <c:tx>
            <c:strRef>
              <c:f>'3nt'!$A$473</c:f>
              <c:strCache>
                <c:ptCount val="1"/>
                <c:pt idx="0">
                  <c:v>CUU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73:$Y$473</c:f>
              <c:numCache>
                <c:formatCode>General</c:formatCode>
                <c:ptCount val="24"/>
                <c:pt idx="0">
                  <c:v>2.1306818181818201</c:v>
                </c:pt>
                <c:pt idx="1">
                  <c:v>1.3920454545454561</c:v>
                </c:pt>
                <c:pt idx="2">
                  <c:v>1.7329545454545459</c:v>
                </c:pt>
                <c:pt idx="3">
                  <c:v>1.8465909090909101</c:v>
                </c:pt>
                <c:pt idx="4">
                  <c:v>1.8181818181818181</c:v>
                </c:pt>
                <c:pt idx="5">
                  <c:v>2.0170454545454537</c:v>
                </c:pt>
                <c:pt idx="6">
                  <c:v>2.045454545454545</c:v>
                </c:pt>
                <c:pt idx="7">
                  <c:v>1.6761363636363742</c:v>
                </c:pt>
                <c:pt idx="8">
                  <c:v>1.6761363636363742</c:v>
                </c:pt>
                <c:pt idx="9">
                  <c:v>1.704545454545455</c:v>
                </c:pt>
                <c:pt idx="10">
                  <c:v>1.704545454545455</c:v>
                </c:pt>
                <c:pt idx="11">
                  <c:v>1.7329545454545459</c:v>
                </c:pt>
                <c:pt idx="12">
                  <c:v>2.045454545454545</c:v>
                </c:pt>
                <c:pt idx="13">
                  <c:v>1.5625</c:v>
                </c:pt>
                <c:pt idx="14">
                  <c:v>1.6761363636363742</c:v>
                </c:pt>
                <c:pt idx="15">
                  <c:v>1.5909090909090808</c:v>
                </c:pt>
                <c:pt idx="16">
                  <c:v>1.6193181818181821</c:v>
                </c:pt>
                <c:pt idx="17">
                  <c:v>1.5909090909090808</c:v>
                </c:pt>
                <c:pt idx="18">
                  <c:v>1.0227272727272718</c:v>
                </c:pt>
                <c:pt idx="19">
                  <c:v>1.0795454545454539</c:v>
                </c:pt>
                <c:pt idx="20">
                  <c:v>1.3068181818181821</c:v>
                </c:pt>
                <c:pt idx="21">
                  <c:v>1.0227272727272718</c:v>
                </c:pt>
                <c:pt idx="22">
                  <c:v>1.6193181818181821</c:v>
                </c:pt>
                <c:pt idx="23">
                  <c:v>1.53409090909091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6-1784-405B-8F91-AE3CBDDEDCBB}"/>
            </c:ext>
          </c:extLst>
        </c:ser>
        <c:ser>
          <c:idx val="23"/>
          <c:order val="23"/>
          <c:tx>
            <c:strRef>
              <c:f>'3nt'!$A$474</c:f>
              <c:strCache>
                <c:ptCount val="1"/>
                <c:pt idx="0">
                  <c:v>UUG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74:$Y$474</c:f>
              <c:numCache>
                <c:formatCode>General</c:formatCode>
                <c:ptCount val="24"/>
                <c:pt idx="0">
                  <c:v>1.960227272727272</c:v>
                </c:pt>
                <c:pt idx="1">
                  <c:v>2.045454545454545</c:v>
                </c:pt>
                <c:pt idx="2">
                  <c:v>1.8181818181818181</c:v>
                </c:pt>
                <c:pt idx="3">
                  <c:v>1.7329545454545459</c:v>
                </c:pt>
                <c:pt idx="4">
                  <c:v>1.9318181818181821</c:v>
                </c:pt>
                <c:pt idx="5">
                  <c:v>1.6477272727272718</c:v>
                </c:pt>
                <c:pt idx="6">
                  <c:v>1.704545454545455</c:v>
                </c:pt>
                <c:pt idx="7">
                  <c:v>2.1022727272727271</c:v>
                </c:pt>
                <c:pt idx="8">
                  <c:v>1.3920454545454561</c:v>
                </c:pt>
                <c:pt idx="9">
                  <c:v>1.6477272727272718</c:v>
                </c:pt>
                <c:pt idx="10">
                  <c:v>1.7329545454545459</c:v>
                </c:pt>
                <c:pt idx="11">
                  <c:v>1.3920454545454561</c:v>
                </c:pt>
                <c:pt idx="12">
                  <c:v>1.25</c:v>
                </c:pt>
                <c:pt idx="13">
                  <c:v>1.3068181818181821</c:v>
                </c:pt>
                <c:pt idx="14">
                  <c:v>1.3636363636363631</c:v>
                </c:pt>
                <c:pt idx="15">
                  <c:v>1.5625</c:v>
                </c:pt>
                <c:pt idx="16">
                  <c:v>1.051136363636364</c:v>
                </c:pt>
                <c:pt idx="17">
                  <c:v>1.0795454545454539</c:v>
                </c:pt>
                <c:pt idx="18">
                  <c:v>1.136363636363636</c:v>
                </c:pt>
                <c:pt idx="19">
                  <c:v>0.9375</c:v>
                </c:pt>
                <c:pt idx="20">
                  <c:v>1.0795454545454539</c:v>
                </c:pt>
                <c:pt idx="21">
                  <c:v>1.0227272727272718</c:v>
                </c:pt>
                <c:pt idx="22">
                  <c:v>1.8465909090909101</c:v>
                </c:pt>
                <c:pt idx="23">
                  <c:v>2.159090909090908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7-1784-405B-8F91-AE3CBDDEDCBB}"/>
            </c:ext>
          </c:extLst>
        </c:ser>
        <c:ser>
          <c:idx val="24"/>
          <c:order val="24"/>
          <c:tx>
            <c:strRef>
              <c:f>'3nt'!$A$475</c:f>
              <c:strCache>
                <c:ptCount val="1"/>
                <c:pt idx="0">
                  <c:v>GUU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75:$Y$475</c:f>
              <c:numCache>
                <c:formatCode>General</c:formatCode>
                <c:ptCount val="24"/>
                <c:pt idx="0">
                  <c:v>2.0738636363636327</c:v>
                </c:pt>
                <c:pt idx="1">
                  <c:v>1.5909090909090808</c:v>
                </c:pt>
                <c:pt idx="2">
                  <c:v>1.7329545454545459</c:v>
                </c:pt>
                <c:pt idx="3">
                  <c:v>1.5625</c:v>
                </c:pt>
                <c:pt idx="4">
                  <c:v>1.4772727272727271</c:v>
                </c:pt>
                <c:pt idx="5">
                  <c:v>1.9034090909090808</c:v>
                </c:pt>
                <c:pt idx="6">
                  <c:v>1.5340909090909101</c:v>
                </c:pt>
                <c:pt idx="7">
                  <c:v>1.5056818181818179</c:v>
                </c:pt>
                <c:pt idx="8">
                  <c:v>1.9886363636363742</c:v>
                </c:pt>
                <c:pt idx="9">
                  <c:v>1.5056818181818179</c:v>
                </c:pt>
                <c:pt idx="10">
                  <c:v>1.1931818181818181</c:v>
                </c:pt>
                <c:pt idx="11">
                  <c:v>1.6477272727272718</c:v>
                </c:pt>
                <c:pt idx="12">
                  <c:v>1.25</c:v>
                </c:pt>
                <c:pt idx="13">
                  <c:v>1.4772727272727271</c:v>
                </c:pt>
                <c:pt idx="14">
                  <c:v>1.5056818181818179</c:v>
                </c:pt>
                <c:pt idx="15">
                  <c:v>1.25</c:v>
                </c:pt>
                <c:pt idx="16">
                  <c:v>1.704545454545455</c:v>
                </c:pt>
                <c:pt idx="17">
                  <c:v>1.3068181818181821</c:v>
                </c:pt>
                <c:pt idx="18">
                  <c:v>1.0227272727272718</c:v>
                </c:pt>
                <c:pt idx="19">
                  <c:v>1.107954545454545</c:v>
                </c:pt>
                <c:pt idx="20">
                  <c:v>1.3920454545454561</c:v>
                </c:pt>
                <c:pt idx="21">
                  <c:v>1.3068181818181821</c:v>
                </c:pt>
                <c:pt idx="22">
                  <c:v>1.8181818181818181</c:v>
                </c:pt>
                <c:pt idx="23">
                  <c:v>1.761363636363635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8-1784-405B-8F91-AE3CBDDEDCBB}"/>
            </c:ext>
          </c:extLst>
        </c:ser>
        <c:ser>
          <c:idx val="25"/>
          <c:order val="25"/>
          <c:tx>
            <c:strRef>
              <c:f>'3nt'!$A$476</c:f>
              <c:strCache>
                <c:ptCount val="1"/>
                <c:pt idx="0">
                  <c:v>UCU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76:$Y$476</c:f>
              <c:numCache>
                <c:formatCode>General</c:formatCode>
                <c:ptCount val="24"/>
                <c:pt idx="0">
                  <c:v>1.5340909090909101</c:v>
                </c:pt>
                <c:pt idx="1">
                  <c:v>1.5340909090909101</c:v>
                </c:pt>
                <c:pt idx="2">
                  <c:v>1.8181818181818181</c:v>
                </c:pt>
                <c:pt idx="3">
                  <c:v>1.5340909090909101</c:v>
                </c:pt>
                <c:pt idx="4">
                  <c:v>2.0170454545454537</c:v>
                </c:pt>
                <c:pt idx="5">
                  <c:v>1.3920454545454561</c:v>
                </c:pt>
                <c:pt idx="6">
                  <c:v>1.6477272727272718</c:v>
                </c:pt>
                <c:pt idx="7">
                  <c:v>1.2784090909090808</c:v>
                </c:pt>
                <c:pt idx="8">
                  <c:v>1.9318181818181821</c:v>
                </c:pt>
                <c:pt idx="9">
                  <c:v>1.3636363636363631</c:v>
                </c:pt>
                <c:pt idx="10">
                  <c:v>1.704545454545455</c:v>
                </c:pt>
                <c:pt idx="11">
                  <c:v>1.5625</c:v>
                </c:pt>
                <c:pt idx="12">
                  <c:v>1.5625</c:v>
                </c:pt>
                <c:pt idx="13">
                  <c:v>1.6193181818181821</c:v>
                </c:pt>
                <c:pt idx="14">
                  <c:v>1.9318181818181821</c:v>
                </c:pt>
                <c:pt idx="15">
                  <c:v>1.6761363636363742</c:v>
                </c:pt>
                <c:pt idx="16">
                  <c:v>2.0170454545454537</c:v>
                </c:pt>
                <c:pt idx="17">
                  <c:v>1.3636363636363631</c:v>
                </c:pt>
                <c:pt idx="18">
                  <c:v>1.2215909090909078</c:v>
                </c:pt>
                <c:pt idx="19">
                  <c:v>1.3920454545454561</c:v>
                </c:pt>
                <c:pt idx="20">
                  <c:v>0.51136363636363602</c:v>
                </c:pt>
                <c:pt idx="21">
                  <c:v>1.0227272727272718</c:v>
                </c:pt>
                <c:pt idx="22">
                  <c:v>1.107954545454545</c:v>
                </c:pt>
                <c:pt idx="23">
                  <c:v>1.42045454545454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9-1784-405B-8F91-AE3CBDDEDCBB}"/>
            </c:ext>
          </c:extLst>
        </c:ser>
        <c:ser>
          <c:idx val="26"/>
          <c:order val="26"/>
          <c:tx>
            <c:strRef>
              <c:f>'3nt'!$A$477</c:f>
              <c:strCache>
                <c:ptCount val="1"/>
                <c:pt idx="0">
                  <c:v>AUG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77:$Y$477</c:f>
              <c:numCache>
                <c:formatCode>General</c:formatCode>
                <c:ptCount val="24"/>
                <c:pt idx="0">
                  <c:v>1.7613636363636358</c:v>
                </c:pt>
                <c:pt idx="1">
                  <c:v>1.3068181818181821</c:v>
                </c:pt>
                <c:pt idx="2">
                  <c:v>1.3352272727272718</c:v>
                </c:pt>
                <c:pt idx="3">
                  <c:v>1.25</c:v>
                </c:pt>
                <c:pt idx="4">
                  <c:v>1.5625</c:v>
                </c:pt>
                <c:pt idx="5">
                  <c:v>1.5056818181818179</c:v>
                </c:pt>
                <c:pt idx="6">
                  <c:v>1.3636363636363631</c:v>
                </c:pt>
                <c:pt idx="7">
                  <c:v>1.8181818181818181</c:v>
                </c:pt>
                <c:pt idx="8">
                  <c:v>1.5909090909090808</c:v>
                </c:pt>
                <c:pt idx="9">
                  <c:v>1.3636363636363631</c:v>
                </c:pt>
                <c:pt idx="10">
                  <c:v>1.4772727272727271</c:v>
                </c:pt>
                <c:pt idx="11">
                  <c:v>1.6477272727272718</c:v>
                </c:pt>
                <c:pt idx="12">
                  <c:v>1.9318181818181821</c:v>
                </c:pt>
                <c:pt idx="13">
                  <c:v>1.6761363636363742</c:v>
                </c:pt>
                <c:pt idx="14">
                  <c:v>1.3352272727272718</c:v>
                </c:pt>
                <c:pt idx="15">
                  <c:v>1.4772727272727271</c:v>
                </c:pt>
                <c:pt idx="16">
                  <c:v>1.1931818181818181</c:v>
                </c:pt>
                <c:pt idx="17">
                  <c:v>1.420454545454545</c:v>
                </c:pt>
                <c:pt idx="18">
                  <c:v>1.0227272727272718</c:v>
                </c:pt>
                <c:pt idx="19">
                  <c:v>1.3068181818181821</c:v>
                </c:pt>
                <c:pt idx="20">
                  <c:v>1.3920454545454561</c:v>
                </c:pt>
                <c:pt idx="21">
                  <c:v>1.7897727272727271</c:v>
                </c:pt>
                <c:pt idx="22">
                  <c:v>1.7897727272727271</c:v>
                </c:pt>
                <c:pt idx="23">
                  <c:v>1.619318181818182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A-1784-405B-8F91-AE3CBDDEDCBB}"/>
            </c:ext>
          </c:extLst>
        </c:ser>
        <c:ser>
          <c:idx val="27"/>
          <c:order val="27"/>
          <c:tx>
            <c:strRef>
              <c:f>'3nt'!$A$478</c:f>
              <c:strCache>
                <c:ptCount val="1"/>
                <c:pt idx="0">
                  <c:v>AGC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78:$Y$478</c:f>
              <c:numCache>
                <c:formatCode>General</c:formatCode>
                <c:ptCount val="24"/>
                <c:pt idx="0">
                  <c:v>1.6761363636363742</c:v>
                </c:pt>
                <c:pt idx="1">
                  <c:v>1.7897727272727271</c:v>
                </c:pt>
                <c:pt idx="2">
                  <c:v>1.25</c:v>
                </c:pt>
                <c:pt idx="3">
                  <c:v>1.5340909090909101</c:v>
                </c:pt>
                <c:pt idx="4">
                  <c:v>1.5340909090909101</c:v>
                </c:pt>
                <c:pt idx="5">
                  <c:v>1.5625</c:v>
                </c:pt>
                <c:pt idx="6">
                  <c:v>1.3920454545454561</c:v>
                </c:pt>
                <c:pt idx="7">
                  <c:v>1.0795454545454539</c:v>
                </c:pt>
                <c:pt idx="8">
                  <c:v>1.3636363636363631</c:v>
                </c:pt>
                <c:pt idx="9">
                  <c:v>1.2784090909090808</c:v>
                </c:pt>
                <c:pt idx="10">
                  <c:v>1.4488636363636358</c:v>
                </c:pt>
                <c:pt idx="11">
                  <c:v>1.3352272727272718</c:v>
                </c:pt>
                <c:pt idx="12">
                  <c:v>0.9375</c:v>
                </c:pt>
                <c:pt idx="13">
                  <c:v>1.2215909090909078</c:v>
                </c:pt>
                <c:pt idx="14">
                  <c:v>1.0227272727272718</c:v>
                </c:pt>
                <c:pt idx="15">
                  <c:v>1.1931818181818181</c:v>
                </c:pt>
                <c:pt idx="16">
                  <c:v>1.1931818181818181</c:v>
                </c:pt>
                <c:pt idx="17">
                  <c:v>1.5056818181818179</c:v>
                </c:pt>
                <c:pt idx="18">
                  <c:v>1.5909090909090808</c:v>
                </c:pt>
                <c:pt idx="19">
                  <c:v>1.9034090909090808</c:v>
                </c:pt>
                <c:pt idx="20">
                  <c:v>2.1306818181818201</c:v>
                </c:pt>
                <c:pt idx="21">
                  <c:v>2.2727272727273009</c:v>
                </c:pt>
                <c:pt idx="22">
                  <c:v>2.0170454545454537</c:v>
                </c:pt>
                <c:pt idx="23">
                  <c:v>1.619318181818182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B-1784-405B-8F91-AE3CBDDEDCBB}"/>
            </c:ext>
          </c:extLst>
        </c:ser>
        <c:ser>
          <c:idx val="28"/>
          <c:order val="28"/>
          <c:tx>
            <c:strRef>
              <c:f>'3nt'!$A$479</c:f>
              <c:strCache>
                <c:ptCount val="1"/>
                <c:pt idx="0">
                  <c:v>UUC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79:$Y$479</c:f>
              <c:numCache>
                <c:formatCode>General</c:formatCode>
                <c:ptCount val="24"/>
                <c:pt idx="0">
                  <c:v>1.875</c:v>
                </c:pt>
                <c:pt idx="1">
                  <c:v>1.9318181818181821</c:v>
                </c:pt>
                <c:pt idx="2">
                  <c:v>1.7329545454545459</c:v>
                </c:pt>
                <c:pt idx="3">
                  <c:v>1.875</c:v>
                </c:pt>
                <c:pt idx="4">
                  <c:v>1.3920454545454561</c:v>
                </c:pt>
                <c:pt idx="5">
                  <c:v>1.8465909090909101</c:v>
                </c:pt>
                <c:pt idx="6">
                  <c:v>1.3920454545454561</c:v>
                </c:pt>
                <c:pt idx="7">
                  <c:v>2.045454545454545</c:v>
                </c:pt>
                <c:pt idx="8">
                  <c:v>1.3920454545454561</c:v>
                </c:pt>
                <c:pt idx="9">
                  <c:v>1.5056818181818179</c:v>
                </c:pt>
                <c:pt idx="10">
                  <c:v>1.25</c:v>
                </c:pt>
                <c:pt idx="11">
                  <c:v>1.420454545454545</c:v>
                </c:pt>
                <c:pt idx="12">
                  <c:v>1.4488636363636358</c:v>
                </c:pt>
                <c:pt idx="13">
                  <c:v>1.5625</c:v>
                </c:pt>
                <c:pt idx="14">
                  <c:v>1.5340909090909101</c:v>
                </c:pt>
                <c:pt idx="15">
                  <c:v>1.4772727272727271</c:v>
                </c:pt>
                <c:pt idx="16">
                  <c:v>0.85227272727272696</c:v>
                </c:pt>
                <c:pt idx="17">
                  <c:v>0.99431818181817688</c:v>
                </c:pt>
                <c:pt idx="18">
                  <c:v>0.90909090909090895</c:v>
                </c:pt>
                <c:pt idx="19">
                  <c:v>0.65340909090909716</c:v>
                </c:pt>
                <c:pt idx="20">
                  <c:v>0.9375</c:v>
                </c:pt>
                <c:pt idx="21">
                  <c:v>1.4488636363636358</c:v>
                </c:pt>
                <c:pt idx="22">
                  <c:v>1.1931818181818181</c:v>
                </c:pt>
                <c:pt idx="23">
                  <c:v>1.96022727272727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C-1784-405B-8F91-AE3CBDDEDCBB}"/>
            </c:ext>
          </c:extLst>
        </c:ser>
        <c:ser>
          <c:idx val="29"/>
          <c:order val="29"/>
          <c:tx>
            <c:strRef>
              <c:f>'3nt'!$A$480</c:f>
              <c:strCache>
                <c:ptCount val="1"/>
                <c:pt idx="0">
                  <c:v>GAU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80:$Y$480</c:f>
              <c:numCache>
                <c:formatCode>General</c:formatCode>
                <c:ptCount val="24"/>
                <c:pt idx="0">
                  <c:v>1.8465909090909101</c:v>
                </c:pt>
                <c:pt idx="1">
                  <c:v>1.4772727272727271</c:v>
                </c:pt>
                <c:pt idx="2">
                  <c:v>1.420454545454545</c:v>
                </c:pt>
                <c:pt idx="3">
                  <c:v>1.3068181818181821</c:v>
                </c:pt>
                <c:pt idx="4">
                  <c:v>1.704545454545455</c:v>
                </c:pt>
                <c:pt idx="5">
                  <c:v>1.5056818181818179</c:v>
                </c:pt>
                <c:pt idx="6">
                  <c:v>1.3636363636363631</c:v>
                </c:pt>
                <c:pt idx="7">
                  <c:v>1.25</c:v>
                </c:pt>
                <c:pt idx="8">
                  <c:v>1.1647727272727373</c:v>
                </c:pt>
                <c:pt idx="9">
                  <c:v>1.6477272727272718</c:v>
                </c:pt>
                <c:pt idx="10">
                  <c:v>1.5909090909090808</c:v>
                </c:pt>
                <c:pt idx="11">
                  <c:v>1.704545454545455</c:v>
                </c:pt>
                <c:pt idx="12">
                  <c:v>1.3352272727272718</c:v>
                </c:pt>
                <c:pt idx="13">
                  <c:v>1.3636363636363631</c:v>
                </c:pt>
                <c:pt idx="14">
                  <c:v>1.420454545454545</c:v>
                </c:pt>
                <c:pt idx="15">
                  <c:v>1.3352272727272718</c:v>
                </c:pt>
                <c:pt idx="16">
                  <c:v>1.3352272727272718</c:v>
                </c:pt>
                <c:pt idx="17">
                  <c:v>1.3636363636363631</c:v>
                </c:pt>
                <c:pt idx="18">
                  <c:v>1.1931818181818181</c:v>
                </c:pt>
                <c:pt idx="19">
                  <c:v>0.9375</c:v>
                </c:pt>
                <c:pt idx="20">
                  <c:v>0.99431818181817688</c:v>
                </c:pt>
                <c:pt idx="21">
                  <c:v>1.5340909090909101</c:v>
                </c:pt>
                <c:pt idx="22">
                  <c:v>1.5340909090909101</c:v>
                </c:pt>
                <c:pt idx="23">
                  <c:v>1.590909090909080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D-1784-405B-8F91-AE3CBDDEDCBB}"/>
            </c:ext>
          </c:extLst>
        </c:ser>
        <c:ser>
          <c:idx val="30"/>
          <c:order val="30"/>
          <c:tx>
            <c:strRef>
              <c:f>'3nt'!$A$481</c:f>
              <c:strCache>
                <c:ptCount val="1"/>
                <c:pt idx="0">
                  <c:v>UCA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81:$Y$481</c:f>
              <c:numCache>
                <c:formatCode>General</c:formatCode>
                <c:ptCount val="24"/>
                <c:pt idx="0">
                  <c:v>1.7613636363636358</c:v>
                </c:pt>
                <c:pt idx="1">
                  <c:v>1.5056818181818179</c:v>
                </c:pt>
                <c:pt idx="2">
                  <c:v>1.6193181818181821</c:v>
                </c:pt>
                <c:pt idx="3">
                  <c:v>1.5340909090909101</c:v>
                </c:pt>
                <c:pt idx="4">
                  <c:v>1.5056818181818179</c:v>
                </c:pt>
                <c:pt idx="5">
                  <c:v>1.5340909090909101</c:v>
                </c:pt>
                <c:pt idx="6">
                  <c:v>1.5340909090909101</c:v>
                </c:pt>
                <c:pt idx="7">
                  <c:v>1.5340909090909101</c:v>
                </c:pt>
                <c:pt idx="8">
                  <c:v>1.8181818181818181</c:v>
                </c:pt>
                <c:pt idx="9">
                  <c:v>1.420454545454545</c:v>
                </c:pt>
                <c:pt idx="10">
                  <c:v>1.5056818181818179</c:v>
                </c:pt>
                <c:pt idx="11">
                  <c:v>1.3352272727272718</c:v>
                </c:pt>
                <c:pt idx="12">
                  <c:v>1.2215909090909078</c:v>
                </c:pt>
                <c:pt idx="13">
                  <c:v>1.4772727272727271</c:v>
                </c:pt>
                <c:pt idx="14">
                  <c:v>1.3920454545454561</c:v>
                </c:pt>
                <c:pt idx="15">
                  <c:v>1.136363636363636</c:v>
                </c:pt>
                <c:pt idx="16">
                  <c:v>1.107954545454545</c:v>
                </c:pt>
                <c:pt idx="17">
                  <c:v>0.88068181818182412</c:v>
                </c:pt>
                <c:pt idx="18">
                  <c:v>0.99431818181817688</c:v>
                </c:pt>
                <c:pt idx="19">
                  <c:v>1.0795454545454539</c:v>
                </c:pt>
                <c:pt idx="20">
                  <c:v>1.0795454545454539</c:v>
                </c:pt>
                <c:pt idx="21">
                  <c:v>1.107954545454545</c:v>
                </c:pt>
                <c:pt idx="22">
                  <c:v>1.4772727272727271</c:v>
                </c:pt>
                <c:pt idx="23">
                  <c:v>1.789772727272727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E-1784-405B-8F91-AE3CBDDEDCBB}"/>
            </c:ext>
          </c:extLst>
        </c:ser>
        <c:ser>
          <c:idx val="31"/>
          <c:order val="31"/>
          <c:tx>
            <c:strRef>
              <c:f>'3nt'!$A$482</c:f>
              <c:strCache>
                <c:ptCount val="1"/>
                <c:pt idx="0">
                  <c:v>AUC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82:$Y$482</c:f>
              <c:numCache>
                <c:formatCode>General</c:formatCode>
                <c:ptCount val="24"/>
                <c:pt idx="0">
                  <c:v>1.5056818181818179</c:v>
                </c:pt>
                <c:pt idx="1">
                  <c:v>1.5340909090909101</c:v>
                </c:pt>
                <c:pt idx="2">
                  <c:v>1.420454545454545</c:v>
                </c:pt>
                <c:pt idx="3">
                  <c:v>1.2784090909090808</c:v>
                </c:pt>
                <c:pt idx="4">
                  <c:v>1.3920454545454561</c:v>
                </c:pt>
                <c:pt idx="5">
                  <c:v>1.25</c:v>
                </c:pt>
                <c:pt idx="6">
                  <c:v>1.5909090909090808</c:v>
                </c:pt>
                <c:pt idx="7">
                  <c:v>1.5625</c:v>
                </c:pt>
                <c:pt idx="8">
                  <c:v>1.25</c:v>
                </c:pt>
                <c:pt idx="9">
                  <c:v>1.420454545454545</c:v>
                </c:pt>
                <c:pt idx="10">
                  <c:v>1.6477272727272718</c:v>
                </c:pt>
                <c:pt idx="11">
                  <c:v>1.25</c:v>
                </c:pt>
                <c:pt idx="12">
                  <c:v>1.1647727272727373</c:v>
                </c:pt>
                <c:pt idx="13">
                  <c:v>1.6193181818181821</c:v>
                </c:pt>
                <c:pt idx="14">
                  <c:v>1.3352272727272718</c:v>
                </c:pt>
                <c:pt idx="15">
                  <c:v>1.1931818181818181</c:v>
                </c:pt>
                <c:pt idx="16">
                  <c:v>0.73863636363636298</c:v>
                </c:pt>
                <c:pt idx="17">
                  <c:v>1.107954545454545</c:v>
                </c:pt>
                <c:pt idx="18">
                  <c:v>1.1931818181818181</c:v>
                </c:pt>
                <c:pt idx="19">
                  <c:v>0.65340909090909716</c:v>
                </c:pt>
                <c:pt idx="20">
                  <c:v>1.0227272727272718</c:v>
                </c:pt>
                <c:pt idx="21">
                  <c:v>1.25</c:v>
                </c:pt>
                <c:pt idx="22">
                  <c:v>1.9034090909090808</c:v>
                </c:pt>
                <c:pt idx="23">
                  <c:v>2.13068181818182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F-1784-405B-8F91-AE3CBDDEDCBB}"/>
            </c:ext>
          </c:extLst>
        </c:ser>
        <c:ser>
          <c:idx val="32"/>
          <c:order val="32"/>
          <c:tx>
            <c:strRef>
              <c:f>'3nt'!$A$483</c:f>
              <c:strCache>
                <c:ptCount val="1"/>
                <c:pt idx="0">
                  <c:v>UGA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83:$Y$483</c:f>
              <c:numCache>
                <c:formatCode>General</c:formatCode>
                <c:ptCount val="24"/>
                <c:pt idx="0">
                  <c:v>1.5625</c:v>
                </c:pt>
                <c:pt idx="1">
                  <c:v>1.3920454545454561</c:v>
                </c:pt>
                <c:pt idx="2">
                  <c:v>1.4488636363636358</c:v>
                </c:pt>
                <c:pt idx="3">
                  <c:v>1.2215909090909078</c:v>
                </c:pt>
                <c:pt idx="4">
                  <c:v>1.3636363636363631</c:v>
                </c:pt>
                <c:pt idx="5">
                  <c:v>1.1931818181818181</c:v>
                </c:pt>
                <c:pt idx="6">
                  <c:v>1.2784090909090808</c:v>
                </c:pt>
                <c:pt idx="7">
                  <c:v>1.136363636363636</c:v>
                </c:pt>
                <c:pt idx="8">
                  <c:v>1.5909090909090808</c:v>
                </c:pt>
                <c:pt idx="9">
                  <c:v>1.3636363636363631</c:v>
                </c:pt>
                <c:pt idx="10">
                  <c:v>1.3352272727272718</c:v>
                </c:pt>
                <c:pt idx="11">
                  <c:v>1.704545454545455</c:v>
                </c:pt>
                <c:pt idx="12">
                  <c:v>1.1931818181818181</c:v>
                </c:pt>
                <c:pt idx="13">
                  <c:v>1.5625</c:v>
                </c:pt>
                <c:pt idx="14">
                  <c:v>1.107954545454545</c:v>
                </c:pt>
                <c:pt idx="15">
                  <c:v>1.2215909090909078</c:v>
                </c:pt>
                <c:pt idx="16">
                  <c:v>1.1647727272727373</c:v>
                </c:pt>
                <c:pt idx="17">
                  <c:v>0.99431818181817688</c:v>
                </c:pt>
                <c:pt idx="18">
                  <c:v>1.0795454545454539</c:v>
                </c:pt>
                <c:pt idx="19">
                  <c:v>1.3068181818181821</c:v>
                </c:pt>
                <c:pt idx="20">
                  <c:v>1.0227272727272718</c:v>
                </c:pt>
                <c:pt idx="21">
                  <c:v>1.136363636363636</c:v>
                </c:pt>
                <c:pt idx="22">
                  <c:v>1.1931818181818181</c:v>
                </c:pt>
                <c:pt idx="23">
                  <c:v>1.590909090909080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0-1784-405B-8F91-AE3CBDDEDCBB}"/>
            </c:ext>
          </c:extLst>
        </c:ser>
        <c:ser>
          <c:idx val="33"/>
          <c:order val="33"/>
          <c:tx>
            <c:strRef>
              <c:f>'3nt'!$A$484</c:f>
              <c:strCache>
                <c:ptCount val="1"/>
                <c:pt idx="0">
                  <c:v>GCU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84:$Y$484</c:f>
              <c:numCache>
                <c:formatCode>General</c:formatCode>
                <c:ptCount val="24"/>
                <c:pt idx="0">
                  <c:v>1.5909090909090808</c:v>
                </c:pt>
                <c:pt idx="1">
                  <c:v>1.1647727272727373</c:v>
                </c:pt>
                <c:pt idx="2">
                  <c:v>1.704545454545455</c:v>
                </c:pt>
                <c:pt idx="3">
                  <c:v>1.3068181818181821</c:v>
                </c:pt>
                <c:pt idx="4">
                  <c:v>1.3920454545454561</c:v>
                </c:pt>
                <c:pt idx="5">
                  <c:v>1.5909090909090808</c:v>
                </c:pt>
                <c:pt idx="6">
                  <c:v>1.1647727272727373</c:v>
                </c:pt>
                <c:pt idx="7">
                  <c:v>1.107954545454545</c:v>
                </c:pt>
                <c:pt idx="8">
                  <c:v>1.0227272727272718</c:v>
                </c:pt>
                <c:pt idx="9">
                  <c:v>1.3068181818181821</c:v>
                </c:pt>
                <c:pt idx="10">
                  <c:v>1.107954545454545</c:v>
                </c:pt>
                <c:pt idx="11">
                  <c:v>1.5340909090909101</c:v>
                </c:pt>
                <c:pt idx="12">
                  <c:v>1.25</c:v>
                </c:pt>
                <c:pt idx="13">
                  <c:v>0.90909090909090895</c:v>
                </c:pt>
                <c:pt idx="14">
                  <c:v>1.2215909090909078</c:v>
                </c:pt>
                <c:pt idx="15">
                  <c:v>0.71022727272727304</c:v>
                </c:pt>
                <c:pt idx="16">
                  <c:v>0.99431818181817688</c:v>
                </c:pt>
                <c:pt idx="17">
                  <c:v>0.99431818181817688</c:v>
                </c:pt>
                <c:pt idx="18">
                  <c:v>1.0227272727272718</c:v>
                </c:pt>
                <c:pt idx="19">
                  <c:v>1.0795454545454539</c:v>
                </c:pt>
                <c:pt idx="20">
                  <c:v>0.82386363636364213</c:v>
                </c:pt>
                <c:pt idx="21">
                  <c:v>1.3920454545454561</c:v>
                </c:pt>
                <c:pt idx="22">
                  <c:v>1.1647727272727373</c:v>
                </c:pt>
                <c:pt idx="23">
                  <c:v>1.590909090909080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1-1784-405B-8F91-AE3CBDDEDCBB}"/>
            </c:ext>
          </c:extLst>
        </c:ser>
        <c:ser>
          <c:idx val="34"/>
          <c:order val="34"/>
          <c:tx>
            <c:strRef>
              <c:f>'3nt'!$A$485</c:f>
              <c:strCache>
                <c:ptCount val="1"/>
                <c:pt idx="0">
                  <c:v>GCA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85:$Y$485</c:f>
              <c:numCache>
                <c:formatCode>General</c:formatCode>
                <c:ptCount val="24"/>
                <c:pt idx="0">
                  <c:v>1.420454545454545</c:v>
                </c:pt>
                <c:pt idx="1">
                  <c:v>1.3636363636363631</c:v>
                </c:pt>
                <c:pt idx="2">
                  <c:v>1.4772727272727271</c:v>
                </c:pt>
                <c:pt idx="3">
                  <c:v>1.3068181818181821</c:v>
                </c:pt>
                <c:pt idx="4">
                  <c:v>1.25</c:v>
                </c:pt>
                <c:pt idx="5">
                  <c:v>1.2784090909090808</c:v>
                </c:pt>
                <c:pt idx="6">
                  <c:v>1.6193181818181821</c:v>
                </c:pt>
                <c:pt idx="7">
                  <c:v>1.3352272727272718</c:v>
                </c:pt>
                <c:pt idx="8">
                  <c:v>1.25</c:v>
                </c:pt>
                <c:pt idx="9">
                  <c:v>1.107954545454545</c:v>
                </c:pt>
                <c:pt idx="10">
                  <c:v>1.136363636363636</c:v>
                </c:pt>
                <c:pt idx="11">
                  <c:v>1.2784090909090808</c:v>
                </c:pt>
                <c:pt idx="12">
                  <c:v>0.73863636363636298</c:v>
                </c:pt>
                <c:pt idx="13">
                  <c:v>0.88068181818182412</c:v>
                </c:pt>
                <c:pt idx="14">
                  <c:v>0.79545454545454497</c:v>
                </c:pt>
                <c:pt idx="15">
                  <c:v>0.9375</c:v>
                </c:pt>
                <c:pt idx="16">
                  <c:v>0.90909090909090895</c:v>
                </c:pt>
                <c:pt idx="17">
                  <c:v>0.45454545454545398</c:v>
                </c:pt>
                <c:pt idx="18">
                  <c:v>0.79545454545454497</c:v>
                </c:pt>
                <c:pt idx="19">
                  <c:v>0.9375</c:v>
                </c:pt>
                <c:pt idx="20">
                  <c:v>1.0795454545454539</c:v>
                </c:pt>
                <c:pt idx="21">
                  <c:v>1.2784090909090808</c:v>
                </c:pt>
                <c:pt idx="22">
                  <c:v>1.8465909090909101</c:v>
                </c:pt>
                <c:pt idx="23">
                  <c:v>1.42045454545454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2-1784-405B-8F91-AE3CBDDEDCBB}"/>
            </c:ext>
          </c:extLst>
        </c:ser>
        <c:ser>
          <c:idx val="35"/>
          <c:order val="35"/>
          <c:tx>
            <c:strRef>
              <c:f>'3nt'!$A$486</c:f>
              <c:strCache>
                <c:ptCount val="1"/>
                <c:pt idx="0">
                  <c:v>ACG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86:$Y$486</c:f>
              <c:numCache>
                <c:formatCode>General</c:formatCode>
                <c:ptCount val="24"/>
                <c:pt idx="0">
                  <c:v>1.2784090909090808</c:v>
                </c:pt>
                <c:pt idx="1">
                  <c:v>1.051136363636364</c:v>
                </c:pt>
                <c:pt idx="2">
                  <c:v>1.2215909090909078</c:v>
                </c:pt>
                <c:pt idx="3">
                  <c:v>1.1931818181818181</c:v>
                </c:pt>
                <c:pt idx="4">
                  <c:v>1.3068181818181821</c:v>
                </c:pt>
                <c:pt idx="5">
                  <c:v>0.90909090909090895</c:v>
                </c:pt>
                <c:pt idx="6">
                  <c:v>1.136363636363636</c:v>
                </c:pt>
                <c:pt idx="7">
                  <c:v>1.2215909090909078</c:v>
                </c:pt>
                <c:pt idx="8">
                  <c:v>1.1931818181818181</c:v>
                </c:pt>
                <c:pt idx="9">
                  <c:v>1.2784090909090808</c:v>
                </c:pt>
                <c:pt idx="10">
                  <c:v>0.9375</c:v>
                </c:pt>
                <c:pt idx="11">
                  <c:v>1.1931818181818181</c:v>
                </c:pt>
                <c:pt idx="12">
                  <c:v>0.99431818181817688</c:v>
                </c:pt>
                <c:pt idx="13">
                  <c:v>0.79545454545454497</c:v>
                </c:pt>
                <c:pt idx="14">
                  <c:v>0.96590909090909716</c:v>
                </c:pt>
                <c:pt idx="15">
                  <c:v>0.82386363636364213</c:v>
                </c:pt>
                <c:pt idx="16">
                  <c:v>0.88068181818182412</c:v>
                </c:pt>
                <c:pt idx="17">
                  <c:v>0.59659090909090284</c:v>
                </c:pt>
                <c:pt idx="18">
                  <c:v>0.88068181818182412</c:v>
                </c:pt>
                <c:pt idx="19">
                  <c:v>0.9375</c:v>
                </c:pt>
                <c:pt idx="20">
                  <c:v>0.9375</c:v>
                </c:pt>
                <c:pt idx="21">
                  <c:v>1.136363636363636</c:v>
                </c:pt>
                <c:pt idx="22">
                  <c:v>1.0795454545454539</c:v>
                </c:pt>
                <c:pt idx="23">
                  <c:v>0.9943181818181768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3-1784-405B-8F91-AE3CBDDEDCBB}"/>
            </c:ext>
          </c:extLst>
        </c:ser>
        <c:ser>
          <c:idx val="36"/>
          <c:order val="36"/>
          <c:tx>
            <c:strRef>
              <c:f>'3nt'!$A$487</c:f>
              <c:strCache>
                <c:ptCount val="1"/>
                <c:pt idx="0">
                  <c:v>CGU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87:$Y$487</c:f>
              <c:numCache>
                <c:formatCode>General</c:formatCode>
                <c:ptCount val="24"/>
                <c:pt idx="0">
                  <c:v>1.3636363636363631</c:v>
                </c:pt>
                <c:pt idx="1">
                  <c:v>0.90909090909090895</c:v>
                </c:pt>
                <c:pt idx="2">
                  <c:v>1.0227272727272718</c:v>
                </c:pt>
                <c:pt idx="3">
                  <c:v>1.2215909090909078</c:v>
                </c:pt>
                <c:pt idx="4">
                  <c:v>0.9375</c:v>
                </c:pt>
                <c:pt idx="5">
                  <c:v>1.2784090909090808</c:v>
                </c:pt>
                <c:pt idx="6">
                  <c:v>1.051136363636364</c:v>
                </c:pt>
                <c:pt idx="7">
                  <c:v>1.1931818181818181</c:v>
                </c:pt>
                <c:pt idx="8">
                  <c:v>1.1931818181818181</c:v>
                </c:pt>
                <c:pt idx="9">
                  <c:v>1.0795454545454539</c:v>
                </c:pt>
                <c:pt idx="10">
                  <c:v>1.051136363636364</c:v>
                </c:pt>
                <c:pt idx="11">
                  <c:v>1.0795454545454539</c:v>
                </c:pt>
                <c:pt idx="12">
                  <c:v>0.85227272727272696</c:v>
                </c:pt>
                <c:pt idx="13">
                  <c:v>0.76704545454546524</c:v>
                </c:pt>
                <c:pt idx="14">
                  <c:v>1.0227272727272718</c:v>
                </c:pt>
                <c:pt idx="15">
                  <c:v>1.0227272727272718</c:v>
                </c:pt>
                <c:pt idx="16">
                  <c:v>1.051136363636364</c:v>
                </c:pt>
                <c:pt idx="17">
                  <c:v>0.79545454545454497</c:v>
                </c:pt>
                <c:pt idx="18">
                  <c:v>0.79545454545454497</c:v>
                </c:pt>
                <c:pt idx="19">
                  <c:v>0.68181818181818199</c:v>
                </c:pt>
                <c:pt idx="20">
                  <c:v>0.62500000000000511</c:v>
                </c:pt>
                <c:pt idx="21">
                  <c:v>0.59659090909090284</c:v>
                </c:pt>
                <c:pt idx="22">
                  <c:v>0.71022727272727304</c:v>
                </c:pt>
                <c:pt idx="23">
                  <c:v>0.738636363636362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4-1784-405B-8F91-AE3CBDDEDCBB}"/>
            </c:ext>
          </c:extLst>
        </c:ser>
        <c:ser>
          <c:idx val="37"/>
          <c:order val="37"/>
          <c:tx>
            <c:strRef>
              <c:f>'3nt'!$A$488</c:f>
              <c:strCache>
                <c:ptCount val="1"/>
                <c:pt idx="0">
                  <c:v>CCA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88:$Y$488</c:f>
              <c:numCache>
                <c:formatCode>General</c:formatCode>
                <c:ptCount val="24"/>
                <c:pt idx="0">
                  <c:v>1.0227272727272718</c:v>
                </c:pt>
                <c:pt idx="1">
                  <c:v>1.1931818181818181</c:v>
                </c:pt>
                <c:pt idx="2">
                  <c:v>1.3068181818181821</c:v>
                </c:pt>
                <c:pt idx="3">
                  <c:v>1.051136363636364</c:v>
                </c:pt>
                <c:pt idx="4">
                  <c:v>1.4772727272727271</c:v>
                </c:pt>
                <c:pt idx="5">
                  <c:v>0.9375</c:v>
                </c:pt>
                <c:pt idx="6">
                  <c:v>1.2784090909090808</c:v>
                </c:pt>
                <c:pt idx="7">
                  <c:v>1.0227272727272718</c:v>
                </c:pt>
                <c:pt idx="8">
                  <c:v>1.1647727272727373</c:v>
                </c:pt>
                <c:pt idx="9">
                  <c:v>0.9375</c:v>
                </c:pt>
                <c:pt idx="10">
                  <c:v>0.99431818181817688</c:v>
                </c:pt>
                <c:pt idx="11">
                  <c:v>1.1931818181818181</c:v>
                </c:pt>
                <c:pt idx="12">
                  <c:v>0.90909090909090895</c:v>
                </c:pt>
                <c:pt idx="13">
                  <c:v>0.65340909090909716</c:v>
                </c:pt>
                <c:pt idx="14">
                  <c:v>0.42613636363636404</c:v>
                </c:pt>
                <c:pt idx="15">
                  <c:v>0.73863636363636298</c:v>
                </c:pt>
                <c:pt idx="16">
                  <c:v>0.71022727272727304</c:v>
                </c:pt>
                <c:pt idx="17">
                  <c:v>0.62500000000000511</c:v>
                </c:pt>
                <c:pt idx="18">
                  <c:v>0.62500000000000511</c:v>
                </c:pt>
                <c:pt idx="19">
                  <c:v>0.56818181818182312</c:v>
                </c:pt>
                <c:pt idx="20">
                  <c:v>0.9375</c:v>
                </c:pt>
                <c:pt idx="21">
                  <c:v>0.85227272727272696</c:v>
                </c:pt>
                <c:pt idx="22">
                  <c:v>0.73863636363636298</c:v>
                </c:pt>
                <c:pt idx="23">
                  <c:v>1.10795454545454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5-1784-405B-8F91-AE3CBDDEDCBB}"/>
            </c:ext>
          </c:extLst>
        </c:ser>
        <c:ser>
          <c:idx val="38"/>
          <c:order val="38"/>
          <c:tx>
            <c:strRef>
              <c:f>'3nt'!$A$489</c:f>
              <c:strCache>
                <c:ptCount val="1"/>
                <c:pt idx="0">
                  <c:v>GAC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89:$Y$489</c:f>
              <c:numCache>
                <c:formatCode>General</c:formatCode>
                <c:ptCount val="24"/>
                <c:pt idx="0">
                  <c:v>1.0795454545454539</c:v>
                </c:pt>
                <c:pt idx="1">
                  <c:v>1.136363636363636</c:v>
                </c:pt>
                <c:pt idx="2">
                  <c:v>1.051136363636364</c:v>
                </c:pt>
                <c:pt idx="3">
                  <c:v>1.420454545454545</c:v>
                </c:pt>
                <c:pt idx="4">
                  <c:v>1.2215909090909078</c:v>
                </c:pt>
                <c:pt idx="5">
                  <c:v>1.136363636363636</c:v>
                </c:pt>
                <c:pt idx="6">
                  <c:v>0.9375</c:v>
                </c:pt>
                <c:pt idx="7">
                  <c:v>1.1647727272727373</c:v>
                </c:pt>
                <c:pt idx="8">
                  <c:v>0.71022727272727304</c:v>
                </c:pt>
                <c:pt idx="9">
                  <c:v>0.71022727272727304</c:v>
                </c:pt>
                <c:pt idx="10">
                  <c:v>0.96590909090909716</c:v>
                </c:pt>
                <c:pt idx="11">
                  <c:v>0.88068181818182412</c:v>
                </c:pt>
                <c:pt idx="12">
                  <c:v>0.65340909090909716</c:v>
                </c:pt>
                <c:pt idx="13">
                  <c:v>0.59659090909090284</c:v>
                </c:pt>
                <c:pt idx="14">
                  <c:v>0.73863636363636298</c:v>
                </c:pt>
                <c:pt idx="15">
                  <c:v>0.62500000000000511</c:v>
                </c:pt>
                <c:pt idx="16">
                  <c:v>0.51136363636363602</c:v>
                </c:pt>
                <c:pt idx="17">
                  <c:v>0.65340909090909716</c:v>
                </c:pt>
                <c:pt idx="18">
                  <c:v>0.65340909090909716</c:v>
                </c:pt>
                <c:pt idx="19">
                  <c:v>0.65340909090909716</c:v>
                </c:pt>
                <c:pt idx="20">
                  <c:v>0.90909090909090895</c:v>
                </c:pt>
                <c:pt idx="21">
                  <c:v>1.136363636363636</c:v>
                </c:pt>
                <c:pt idx="22">
                  <c:v>1.3352272727272718</c:v>
                </c:pt>
                <c:pt idx="23">
                  <c:v>1.363636363636363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6-1784-405B-8F91-AE3CBDDEDCBB}"/>
            </c:ext>
          </c:extLst>
        </c:ser>
        <c:ser>
          <c:idx val="39"/>
          <c:order val="39"/>
          <c:tx>
            <c:strRef>
              <c:f>'3nt'!$A$490</c:f>
              <c:strCache>
                <c:ptCount val="1"/>
                <c:pt idx="0">
                  <c:v>UGC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90:$Y$490</c:f>
              <c:numCache>
                <c:formatCode>General</c:formatCode>
                <c:ptCount val="24"/>
                <c:pt idx="0">
                  <c:v>0.71022727272727304</c:v>
                </c:pt>
                <c:pt idx="1">
                  <c:v>1.1931818181818181</c:v>
                </c:pt>
                <c:pt idx="2">
                  <c:v>1.1931818181818181</c:v>
                </c:pt>
                <c:pt idx="3">
                  <c:v>1.2784090909090808</c:v>
                </c:pt>
                <c:pt idx="4">
                  <c:v>1.25</c:v>
                </c:pt>
                <c:pt idx="5">
                  <c:v>1.0795454545454539</c:v>
                </c:pt>
                <c:pt idx="6">
                  <c:v>1.1647727272727373</c:v>
                </c:pt>
                <c:pt idx="7">
                  <c:v>1.3636363636363631</c:v>
                </c:pt>
                <c:pt idx="8">
                  <c:v>1.2784090909090808</c:v>
                </c:pt>
                <c:pt idx="9">
                  <c:v>0.88068181818182412</c:v>
                </c:pt>
                <c:pt idx="10">
                  <c:v>0.99431818181817688</c:v>
                </c:pt>
                <c:pt idx="11">
                  <c:v>0.82386363636364213</c:v>
                </c:pt>
                <c:pt idx="12">
                  <c:v>0.76704545454546524</c:v>
                </c:pt>
                <c:pt idx="13">
                  <c:v>0.71022727272727304</c:v>
                </c:pt>
                <c:pt idx="14">
                  <c:v>0.71022727272727304</c:v>
                </c:pt>
                <c:pt idx="15">
                  <c:v>0.65340909090909716</c:v>
                </c:pt>
                <c:pt idx="16">
                  <c:v>0.65340909090909716</c:v>
                </c:pt>
                <c:pt idx="17">
                  <c:v>0.28409090909091206</c:v>
                </c:pt>
                <c:pt idx="18">
                  <c:v>0.68181818181818199</c:v>
                </c:pt>
                <c:pt idx="19">
                  <c:v>0.3693181818181861</c:v>
                </c:pt>
                <c:pt idx="20">
                  <c:v>0.76704545454546524</c:v>
                </c:pt>
                <c:pt idx="21">
                  <c:v>0.88068181818182412</c:v>
                </c:pt>
                <c:pt idx="22">
                  <c:v>1.107954545454545</c:v>
                </c:pt>
                <c:pt idx="23">
                  <c:v>1.363636363636363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7-1784-405B-8F91-AE3CBDDEDCBB}"/>
            </c:ext>
          </c:extLst>
        </c:ser>
        <c:ser>
          <c:idx val="40"/>
          <c:order val="40"/>
          <c:tx>
            <c:strRef>
              <c:f>'3nt'!$A$491</c:f>
              <c:strCache>
                <c:ptCount val="1"/>
                <c:pt idx="0">
                  <c:v>CAG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91:$Y$491</c:f>
              <c:numCache>
                <c:formatCode>General</c:formatCode>
                <c:ptCount val="24"/>
                <c:pt idx="0">
                  <c:v>1.3068181818181821</c:v>
                </c:pt>
                <c:pt idx="1">
                  <c:v>1.1931818181818181</c:v>
                </c:pt>
                <c:pt idx="2">
                  <c:v>1.0227272727272718</c:v>
                </c:pt>
                <c:pt idx="3">
                  <c:v>1.25</c:v>
                </c:pt>
                <c:pt idx="4">
                  <c:v>1.3636363636363631</c:v>
                </c:pt>
                <c:pt idx="5">
                  <c:v>0.99431818181817688</c:v>
                </c:pt>
                <c:pt idx="6">
                  <c:v>1.051136363636364</c:v>
                </c:pt>
                <c:pt idx="7">
                  <c:v>1.051136363636364</c:v>
                </c:pt>
                <c:pt idx="8">
                  <c:v>0.85227272727272696</c:v>
                </c:pt>
                <c:pt idx="9">
                  <c:v>0.99431818181817688</c:v>
                </c:pt>
                <c:pt idx="10">
                  <c:v>0.73863636363636298</c:v>
                </c:pt>
                <c:pt idx="11">
                  <c:v>0.85227272727272696</c:v>
                </c:pt>
                <c:pt idx="12">
                  <c:v>1.1931818181818181</c:v>
                </c:pt>
                <c:pt idx="13">
                  <c:v>0.62500000000000511</c:v>
                </c:pt>
                <c:pt idx="14">
                  <c:v>0.68181818181818199</c:v>
                </c:pt>
                <c:pt idx="15">
                  <c:v>0.79545454545454497</c:v>
                </c:pt>
                <c:pt idx="16">
                  <c:v>0.73863636363636298</c:v>
                </c:pt>
                <c:pt idx="17">
                  <c:v>0.76704545454546524</c:v>
                </c:pt>
                <c:pt idx="18">
                  <c:v>0.59659090909090284</c:v>
                </c:pt>
                <c:pt idx="19">
                  <c:v>0.76704545454546524</c:v>
                </c:pt>
                <c:pt idx="20">
                  <c:v>0.68181818181818199</c:v>
                </c:pt>
                <c:pt idx="21">
                  <c:v>0.99431818181817688</c:v>
                </c:pt>
                <c:pt idx="22">
                  <c:v>0.73863636363636298</c:v>
                </c:pt>
                <c:pt idx="23">
                  <c:v>0.9090909090909089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8-1784-405B-8F91-AE3CBDDEDCBB}"/>
            </c:ext>
          </c:extLst>
        </c:ser>
        <c:ser>
          <c:idx val="41"/>
          <c:order val="41"/>
          <c:tx>
            <c:strRef>
              <c:f>'3nt'!$A$492</c:f>
              <c:strCache>
                <c:ptCount val="1"/>
                <c:pt idx="0">
                  <c:v>ACC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92:$Y$492</c:f>
              <c:numCache>
                <c:formatCode>General</c:formatCode>
                <c:ptCount val="24"/>
                <c:pt idx="0">
                  <c:v>1.0227272727272718</c:v>
                </c:pt>
                <c:pt idx="1">
                  <c:v>1.0795454545454539</c:v>
                </c:pt>
                <c:pt idx="2">
                  <c:v>0.90909090909090895</c:v>
                </c:pt>
                <c:pt idx="3">
                  <c:v>1.1647727272727373</c:v>
                </c:pt>
                <c:pt idx="4">
                  <c:v>0.79545454545454497</c:v>
                </c:pt>
                <c:pt idx="5">
                  <c:v>1.0227272727272718</c:v>
                </c:pt>
                <c:pt idx="6">
                  <c:v>1.1647727272727373</c:v>
                </c:pt>
                <c:pt idx="7">
                  <c:v>1.0795454545454539</c:v>
                </c:pt>
                <c:pt idx="8">
                  <c:v>1.0227272727272718</c:v>
                </c:pt>
                <c:pt idx="9">
                  <c:v>0.76704545454546524</c:v>
                </c:pt>
                <c:pt idx="10">
                  <c:v>1.136363636363636</c:v>
                </c:pt>
                <c:pt idx="11">
                  <c:v>0.85227272727272696</c:v>
                </c:pt>
                <c:pt idx="12">
                  <c:v>0.90909090909090895</c:v>
                </c:pt>
                <c:pt idx="13">
                  <c:v>0.71022727272727304</c:v>
                </c:pt>
                <c:pt idx="14">
                  <c:v>1.0227272727272718</c:v>
                </c:pt>
                <c:pt idx="15">
                  <c:v>0.65340909090909716</c:v>
                </c:pt>
                <c:pt idx="16">
                  <c:v>0.68181818181818199</c:v>
                </c:pt>
                <c:pt idx="17">
                  <c:v>0.76704545454546524</c:v>
                </c:pt>
                <c:pt idx="18">
                  <c:v>0.56818181818182312</c:v>
                </c:pt>
                <c:pt idx="19">
                  <c:v>0.79545454545454497</c:v>
                </c:pt>
                <c:pt idx="20">
                  <c:v>0.65340909090909716</c:v>
                </c:pt>
                <c:pt idx="21">
                  <c:v>0.79545454545454497</c:v>
                </c:pt>
                <c:pt idx="22">
                  <c:v>1.3068181818181821</c:v>
                </c:pt>
                <c:pt idx="23">
                  <c:v>1.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9-1784-405B-8F91-AE3CBDDEDCBB}"/>
            </c:ext>
          </c:extLst>
        </c:ser>
        <c:ser>
          <c:idx val="42"/>
          <c:order val="42"/>
          <c:tx>
            <c:strRef>
              <c:f>'3nt'!$A$493</c:f>
              <c:strCache>
                <c:ptCount val="1"/>
                <c:pt idx="0">
                  <c:v>GGA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93:$Y$493</c:f>
              <c:numCache>
                <c:formatCode>General</c:formatCode>
                <c:ptCount val="24"/>
                <c:pt idx="0">
                  <c:v>0.99431818181817688</c:v>
                </c:pt>
                <c:pt idx="1">
                  <c:v>0.99431818181817688</c:v>
                </c:pt>
                <c:pt idx="2">
                  <c:v>1.5056818181818179</c:v>
                </c:pt>
                <c:pt idx="3">
                  <c:v>1.4772727272727271</c:v>
                </c:pt>
                <c:pt idx="4">
                  <c:v>1.0227272727272718</c:v>
                </c:pt>
                <c:pt idx="5">
                  <c:v>1.2784090909090808</c:v>
                </c:pt>
                <c:pt idx="6">
                  <c:v>0.76704545454546524</c:v>
                </c:pt>
                <c:pt idx="7">
                  <c:v>0.90909090909090895</c:v>
                </c:pt>
                <c:pt idx="8">
                  <c:v>0.99431818181817688</c:v>
                </c:pt>
                <c:pt idx="9">
                  <c:v>0.76704545454546524</c:v>
                </c:pt>
                <c:pt idx="10">
                  <c:v>0.82386363636364213</c:v>
                </c:pt>
                <c:pt idx="11">
                  <c:v>0.90909090909090895</c:v>
                </c:pt>
                <c:pt idx="12">
                  <c:v>0.59659090909090284</c:v>
                </c:pt>
                <c:pt idx="13">
                  <c:v>0.53977272727272696</c:v>
                </c:pt>
                <c:pt idx="14">
                  <c:v>0.96590909090909716</c:v>
                </c:pt>
                <c:pt idx="15">
                  <c:v>0.65340909090909716</c:v>
                </c:pt>
                <c:pt idx="16">
                  <c:v>0.56818181818182312</c:v>
                </c:pt>
                <c:pt idx="17">
                  <c:v>0.59659090909090284</c:v>
                </c:pt>
                <c:pt idx="18">
                  <c:v>0.45454545454545398</c:v>
                </c:pt>
                <c:pt idx="19">
                  <c:v>0.62500000000000511</c:v>
                </c:pt>
                <c:pt idx="20">
                  <c:v>1.136363636363636</c:v>
                </c:pt>
                <c:pt idx="21">
                  <c:v>0.9375</c:v>
                </c:pt>
                <c:pt idx="22">
                  <c:v>0.90909090909090895</c:v>
                </c:pt>
                <c:pt idx="23">
                  <c:v>1.278409090909080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A-1784-405B-8F91-AE3CBDDEDCBB}"/>
            </c:ext>
          </c:extLst>
        </c:ser>
        <c:ser>
          <c:idx val="43"/>
          <c:order val="43"/>
          <c:tx>
            <c:strRef>
              <c:f>'3nt'!$A$494</c:f>
              <c:strCache>
                <c:ptCount val="1"/>
                <c:pt idx="0">
                  <c:v>AGG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94:$Y$494</c:f>
              <c:numCache>
                <c:formatCode>General</c:formatCode>
                <c:ptCount val="24"/>
                <c:pt idx="0">
                  <c:v>0.79545454545454497</c:v>
                </c:pt>
                <c:pt idx="1">
                  <c:v>1.5056818181818179</c:v>
                </c:pt>
                <c:pt idx="2">
                  <c:v>1.25</c:v>
                </c:pt>
                <c:pt idx="3">
                  <c:v>0.99431818181817688</c:v>
                </c:pt>
                <c:pt idx="4">
                  <c:v>1.0227272727272718</c:v>
                </c:pt>
                <c:pt idx="5">
                  <c:v>0.85227272727272696</c:v>
                </c:pt>
                <c:pt idx="6">
                  <c:v>0.73863636363636298</c:v>
                </c:pt>
                <c:pt idx="7">
                  <c:v>0.65340909090909716</c:v>
                </c:pt>
                <c:pt idx="8">
                  <c:v>0.59659090909090284</c:v>
                </c:pt>
                <c:pt idx="9">
                  <c:v>0.65340909090909716</c:v>
                </c:pt>
                <c:pt idx="10">
                  <c:v>0.68181818181818199</c:v>
                </c:pt>
                <c:pt idx="11">
                  <c:v>0.68181818181818199</c:v>
                </c:pt>
                <c:pt idx="12">
                  <c:v>0.82386363636364213</c:v>
                </c:pt>
                <c:pt idx="13">
                  <c:v>0.85227272727272696</c:v>
                </c:pt>
                <c:pt idx="14">
                  <c:v>0.68181818181818199</c:v>
                </c:pt>
                <c:pt idx="15">
                  <c:v>0.48295454545454808</c:v>
                </c:pt>
                <c:pt idx="16">
                  <c:v>0.56818181818182312</c:v>
                </c:pt>
                <c:pt idx="17">
                  <c:v>0.68181818181818199</c:v>
                </c:pt>
                <c:pt idx="18">
                  <c:v>0.88068181818182412</c:v>
                </c:pt>
                <c:pt idx="19">
                  <c:v>1.107954545454545</c:v>
                </c:pt>
                <c:pt idx="20">
                  <c:v>1.3920454545454561</c:v>
                </c:pt>
                <c:pt idx="21">
                  <c:v>1.25</c:v>
                </c:pt>
                <c:pt idx="22">
                  <c:v>1.3920454545454561</c:v>
                </c:pt>
                <c:pt idx="23">
                  <c:v>0.9090909090909089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B-1784-405B-8F91-AE3CBDDEDCBB}"/>
            </c:ext>
          </c:extLst>
        </c:ser>
        <c:ser>
          <c:idx val="44"/>
          <c:order val="44"/>
          <c:tx>
            <c:strRef>
              <c:f>'3nt'!$A$495</c:f>
              <c:strCache>
                <c:ptCount val="1"/>
                <c:pt idx="0">
                  <c:v>CAC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95:$Y$495</c:f>
              <c:numCache>
                <c:formatCode>General</c:formatCode>
                <c:ptCount val="24"/>
                <c:pt idx="0">
                  <c:v>1.107954545454545</c:v>
                </c:pt>
                <c:pt idx="1">
                  <c:v>0.90909090909090895</c:v>
                </c:pt>
                <c:pt idx="2">
                  <c:v>0.96590909090909716</c:v>
                </c:pt>
                <c:pt idx="3">
                  <c:v>0.56818181818182312</c:v>
                </c:pt>
                <c:pt idx="4">
                  <c:v>1.2215909090909078</c:v>
                </c:pt>
                <c:pt idx="5">
                  <c:v>1.1647727272727373</c:v>
                </c:pt>
                <c:pt idx="6">
                  <c:v>1.1647727272727373</c:v>
                </c:pt>
                <c:pt idx="7">
                  <c:v>1.25</c:v>
                </c:pt>
                <c:pt idx="8">
                  <c:v>1.051136363636364</c:v>
                </c:pt>
                <c:pt idx="9">
                  <c:v>0.79545454545454497</c:v>
                </c:pt>
                <c:pt idx="10">
                  <c:v>0.82386363636364213</c:v>
                </c:pt>
                <c:pt idx="11">
                  <c:v>1.0227272727272718</c:v>
                </c:pt>
                <c:pt idx="12">
                  <c:v>0.68181818181818199</c:v>
                </c:pt>
                <c:pt idx="13">
                  <c:v>0.76704545454546524</c:v>
                </c:pt>
                <c:pt idx="14">
                  <c:v>0.71022727272727304</c:v>
                </c:pt>
                <c:pt idx="15">
                  <c:v>0.45454545454545398</c:v>
                </c:pt>
                <c:pt idx="16">
                  <c:v>0.73863636363636298</c:v>
                </c:pt>
                <c:pt idx="17">
                  <c:v>0.56818181818182312</c:v>
                </c:pt>
                <c:pt idx="18">
                  <c:v>0.53977272727272696</c:v>
                </c:pt>
                <c:pt idx="19">
                  <c:v>0.65340909090909716</c:v>
                </c:pt>
                <c:pt idx="20">
                  <c:v>0.82386363636364213</c:v>
                </c:pt>
                <c:pt idx="21">
                  <c:v>0.56818181818182312</c:v>
                </c:pt>
                <c:pt idx="22">
                  <c:v>1.136363636363636</c:v>
                </c:pt>
                <c:pt idx="23">
                  <c:v>1.278409090909080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C-1784-405B-8F91-AE3CBDDEDCBB}"/>
            </c:ext>
          </c:extLst>
        </c:ser>
        <c:ser>
          <c:idx val="45"/>
          <c:order val="45"/>
          <c:tx>
            <c:strRef>
              <c:f>'3nt'!$A$496</c:f>
              <c:strCache>
                <c:ptCount val="1"/>
                <c:pt idx="0">
                  <c:v>GAG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96:$Y$496</c:f>
              <c:numCache>
                <c:formatCode>General</c:formatCode>
                <c:ptCount val="24"/>
                <c:pt idx="0">
                  <c:v>1.0795454545454539</c:v>
                </c:pt>
                <c:pt idx="1">
                  <c:v>1.3068181818181821</c:v>
                </c:pt>
                <c:pt idx="2">
                  <c:v>1.051136363636364</c:v>
                </c:pt>
                <c:pt idx="3">
                  <c:v>1.3920454545454561</c:v>
                </c:pt>
                <c:pt idx="4">
                  <c:v>0.99431818181817688</c:v>
                </c:pt>
                <c:pt idx="5">
                  <c:v>0.9375</c:v>
                </c:pt>
                <c:pt idx="6">
                  <c:v>0.73863636363636298</c:v>
                </c:pt>
                <c:pt idx="7">
                  <c:v>0.62500000000000511</c:v>
                </c:pt>
                <c:pt idx="8">
                  <c:v>0.79545454545454497</c:v>
                </c:pt>
                <c:pt idx="9">
                  <c:v>0.56818181818182312</c:v>
                </c:pt>
                <c:pt idx="10">
                  <c:v>0.82386363636364213</c:v>
                </c:pt>
                <c:pt idx="11">
                  <c:v>0.65340909090909716</c:v>
                </c:pt>
                <c:pt idx="12">
                  <c:v>0.71022727272727304</c:v>
                </c:pt>
                <c:pt idx="13">
                  <c:v>0.56818181818182312</c:v>
                </c:pt>
                <c:pt idx="14">
                  <c:v>0.65340909090909716</c:v>
                </c:pt>
                <c:pt idx="15">
                  <c:v>0.62500000000000511</c:v>
                </c:pt>
                <c:pt idx="16">
                  <c:v>0.62500000000000511</c:v>
                </c:pt>
                <c:pt idx="17">
                  <c:v>0.53977272727272696</c:v>
                </c:pt>
                <c:pt idx="18">
                  <c:v>0.79545454545454497</c:v>
                </c:pt>
                <c:pt idx="19">
                  <c:v>0.96590909090909716</c:v>
                </c:pt>
                <c:pt idx="20">
                  <c:v>1.136363636363636</c:v>
                </c:pt>
                <c:pt idx="21">
                  <c:v>1.25</c:v>
                </c:pt>
                <c:pt idx="22">
                  <c:v>0.88068181818182412</c:v>
                </c:pt>
                <c:pt idx="23">
                  <c:v>1.221590909090907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D-1784-405B-8F91-AE3CBDDEDCBB}"/>
            </c:ext>
          </c:extLst>
        </c:ser>
        <c:ser>
          <c:idx val="46"/>
          <c:order val="46"/>
          <c:tx>
            <c:strRef>
              <c:f>'3nt'!$A$497</c:f>
              <c:strCache>
                <c:ptCount val="1"/>
                <c:pt idx="0">
                  <c:v>CGA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97:$Y$497</c:f>
              <c:numCache>
                <c:formatCode>General</c:formatCode>
                <c:ptCount val="24"/>
                <c:pt idx="0">
                  <c:v>1.2784090909090808</c:v>
                </c:pt>
                <c:pt idx="1">
                  <c:v>1.107954545454545</c:v>
                </c:pt>
                <c:pt idx="2">
                  <c:v>1.1931818181818181</c:v>
                </c:pt>
                <c:pt idx="3">
                  <c:v>1.3352272727272718</c:v>
                </c:pt>
                <c:pt idx="4">
                  <c:v>0.96590909090909716</c:v>
                </c:pt>
                <c:pt idx="5">
                  <c:v>0.99431818181817688</c:v>
                </c:pt>
                <c:pt idx="6">
                  <c:v>0.85227272727272696</c:v>
                </c:pt>
                <c:pt idx="7">
                  <c:v>0.76704545454546524</c:v>
                </c:pt>
                <c:pt idx="8">
                  <c:v>1.136363636363636</c:v>
                </c:pt>
                <c:pt idx="9">
                  <c:v>1.2784090909090808</c:v>
                </c:pt>
                <c:pt idx="10">
                  <c:v>1.0227272727272718</c:v>
                </c:pt>
                <c:pt idx="11">
                  <c:v>0.82386363636364213</c:v>
                </c:pt>
                <c:pt idx="12">
                  <c:v>0.96590909090909716</c:v>
                </c:pt>
                <c:pt idx="13">
                  <c:v>0.82386363636364213</c:v>
                </c:pt>
                <c:pt idx="14">
                  <c:v>0.65340909090909716</c:v>
                </c:pt>
                <c:pt idx="15">
                  <c:v>0.42613636363636404</c:v>
                </c:pt>
                <c:pt idx="16">
                  <c:v>0.59659090909090284</c:v>
                </c:pt>
                <c:pt idx="17">
                  <c:v>0.48295454545454808</c:v>
                </c:pt>
                <c:pt idx="18">
                  <c:v>0.51136363636363602</c:v>
                </c:pt>
                <c:pt idx="19">
                  <c:v>0.51136363636363602</c:v>
                </c:pt>
                <c:pt idx="20">
                  <c:v>0.71022727272727304</c:v>
                </c:pt>
                <c:pt idx="21">
                  <c:v>0.65340909090909716</c:v>
                </c:pt>
                <c:pt idx="22">
                  <c:v>0.90909090909090895</c:v>
                </c:pt>
                <c:pt idx="23">
                  <c:v>0.937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E-1784-405B-8F91-AE3CBDDEDCBB}"/>
            </c:ext>
          </c:extLst>
        </c:ser>
        <c:ser>
          <c:idx val="47"/>
          <c:order val="47"/>
          <c:tx>
            <c:strRef>
              <c:f>'3nt'!$A$498</c:f>
              <c:strCache>
                <c:ptCount val="1"/>
                <c:pt idx="0">
                  <c:v>GUC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98:$Y$498</c:f>
              <c:numCache>
                <c:formatCode>General</c:formatCode>
                <c:ptCount val="24"/>
                <c:pt idx="0">
                  <c:v>1.1931818181818181</c:v>
                </c:pt>
                <c:pt idx="1">
                  <c:v>1.136363636363636</c:v>
                </c:pt>
                <c:pt idx="2">
                  <c:v>1.1931818181818181</c:v>
                </c:pt>
                <c:pt idx="3">
                  <c:v>0.79545454545454497</c:v>
                </c:pt>
                <c:pt idx="4">
                  <c:v>0.96590909090909716</c:v>
                </c:pt>
                <c:pt idx="5">
                  <c:v>0.90909090909090895</c:v>
                </c:pt>
                <c:pt idx="6">
                  <c:v>0.82386363636364213</c:v>
                </c:pt>
                <c:pt idx="7">
                  <c:v>0.9375</c:v>
                </c:pt>
                <c:pt idx="8">
                  <c:v>0.96590909090909716</c:v>
                </c:pt>
                <c:pt idx="9">
                  <c:v>0.9375</c:v>
                </c:pt>
                <c:pt idx="10">
                  <c:v>0.48295454545454808</c:v>
                </c:pt>
                <c:pt idx="11">
                  <c:v>0.59659090909090284</c:v>
                </c:pt>
                <c:pt idx="12">
                  <c:v>0.59659090909090284</c:v>
                </c:pt>
                <c:pt idx="13">
                  <c:v>0.53977272727272696</c:v>
                </c:pt>
                <c:pt idx="14">
                  <c:v>0.79545454545454497</c:v>
                </c:pt>
                <c:pt idx="15">
                  <c:v>0.90909090909090895</c:v>
                </c:pt>
                <c:pt idx="16">
                  <c:v>0.51136363636363602</c:v>
                </c:pt>
                <c:pt idx="17">
                  <c:v>0.53977272727272696</c:v>
                </c:pt>
                <c:pt idx="18">
                  <c:v>0.56818181818182312</c:v>
                </c:pt>
                <c:pt idx="19">
                  <c:v>0.73863636363636298</c:v>
                </c:pt>
                <c:pt idx="20">
                  <c:v>0.71022727272727304</c:v>
                </c:pt>
                <c:pt idx="21">
                  <c:v>0.82386363636364213</c:v>
                </c:pt>
                <c:pt idx="22">
                  <c:v>1.25</c:v>
                </c:pt>
                <c:pt idx="23">
                  <c:v>1.193181818181818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F-1784-405B-8F91-AE3CBDDEDCBB}"/>
            </c:ext>
          </c:extLst>
        </c:ser>
        <c:ser>
          <c:idx val="48"/>
          <c:order val="48"/>
          <c:tx>
            <c:strRef>
              <c:f>'3nt'!$A$499</c:f>
              <c:strCache>
                <c:ptCount val="1"/>
                <c:pt idx="0">
                  <c:v>GUG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499:$Y$499</c:f>
              <c:numCache>
                <c:formatCode>General</c:formatCode>
                <c:ptCount val="24"/>
                <c:pt idx="0">
                  <c:v>0.9375</c:v>
                </c:pt>
                <c:pt idx="1">
                  <c:v>0.9375</c:v>
                </c:pt>
                <c:pt idx="2">
                  <c:v>0.9375</c:v>
                </c:pt>
                <c:pt idx="3">
                  <c:v>1.0227272727272718</c:v>
                </c:pt>
                <c:pt idx="4">
                  <c:v>1.0795454545454539</c:v>
                </c:pt>
                <c:pt idx="5">
                  <c:v>0.85227272727272696</c:v>
                </c:pt>
                <c:pt idx="6">
                  <c:v>1.25</c:v>
                </c:pt>
                <c:pt idx="7">
                  <c:v>0.85227272727272696</c:v>
                </c:pt>
                <c:pt idx="8">
                  <c:v>0.82386363636364213</c:v>
                </c:pt>
                <c:pt idx="9">
                  <c:v>0.79545454545454497</c:v>
                </c:pt>
                <c:pt idx="10">
                  <c:v>0.59659090909090284</c:v>
                </c:pt>
                <c:pt idx="11">
                  <c:v>0.59659090909090284</c:v>
                </c:pt>
                <c:pt idx="12">
                  <c:v>0.79545454545454497</c:v>
                </c:pt>
                <c:pt idx="13">
                  <c:v>0.82386363636364213</c:v>
                </c:pt>
                <c:pt idx="14">
                  <c:v>0.62500000000000511</c:v>
                </c:pt>
                <c:pt idx="15">
                  <c:v>0.90909090909090895</c:v>
                </c:pt>
                <c:pt idx="16">
                  <c:v>0.45454545454545398</c:v>
                </c:pt>
                <c:pt idx="17">
                  <c:v>0.51136363636363602</c:v>
                </c:pt>
                <c:pt idx="18">
                  <c:v>0.85227272727272696</c:v>
                </c:pt>
                <c:pt idx="19">
                  <c:v>0.68181818181818199</c:v>
                </c:pt>
                <c:pt idx="20">
                  <c:v>0.85227272727272696</c:v>
                </c:pt>
                <c:pt idx="21">
                  <c:v>0.82386363636364213</c:v>
                </c:pt>
                <c:pt idx="22">
                  <c:v>0.9375</c:v>
                </c:pt>
                <c:pt idx="23">
                  <c:v>0.852272727272726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0-1784-405B-8F91-AE3CBDDEDCBB}"/>
            </c:ext>
          </c:extLst>
        </c:ser>
        <c:ser>
          <c:idx val="49"/>
          <c:order val="49"/>
          <c:tx>
            <c:strRef>
              <c:f>'3nt'!$A$500</c:f>
              <c:strCache>
                <c:ptCount val="1"/>
                <c:pt idx="0">
                  <c:v>CCU</c:v>
                </c:pt>
              </c:strCache>
            </c:strRef>
          </c:tx>
          <c:marker>
            <c:symbol val="none"/>
          </c:marker>
          <c:cat>
            <c:numRef>
              <c:f>'3nt'!$B$450:$Y$450</c:f>
              <c:numCache>
                <c:formatCode>General</c:formatCode>
                <c:ptCount val="24"/>
                <c:pt idx="0">
                  <c:v>-40</c:v>
                </c:pt>
                <c:pt idx="1">
                  <c:v>-39</c:v>
                </c:pt>
                <c:pt idx="2">
                  <c:v>-38</c:v>
                </c:pt>
                <c:pt idx="3">
                  <c:v>-37</c:v>
                </c:pt>
                <c:pt idx="4">
                  <c:v>-36</c:v>
                </c:pt>
                <c:pt idx="5">
                  <c:v>-35</c:v>
                </c:pt>
                <c:pt idx="6">
                  <c:v>-34</c:v>
                </c:pt>
                <c:pt idx="7">
                  <c:v>-33</c:v>
                </c:pt>
                <c:pt idx="8">
                  <c:v>-32</c:v>
                </c:pt>
                <c:pt idx="9">
                  <c:v>-31</c:v>
                </c:pt>
                <c:pt idx="10">
                  <c:v>-30</c:v>
                </c:pt>
                <c:pt idx="11">
                  <c:v>-29</c:v>
                </c:pt>
                <c:pt idx="12">
                  <c:v>-28</c:v>
                </c:pt>
                <c:pt idx="13">
                  <c:v>-27</c:v>
                </c:pt>
                <c:pt idx="14">
                  <c:v>-26</c:v>
                </c:pt>
                <c:pt idx="15">
                  <c:v>-25</c:v>
                </c:pt>
                <c:pt idx="16">
                  <c:v>-24</c:v>
                </c:pt>
                <c:pt idx="17">
                  <c:v>-23</c:v>
                </c:pt>
                <c:pt idx="18">
                  <c:v>-22</c:v>
                </c:pt>
                <c:pt idx="19">
                  <c:v>-21</c:v>
                </c:pt>
                <c:pt idx="20">
                  <c:v>-20</c:v>
                </c:pt>
                <c:pt idx="21">
                  <c:v>-19</c:v>
                </c:pt>
                <c:pt idx="22">
                  <c:v>-18</c:v>
                </c:pt>
                <c:pt idx="23">
                  <c:v>-17</c:v>
                </c:pt>
              </c:numCache>
            </c:numRef>
          </c:cat>
          <c:val>
            <c:numRef>
              <c:f>'3nt'!$B$500:$Y$500</c:f>
              <c:numCache>
                <c:formatCode>General</c:formatCode>
                <c:ptCount val="24"/>
                <c:pt idx="0">
                  <c:v>0.90909090909090895</c:v>
                </c:pt>
                <c:pt idx="1">
                  <c:v>0.99431818181817688</c:v>
                </c:pt>
                <c:pt idx="2">
                  <c:v>1.107954545454545</c:v>
                </c:pt>
                <c:pt idx="3">
                  <c:v>0.90909090909090895</c:v>
                </c:pt>
                <c:pt idx="4">
                  <c:v>1.3352272727272718</c:v>
                </c:pt>
                <c:pt idx="5">
                  <c:v>1.107954545454545</c:v>
                </c:pt>
                <c:pt idx="6">
                  <c:v>0.82386363636364213</c:v>
                </c:pt>
                <c:pt idx="7">
                  <c:v>1.0227272727272718</c:v>
                </c:pt>
                <c:pt idx="8">
                  <c:v>0.82386363636364213</c:v>
                </c:pt>
                <c:pt idx="9">
                  <c:v>1.0227272727272718</c:v>
                </c:pt>
                <c:pt idx="10">
                  <c:v>0.85227272727272696</c:v>
                </c:pt>
                <c:pt idx="11">
                  <c:v>0.82386363636364213</c:v>
                </c:pt>
                <c:pt idx="12">
                  <c:v>0.68181818181818199</c:v>
                </c:pt>
                <c:pt idx="13">
                  <c:v>0.88068181818182412</c:v>
                </c:pt>
                <c:pt idx="14">
                  <c:v>0.82386363636364213</c:v>
                </c:pt>
                <c:pt idx="15">
                  <c:v>1.0227272727272718</c:v>
                </c:pt>
                <c:pt idx="16">
                  <c:v>0.79545454545454497</c:v>
                </c:pt>
                <c:pt idx="17">
                  <c:v>0.53977272727272696</c:v>
                </c:pt>
                <c:pt idx="18">
                  <c:v>0.56818181818182312</c:v>
                </c:pt>
                <c:pt idx="19">
                  <c:v>0.65340909090909716</c:v>
                </c:pt>
                <c:pt idx="20">
                  <c:v>0.19886363636363599</c:v>
                </c:pt>
                <c:pt idx="21">
                  <c:v>0.51136363636363602</c:v>
                </c:pt>
                <c:pt idx="22">
                  <c:v>0.45454545454545398</c:v>
                </c:pt>
                <c:pt idx="23">
                  <c:v>0.795454545454544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1-1784-405B-8F91-AE3CBDDEDCB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79488896"/>
        <c:axId val="79490432"/>
      </c:lineChart>
      <c:catAx>
        <c:axId val="794888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zh-CN"/>
            </a:pPr>
            <a:endParaRPr lang="en-US"/>
          </a:p>
        </c:txPr>
        <c:crossAx val="79490432"/>
        <c:crosses val="autoZero"/>
        <c:auto val="1"/>
        <c:lblAlgn val="ctr"/>
        <c:lblOffset val="100"/>
        <c:noMultiLvlLbl val="0"/>
      </c:catAx>
      <c:valAx>
        <c:axId val="794904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zh-CN"/>
            </a:pPr>
            <a:endParaRPr lang="en-US"/>
          </a:p>
        </c:txPr>
        <c:crossAx val="7948889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9.1510379384394729E-4"/>
          <c:y val="0.62796751968504005"/>
          <c:w val="0.99666065378191293"/>
          <c:h val="0.36571850393700811"/>
        </c:manualLayout>
      </c:layout>
      <c:overlay val="0"/>
      <c:txPr>
        <a:bodyPr/>
        <a:lstStyle/>
        <a:p>
          <a:pPr>
            <a:defRPr lang="zh-CN" sz="600" baseline="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6254318575141609E-2"/>
          <c:y val="0.10724283274424401"/>
          <c:w val="0.95421687708744396"/>
          <c:h val="0.36814729041222799"/>
        </c:manualLayout>
      </c:layout>
      <c:lineChart>
        <c:grouping val="standard"/>
        <c:varyColors val="0"/>
        <c:ser>
          <c:idx val="0"/>
          <c:order val="0"/>
          <c:tx>
            <c:strRef>
              <c:f>'5nt_2'!$A$88</c:f>
              <c:strCache>
                <c:ptCount val="1"/>
                <c:pt idx="0">
                  <c:v>AAAAU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88:$M$88</c:f>
              <c:numCache>
                <c:formatCode>General</c:formatCode>
                <c:ptCount val="12"/>
                <c:pt idx="0">
                  <c:v>1.465738365701722</c:v>
                </c:pt>
                <c:pt idx="1">
                  <c:v>1.465738365701722</c:v>
                </c:pt>
                <c:pt idx="2">
                  <c:v>2.3085379259802132</c:v>
                </c:pt>
                <c:pt idx="3">
                  <c:v>1.2825210699890071</c:v>
                </c:pt>
                <c:pt idx="4">
                  <c:v>1.7955294979845946</c:v>
                </c:pt>
                <c:pt idx="5">
                  <c:v>1.5390252839868079</c:v>
                </c:pt>
                <c:pt idx="6">
                  <c:v>2.0153902528398682</c:v>
                </c:pt>
                <c:pt idx="7">
                  <c:v>2.1986075485526109</c:v>
                </c:pt>
                <c:pt idx="8">
                  <c:v>1.832172957127153</c:v>
                </c:pt>
                <c:pt idx="9">
                  <c:v>1.2458776108464638</c:v>
                </c:pt>
                <c:pt idx="10">
                  <c:v>1.5756687431293428</c:v>
                </c:pt>
                <c:pt idx="11">
                  <c:v>1.685599120556981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2380-452E-9084-E04C841310C9}"/>
            </c:ext>
          </c:extLst>
        </c:ser>
        <c:ser>
          <c:idx val="1"/>
          <c:order val="1"/>
          <c:tx>
            <c:strRef>
              <c:f>'5nt_2'!$A$89</c:f>
              <c:strCache>
                <c:ptCount val="1"/>
                <c:pt idx="0">
                  <c:v>UUAAA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89:$M$89</c:f>
              <c:numCache>
                <c:formatCode>General</c:formatCode>
                <c:ptCount val="12"/>
                <c:pt idx="0">
                  <c:v>1.4290949065591676</c:v>
                </c:pt>
                <c:pt idx="1">
                  <c:v>2.1253206302675012</c:v>
                </c:pt>
                <c:pt idx="2">
                  <c:v>2.16196408941004</c:v>
                </c:pt>
                <c:pt idx="3">
                  <c:v>1.9787467936973251</c:v>
                </c:pt>
                <c:pt idx="4">
                  <c:v>2.491755221692928</c:v>
                </c:pt>
                <c:pt idx="5">
                  <c:v>2.2718944668376704</c:v>
                </c:pt>
                <c:pt idx="6">
                  <c:v>1.832172957127153</c:v>
                </c:pt>
                <c:pt idx="7">
                  <c:v>1.832172957127153</c:v>
                </c:pt>
                <c:pt idx="8">
                  <c:v>1.1359472334188352</c:v>
                </c:pt>
                <c:pt idx="9">
                  <c:v>1.2825210699890071</c:v>
                </c:pt>
                <c:pt idx="10">
                  <c:v>0.91608647856358116</c:v>
                </c:pt>
                <c:pt idx="11">
                  <c:v>0.73286918285086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2380-452E-9084-E04C841310C9}"/>
            </c:ext>
          </c:extLst>
        </c:ser>
        <c:ser>
          <c:idx val="2"/>
          <c:order val="2"/>
          <c:tx>
            <c:strRef>
              <c:f>'5nt_2'!$A$90</c:f>
              <c:strCache>
                <c:ptCount val="1"/>
                <c:pt idx="0">
                  <c:v>UAAAU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90:$M$90</c:f>
              <c:numCache>
                <c:formatCode>General</c:formatCode>
                <c:ptCount val="12"/>
                <c:pt idx="0">
                  <c:v>1.355807988274093</c:v>
                </c:pt>
                <c:pt idx="1">
                  <c:v>1.0260168559912133</c:v>
                </c:pt>
                <c:pt idx="2">
                  <c:v>2.0153902528398682</c:v>
                </c:pt>
                <c:pt idx="3">
                  <c:v>1.7222425796995322</c:v>
                </c:pt>
                <c:pt idx="4">
                  <c:v>1.355807988274093</c:v>
                </c:pt>
                <c:pt idx="5">
                  <c:v>1.9421033345547902</c:v>
                </c:pt>
                <c:pt idx="6">
                  <c:v>2.0886771711249552</c:v>
                </c:pt>
                <c:pt idx="7">
                  <c:v>2.16196408941004</c:v>
                </c:pt>
                <c:pt idx="8">
                  <c:v>1.6489556614144381</c:v>
                </c:pt>
                <c:pt idx="9">
                  <c:v>1.0260168559912133</c:v>
                </c:pt>
                <c:pt idx="10">
                  <c:v>1.355807988274093</c:v>
                </c:pt>
                <c:pt idx="11">
                  <c:v>1.392451447416636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2380-452E-9084-E04C841310C9}"/>
            </c:ext>
          </c:extLst>
        </c:ser>
        <c:ser>
          <c:idx val="3"/>
          <c:order val="3"/>
          <c:tx>
            <c:strRef>
              <c:f>'5nt_2'!$A$91</c:f>
              <c:strCache>
                <c:ptCount val="1"/>
                <c:pt idx="0">
                  <c:v>AAAUU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91:$M$91</c:f>
              <c:numCache>
                <c:formatCode>General</c:formatCode>
                <c:ptCount val="12"/>
                <c:pt idx="0">
                  <c:v>1.2825210699890071</c:v>
                </c:pt>
                <c:pt idx="1">
                  <c:v>1.6123122022718941</c:v>
                </c:pt>
                <c:pt idx="2">
                  <c:v>1.5023818248442733</c:v>
                </c:pt>
                <c:pt idx="3">
                  <c:v>1.8688164162696959</c:v>
                </c:pt>
                <c:pt idx="4">
                  <c:v>1.5390252839868079</c:v>
                </c:pt>
                <c:pt idx="5">
                  <c:v>1.3924514474166361</c:v>
                </c:pt>
                <c:pt idx="6">
                  <c:v>1.7222425796995322</c:v>
                </c:pt>
                <c:pt idx="7">
                  <c:v>1.7588860388420671</c:v>
                </c:pt>
                <c:pt idx="8">
                  <c:v>1.9787467936973251</c:v>
                </c:pt>
                <c:pt idx="9">
                  <c:v>1.5756687431293428</c:v>
                </c:pt>
                <c:pt idx="10">
                  <c:v>1.2825210699890071</c:v>
                </c:pt>
                <c:pt idx="11">
                  <c:v>1.31916452913155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2380-452E-9084-E04C841310C9}"/>
            </c:ext>
          </c:extLst>
        </c:ser>
        <c:ser>
          <c:idx val="4"/>
          <c:order val="4"/>
          <c:tx>
            <c:strRef>
              <c:f>'5nt_2'!$A$92</c:f>
              <c:strCache>
                <c:ptCount val="1"/>
                <c:pt idx="0">
                  <c:v>UUUAA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92:$M$92</c:f>
              <c:numCache>
                <c:formatCode>General</c:formatCode>
                <c:ptCount val="12"/>
                <c:pt idx="0">
                  <c:v>1.9054598754122392</c:v>
                </c:pt>
                <c:pt idx="1">
                  <c:v>2.0153902528398682</c:v>
                </c:pt>
                <c:pt idx="2">
                  <c:v>1.7222425796995322</c:v>
                </c:pt>
                <c:pt idx="3">
                  <c:v>1.832172957127153</c:v>
                </c:pt>
                <c:pt idx="4">
                  <c:v>2.0520337119824212</c:v>
                </c:pt>
                <c:pt idx="5">
                  <c:v>1.6489556614144381</c:v>
                </c:pt>
                <c:pt idx="6">
                  <c:v>2.2718944668376704</c:v>
                </c:pt>
                <c:pt idx="7">
                  <c:v>1.6123122022718941</c:v>
                </c:pt>
                <c:pt idx="8">
                  <c:v>1.0626603151337499</c:v>
                </c:pt>
                <c:pt idx="9">
                  <c:v>0.87944301942103409</c:v>
                </c:pt>
                <c:pt idx="10">
                  <c:v>0.76951264199340397</c:v>
                </c:pt>
                <c:pt idx="11">
                  <c:v>0.8794430194210340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2380-452E-9084-E04C841310C9}"/>
            </c:ext>
          </c:extLst>
        </c:ser>
        <c:ser>
          <c:idx val="5"/>
          <c:order val="5"/>
          <c:tx>
            <c:strRef>
              <c:f>'5nt_2'!$A$93</c:f>
              <c:strCache>
                <c:ptCount val="1"/>
                <c:pt idx="0">
                  <c:v>AUUUU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93:$M$93</c:f>
              <c:numCache>
                <c:formatCode>General</c:formatCode>
                <c:ptCount val="12"/>
                <c:pt idx="0">
                  <c:v>1.6123122022718941</c:v>
                </c:pt>
                <c:pt idx="1">
                  <c:v>2.4184683034078156</c:v>
                </c:pt>
                <c:pt idx="2">
                  <c:v>2.0153902528398682</c:v>
                </c:pt>
                <c:pt idx="3">
                  <c:v>1.3924514474166361</c:v>
                </c:pt>
                <c:pt idx="4">
                  <c:v>1.6855991205569811</c:v>
                </c:pt>
                <c:pt idx="5">
                  <c:v>1.2092341517039198</c:v>
                </c:pt>
                <c:pt idx="6">
                  <c:v>1.2458776108464638</c:v>
                </c:pt>
                <c:pt idx="7">
                  <c:v>0.87944301942103409</c:v>
                </c:pt>
                <c:pt idx="8">
                  <c:v>1.1359472334188352</c:v>
                </c:pt>
                <c:pt idx="9">
                  <c:v>1.4290949065591676</c:v>
                </c:pt>
                <c:pt idx="10">
                  <c:v>1.5023818248442733</c:v>
                </c:pt>
                <c:pt idx="11">
                  <c:v>1.612312202271894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2380-452E-9084-E04C841310C9}"/>
            </c:ext>
          </c:extLst>
        </c:ser>
        <c:ser>
          <c:idx val="6"/>
          <c:order val="6"/>
          <c:tx>
            <c:strRef>
              <c:f>'5nt_2'!$A$94</c:f>
              <c:strCache>
                <c:ptCount val="1"/>
                <c:pt idx="0">
                  <c:v>UAAAA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94:$M$94</c:f>
              <c:numCache>
                <c:formatCode>General</c:formatCode>
                <c:ptCount val="12"/>
                <c:pt idx="0">
                  <c:v>1.9421033345547902</c:v>
                </c:pt>
                <c:pt idx="1">
                  <c:v>1.6855991205569811</c:v>
                </c:pt>
                <c:pt idx="2">
                  <c:v>1.7222425796995322</c:v>
                </c:pt>
                <c:pt idx="3">
                  <c:v>1.4290949065591676</c:v>
                </c:pt>
                <c:pt idx="4">
                  <c:v>1.6123122022718941</c:v>
                </c:pt>
                <c:pt idx="5">
                  <c:v>1.6855991205569811</c:v>
                </c:pt>
                <c:pt idx="6">
                  <c:v>1.7955294979845946</c:v>
                </c:pt>
                <c:pt idx="7">
                  <c:v>1.5023818248442733</c:v>
                </c:pt>
                <c:pt idx="8">
                  <c:v>1.1359472334188352</c:v>
                </c:pt>
                <c:pt idx="9">
                  <c:v>1.355807988274093</c:v>
                </c:pt>
                <c:pt idx="10">
                  <c:v>1.2092341517039198</c:v>
                </c:pt>
                <c:pt idx="11">
                  <c:v>0.8427995602784992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2380-452E-9084-E04C841310C9}"/>
            </c:ext>
          </c:extLst>
        </c:ser>
        <c:ser>
          <c:idx val="7"/>
          <c:order val="7"/>
          <c:tx>
            <c:strRef>
              <c:f>'5nt_2'!$A$95</c:f>
              <c:strCache>
                <c:ptCount val="1"/>
                <c:pt idx="0">
                  <c:v>AAAUA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95:$M$95</c:f>
              <c:numCache>
                <c:formatCode>General</c:formatCode>
                <c:ptCount val="12"/>
                <c:pt idx="0">
                  <c:v>1.0260168559912133</c:v>
                </c:pt>
                <c:pt idx="1">
                  <c:v>1.1725906925613778</c:v>
                </c:pt>
                <c:pt idx="2">
                  <c:v>1.0260168559912133</c:v>
                </c:pt>
                <c:pt idx="3">
                  <c:v>1.7222425796995322</c:v>
                </c:pt>
                <c:pt idx="4">
                  <c:v>1.355807988274093</c:v>
                </c:pt>
                <c:pt idx="5">
                  <c:v>1.5390252839868079</c:v>
                </c:pt>
                <c:pt idx="6">
                  <c:v>1.7588860388420671</c:v>
                </c:pt>
                <c:pt idx="7">
                  <c:v>2.2352510076951271</c:v>
                </c:pt>
                <c:pt idx="8">
                  <c:v>1.9054598754122392</c:v>
                </c:pt>
                <c:pt idx="9">
                  <c:v>1.4290949065591676</c:v>
                </c:pt>
                <c:pt idx="10">
                  <c:v>0.98937339684865888</c:v>
                </c:pt>
                <c:pt idx="11">
                  <c:v>1.282521069989007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2380-452E-9084-E04C841310C9}"/>
            </c:ext>
          </c:extLst>
        </c:ser>
        <c:ser>
          <c:idx val="8"/>
          <c:order val="8"/>
          <c:tx>
            <c:strRef>
              <c:f>'5nt_2'!$A$96</c:f>
              <c:strCache>
                <c:ptCount val="1"/>
                <c:pt idx="0">
                  <c:v>AAUUU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96:$M$96</c:f>
              <c:numCache>
                <c:formatCode>General</c:formatCode>
                <c:ptCount val="12"/>
                <c:pt idx="0">
                  <c:v>1.465738365701722</c:v>
                </c:pt>
                <c:pt idx="1">
                  <c:v>1.6489556614144381</c:v>
                </c:pt>
                <c:pt idx="2">
                  <c:v>1.7588860388420671</c:v>
                </c:pt>
                <c:pt idx="3">
                  <c:v>1.3924514474166361</c:v>
                </c:pt>
                <c:pt idx="4">
                  <c:v>1.5390252839868079</c:v>
                </c:pt>
                <c:pt idx="5">
                  <c:v>1.6123122022718941</c:v>
                </c:pt>
                <c:pt idx="6">
                  <c:v>0.84279956027849923</c:v>
                </c:pt>
                <c:pt idx="7">
                  <c:v>1.2092341517039198</c:v>
                </c:pt>
                <c:pt idx="8">
                  <c:v>1.1359472334188352</c:v>
                </c:pt>
                <c:pt idx="9">
                  <c:v>1.9054598754122392</c:v>
                </c:pt>
                <c:pt idx="10">
                  <c:v>1.465738365701722</c:v>
                </c:pt>
                <c:pt idx="11">
                  <c:v>1.06266031513374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2380-452E-9084-E04C841310C9}"/>
            </c:ext>
          </c:extLst>
        </c:ser>
        <c:ser>
          <c:idx val="9"/>
          <c:order val="9"/>
          <c:tx>
            <c:strRef>
              <c:f>'5nt_2'!$A$97</c:f>
              <c:strCache>
                <c:ptCount val="1"/>
                <c:pt idx="0">
                  <c:v>UUUUA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97:$M$97</c:f>
              <c:numCache>
                <c:formatCode>General</c:formatCode>
                <c:ptCount val="12"/>
                <c:pt idx="0">
                  <c:v>1.465738365701722</c:v>
                </c:pt>
                <c:pt idx="1">
                  <c:v>1.4290949065591676</c:v>
                </c:pt>
                <c:pt idx="2">
                  <c:v>1.7955294979845946</c:v>
                </c:pt>
                <c:pt idx="3">
                  <c:v>1.7588860388420671</c:v>
                </c:pt>
                <c:pt idx="4">
                  <c:v>1.6489556614144381</c:v>
                </c:pt>
                <c:pt idx="5">
                  <c:v>1.6489556614144381</c:v>
                </c:pt>
                <c:pt idx="6">
                  <c:v>1.4290949065591676</c:v>
                </c:pt>
                <c:pt idx="7">
                  <c:v>1.0993037742762921</c:v>
                </c:pt>
                <c:pt idx="8">
                  <c:v>1.1725906925613778</c:v>
                </c:pt>
                <c:pt idx="9">
                  <c:v>0.95272993770612413</c:v>
                </c:pt>
                <c:pt idx="10">
                  <c:v>1.1725906925613778</c:v>
                </c:pt>
                <c:pt idx="11">
                  <c:v>1.31916452913155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2380-452E-9084-E04C841310C9}"/>
            </c:ext>
          </c:extLst>
        </c:ser>
        <c:ser>
          <c:idx val="10"/>
          <c:order val="10"/>
          <c:tx>
            <c:strRef>
              <c:f>'5nt_2'!$A$98</c:f>
              <c:strCache>
                <c:ptCount val="1"/>
                <c:pt idx="0">
                  <c:v>UAUUU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98:$M$98</c:f>
              <c:numCache>
                <c:formatCode>General</c:formatCode>
                <c:ptCount val="12"/>
                <c:pt idx="0">
                  <c:v>2.2352510076951271</c:v>
                </c:pt>
                <c:pt idx="1">
                  <c:v>1.7588860388420671</c:v>
                </c:pt>
                <c:pt idx="2">
                  <c:v>1.1359472334188352</c:v>
                </c:pt>
                <c:pt idx="3">
                  <c:v>1.3924514474166361</c:v>
                </c:pt>
                <c:pt idx="4">
                  <c:v>1.2092341517039198</c:v>
                </c:pt>
                <c:pt idx="5">
                  <c:v>0.95272993770612413</c:v>
                </c:pt>
                <c:pt idx="6">
                  <c:v>1.0993037742762921</c:v>
                </c:pt>
                <c:pt idx="7">
                  <c:v>0.87944301942103409</c:v>
                </c:pt>
                <c:pt idx="8">
                  <c:v>1.1725906925613778</c:v>
                </c:pt>
                <c:pt idx="9">
                  <c:v>1.3924514474166361</c:v>
                </c:pt>
                <c:pt idx="10">
                  <c:v>1.5023818248442733</c:v>
                </c:pt>
                <c:pt idx="11">
                  <c:v>1.722242579699532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2380-452E-9084-E04C841310C9}"/>
            </c:ext>
          </c:extLst>
        </c:ser>
        <c:ser>
          <c:idx val="11"/>
          <c:order val="11"/>
          <c:tx>
            <c:strRef>
              <c:f>'5nt_2'!$A$99</c:f>
              <c:strCache>
                <c:ptCount val="1"/>
                <c:pt idx="0">
                  <c:v>AUAAA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99:$M$99</c:f>
              <c:numCache>
                <c:formatCode>General</c:formatCode>
                <c:ptCount val="12"/>
                <c:pt idx="0">
                  <c:v>1.2092341517039198</c:v>
                </c:pt>
                <c:pt idx="1">
                  <c:v>1.7222425796995322</c:v>
                </c:pt>
                <c:pt idx="2">
                  <c:v>0.98937339684865888</c:v>
                </c:pt>
                <c:pt idx="3">
                  <c:v>0.91608647856358116</c:v>
                </c:pt>
                <c:pt idx="4">
                  <c:v>1.2092341517039198</c:v>
                </c:pt>
                <c:pt idx="5">
                  <c:v>1.2458776108464638</c:v>
                </c:pt>
                <c:pt idx="6">
                  <c:v>1.9054598754122392</c:v>
                </c:pt>
                <c:pt idx="7">
                  <c:v>1.2092341517039198</c:v>
                </c:pt>
                <c:pt idx="8">
                  <c:v>0.91608647856358116</c:v>
                </c:pt>
                <c:pt idx="9">
                  <c:v>1.3191645291315501</c:v>
                </c:pt>
                <c:pt idx="10">
                  <c:v>1.2092341517039198</c:v>
                </c:pt>
                <c:pt idx="11">
                  <c:v>0.9160864785635811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2380-452E-9084-E04C841310C9}"/>
            </c:ext>
          </c:extLst>
        </c:ser>
        <c:ser>
          <c:idx val="12"/>
          <c:order val="12"/>
          <c:tx>
            <c:strRef>
              <c:f>'5nt_2'!$A$100</c:f>
              <c:strCache>
                <c:ptCount val="1"/>
                <c:pt idx="0">
                  <c:v>UAAUU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100:$M$100</c:f>
              <c:numCache>
                <c:formatCode>General</c:formatCode>
                <c:ptCount val="12"/>
                <c:pt idx="0">
                  <c:v>1.5390252839868079</c:v>
                </c:pt>
                <c:pt idx="1">
                  <c:v>1.6489556614144381</c:v>
                </c:pt>
                <c:pt idx="2">
                  <c:v>1.1725906925613778</c:v>
                </c:pt>
                <c:pt idx="3">
                  <c:v>1.1359472334188352</c:v>
                </c:pt>
                <c:pt idx="4">
                  <c:v>0.95272993770612413</c:v>
                </c:pt>
                <c:pt idx="5">
                  <c:v>0.80615610113594183</c:v>
                </c:pt>
                <c:pt idx="6">
                  <c:v>1.0626603151337499</c:v>
                </c:pt>
                <c:pt idx="7">
                  <c:v>1.2092341517039198</c:v>
                </c:pt>
                <c:pt idx="8">
                  <c:v>1.355807988274093</c:v>
                </c:pt>
                <c:pt idx="9">
                  <c:v>1.1725906925613778</c:v>
                </c:pt>
                <c:pt idx="10">
                  <c:v>1.1725906925613778</c:v>
                </c:pt>
                <c:pt idx="11">
                  <c:v>1.539025283986807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C-2380-452E-9084-E04C841310C9}"/>
            </c:ext>
          </c:extLst>
        </c:ser>
        <c:ser>
          <c:idx val="13"/>
          <c:order val="13"/>
          <c:tx>
            <c:strRef>
              <c:f>'5nt_2'!$A$101</c:f>
              <c:strCache>
                <c:ptCount val="1"/>
                <c:pt idx="0">
                  <c:v>AUUUA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101:$M$101</c:f>
              <c:numCache>
                <c:formatCode>General</c:formatCode>
                <c:ptCount val="12"/>
                <c:pt idx="0">
                  <c:v>1.6489556614144381</c:v>
                </c:pt>
                <c:pt idx="1">
                  <c:v>1.1725906925613778</c:v>
                </c:pt>
                <c:pt idx="2">
                  <c:v>1.2092341517039198</c:v>
                </c:pt>
                <c:pt idx="3">
                  <c:v>1.1725906925613778</c:v>
                </c:pt>
                <c:pt idx="4">
                  <c:v>1.3191645291315501</c:v>
                </c:pt>
                <c:pt idx="5">
                  <c:v>1.355807988274093</c:v>
                </c:pt>
                <c:pt idx="6">
                  <c:v>1.2092341517039198</c:v>
                </c:pt>
                <c:pt idx="7">
                  <c:v>1.0626603151337499</c:v>
                </c:pt>
                <c:pt idx="8">
                  <c:v>0.98937339684865888</c:v>
                </c:pt>
                <c:pt idx="9">
                  <c:v>1.0260168559912133</c:v>
                </c:pt>
                <c:pt idx="10">
                  <c:v>1.2092341517039198</c:v>
                </c:pt>
                <c:pt idx="11">
                  <c:v>0.9893733968486588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D-2380-452E-9084-E04C841310C9}"/>
            </c:ext>
          </c:extLst>
        </c:ser>
        <c:ser>
          <c:idx val="14"/>
          <c:order val="14"/>
          <c:tx>
            <c:strRef>
              <c:f>'5nt_2'!$A$102</c:f>
              <c:strCache>
                <c:ptCount val="1"/>
                <c:pt idx="0">
                  <c:v>UUAUU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102:$M$102</c:f>
              <c:numCache>
                <c:formatCode>General</c:formatCode>
                <c:ptCount val="12"/>
                <c:pt idx="0">
                  <c:v>1.3191645291315501</c:v>
                </c:pt>
                <c:pt idx="1">
                  <c:v>0.95272993770612413</c:v>
                </c:pt>
                <c:pt idx="2">
                  <c:v>1.2458776108464638</c:v>
                </c:pt>
                <c:pt idx="3">
                  <c:v>1.3924514474166361</c:v>
                </c:pt>
                <c:pt idx="4">
                  <c:v>0.98937339684865888</c:v>
                </c:pt>
                <c:pt idx="5">
                  <c:v>0.87944301942103409</c:v>
                </c:pt>
                <c:pt idx="6">
                  <c:v>1.1725906925613778</c:v>
                </c:pt>
                <c:pt idx="7">
                  <c:v>1.0993037742762921</c:v>
                </c:pt>
                <c:pt idx="8">
                  <c:v>1.1725906925613778</c:v>
                </c:pt>
                <c:pt idx="9">
                  <c:v>1.2825210699890071</c:v>
                </c:pt>
                <c:pt idx="10">
                  <c:v>1.2092341517039198</c:v>
                </c:pt>
                <c:pt idx="11">
                  <c:v>1.392451447416636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E-2380-452E-9084-E04C841310C9}"/>
            </c:ext>
          </c:extLst>
        </c:ser>
        <c:ser>
          <c:idx val="15"/>
          <c:order val="15"/>
          <c:tx>
            <c:strRef>
              <c:f>'5nt_2'!$A$103</c:f>
              <c:strCache>
                <c:ptCount val="1"/>
                <c:pt idx="0">
                  <c:v>AAUUA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103:$M$103</c:f>
              <c:numCache>
                <c:formatCode>General</c:formatCode>
                <c:ptCount val="12"/>
                <c:pt idx="0">
                  <c:v>0.84279956027849923</c:v>
                </c:pt>
                <c:pt idx="1">
                  <c:v>0.95272993770612413</c:v>
                </c:pt>
                <c:pt idx="2">
                  <c:v>1.0626603151337499</c:v>
                </c:pt>
                <c:pt idx="3">
                  <c:v>1.0993037742762921</c:v>
                </c:pt>
                <c:pt idx="4">
                  <c:v>1.355807988274093</c:v>
                </c:pt>
                <c:pt idx="5">
                  <c:v>1.0626603151337499</c:v>
                </c:pt>
                <c:pt idx="6">
                  <c:v>1.0993037742762921</c:v>
                </c:pt>
                <c:pt idx="7">
                  <c:v>1.465738365701722</c:v>
                </c:pt>
                <c:pt idx="8">
                  <c:v>1.5390252839868079</c:v>
                </c:pt>
                <c:pt idx="9">
                  <c:v>1.2092341517039198</c:v>
                </c:pt>
                <c:pt idx="10">
                  <c:v>1.1359472334188352</c:v>
                </c:pt>
                <c:pt idx="11">
                  <c:v>1.135947233418835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F-2380-452E-9084-E04C841310C9}"/>
            </c:ext>
          </c:extLst>
        </c:ser>
        <c:ser>
          <c:idx val="16"/>
          <c:order val="16"/>
          <c:tx>
            <c:strRef>
              <c:f>'5nt_2'!$A$104</c:f>
              <c:strCache>
                <c:ptCount val="1"/>
                <c:pt idx="0">
                  <c:v>UUUUU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104:$M$104</c:f>
              <c:numCache>
                <c:formatCode>General</c:formatCode>
                <c:ptCount val="12"/>
                <c:pt idx="0">
                  <c:v>0.84279956027849923</c:v>
                </c:pt>
                <c:pt idx="1">
                  <c:v>1.0993037742762921</c:v>
                </c:pt>
                <c:pt idx="2">
                  <c:v>1.3191645291315501</c:v>
                </c:pt>
                <c:pt idx="3">
                  <c:v>1.3924514474166361</c:v>
                </c:pt>
                <c:pt idx="4">
                  <c:v>1.6855991205569811</c:v>
                </c:pt>
                <c:pt idx="5">
                  <c:v>0.95272993770612413</c:v>
                </c:pt>
                <c:pt idx="6">
                  <c:v>0.80615610113594183</c:v>
                </c:pt>
                <c:pt idx="7">
                  <c:v>0.98937339684865888</c:v>
                </c:pt>
                <c:pt idx="8">
                  <c:v>0.732869182850861</c:v>
                </c:pt>
                <c:pt idx="9">
                  <c:v>1.3924514474166361</c:v>
                </c:pt>
                <c:pt idx="10">
                  <c:v>1.0260168559912133</c:v>
                </c:pt>
                <c:pt idx="11">
                  <c:v>1.612312202271894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0-2380-452E-9084-E04C841310C9}"/>
            </c:ext>
          </c:extLst>
        </c:ser>
        <c:ser>
          <c:idx val="17"/>
          <c:order val="17"/>
          <c:tx>
            <c:strRef>
              <c:f>'5nt_2'!$A$105</c:f>
              <c:strCache>
                <c:ptCount val="1"/>
                <c:pt idx="0">
                  <c:v>AUUAA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105:$M$105</c:f>
              <c:numCache>
                <c:formatCode>General</c:formatCode>
                <c:ptCount val="12"/>
                <c:pt idx="0">
                  <c:v>1.0626603151337499</c:v>
                </c:pt>
                <c:pt idx="1">
                  <c:v>1.0626603151337499</c:v>
                </c:pt>
                <c:pt idx="2">
                  <c:v>1.0626603151337499</c:v>
                </c:pt>
                <c:pt idx="3">
                  <c:v>1.465738365701722</c:v>
                </c:pt>
                <c:pt idx="4">
                  <c:v>1.355807988274093</c:v>
                </c:pt>
                <c:pt idx="5">
                  <c:v>1.3924514474166361</c:v>
                </c:pt>
                <c:pt idx="6">
                  <c:v>1.2825210699890071</c:v>
                </c:pt>
                <c:pt idx="7">
                  <c:v>1.1725906925613778</c:v>
                </c:pt>
                <c:pt idx="8">
                  <c:v>1.1359472334188352</c:v>
                </c:pt>
                <c:pt idx="9">
                  <c:v>0.95272993770612413</c:v>
                </c:pt>
                <c:pt idx="10">
                  <c:v>0.80615610113594183</c:v>
                </c:pt>
                <c:pt idx="11">
                  <c:v>0.8427995602784992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1-2380-452E-9084-E04C841310C9}"/>
            </c:ext>
          </c:extLst>
        </c:ser>
        <c:ser>
          <c:idx val="18"/>
          <c:order val="18"/>
          <c:tx>
            <c:strRef>
              <c:f>'5nt_2'!$A$106</c:f>
              <c:strCache>
                <c:ptCount val="1"/>
                <c:pt idx="0">
                  <c:v>AAUAA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106:$M$106</c:f>
              <c:numCache>
                <c:formatCode>General</c:formatCode>
                <c:ptCount val="12"/>
                <c:pt idx="0">
                  <c:v>1.2458776108464638</c:v>
                </c:pt>
                <c:pt idx="1">
                  <c:v>0.732869182850861</c:v>
                </c:pt>
                <c:pt idx="2">
                  <c:v>0.65958226456577607</c:v>
                </c:pt>
                <c:pt idx="3">
                  <c:v>0.84279956027849923</c:v>
                </c:pt>
                <c:pt idx="4">
                  <c:v>1.2458776108464638</c:v>
                </c:pt>
                <c:pt idx="5">
                  <c:v>1.4290949065591676</c:v>
                </c:pt>
                <c:pt idx="6">
                  <c:v>0.95272993770612413</c:v>
                </c:pt>
                <c:pt idx="7">
                  <c:v>1.2825210699890071</c:v>
                </c:pt>
                <c:pt idx="8">
                  <c:v>1.7588860388420671</c:v>
                </c:pt>
                <c:pt idx="9">
                  <c:v>1.465738365701722</c:v>
                </c:pt>
                <c:pt idx="10">
                  <c:v>1.2092341517039198</c:v>
                </c:pt>
                <c:pt idx="11">
                  <c:v>0.513008427995602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2-2380-452E-9084-E04C841310C9}"/>
            </c:ext>
          </c:extLst>
        </c:ser>
        <c:ser>
          <c:idx val="19"/>
          <c:order val="19"/>
          <c:tx>
            <c:strRef>
              <c:f>'5nt_2'!$A$107</c:f>
              <c:strCache>
                <c:ptCount val="1"/>
                <c:pt idx="0">
                  <c:v>UUAAU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107:$M$107</c:f>
              <c:numCache>
                <c:formatCode>General</c:formatCode>
                <c:ptCount val="12"/>
                <c:pt idx="0">
                  <c:v>0.98937339684865888</c:v>
                </c:pt>
                <c:pt idx="1">
                  <c:v>1.0993037742762921</c:v>
                </c:pt>
                <c:pt idx="2">
                  <c:v>1.0626603151337499</c:v>
                </c:pt>
                <c:pt idx="3">
                  <c:v>0.98937339684865888</c:v>
                </c:pt>
                <c:pt idx="4">
                  <c:v>0.91608647856358116</c:v>
                </c:pt>
                <c:pt idx="5">
                  <c:v>0.98937339684865888</c:v>
                </c:pt>
                <c:pt idx="6">
                  <c:v>1.2458776108464638</c:v>
                </c:pt>
                <c:pt idx="7">
                  <c:v>1.3191645291315501</c:v>
                </c:pt>
                <c:pt idx="8">
                  <c:v>1.2825210699890071</c:v>
                </c:pt>
                <c:pt idx="9">
                  <c:v>1.0260168559912133</c:v>
                </c:pt>
                <c:pt idx="10">
                  <c:v>1.0993037742762921</c:v>
                </c:pt>
                <c:pt idx="11">
                  <c:v>0.8427995602784992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3-2380-452E-9084-E04C841310C9}"/>
            </c:ext>
          </c:extLst>
        </c:ser>
        <c:ser>
          <c:idx val="20"/>
          <c:order val="20"/>
          <c:tx>
            <c:strRef>
              <c:f>'5nt_2'!$A$108</c:f>
              <c:strCache>
                <c:ptCount val="1"/>
                <c:pt idx="0">
                  <c:v>UUUAU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108:$M$108</c:f>
              <c:numCache>
                <c:formatCode>General</c:formatCode>
                <c:ptCount val="12"/>
                <c:pt idx="0">
                  <c:v>0.84279956027849923</c:v>
                </c:pt>
                <c:pt idx="1">
                  <c:v>1.0993037742762921</c:v>
                </c:pt>
                <c:pt idx="2">
                  <c:v>1.0260168559912133</c:v>
                </c:pt>
                <c:pt idx="3">
                  <c:v>1.3924514474166361</c:v>
                </c:pt>
                <c:pt idx="4">
                  <c:v>0.732869182850861</c:v>
                </c:pt>
                <c:pt idx="5">
                  <c:v>1.0993037742762921</c:v>
                </c:pt>
                <c:pt idx="6">
                  <c:v>0.98937339684865888</c:v>
                </c:pt>
                <c:pt idx="7">
                  <c:v>1.0993037742762921</c:v>
                </c:pt>
                <c:pt idx="8">
                  <c:v>1.0993037742762921</c:v>
                </c:pt>
                <c:pt idx="9">
                  <c:v>1.0260168559912133</c:v>
                </c:pt>
                <c:pt idx="10">
                  <c:v>1.0626603151337499</c:v>
                </c:pt>
                <c:pt idx="11">
                  <c:v>1.135947233418835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4-2380-452E-9084-E04C841310C9}"/>
            </c:ext>
          </c:extLst>
        </c:ser>
        <c:ser>
          <c:idx val="21"/>
          <c:order val="21"/>
          <c:tx>
            <c:strRef>
              <c:f>'5nt_2'!$A$109</c:f>
              <c:strCache>
                <c:ptCount val="1"/>
                <c:pt idx="0">
                  <c:v>AAAAA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109:$M$109</c:f>
              <c:numCache>
                <c:formatCode>General</c:formatCode>
                <c:ptCount val="12"/>
                <c:pt idx="0">
                  <c:v>0.6229388054232341</c:v>
                </c:pt>
                <c:pt idx="1">
                  <c:v>1.4290949065591676</c:v>
                </c:pt>
                <c:pt idx="2">
                  <c:v>0.732869182850861</c:v>
                </c:pt>
                <c:pt idx="3">
                  <c:v>0.98937339684865888</c:v>
                </c:pt>
                <c:pt idx="4">
                  <c:v>1.5390252839868079</c:v>
                </c:pt>
                <c:pt idx="5">
                  <c:v>1.2825210699890071</c:v>
                </c:pt>
                <c:pt idx="6">
                  <c:v>0.91608647856358116</c:v>
                </c:pt>
                <c:pt idx="7">
                  <c:v>0.98937339684865888</c:v>
                </c:pt>
                <c:pt idx="8">
                  <c:v>0.69622572370831803</c:v>
                </c:pt>
                <c:pt idx="9">
                  <c:v>1.1359472334188352</c:v>
                </c:pt>
                <c:pt idx="10">
                  <c:v>0.69622572370831803</c:v>
                </c:pt>
                <c:pt idx="11">
                  <c:v>0.769512641993403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5-2380-452E-9084-E04C841310C9}"/>
            </c:ext>
          </c:extLst>
        </c:ser>
        <c:ser>
          <c:idx val="22"/>
          <c:order val="22"/>
          <c:tx>
            <c:strRef>
              <c:f>'5nt_2'!$A$110</c:f>
              <c:strCache>
                <c:ptCount val="1"/>
                <c:pt idx="0">
                  <c:v>AAUAU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110:$M$110</c:f>
              <c:numCache>
                <c:formatCode>General</c:formatCode>
                <c:ptCount val="12"/>
                <c:pt idx="0">
                  <c:v>1.1725906925613778</c:v>
                </c:pt>
                <c:pt idx="1">
                  <c:v>0.98937339684865888</c:v>
                </c:pt>
                <c:pt idx="2">
                  <c:v>0.80615610113594183</c:v>
                </c:pt>
                <c:pt idx="3">
                  <c:v>0.76951264199340397</c:v>
                </c:pt>
                <c:pt idx="4">
                  <c:v>1.0626603151337499</c:v>
                </c:pt>
                <c:pt idx="5">
                  <c:v>0.6229388054232341</c:v>
                </c:pt>
                <c:pt idx="6">
                  <c:v>0.95272993770612413</c:v>
                </c:pt>
                <c:pt idx="7">
                  <c:v>1.1725906925613778</c:v>
                </c:pt>
                <c:pt idx="8">
                  <c:v>1.2092341517039198</c:v>
                </c:pt>
                <c:pt idx="9">
                  <c:v>0.98937339684865888</c:v>
                </c:pt>
                <c:pt idx="10">
                  <c:v>0.91608647856358116</c:v>
                </c:pt>
                <c:pt idx="11">
                  <c:v>1.026016855991213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6-2380-452E-9084-E04C841310C9}"/>
            </c:ext>
          </c:extLst>
        </c:ser>
        <c:ser>
          <c:idx val="23"/>
          <c:order val="23"/>
          <c:tx>
            <c:strRef>
              <c:f>'5nt_2'!$A$111</c:f>
              <c:strCache>
                <c:ptCount val="1"/>
                <c:pt idx="0">
                  <c:v>AUAUU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111:$M$111</c:f>
              <c:numCache>
                <c:formatCode>General</c:formatCode>
                <c:ptCount val="12"/>
                <c:pt idx="0">
                  <c:v>0.87944301942103409</c:v>
                </c:pt>
                <c:pt idx="1">
                  <c:v>0.91608647856358116</c:v>
                </c:pt>
                <c:pt idx="2">
                  <c:v>1.1725906925613778</c:v>
                </c:pt>
                <c:pt idx="3">
                  <c:v>0.98937339684865888</c:v>
                </c:pt>
                <c:pt idx="4">
                  <c:v>0.76951264199340397</c:v>
                </c:pt>
                <c:pt idx="5">
                  <c:v>1.0993037742762921</c:v>
                </c:pt>
                <c:pt idx="6">
                  <c:v>0.58629534628068902</c:v>
                </c:pt>
                <c:pt idx="7">
                  <c:v>0.80615610113594183</c:v>
                </c:pt>
                <c:pt idx="8">
                  <c:v>0.91608647856358116</c:v>
                </c:pt>
                <c:pt idx="9">
                  <c:v>1.1725906925613778</c:v>
                </c:pt>
                <c:pt idx="10">
                  <c:v>1.355807988274093</c:v>
                </c:pt>
                <c:pt idx="11">
                  <c:v>0.9527299377061241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7-2380-452E-9084-E04C841310C9}"/>
            </c:ext>
          </c:extLst>
        </c:ser>
        <c:ser>
          <c:idx val="24"/>
          <c:order val="24"/>
          <c:tx>
            <c:strRef>
              <c:f>'5nt_2'!$A$112</c:f>
              <c:strCache>
                <c:ptCount val="1"/>
                <c:pt idx="0">
                  <c:v>AUUAU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112:$M$112</c:f>
              <c:numCache>
                <c:formatCode>General</c:formatCode>
                <c:ptCount val="12"/>
                <c:pt idx="0">
                  <c:v>0.76951264199340397</c:v>
                </c:pt>
                <c:pt idx="1">
                  <c:v>0.69622572370831803</c:v>
                </c:pt>
                <c:pt idx="2">
                  <c:v>0.76951264199340397</c:v>
                </c:pt>
                <c:pt idx="3">
                  <c:v>0.65958226456577607</c:v>
                </c:pt>
                <c:pt idx="4">
                  <c:v>0.80615610113594183</c:v>
                </c:pt>
                <c:pt idx="5">
                  <c:v>0.65958226456577607</c:v>
                </c:pt>
                <c:pt idx="6">
                  <c:v>0.54965188713815116</c:v>
                </c:pt>
                <c:pt idx="7">
                  <c:v>0.51300842799560298</c:v>
                </c:pt>
                <c:pt idx="8">
                  <c:v>0.84279956027849923</c:v>
                </c:pt>
                <c:pt idx="9">
                  <c:v>1.1359472334188352</c:v>
                </c:pt>
                <c:pt idx="10">
                  <c:v>0.87944301942103409</c:v>
                </c:pt>
                <c:pt idx="11">
                  <c:v>0.9160864785635811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8-2380-452E-9084-E04C841310C9}"/>
            </c:ext>
          </c:extLst>
        </c:ser>
        <c:ser>
          <c:idx val="25"/>
          <c:order val="25"/>
          <c:tx>
            <c:strRef>
              <c:f>'5nt_2'!$A$113</c:f>
              <c:strCache>
                <c:ptCount val="1"/>
                <c:pt idx="0">
                  <c:v>UAUUA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113:$M$113</c:f>
              <c:numCache>
                <c:formatCode>General</c:formatCode>
                <c:ptCount val="12"/>
                <c:pt idx="0">
                  <c:v>0.80615610113594183</c:v>
                </c:pt>
                <c:pt idx="1">
                  <c:v>0.87944301942103409</c:v>
                </c:pt>
                <c:pt idx="2">
                  <c:v>0.95272993770612413</c:v>
                </c:pt>
                <c:pt idx="3">
                  <c:v>1.0626603151337499</c:v>
                </c:pt>
                <c:pt idx="4">
                  <c:v>0.84279956027849923</c:v>
                </c:pt>
                <c:pt idx="5">
                  <c:v>0.69622572370831803</c:v>
                </c:pt>
                <c:pt idx="6">
                  <c:v>0.69622572370831803</c:v>
                </c:pt>
                <c:pt idx="7">
                  <c:v>0.69622572370831803</c:v>
                </c:pt>
                <c:pt idx="8">
                  <c:v>0.32979113228288803</c:v>
                </c:pt>
                <c:pt idx="9">
                  <c:v>0.732869182850861</c:v>
                </c:pt>
                <c:pt idx="10">
                  <c:v>0.732869182850861</c:v>
                </c:pt>
                <c:pt idx="11">
                  <c:v>0.5496518871381511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9-2380-452E-9084-E04C841310C9}"/>
            </c:ext>
          </c:extLst>
        </c:ser>
        <c:ser>
          <c:idx val="26"/>
          <c:order val="26"/>
          <c:tx>
            <c:strRef>
              <c:f>'5nt_2'!$A$114</c:f>
              <c:strCache>
                <c:ptCount val="1"/>
                <c:pt idx="0">
                  <c:v>AUAAU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114:$M$114</c:f>
              <c:numCache>
                <c:formatCode>General</c:formatCode>
                <c:ptCount val="12"/>
                <c:pt idx="0">
                  <c:v>0.87944301942103409</c:v>
                </c:pt>
                <c:pt idx="1">
                  <c:v>0.6229388054232341</c:v>
                </c:pt>
                <c:pt idx="2">
                  <c:v>0.65958226456577607</c:v>
                </c:pt>
                <c:pt idx="3">
                  <c:v>0.58629534628068902</c:v>
                </c:pt>
                <c:pt idx="4">
                  <c:v>0.732869182850861</c:v>
                </c:pt>
                <c:pt idx="5">
                  <c:v>0.32979113228288803</c:v>
                </c:pt>
                <c:pt idx="6">
                  <c:v>0.51300842799560298</c:v>
                </c:pt>
                <c:pt idx="7">
                  <c:v>0.58629534628068902</c:v>
                </c:pt>
                <c:pt idx="8">
                  <c:v>0.58629534628068902</c:v>
                </c:pt>
                <c:pt idx="9">
                  <c:v>1.0993037742762921</c:v>
                </c:pt>
                <c:pt idx="10">
                  <c:v>1.0993037742762921</c:v>
                </c:pt>
                <c:pt idx="11">
                  <c:v>1.099303774276292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A-2380-452E-9084-E04C841310C9}"/>
            </c:ext>
          </c:extLst>
        </c:ser>
        <c:ser>
          <c:idx val="27"/>
          <c:order val="27"/>
          <c:tx>
            <c:strRef>
              <c:f>'5nt_2'!$A$115</c:f>
              <c:strCache>
                <c:ptCount val="1"/>
                <c:pt idx="0">
                  <c:v>UAAUA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115:$M$115</c:f>
              <c:numCache>
                <c:formatCode>General</c:formatCode>
                <c:ptCount val="12"/>
                <c:pt idx="0">
                  <c:v>0.69622572370831803</c:v>
                </c:pt>
                <c:pt idx="1">
                  <c:v>0.51300842799560298</c:v>
                </c:pt>
                <c:pt idx="2">
                  <c:v>0.732869182850861</c:v>
                </c:pt>
                <c:pt idx="3">
                  <c:v>0.69622572370831803</c:v>
                </c:pt>
                <c:pt idx="4">
                  <c:v>0.69622572370831803</c:v>
                </c:pt>
                <c:pt idx="5">
                  <c:v>0.69622572370831803</c:v>
                </c:pt>
                <c:pt idx="6">
                  <c:v>0.51300842799560298</c:v>
                </c:pt>
                <c:pt idx="7">
                  <c:v>0.58629534628068902</c:v>
                </c:pt>
                <c:pt idx="8">
                  <c:v>0.6229388054232341</c:v>
                </c:pt>
                <c:pt idx="9">
                  <c:v>0.58629534628068902</c:v>
                </c:pt>
                <c:pt idx="10">
                  <c:v>0.69622572370831803</c:v>
                </c:pt>
                <c:pt idx="11">
                  <c:v>0.586295346280689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B-2380-452E-9084-E04C841310C9}"/>
            </c:ext>
          </c:extLst>
        </c:ser>
        <c:ser>
          <c:idx val="28"/>
          <c:order val="28"/>
          <c:tx>
            <c:strRef>
              <c:f>'5nt_2'!$A$116</c:f>
              <c:strCache>
                <c:ptCount val="1"/>
                <c:pt idx="0">
                  <c:v>AUUCA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116:$M$116</c:f>
              <c:numCache>
                <c:formatCode>General</c:formatCode>
                <c:ptCount val="12"/>
                <c:pt idx="0">
                  <c:v>0.47636496885306412</c:v>
                </c:pt>
                <c:pt idx="1">
                  <c:v>0.47636496885306412</c:v>
                </c:pt>
                <c:pt idx="2">
                  <c:v>0.51300842799560298</c:v>
                </c:pt>
                <c:pt idx="3">
                  <c:v>0.80615610113594183</c:v>
                </c:pt>
                <c:pt idx="4">
                  <c:v>0.43972150971051704</c:v>
                </c:pt>
                <c:pt idx="5">
                  <c:v>0.6229388054232341</c:v>
                </c:pt>
                <c:pt idx="6">
                  <c:v>0.40307805056797402</c:v>
                </c:pt>
                <c:pt idx="7">
                  <c:v>0.732869182850861</c:v>
                </c:pt>
                <c:pt idx="8">
                  <c:v>0.6229388054232341</c:v>
                </c:pt>
                <c:pt idx="9">
                  <c:v>0.51300842799560298</c:v>
                </c:pt>
                <c:pt idx="10">
                  <c:v>0.51300842799560298</c:v>
                </c:pt>
                <c:pt idx="11">
                  <c:v>0.9527299377061241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C-2380-452E-9084-E04C841310C9}"/>
            </c:ext>
          </c:extLst>
        </c:ser>
        <c:ser>
          <c:idx val="29"/>
          <c:order val="29"/>
          <c:tx>
            <c:strRef>
              <c:f>'5nt_2'!$A$117</c:f>
              <c:strCache>
                <c:ptCount val="1"/>
                <c:pt idx="0">
                  <c:v>UUAUA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117:$M$117</c:f>
              <c:numCache>
                <c:formatCode>General</c:formatCode>
                <c:ptCount val="12"/>
                <c:pt idx="0">
                  <c:v>0.84279956027849923</c:v>
                </c:pt>
                <c:pt idx="1">
                  <c:v>0.6229388054232341</c:v>
                </c:pt>
                <c:pt idx="2">
                  <c:v>0.58629534628068902</c:v>
                </c:pt>
                <c:pt idx="3">
                  <c:v>0.69622572370831803</c:v>
                </c:pt>
                <c:pt idx="4">
                  <c:v>0.732869182850861</c:v>
                </c:pt>
                <c:pt idx="5">
                  <c:v>0.65958226456577607</c:v>
                </c:pt>
                <c:pt idx="6">
                  <c:v>0.40307805056797402</c:v>
                </c:pt>
                <c:pt idx="7">
                  <c:v>0.47636496885306412</c:v>
                </c:pt>
                <c:pt idx="8">
                  <c:v>0.54965188713815116</c:v>
                </c:pt>
                <c:pt idx="9">
                  <c:v>0.51300842799560298</c:v>
                </c:pt>
                <c:pt idx="10">
                  <c:v>0.43972150971051704</c:v>
                </c:pt>
                <c:pt idx="11">
                  <c:v>0.5496518871381511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D-2380-452E-9084-E04C841310C9}"/>
            </c:ext>
          </c:extLst>
        </c:ser>
        <c:ser>
          <c:idx val="30"/>
          <c:order val="30"/>
          <c:tx>
            <c:strRef>
              <c:f>'5nt_2'!$A$118</c:f>
              <c:strCache>
                <c:ptCount val="1"/>
                <c:pt idx="0">
                  <c:v>UAUAA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118:$M$118</c:f>
              <c:numCache>
                <c:formatCode>General</c:formatCode>
                <c:ptCount val="12"/>
                <c:pt idx="0">
                  <c:v>0.54965188713815116</c:v>
                </c:pt>
                <c:pt idx="1">
                  <c:v>0.732869182850861</c:v>
                </c:pt>
                <c:pt idx="2">
                  <c:v>0.54965188713815116</c:v>
                </c:pt>
                <c:pt idx="3">
                  <c:v>0.76951264199340397</c:v>
                </c:pt>
                <c:pt idx="4">
                  <c:v>0.58629534628068902</c:v>
                </c:pt>
                <c:pt idx="5">
                  <c:v>0.69622572370831803</c:v>
                </c:pt>
                <c:pt idx="6">
                  <c:v>0.58629534628068902</c:v>
                </c:pt>
                <c:pt idx="7">
                  <c:v>0.43972150971051704</c:v>
                </c:pt>
                <c:pt idx="8">
                  <c:v>0.36643459142543205</c:v>
                </c:pt>
                <c:pt idx="9">
                  <c:v>0.58629534628068902</c:v>
                </c:pt>
                <c:pt idx="10">
                  <c:v>0.51300842799560298</c:v>
                </c:pt>
                <c:pt idx="11">
                  <c:v>0.3664345914254320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E-2380-452E-9084-E04C841310C9}"/>
            </c:ext>
          </c:extLst>
        </c:ser>
        <c:ser>
          <c:idx val="31"/>
          <c:order val="31"/>
          <c:tx>
            <c:strRef>
              <c:f>'5nt_2'!$A$119</c:f>
              <c:strCache>
                <c:ptCount val="1"/>
                <c:pt idx="0">
                  <c:v>CUUUU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119:$M$119</c:f>
              <c:numCache>
                <c:formatCode>General</c:formatCode>
                <c:ptCount val="12"/>
                <c:pt idx="0">
                  <c:v>0.51300842799560298</c:v>
                </c:pt>
                <c:pt idx="1">
                  <c:v>0.58629534628068902</c:v>
                </c:pt>
                <c:pt idx="2">
                  <c:v>0.43972150971051704</c:v>
                </c:pt>
                <c:pt idx="3">
                  <c:v>0.732869182850861</c:v>
                </c:pt>
                <c:pt idx="4">
                  <c:v>0.76951264199340397</c:v>
                </c:pt>
                <c:pt idx="5">
                  <c:v>0.58629534628068902</c:v>
                </c:pt>
                <c:pt idx="6">
                  <c:v>0.54965188713815116</c:v>
                </c:pt>
                <c:pt idx="7">
                  <c:v>0.40307805056797402</c:v>
                </c:pt>
                <c:pt idx="8">
                  <c:v>0.40307805056797402</c:v>
                </c:pt>
                <c:pt idx="9">
                  <c:v>0.732869182850861</c:v>
                </c:pt>
                <c:pt idx="10">
                  <c:v>0.40307805056797402</c:v>
                </c:pt>
                <c:pt idx="11">
                  <c:v>0.513008427995602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F-2380-452E-9084-E04C841310C9}"/>
            </c:ext>
          </c:extLst>
        </c:ser>
        <c:ser>
          <c:idx val="32"/>
          <c:order val="32"/>
          <c:tx>
            <c:strRef>
              <c:f>'5nt_2'!$A$120</c:f>
              <c:strCache>
                <c:ptCount val="1"/>
                <c:pt idx="0">
                  <c:v>UCAAA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120:$M$120</c:f>
              <c:numCache>
                <c:formatCode>General</c:formatCode>
                <c:ptCount val="12"/>
                <c:pt idx="0">
                  <c:v>0.36643459142543205</c:v>
                </c:pt>
                <c:pt idx="1">
                  <c:v>0.43972150971051704</c:v>
                </c:pt>
                <c:pt idx="2">
                  <c:v>0.58629534628068902</c:v>
                </c:pt>
                <c:pt idx="3">
                  <c:v>0.69622572370831803</c:v>
                </c:pt>
                <c:pt idx="4">
                  <c:v>0.80615610113594183</c:v>
                </c:pt>
                <c:pt idx="5">
                  <c:v>0.80615610113594183</c:v>
                </c:pt>
                <c:pt idx="6">
                  <c:v>0.54965188713815116</c:v>
                </c:pt>
                <c:pt idx="7">
                  <c:v>0.54965188713815116</c:v>
                </c:pt>
                <c:pt idx="8">
                  <c:v>0.40307805056797402</c:v>
                </c:pt>
                <c:pt idx="9">
                  <c:v>0.47636496885306412</c:v>
                </c:pt>
                <c:pt idx="10">
                  <c:v>0.40307805056797402</c:v>
                </c:pt>
                <c:pt idx="11">
                  <c:v>0.3664345914254320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0-2380-452E-9084-E04C841310C9}"/>
            </c:ext>
          </c:extLst>
        </c:ser>
        <c:ser>
          <c:idx val="33"/>
          <c:order val="33"/>
          <c:tx>
            <c:strRef>
              <c:f>'5nt_2'!$A$121</c:f>
              <c:strCache>
                <c:ptCount val="1"/>
                <c:pt idx="0">
                  <c:v>UUCAA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121:$M$121</c:f>
              <c:numCache>
                <c:formatCode>General</c:formatCode>
                <c:ptCount val="12"/>
                <c:pt idx="0">
                  <c:v>0.32979113228288803</c:v>
                </c:pt>
                <c:pt idx="1">
                  <c:v>0.54965188713815116</c:v>
                </c:pt>
                <c:pt idx="2">
                  <c:v>0.65958226456577607</c:v>
                </c:pt>
                <c:pt idx="3">
                  <c:v>0.69622572370831803</c:v>
                </c:pt>
                <c:pt idx="4">
                  <c:v>0.87944301942103409</c:v>
                </c:pt>
                <c:pt idx="5">
                  <c:v>0.69622572370831803</c:v>
                </c:pt>
                <c:pt idx="6">
                  <c:v>0.58629534628068902</c:v>
                </c:pt>
                <c:pt idx="7">
                  <c:v>0.32979113228288803</c:v>
                </c:pt>
                <c:pt idx="8">
                  <c:v>0.43972150971051704</c:v>
                </c:pt>
                <c:pt idx="9">
                  <c:v>0.43972150971051704</c:v>
                </c:pt>
                <c:pt idx="10">
                  <c:v>0.40307805056797402</c:v>
                </c:pt>
                <c:pt idx="11">
                  <c:v>0.403078050567974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1-2380-452E-9084-E04C841310C9}"/>
            </c:ext>
          </c:extLst>
        </c:ser>
        <c:ser>
          <c:idx val="34"/>
          <c:order val="34"/>
          <c:tx>
            <c:strRef>
              <c:f>'5nt_2'!$A$122</c:f>
              <c:strCache>
                <c:ptCount val="1"/>
                <c:pt idx="0">
                  <c:v>AUAUA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122:$M$122</c:f>
              <c:numCache>
                <c:formatCode>General</c:formatCode>
                <c:ptCount val="12"/>
                <c:pt idx="0">
                  <c:v>0.47636496885306412</c:v>
                </c:pt>
                <c:pt idx="1">
                  <c:v>0.40307805056797402</c:v>
                </c:pt>
                <c:pt idx="2">
                  <c:v>0.51300842799560298</c:v>
                </c:pt>
                <c:pt idx="3">
                  <c:v>0.58629534628068902</c:v>
                </c:pt>
                <c:pt idx="4">
                  <c:v>0.58629534628068902</c:v>
                </c:pt>
                <c:pt idx="5">
                  <c:v>0.51300842799560298</c:v>
                </c:pt>
                <c:pt idx="6">
                  <c:v>0.32979113228288803</c:v>
                </c:pt>
                <c:pt idx="7">
                  <c:v>0.43972150971051704</c:v>
                </c:pt>
                <c:pt idx="8">
                  <c:v>0.51300842799560298</c:v>
                </c:pt>
                <c:pt idx="9">
                  <c:v>0.69622572370831803</c:v>
                </c:pt>
                <c:pt idx="10">
                  <c:v>0.51300842799560298</c:v>
                </c:pt>
                <c:pt idx="11">
                  <c:v>0.8061561011359418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2-2380-452E-9084-E04C841310C9}"/>
            </c:ext>
          </c:extLst>
        </c:ser>
        <c:ser>
          <c:idx val="35"/>
          <c:order val="35"/>
          <c:tx>
            <c:strRef>
              <c:f>'5nt_2'!$A$123</c:f>
              <c:strCache>
                <c:ptCount val="1"/>
                <c:pt idx="0">
                  <c:v>UUUCA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123:$M$123</c:f>
              <c:numCache>
                <c:formatCode>General</c:formatCode>
                <c:ptCount val="12"/>
                <c:pt idx="0">
                  <c:v>0.32979113228288803</c:v>
                </c:pt>
                <c:pt idx="1">
                  <c:v>0.76951264199340397</c:v>
                </c:pt>
                <c:pt idx="2">
                  <c:v>0.58629534628068902</c:v>
                </c:pt>
                <c:pt idx="3">
                  <c:v>0.58629534628068902</c:v>
                </c:pt>
                <c:pt idx="4">
                  <c:v>0.6229388054232341</c:v>
                </c:pt>
                <c:pt idx="5">
                  <c:v>0.6229388054232341</c:v>
                </c:pt>
                <c:pt idx="6">
                  <c:v>0.51300842799560298</c:v>
                </c:pt>
                <c:pt idx="7">
                  <c:v>0.36643459142543205</c:v>
                </c:pt>
                <c:pt idx="8">
                  <c:v>0.21986075485525802</c:v>
                </c:pt>
                <c:pt idx="9">
                  <c:v>0.32979113228288803</c:v>
                </c:pt>
                <c:pt idx="10">
                  <c:v>0.43972150971051704</c:v>
                </c:pt>
                <c:pt idx="11">
                  <c:v>0.73286918285086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3-2380-452E-9084-E04C841310C9}"/>
            </c:ext>
          </c:extLst>
        </c:ser>
        <c:ser>
          <c:idx val="36"/>
          <c:order val="36"/>
          <c:tx>
            <c:strRef>
              <c:f>'5nt_2'!$A$124</c:f>
              <c:strCache>
                <c:ptCount val="1"/>
                <c:pt idx="0">
                  <c:v>UUUUC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124:$M$124</c:f>
              <c:numCache>
                <c:formatCode>General</c:formatCode>
                <c:ptCount val="12"/>
                <c:pt idx="0">
                  <c:v>0.58629534628068902</c:v>
                </c:pt>
                <c:pt idx="1">
                  <c:v>0.43972150971051704</c:v>
                </c:pt>
                <c:pt idx="2">
                  <c:v>0.80615610113594183</c:v>
                </c:pt>
                <c:pt idx="3">
                  <c:v>0.732869182850861</c:v>
                </c:pt>
                <c:pt idx="4">
                  <c:v>0.65958226456577607</c:v>
                </c:pt>
                <c:pt idx="5">
                  <c:v>0.58629534628068902</c:v>
                </c:pt>
                <c:pt idx="6">
                  <c:v>0.21986075485525802</c:v>
                </c:pt>
                <c:pt idx="7">
                  <c:v>0.51300842799560298</c:v>
                </c:pt>
                <c:pt idx="8">
                  <c:v>0.2565042139978051</c:v>
                </c:pt>
                <c:pt idx="9">
                  <c:v>0.36643459142543205</c:v>
                </c:pt>
                <c:pt idx="10">
                  <c:v>0.47636496885306412</c:v>
                </c:pt>
                <c:pt idx="11">
                  <c:v>0.403078050567974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4-2380-452E-9084-E04C841310C9}"/>
            </c:ext>
          </c:extLst>
        </c:ser>
        <c:ser>
          <c:idx val="37"/>
          <c:order val="37"/>
          <c:tx>
            <c:strRef>
              <c:f>'5nt_2'!$A$125</c:f>
              <c:strCache>
                <c:ptCount val="1"/>
                <c:pt idx="0">
                  <c:v>UAUAU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125:$M$125</c:f>
              <c:numCache>
                <c:formatCode>General</c:formatCode>
                <c:ptCount val="12"/>
                <c:pt idx="0">
                  <c:v>0.32979113228288803</c:v>
                </c:pt>
                <c:pt idx="1">
                  <c:v>0.732869182850861</c:v>
                </c:pt>
                <c:pt idx="2">
                  <c:v>0.51300842799560298</c:v>
                </c:pt>
                <c:pt idx="3">
                  <c:v>0.51300842799560298</c:v>
                </c:pt>
                <c:pt idx="4">
                  <c:v>0.51300842799560298</c:v>
                </c:pt>
                <c:pt idx="5">
                  <c:v>0.40307805056797402</c:v>
                </c:pt>
                <c:pt idx="6">
                  <c:v>0.40307805056797402</c:v>
                </c:pt>
                <c:pt idx="7">
                  <c:v>0.18321729571271705</c:v>
                </c:pt>
                <c:pt idx="8">
                  <c:v>0.54965188713815116</c:v>
                </c:pt>
                <c:pt idx="9">
                  <c:v>0.54965188713815116</c:v>
                </c:pt>
                <c:pt idx="10">
                  <c:v>0.65958226456577607</c:v>
                </c:pt>
                <c:pt idx="11">
                  <c:v>0.513008427995602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5-2380-452E-9084-E04C841310C9}"/>
            </c:ext>
          </c:extLst>
        </c:ser>
        <c:ser>
          <c:idx val="38"/>
          <c:order val="38"/>
          <c:tx>
            <c:strRef>
              <c:f>'5nt_2'!$A$126</c:f>
              <c:strCache>
                <c:ptCount val="1"/>
                <c:pt idx="0">
                  <c:v>CAAAA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126:$M$126</c:f>
              <c:numCache>
                <c:formatCode>General</c:formatCode>
                <c:ptCount val="12"/>
                <c:pt idx="0">
                  <c:v>0.36643459142543205</c:v>
                </c:pt>
                <c:pt idx="1">
                  <c:v>0.43972150971051704</c:v>
                </c:pt>
                <c:pt idx="2">
                  <c:v>0.40307805056797402</c:v>
                </c:pt>
                <c:pt idx="3">
                  <c:v>0.54965188713815116</c:v>
                </c:pt>
                <c:pt idx="4">
                  <c:v>0.54965188713815116</c:v>
                </c:pt>
                <c:pt idx="5">
                  <c:v>0.36643459142543205</c:v>
                </c:pt>
                <c:pt idx="6">
                  <c:v>0.43972150971051704</c:v>
                </c:pt>
                <c:pt idx="7">
                  <c:v>0.54965188713815116</c:v>
                </c:pt>
                <c:pt idx="8">
                  <c:v>0.40307805056797402</c:v>
                </c:pt>
                <c:pt idx="9">
                  <c:v>0.6229388054232341</c:v>
                </c:pt>
                <c:pt idx="10">
                  <c:v>0.58629534628068902</c:v>
                </c:pt>
                <c:pt idx="11">
                  <c:v>0.513008427995602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6-2380-452E-9084-E04C841310C9}"/>
            </c:ext>
          </c:extLst>
        </c:ser>
        <c:ser>
          <c:idx val="39"/>
          <c:order val="39"/>
          <c:tx>
            <c:strRef>
              <c:f>'5nt_2'!$A$127</c:f>
              <c:strCache>
                <c:ptCount val="1"/>
                <c:pt idx="0">
                  <c:v>UUCAU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127:$M$127</c:f>
              <c:numCache>
                <c:formatCode>General</c:formatCode>
                <c:ptCount val="12"/>
                <c:pt idx="0">
                  <c:v>0.21986075485525802</c:v>
                </c:pt>
                <c:pt idx="1">
                  <c:v>0.10993037742763002</c:v>
                </c:pt>
                <c:pt idx="2">
                  <c:v>0.732869182850861</c:v>
                </c:pt>
                <c:pt idx="3">
                  <c:v>0.47636496885306412</c:v>
                </c:pt>
                <c:pt idx="4">
                  <c:v>0.65958226456577607</c:v>
                </c:pt>
                <c:pt idx="5">
                  <c:v>0.54965188713815116</c:v>
                </c:pt>
                <c:pt idx="6">
                  <c:v>0.54965188713815116</c:v>
                </c:pt>
                <c:pt idx="7">
                  <c:v>0.69622572370831803</c:v>
                </c:pt>
                <c:pt idx="8">
                  <c:v>0.51300842799560298</c:v>
                </c:pt>
                <c:pt idx="9">
                  <c:v>0.29314767314034607</c:v>
                </c:pt>
                <c:pt idx="10">
                  <c:v>0.40307805056797402</c:v>
                </c:pt>
                <c:pt idx="11">
                  <c:v>0.513008427995602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7-2380-452E-9084-E04C841310C9}"/>
            </c:ext>
          </c:extLst>
        </c:ser>
        <c:ser>
          <c:idx val="40"/>
          <c:order val="40"/>
          <c:tx>
            <c:strRef>
              <c:f>'5nt_2'!$A$128</c:f>
              <c:strCache>
                <c:ptCount val="1"/>
                <c:pt idx="0">
                  <c:v>UUCUU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128:$M$128</c:f>
              <c:numCache>
                <c:formatCode>General</c:formatCode>
                <c:ptCount val="12"/>
                <c:pt idx="0">
                  <c:v>0.40307805056797402</c:v>
                </c:pt>
                <c:pt idx="1">
                  <c:v>0.58629534628068902</c:v>
                </c:pt>
                <c:pt idx="2">
                  <c:v>0.40307805056797402</c:v>
                </c:pt>
                <c:pt idx="3">
                  <c:v>0.43972150971051704</c:v>
                </c:pt>
                <c:pt idx="4">
                  <c:v>0.43972150971051704</c:v>
                </c:pt>
                <c:pt idx="5">
                  <c:v>0.36643459142543205</c:v>
                </c:pt>
                <c:pt idx="6">
                  <c:v>0.43972150971051704</c:v>
                </c:pt>
                <c:pt idx="7">
                  <c:v>0.54965188713815116</c:v>
                </c:pt>
                <c:pt idx="8">
                  <c:v>0.43972150971051704</c:v>
                </c:pt>
                <c:pt idx="9">
                  <c:v>0.43972150971051704</c:v>
                </c:pt>
                <c:pt idx="10">
                  <c:v>0.36643459142543205</c:v>
                </c:pt>
                <c:pt idx="11">
                  <c:v>0.696225723708318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8-2380-452E-9084-E04C841310C9}"/>
            </c:ext>
          </c:extLst>
        </c:ser>
        <c:ser>
          <c:idx val="41"/>
          <c:order val="41"/>
          <c:tx>
            <c:strRef>
              <c:f>'5nt_2'!$A$129</c:f>
              <c:strCache>
                <c:ptCount val="1"/>
                <c:pt idx="0">
                  <c:v>AAAUC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129:$M$129</c:f>
              <c:numCache>
                <c:formatCode>General</c:formatCode>
                <c:ptCount val="12"/>
                <c:pt idx="0">
                  <c:v>0.32979113228288803</c:v>
                </c:pt>
                <c:pt idx="1">
                  <c:v>0.2565042139978051</c:v>
                </c:pt>
                <c:pt idx="2">
                  <c:v>0.21986075485525802</c:v>
                </c:pt>
                <c:pt idx="3">
                  <c:v>0.80615610113594183</c:v>
                </c:pt>
                <c:pt idx="4">
                  <c:v>0.14657383657017303</c:v>
                </c:pt>
                <c:pt idx="5">
                  <c:v>0.47636496885306412</c:v>
                </c:pt>
                <c:pt idx="6">
                  <c:v>0.54965188713815116</c:v>
                </c:pt>
                <c:pt idx="7">
                  <c:v>0.54965188713815116</c:v>
                </c:pt>
                <c:pt idx="8">
                  <c:v>0.6229388054232341</c:v>
                </c:pt>
                <c:pt idx="9">
                  <c:v>0.65958226456577607</c:v>
                </c:pt>
                <c:pt idx="10">
                  <c:v>0.6229388054232341</c:v>
                </c:pt>
                <c:pt idx="11">
                  <c:v>0.329791132282888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9-2380-452E-9084-E04C841310C9}"/>
            </c:ext>
          </c:extLst>
        </c:ser>
        <c:ser>
          <c:idx val="42"/>
          <c:order val="42"/>
          <c:tx>
            <c:strRef>
              <c:f>'5nt_2'!$A$130</c:f>
              <c:strCache>
                <c:ptCount val="1"/>
                <c:pt idx="0">
                  <c:v>AAUUC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130:$M$130</c:f>
              <c:numCache>
                <c:formatCode>General</c:formatCode>
                <c:ptCount val="12"/>
                <c:pt idx="0">
                  <c:v>0.21986075485525802</c:v>
                </c:pt>
                <c:pt idx="1">
                  <c:v>0.47636496885306412</c:v>
                </c:pt>
                <c:pt idx="2">
                  <c:v>0.58629534628068902</c:v>
                </c:pt>
                <c:pt idx="3">
                  <c:v>0.2565042139978051</c:v>
                </c:pt>
                <c:pt idx="4">
                  <c:v>0.43972150971051704</c:v>
                </c:pt>
                <c:pt idx="5">
                  <c:v>0.2565042139978051</c:v>
                </c:pt>
                <c:pt idx="6">
                  <c:v>0.36643459142543205</c:v>
                </c:pt>
                <c:pt idx="7">
                  <c:v>0.54965188713815116</c:v>
                </c:pt>
                <c:pt idx="8">
                  <c:v>0.6229388054232341</c:v>
                </c:pt>
                <c:pt idx="9">
                  <c:v>0.6229388054232341</c:v>
                </c:pt>
                <c:pt idx="10">
                  <c:v>0.54965188713815116</c:v>
                </c:pt>
                <c:pt idx="11">
                  <c:v>0.3664345914254320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A-2380-452E-9084-E04C841310C9}"/>
            </c:ext>
          </c:extLst>
        </c:ser>
        <c:ser>
          <c:idx val="43"/>
          <c:order val="43"/>
          <c:tx>
            <c:strRef>
              <c:f>'5nt_2'!$A$131</c:f>
              <c:strCache>
                <c:ptCount val="1"/>
                <c:pt idx="0">
                  <c:v>UUUCU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131:$M$131</c:f>
              <c:numCache>
                <c:formatCode>General</c:formatCode>
                <c:ptCount val="12"/>
                <c:pt idx="0">
                  <c:v>0.18321729571271705</c:v>
                </c:pt>
                <c:pt idx="1">
                  <c:v>0.47636496885306412</c:v>
                </c:pt>
                <c:pt idx="2">
                  <c:v>0.29314767314034607</c:v>
                </c:pt>
                <c:pt idx="3">
                  <c:v>0.69622572370831803</c:v>
                </c:pt>
                <c:pt idx="4">
                  <c:v>0.6229388054232341</c:v>
                </c:pt>
                <c:pt idx="5">
                  <c:v>0.43972150971051704</c:v>
                </c:pt>
                <c:pt idx="6">
                  <c:v>0.6229388054232341</c:v>
                </c:pt>
                <c:pt idx="7">
                  <c:v>0.36643459142543205</c:v>
                </c:pt>
                <c:pt idx="8">
                  <c:v>0.58629534628068902</c:v>
                </c:pt>
                <c:pt idx="9">
                  <c:v>0.14657383657017303</c:v>
                </c:pt>
                <c:pt idx="10">
                  <c:v>0.43972150971051704</c:v>
                </c:pt>
                <c:pt idx="11">
                  <c:v>0.329791132282888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B-2380-452E-9084-E04C841310C9}"/>
            </c:ext>
          </c:extLst>
        </c:ser>
        <c:ser>
          <c:idx val="44"/>
          <c:order val="44"/>
          <c:tx>
            <c:strRef>
              <c:f>'5nt_2'!$A$132</c:f>
              <c:strCache>
                <c:ptCount val="1"/>
                <c:pt idx="0">
                  <c:v>AUUUC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132:$M$132</c:f>
              <c:numCache>
                <c:formatCode>General</c:formatCode>
                <c:ptCount val="12"/>
                <c:pt idx="0">
                  <c:v>0.51300842799560298</c:v>
                </c:pt>
                <c:pt idx="1">
                  <c:v>0.43972150971051704</c:v>
                </c:pt>
                <c:pt idx="2">
                  <c:v>0.2565042139978051</c:v>
                </c:pt>
                <c:pt idx="3">
                  <c:v>0.47636496885306412</c:v>
                </c:pt>
                <c:pt idx="4">
                  <c:v>0.14657383657017303</c:v>
                </c:pt>
                <c:pt idx="5">
                  <c:v>0.40307805056797402</c:v>
                </c:pt>
                <c:pt idx="6">
                  <c:v>0.54965188713815116</c:v>
                </c:pt>
                <c:pt idx="7">
                  <c:v>0.21986075485525802</c:v>
                </c:pt>
                <c:pt idx="8">
                  <c:v>0.32979113228288803</c:v>
                </c:pt>
                <c:pt idx="9">
                  <c:v>0.40307805056797402</c:v>
                </c:pt>
                <c:pt idx="10">
                  <c:v>0.65958226456577607</c:v>
                </c:pt>
                <c:pt idx="11">
                  <c:v>0.696225723708318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C-2380-452E-9084-E04C841310C9}"/>
            </c:ext>
          </c:extLst>
        </c:ser>
        <c:ser>
          <c:idx val="45"/>
          <c:order val="45"/>
          <c:tx>
            <c:strRef>
              <c:f>'5nt_2'!$A$133</c:f>
              <c:strCache>
                <c:ptCount val="1"/>
                <c:pt idx="0">
                  <c:v>ACUUU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133:$M$133</c:f>
              <c:numCache>
                <c:formatCode>General</c:formatCode>
                <c:ptCount val="12"/>
                <c:pt idx="0">
                  <c:v>0.58629534628068902</c:v>
                </c:pt>
                <c:pt idx="1">
                  <c:v>0.51300842799560298</c:v>
                </c:pt>
                <c:pt idx="2">
                  <c:v>0.51300842799560298</c:v>
                </c:pt>
                <c:pt idx="3">
                  <c:v>0.40307805056797402</c:v>
                </c:pt>
                <c:pt idx="4">
                  <c:v>0.40307805056797402</c:v>
                </c:pt>
                <c:pt idx="5">
                  <c:v>0.36643459142543205</c:v>
                </c:pt>
                <c:pt idx="6">
                  <c:v>0.47636496885306412</c:v>
                </c:pt>
                <c:pt idx="7">
                  <c:v>0.18321729571271705</c:v>
                </c:pt>
                <c:pt idx="8">
                  <c:v>0.29314767314034607</c:v>
                </c:pt>
                <c:pt idx="9">
                  <c:v>0.40307805056797402</c:v>
                </c:pt>
                <c:pt idx="10">
                  <c:v>0.43972150971051704</c:v>
                </c:pt>
                <c:pt idx="11">
                  <c:v>0.439721509710517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D-2380-452E-9084-E04C841310C9}"/>
            </c:ext>
          </c:extLst>
        </c:ser>
        <c:ser>
          <c:idx val="46"/>
          <c:order val="46"/>
          <c:tx>
            <c:strRef>
              <c:f>'5nt_2'!$A$134</c:f>
              <c:strCache>
                <c:ptCount val="1"/>
                <c:pt idx="0">
                  <c:v>UUACU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134:$M$134</c:f>
              <c:numCache>
                <c:formatCode>General</c:formatCode>
                <c:ptCount val="12"/>
                <c:pt idx="0">
                  <c:v>0.65958226456577607</c:v>
                </c:pt>
                <c:pt idx="1">
                  <c:v>0.40307805056797402</c:v>
                </c:pt>
                <c:pt idx="2">
                  <c:v>0.54965188713815116</c:v>
                </c:pt>
                <c:pt idx="3">
                  <c:v>0.32979113228288803</c:v>
                </c:pt>
                <c:pt idx="4">
                  <c:v>0.40307805056797402</c:v>
                </c:pt>
                <c:pt idx="5">
                  <c:v>0.36643459142543205</c:v>
                </c:pt>
                <c:pt idx="6">
                  <c:v>0.32979113228288803</c:v>
                </c:pt>
                <c:pt idx="7">
                  <c:v>0.29314767314034607</c:v>
                </c:pt>
                <c:pt idx="8">
                  <c:v>0.51300842799560298</c:v>
                </c:pt>
                <c:pt idx="9">
                  <c:v>0.43972150971051704</c:v>
                </c:pt>
                <c:pt idx="10">
                  <c:v>0.32979113228288803</c:v>
                </c:pt>
                <c:pt idx="11">
                  <c:v>0.403078050567974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E-2380-452E-9084-E04C841310C9}"/>
            </c:ext>
          </c:extLst>
        </c:ser>
        <c:ser>
          <c:idx val="47"/>
          <c:order val="47"/>
          <c:tx>
            <c:strRef>
              <c:f>'5nt_2'!$A$135</c:f>
              <c:strCache>
                <c:ptCount val="1"/>
                <c:pt idx="0">
                  <c:v>UCAUU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135:$M$135</c:f>
              <c:numCache>
                <c:formatCode>General</c:formatCode>
                <c:ptCount val="12"/>
                <c:pt idx="0">
                  <c:v>0.32979113228288803</c:v>
                </c:pt>
                <c:pt idx="1">
                  <c:v>0.43972150971051704</c:v>
                </c:pt>
                <c:pt idx="2">
                  <c:v>0.36643459142543205</c:v>
                </c:pt>
                <c:pt idx="3">
                  <c:v>0.43972150971051704</c:v>
                </c:pt>
                <c:pt idx="4">
                  <c:v>0.47636496885306412</c:v>
                </c:pt>
                <c:pt idx="5">
                  <c:v>0.29314767314034607</c:v>
                </c:pt>
                <c:pt idx="6">
                  <c:v>0.54965188713815116</c:v>
                </c:pt>
                <c:pt idx="7">
                  <c:v>0.43972150971051704</c:v>
                </c:pt>
                <c:pt idx="8">
                  <c:v>0.36643459142543205</c:v>
                </c:pt>
                <c:pt idx="9">
                  <c:v>0.29314767314034607</c:v>
                </c:pt>
                <c:pt idx="10">
                  <c:v>0.43972150971051704</c:v>
                </c:pt>
                <c:pt idx="11">
                  <c:v>0.4763649688530641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F-2380-452E-9084-E04C841310C9}"/>
            </c:ext>
          </c:extLst>
        </c:ser>
        <c:ser>
          <c:idx val="48"/>
          <c:order val="48"/>
          <c:tx>
            <c:strRef>
              <c:f>'5nt_2'!$A$136</c:f>
              <c:strCache>
                <c:ptCount val="1"/>
                <c:pt idx="0">
                  <c:v>UUUUG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136:$M$136</c:f>
              <c:numCache>
                <c:formatCode>General</c:formatCode>
                <c:ptCount val="12"/>
                <c:pt idx="0">
                  <c:v>0.43972150971051704</c:v>
                </c:pt>
                <c:pt idx="1">
                  <c:v>0.10993037742763002</c:v>
                </c:pt>
                <c:pt idx="2">
                  <c:v>0.43972150971051704</c:v>
                </c:pt>
                <c:pt idx="3">
                  <c:v>0.51300842799560298</c:v>
                </c:pt>
                <c:pt idx="4">
                  <c:v>0.54965188713815116</c:v>
                </c:pt>
                <c:pt idx="5">
                  <c:v>0.36643459142543205</c:v>
                </c:pt>
                <c:pt idx="6">
                  <c:v>0.54965188713815116</c:v>
                </c:pt>
                <c:pt idx="7">
                  <c:v>0.43972150971051704</c:v>
                </c:pt>
                <c:pt idx="8">
                  <c:v>0.2565042139978051</c:v>
                </c:pt>
                <c:pt idx="9">
                  <c:v>0.43972150971051704</c:v>
                </c:pt>
                <c:pt idx="10">
                  <c:v>0.43972150971051704</c:v>
                </c:pt>
                <c:pt idx="11">
                  <c:v>0.3664345914254320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0-2380-452E-9084-E04C841310C9}"/>
            </c:ext>
          </c:extLst>
        </c:ser>
        <c:ser>
          <c:idx val="49"/>
          <c:order val="49"/>
          <c:tx>
            <c:strRef>
              <c:f>'5nt_2'!$A$137</c:f>
              <c:strCache>
                <c:ptCount val="1"/>
                <c:pt idx="0">
                  <c:v>AUCUU</c:v>
                </c:pt>
              </c:strCache>
            </c:strRef>
          </c:tx>
          <c:marker>
            <c:symbol val="none"/>
          </c:marker>
          <c:cat>
            <c:numRef>
              <c:f>'5nt_2'!$B$87:$M$87</c:f>
              <c:numCache>
                <c:formatCode>General</c:formatCode>
                <c:ptCount val="12"/>
                <c:pt idx="0">
                  <c:v>-20</c:v>
                </c:pt>
                <c:pt idx="1">
                  <c:v>-19</c:v>
                </c:pt>
                <c:pt idx="2">
                  <c:v>-18</c:v>
                </c:pt>
                <c:pt idx="3">
                  <c:v>-17</c:v>
                </c:pt>
                <c:pt idx="4">
                  <c:v>-16</c:v>
                </c:pt>
                <c:pt idx="5">
                  <c:v>-15</c:v>
                </c:pt>
                <c:pt idx="6">
                  <c:v>-14</c:v>
                </c:pt>
                <c:pt idx="7">
                  <c:v>-13</c:v>
                </c:pt>
                <c:pt idx="8">
                  <c:v>-12</c:v>
                </c:pt>
                <c:pt idx="9">
                  <c:v>-11</c:v>
                </c:pt>
                <c:pt idx="10">
                  <c:v>-10</c:v>
                </c:pt>
                <c:pt idx="11">
                  <c:v>-9</c:v>
                </c:pt>
              </c:numCache>
            </c:numRef>
          </c:cat>
          <c:val>
            <c:numRef>
              <c:f>'5nt_2'!$B$137:$M$137</c:f>
              <c:numCache>
                <c:formatCode>General</c:formatCode>
                <c:ptCount val="12"/>
                <c:pt idx="0">
                  <c:v>0.43972150971051704</c:v>
                </c:pt>
                <c:pt idx="1">
                  <c:v>0.36643459142543205</c:v>
                </c:pt>
                <c:pt idx="2">
                  <c:v>0.65958226456577607</c:v>
                </c:pt>
                <c:pt idx="3">
                  <c:v>0.32979113228288803</c:v>
                </c:pt>
                <c:pt idx="4">
                  <c:v>0.36643459142543205</c:v>
                </c:pt>
                <c:pt idx="5">
                  <c:v>0.36643459142543205</c:v>
                </c:pt>
                <c:pt idx="6">
                  <c:v>0.29314767314034607</c:v>
                </c:pt>
                <c:pt idx="7">
                  <c:v>0.21986075485525802</c:v>
                </c:pt>
                <c:pt idx="8">
                  <c:v>0.43972150971051704</c:v>
                </c:pt>
                <c:pt idx="9">
                  <c:v>0.29314767314034607</c:v>
                </c:pt>
                <c:pt idx="10">
                  <c:v>0.40307805056797402</c:v>
                </c:pt>
                <c:pt idx="11">
                  <c:v>0.6595822645657760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1-2380-452E-9084-E04C841310C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80616832"/>
        <c:axId val="80647296"/>
      </c:lineChart>
      <c:catAx>
        <c:axId val="806168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zh-CN"/>
            </a:pPr>
            <a:endParaRPr lang="en-US"/>
          </a:p>
        </c:txPr>
        <c:crossAx val="80647296"/>
        <c:crosses val="autoZero"/>
        <c:auto val="1"/>
        <c:lblAlgn val="ctr"/>
        <c:lblOffset val="100"/>
        <c:noMultiLvlLbl val="0"/>
      </c:catAx>
      <c:valAx>
        <c:axId val="806472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zh-CN"/>
            </a:pPr>
            <a:endParaRPr lang="en-US"/>
          </a:p>
        </c:txPr>
        <c:crossAx val="8061683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1.9191388955168607E-3"/>
          <c:y val="0.64569631002007222"/>
          <c:w val="0.98865325167687812"/>
          <c:h val="0.34835186042921107"/>
        </c:manualLayout>
      </c:layout>
      <c:overlay val="0"/>
      <c:txPr>
        <a:bodyPr/>
        <a:lstStyle/>
        <a:p>
          <a:pPr>
            <a:defRPr lang="zh-CN" sz="600" baseline="0"/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6183752578373009E-2"/>
          <c:y val="0.12547274839832601"/>
          <c:w val="0.96381624742162697"/>
          <c:h val="0.34222479542998308"/>
        </c:manualLayout>
      </c:layout>
      <c:lineChart>
        <c:grouping val="standard"/>
        <c:varyColors val="0"/>
        <c:ser>
          <c:idx val="0"/>
          <c:order val="0"/>
          <c:tx>
            <c:strRef>
              <c:f>'NUE-5nt'!$A$62</c:f>
              <c:strCache>
                <c:ptCount val="1"/>
                <c:pt idx="0">
                  <c:v>UGUAA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62:$R$62</c:f>
              <c:numCache>
                <c:formatCode>General</c:formatCode>
                <c:ptCount val="17"/>
                <c:pt idx="0">
                  <c:v>0.12771392081737104</c:v>
                </c:pt>
                <c:pt idx="1">
                  <c:v>0.25542784163473803</c:v>
                </c:pt>
                <c:pt idx="2">
                  <c:v>0.63856960408684604</c:v>
                </c:pt>
                <c:pt idx="3">
                  <c:v>1.1494252873563218</c:v>
                </c:pt>
                <c:pt idx="4">
                  <c:v>2.2988505747126431</c:v>
                </c:pt>
                <c:pt idx="5">
                  <c:v>2.2988505747126431</c:v>
                </c:pt>
                <c:pt idx="6">
                  <c:v>4.8531289910600304</c:v>
                </c:pt>
                <c:pt idx="7">
                  <c:v>3.5759897828863605</c:v>
                </c:pt>
                <c:pt idx="8">
                  <c:v>4.7254150702426436</c:v>
                </c:pt>
                <c:pt idx="9">
                  <c:v>2.9374201787994889</c:v>
                </c:pt>
                <c:pt idx="10">
                  <c:v>2.426564495530013</c:v>
                </c:pt>
                <c:pt idx="11">
                  <c:v>1.7879948914431536</c:v>
                </c:pt>
                <c:pt idx="12">
                  <c:v>1.021711366538953</c:v>
                </c:pt>
                <c:pt idx="13">
                  <c:v>0.76628352490421492</c:v>
                </c:pt>
                <c:pt idx="14">
                  <c:v>1.4048531289910702</c:v>
                </c:pt>
                <c:pt idx="15">
                  <c:v>0.25542784163473803</c:v>
                </c:pt>
                <c:pt idx="16">
                  <c:v>0.255427841634738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EBA-42F2-9AAB-B419A77AFF71}"/>
            </c:ext>
          </c:extLst>
        </c:ser>
        <c:ser>
          <c:idx val="1"/>
          <c:order val="1"/>
          <c:tx>
            <c:strRef>
              <c:f>'NUE-5nt'!$A$63</c:f>
              <c:strCache>
                <c:ptCount val="1"/>
                <c:pt idx="0">
                  <c:v>UUGUA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63:$R$63</c:f>
              <c:numCache>
                <c:formatCode>General</c:formatCode>
                <c:ptCount val="17"/>
                <c:pt idx="0">
                  <c:v>0.12771392081737104</c:v>
                </c:pt>
                <c:pt idx="1">
                  <c:v>0.25542784163473803</c:v>
                </c:pt>
                <c:pt idx="2">
                  <c:v>0.51085568326948316</c:v>
                </c:pt>
                <c:pt idx="3">
                  <c:v>1.2771392081736788</c:v>
                </c:pt>
                <c:pt idx="4">
                  <c:v>1.5325670498084301</c:v>
                </c:pt>
                <c:pt idx="5">
                  <c:v>3.9591315453384452</c:v>
                </c:pt>
                <c:pt idx="6">
                  <c:v>2.8097062579821404</c:v>
                </c:pt>
                <c:pt idx="7">
                  <c:v>3.3205619412516012</c:v>
                </c:pt>
                <c:pt idx="8">
                  <c:v>2.0434227330779065</c:v>
                </c:pt>
                <c:pt idx="9">
                  <c:v>1.5325670498084301</c:v>
                </c:pt>
                <c:pt idx="10">
                  <c:v>1.2771392081736788</c:v>
                </c:pt>
                <c:pt idx="11">
                  <c:v>0.76628352490421492</c:v>
                </c:pt>
                <c:pt idx="12">
                  <c:v>0.76628352490421492</c:v>
                </c:pt>
                <c:pt idx="13">
                  <c:v>1.021711366538953</c:v>
                </c:pt>
                <c:pt idx="14">
                  <c:v>0.25542784163473803</c:v>
                </c:pt>
                <c:pt idx="15">
                  <c:v>0</c:v>
                </c:pt>
                <c:pt idx="16">
                  <c:v>0.127713920817371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EBA-42F2-9AAB-B419A77AFF71}"/>
            </c:ext>
          </c:extLst>
        </c:ser>
        <c:ser>
          <c:idx val="2"/>
          <c:order val="2"/>
          <c:tx>
            <c:strRef>
              <c:f>'NUE-5nt'!$A$64</c:f>
              <c:strCache>
                <c:ptCount val="1"/>
                <c:pt idx="0">
                  <c:v>GUAAU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64:$R$64</c:f>
              <c:numCache>
                <c:formatCode>General</c:formatCode>
                <c:ptCount val="17"/>
                <c:pt idx="0">
                  <c:v>0.12771392081737104</c:v>
                </c:pt>
                <c:pt idx="1">
                  <c:v>0.12771392081737104</c:v>
                </c:pt>
                <c:pt idx="2">
                  <c:v>0.12771392081737104</c:v>
                </c:pt>
                <c:pt idx="3">
                  <c:v>0.76628352490421492</c:v>
                </c:pt>
                <c:pt idx="4">
                  <c:v>0.63856960408684604</c:v>
                </c:pt>
                <c:pt idx="5">
                  <c:v>1.6602809706258164</c:v>
                </c:pt>
                <c:pt idx="6">
                  <c:v>1.9157088122605359</c:v>
                </c:pt>
                <c:pt idx="7">
                  <c:v>2.6819923371647509</c:v>
                </c:pt>
                <c:pt idx="8">
                  <c:v>2.171136653895275</c:v>
                </c:pt>
                <c:pt idx="9">
                  <c:v>2.2988505747126431</c:v>
                </c:pt>
                <c:pt idx="10">
                  <c:v>1.7879948914431536</c:v>
                </c:pt>
                <c:pt idx="11">
                  <c:v>0.89399744572158402</c:v>
                </c:pt>
                <c:pt idx="12">
                  <c:v>1.1494252873563218</c:v>
                </c:pt>
                <c:pt idx="13">
                  <c:v>0.38314176245210702</c:v>
                </c:pt>
                <c:pt idx="14">
                  <c:v>0.63856960408684604</c:v>
                </c:pt>
                <c:pt idx="15">
                  <c:v>0.63856960408684604</c:v>
                </c:pt>
                <c:pt idx="16">
                  <c:v>0.383141762452107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8EBA-42F2-9AAB-B419A77AFF71}"/>
            </c:ext>
          </c:extLst>
        </c:ser>
        <c:ser>
          <c:idx val="3"/>
          <c:order val="3"/>
          <c:tx>
            <c:strRef>
              <c:f>'NUE-5nt'!$A$65</c:f>
              <c:strCache>
                <c:ptCount val="1"/>
                <c:pt idx="0">
                  <c:v>UAAUA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65:$R$65</c:f>
              <c:numCache>
                <c:formatCode>General</c:formatCode>
                <c:ptCount val="17"/>
                <c:pt idx="0">
                  <c:v>0</c:v>
                </c:pt>
                <c:pt idx="1">
                  <c:v>0.25542784163473803</c:v>
                </c:pt>
                <c:pt idx="2">
                  <c:v>0.12771392081737104</c:v>
                </c:pt>
                <c:pt idx="3">
                  <c:v>0.25542784163473803</c:v>
                </c:pt>
                <c:pt idx="4">
                  <c:v>0.12771392081737104</c:v>
                </c:pt>
                <c:pt idx="5">
                  <c:v>0.51085568326948316</c:v>
                </c:pt>
                <c:pt idx="6">
                  <c:v>0.63856960408684604</c:v>
                </c:pt>
                <c:pt idx="7">
                  <c:v>1.021711366538953</c:v>
                </c:pt>
                <c:pt idx="8">
                  <c:v>2.8097062579821404</c:v>
                </c:pt>
                <c:pt idx="9">
                  <c:v>1.4048531289910702</c:v>
                </c:pt>
                <c:pt idx="10">
                  <c:v>1.2771392081736788</c:v>
                </c:pt>
                <c:pt idx="11">
                  <c:v>0.63856960408684604</c:v>
                </c:pt>
                <c:pt idx="12">
                  <c:v>1.021711366538953</c:v>
                </c:pt>
                <c:pt idx="13">
                  <c:v>1.021711366538953</c:v>
                </c:pt>
                <c:pt idx="14">
                  <c:v>0.76628352490421492</c:v>
                </c:pt>
                <c:pt idx="15">
                  <c:v>0.63856960408684604</c:v>
                </c:pt>
                <c:pt idx="16">
                  <c:v>0.255427841634738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8EBA-42F2-9AAB-B419A77AFF71}"/>
            </c:ext>
          </c:extLst>
        </c:ser>
        <c:ser>
          <c:idx val="4"/>
          <c:order val="4"/>
          <c:tx>
            <c:strRef>
              <c:f>'NUE-5nt'!$A$66</c:f>
              <c:strCache>
                <c:ptCount val="1"/>
                <c:pt idx="0">
                  <c:v>UUUGU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66:$R$66</c:f>
              <c:numCache>
                <c:formatCode>General</c:formatCode>
                <c:ptCount val="17"/>
                <c:pt idx="0">
                  <c:v>0.38314176245210702</c:v>
                </c:pt>
                <c:pt idx="1">
                  <c:v>1.1494252873563218</c:v>
                </c:pt>
                <c:pt idx="2">
                  <c:v>0.63856960408684604</c:v>
                </c:pt>
                <c:pt idx="3">
                  <c:v>1.021711366538953</c:v>
                </c:pt>
                <c:pt idx="4">
                  <c:v>1.7879948914431536</c:v>
                </c:pt>
                <c:pt idx="5">
                  <c:v>1.6602809706258164</c:v>
                </c:pt>
                <c:pt idx="6">
                  <c:v>1.1494252873563218</c:v>
                </c:pt>
                <c:pt idx="7">
                  <c:v>1.2771392081736788</c:v>
                </c:pt>
                <c:pt idx="8">
                  <c:v>0.63856960408684604</c:v>
                </c:pt>
                <c:pt idx="9">
                  <c:v>0.51085568326948316</c:v>
                </c:pt>
                <c:pt idx="10">
                  <c:v>0.25542784163473803</c:v>
                </c:pt>
                <c:pt idx="11">
                  <c:v>0.63856960408684604</c:v>
                </c:pt>
                <c:pt idx="12">
                  <c:v>0.38314176245210702</c:v>
                </c:pt>
                <c:pt idx="13">
                  <c:v>0.12771392081737104</c:v>
                </c:pt>
                <c:pt idx="14">
                  <c:v>0</c:v>
                </c:pt>
                <c:pt idx="15">
                  <c:v>0.25542784163473803</c:v>
                </c:pt>
                <c:pt idx="16">
                  <c:v>0.127713920817371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8EBA-42F2-9AAB-B419A77AFF71}"/>
            </c:ext>
          </c:extLst>
        </c:ser>
        <c:ser>
          <c:idx val="5"/>
          <c:order val="5"/>
          <c:tx>
            <c:strRef>
              <c:f>'NUE-5nt'!$A$67</c:f>
              <c:strCache>
                <c:ptCount val="1"/>
                <c:pt idx="0">
                  <c:v>AAUAA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67:$R$67</c:f>
              <c:numCache>
                <c:formatCode>General</c:formatCode>
                <c:ptCount val="17"/>
                <c:pt idx="0">
                  <c:v>0.51085568326948316</c:v>
                </c:pt>
                <c:pt idx="1">
                  <c:v>0</c:v>
                </c:pt>
                <c:pt idx="2">
                  <c:v>0.38314176245210702</c:v>
                </c:pt>
                <c:pt idx="3">
                  <c:v>0.12771392081737104</c:v>
                </c:pt>
                <c:pt idx="4">
                  <c:v>0.12771392081737104</c:v>
                </c:pt>
                <c:pt idx="5">
                  <c:v>0.12771392081737104</c:v>
                </c:pt>
                <c:pt idx="6">
                  <c:v>0.38314176245210702</c:v>
                </c:pt>
                <c:pt idx="7">
                  <c:v>1.1494252873563218</c:v>
                </c:pt>
                <c:pt idx="8">
                  <c:v>1.1494252873563218</c:v>
                </c:pt>
                <c:pt idx="9">
                  <c:v>1.5325670498084301</c:v>
                </c:pt>
                <c:pt idx="10">
                  <c:v>1.021711366538953</c:v>
                </c:pt>
                <c:pt idx="11">
                  <c:v>0.63856960408684604</c:v>
                </c:pt>
                <c:pt idx="12">
                  <c:v>1.2771392081736788</c:v>
                </c:pt>
                <c:pt idx="13">
                  <c:v>1.1494252873563218</c:v>
                </c:pt>
                <c:pt idx="14">
                  <c:v>1.021711366538953</c:v>
                </c:pt>
                <c:pt idx="15">
                  <c:v>0.38314176245210702</c:v>
                </c:pt>
                <c:pt idx="16">
                  <c:v>0.5108556832694831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8EBA-42F2-9AAB-B419A77AFF71}"/>
            </c:ext>
          </c:extLst>
        </c:ser>
        <c:ser>
          <c:idx val="6"/>
          <c:order val="6"/>
          <c:tx>
            <c:strRef>
              <c:f>'NUE-5nt'!$A$68</c:f>
              <c:strCache>
                <c:ptCount val="1"/>
                <c:pt idx="0">
                  <c:v>UUAAU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68:$R$68</c:f>
              <c:numCache>
                <c:formatCode>General</c:formatCode>
                <c:ptCount val="17"/>
                <c:pt idx="0">
                  <c:v>0.25542784163473803</c:v>
                </c:pt>
                <c:pt idx="1">
                  <c:v>0</c:v>
                </c:pt>
                <c:pt idx="2">
                  <c:v>0.38314176245210702</c:v>
                </c:pt>
                <c:pt idx="3">
                  <c:v>0.12771392081737104</c:v>
                </c:pt>
                <c:pt idx="4">
                  <c:v>0.38314176245210702</c:v>
                </c:pt>
                <c:pt idx="5">
                  <c:v>1.021711366538953</c:v>
                </c:pt>
                <c:pt idx="6">
                  <c:v>1.1494252873563218</c:v>
                </c:pt>
                <c:pt idx="7">
                  <c:v>1.7879948914431536</c:v>
                </c:pt>
                <c:pt idx="8">
                  <c:v>1.1494252873563218</c:v>
                </c:pt>
                <c:pt idx="9">
                  <c:v>0.76628352490421492</c:v>
                </c:pt>
                <c:pt idx="10">
                  <c:v>1.4048531289910702</c:v>
                </c:pt>
                <c:pt idx="11">
                  <c:v>0.76628352490421492</c:v>
                </c:pt>
                <c:pt idx="12">
                  <c:v>0.38314176245210702</c:v>
                </c:pt>
                <c:pt idx="13">
                  <c:v>0.63856960408684604</c:v>
                </c:pt>
                <c:pt idx="14">
                  <c:v>0.63856960408684604</c:v>
                </c:pt>
                <c:pt idx="15">
                  <c:v>0.12771392081737104</c:v>
                </c:pt>
                <c:pt idx="16">
                  <c:v>0.255427841634738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8EBA-42F2-9AAB-B419A77AFF71}"/>
            </c:ext>
          </c:extLst>
        </c:ser>
        <c:ser>
          <c:idx val="7"/>
          <c:order val="7"/>
          <c:tx>
            <c:strRef>
              <c:f>'NUE-5nt'!$A$69</c:f>
              <c:strCache>
                <c:ptCount val="1"/>
                <c:pt idx="0">
                  <c:v>UAAUU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69:$R$69</c:f>
              <c:numCache>
                <c:formatCode>General</c:formatCode>
                <c:ptCount val="17"/>
                <c:pt idx="0">
                  <c:v>0.12771392081737104</c:v>
                </c:pt>
                <c:pt idx="1">
                  <c:v>0.25542784163473803</c:v>
                </c:pt>
                <c:pt idx="2">
                  <c:v>0.12771392081737104</c:v>
                </c:pt>
                <c:pt idx="3">
                  <c:v>0.12771392081737104</c:v>
                </c:pt>
                <c:pt idx="4">
                  <c:v>0.76628352490421492</c:v>
                </c:pt>
                <c:pt idx="5">
                  <c:v>0.63856960408684604</c:v>
                </c:pt>
                <c:pt idx="6">
                  <c:v>1.021711366538953</c:v>
                </c:pt>
                <c:pt idx="7">
                  <c:v>1.2771392081736788</c:v>
                </c:pt>
                <c:pt idx="8">
                  <c:v>1.2771392081736788</c:v>
                </c:pt>
                <c:pt idx="9">
                  <c:v>0.63856960408684604</c:v>
                </c:pt>
                <c:pt idx="10">
                  <c:v>1.2771392081736788</c:v>
                </c:pt>
                <c:pt idx="11">
                  <c:v>1.2771392081736788</c:v>
                </c:pt>
                <c:pt idx="12">
                  <c:v>0.12771392081737104</c:v>
                </c:pt>
                <c:pt idx="13">
                  <c:v>0.63856960408684604</c:v>
                </c:pt>
                <c:pt idx="14">
                  <c:v>0.63856960408684604</c:v>
                </c:pt>
                <c:pt idx="15">
                  <c:v>0.38314176245210702</c:v>
                </c:pt>
                <c:pt idx="16">
                  <c:v>0.5108556832694831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8EBA-42F2-9AAB-B419A77AFF71}"/>
            </c:ext>
          </c:extLst>
        </c:ser>
        <c:ser>
          <c:idx val="8"/>
          <c:order val="8"/>
          <c:tx>
            <c:strRef>
              <c:f>'NUE-5nt'!$A$70</c:f>
              <c:strCache>
                <c:ptCount val="1"/>
                <c:pt idx="0">
                  <c:v>UUUAA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70:$R$70</c:f>
              <c:numCache>
                <c:formatCode>General</c:formatCode>
                <c:ptCount val="17"/>
                <c:pt idx="0">
                  <c:v>0.12771392081737104</c:v>
                </c:pt>
                <c:pt idx="1">
                  <c:v>0.51085568326948316</c:v>
                </c:pt>
                <c:pt idx="2">
                  <c:v>0.12771392081737104</c:v>
                </c:pt>
                <c:pt idx="3">
                  <c:v>0.63856960408684604</c:v>
                </c:pt>
                <c:pt idx="4">
                  <c:v>0.51085568326948316</c:v>
                </c:pt>
                <c:pt idx="5">
                  <c:v>0.89399744572158402</c:v>
                </c:pt>
                <c:pt idx="6">
                  <c:v>2.2988505747126431</c:v>
                </c:pt>
                <c:pt idx="7">
                  <c:v>1.1494252873563218</c:v>
                </c:pt>
                <c:pt idx="8">
                  <c:v>0.76628352490421492</c:v>
                </c:pt>
                <c:pt idx="9">
                  <c:v>1.2771392081736788</c:v>
                </c:pt>
                <c:pt idx="10">
                  <c:v>0.51085568326948316</c:v>
                </c:pt>
                <c:pt idx="11">
                  <c:v>0.38314176245210702</c:v>
                </c:pt>
                <c:pt idx="12">
                  <c:v>0.51085568326948316</c:v>
                </c:pt>
                <c:pt idx="13">
                  <c:v>0.38314176245210702</c:v>
                </c:pt>
                <c:pt idx="14">
                  <c:v>0.51085568326948316</c:v>
                </c:pt>
                <c:pt idx="15">
                  <c:v>0.25542784163473803</c:v>
                </c:pt>
                <c:pt idx="16">
                  <c:v>0.127713920817371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8EBA-42F2-9AAB-B419A77AFF71}"/>
            </c:ext>
          </c:extLst>
        </c:ser>
        <c:ser>
          <c:idx val="9"/>
          <c:order val="9"/>
          <c:tx>
            <c:strRef>
              <c:f>'NUE-5nt'!$A$71</c:f>
              <c:strCache>
                <c:ptCount val="1"/>
                <c:pt idx="0">
                  <c:v>GUUGU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71:$R$71</c:f>
              <c:numCache>
                <c:formatCode>General</c:formatCode>
                <c:ptCount val="17"/>
                <c:pt idx="0">
                  <c:v>0.12771392081737104</c:v>
                </c:pt>
                <c:pt idx="1">
                  <c:v>0.51085568326948316</c:v>
                </c:pt>
                <c:pt idx="2">
                  <c:v>1.021711366538953</c:v>
                </c:pt>
                <c:pt idx="3">
                  <c:v>1.021711366538953</c:v>
                </c:pt>
                <c:pt idx="4">
                  <c:v>2.0434227330779065</c:v>
                </c:pt>
                <c:pt idx="5">
                  <c:v>1.1494252873563218</c:v>
                </c:pt>
                <c:pt idx="6">
                  <c:v>1.7879948914431536</c:v>
                </c:pt>
                <c:pt idx="7">
                  <c:v>1.021711366538953</c:v>
                </c:pt>
                <c:pt idx="8">
                  <c:v>0.51085568326948316</c:v>
                </c:pt>
                <c:pt idx="9">
                  <c:v>0.51085568326948316</c:v>
                </c:pt>
                <c:pt idx="10">
                  <c:v>0.38314176245210702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8EBA-42F2-9AAB-B419A77AFF71}"/>
            </c:ext>
          </c:extLst>
        </c:ser>
        <c:ser>
          <c:idx val="10"/>
          <c:order val="10"/>
          <c:tx>
            <c:strRef>
              <c:f>'NUE-5nt'!$A$72</c:f>
              <c:strCache>
                <c:ptCount val="1"/>
                <c:pt idx="0">
                  <c:v>UUUUA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72:$R$72</c:f>
              <c:numCache>
                <c:formatCode>General</c:formatCode>
                <c:ptCount val="17"/>
                <c:pt idx="0">
                  <c:v>0.51085568326948316</c:v>
                </c:pt>
                <c:pt idx="1">
                  <c:v>0</c:v>
                </c:pt>
                <c:pt idx="2">
                  <c:v>0.89399744572158402</c:v>
                </c:pt>
                <c:pt idx="3">
                  <c:v>0.25542784163473803</c:v>
                </c:pt>
                <c:pt idx="4">
                  <c:v>0.51085568326948316</c:v>
                </c:pt>
                <c:pt idx="5">
                  <c:v>1.9157088122605359</c:v>
                </c:pt>
                <c:pt idx="6">
                  <c:v>1.1494252873563218</c:v>
                </c:pt>
                <c:pt idx="7">
                  <c:v>1.021711366538953</c:v>
                </c:pt>
                <c:pt idx="8">
                  <c:v>0.89399744572158402</c:v>
                </c:pt>
                <c:pt idx="9">
                  <c:v>0.51085568326948316</c:v>
                </c:pt>
                <c:pt idx="10">
                  <c:v>0.25542784163473803</c:v>
                </c:pt>
                <c:pt idx="11">
                  <c:v>0.25542784163473803</c:v>
                </c:pt>
                <c:pt idx="12">
                  <c:v>0.51085568326948316</c:v>
                </c:pt>
                <c:pt idx="13">
                  <c:v>0.38314176245210702</c:v>
                </c:pt>
                <c:pt idx="14">
                  <c:v>0.25542784163473803</c:v>
                </c:pt>
                <c:pt idx="15">
                  <c:v>0.12771392081737104</c:v>
                </c:pt>
                <c:pt idx="16">
                  <c:v>0.255427841634738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8EBA-42F2-9AAB-B419A77AFF71}"/>
            </c:ext>
          </c:extLst>
        </c:ser>
        <c:ser>
          <c:idx val="11"/>
          <c:order val="11"/>
          <c:tx>
            <c:strRef>
              <c:f>'NUE-5nt'!$A$73</c:f>
              <c:strCache>
                <c:ptCount val="1"/>
                <c:pt idx="0">
                  <c:v>AAUUU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73:$R$73</c:f>
              <c:numCache>
                <c:formatCode>General</c:formatCode>
                <c:ptCount val="17"/>
                <c:pt idx="0">
                  <c:v>0.25542784163473803</c:v>
                </c:pt>
                <c:pt idx="1">
                  <c:v>0.51085568326948316</c:v>
                </c:pt>
                <c:pt idx="2">
                  <c:v>0.63856960408684604</c:v>
                </c:pt>
                <c:pt idx="3">
                  <c:v>0.25542784163473803</c:v>
                </c:pt>
                <c:pt idx="4">
                  <c:v>0.76628352490421492</c:v>
                </c:pt>
                <c:pt idx="5">
                  <c:v>0.12771392081737104</c:v>
                </c:pt>
                <c:pt idx="6">
                  <c:v>0.51085568326948316</c:v>
                </c:pt>
                <c:pt idx="7">
                  <c:v>0.25542784163473803</c:v>
                </c:pt>
                <c:pt idx="8">
                  <c:v>0.51085568326948316</c:v>
                </c:pt>
                <c:pt idx="9">
                  <c:v>0.89399744572158402</c:v>
                </c:pt>
                <c:pt idx="10">
                  <c:v>0.38314176245210702</c:v>
                </c:pt>
                <c:pt idx="11">
                  <c:v>1.021711366538953</c:v>
                </c:pt>
                <c:pt idx="12">
                  <c:v>1.2771392081736788</c:v>
                </c:pt>
                <c:pt idx="13">
                  <c:v>0.51085568326948316</c:v>
                </c:pt>
                <c:pt idx="14">
                  <c:v>0.38314176245210702</c:v>
                </c:pt>
                <c:pt idx="15">
                  <c:v>0.38314176245210702</c:v>
                </c:pt>
                <c:pt idx="16">
                  <c:v>0.7662835249042149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8EBA-42F2-9AAB-B419A77AFF71}"/>
            </c:ext>
          </c:extLst>
        </c:ser>
        <c:ser>
          <c:idx val="12"/>
          <c:order val="12"/>
          <c:tx>
            <c:strRef>
              <c:f>'NUE-5nt'!$A$74</c:f>
              <c:strCache>
                <c:ptCount val="1"/>
                <c:pt idx="0">
                  <c:v>GUAAA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74:$R$74</c:f>
              <c:numCache>
                <c:formatCode>General</c:formatCode>
                <c:ptCount val="17"/>
                <c:pt idx="0">
                  <c:v>0.38314176245210702</c:v>
                </c:pt>
                <c:pt idx="1">
                  <c:v>0</c:v>
                </c:pt>
                <c:pt idx="2">
                  <c:v>0.12771392081737104</c:v>
                </c:pt>
                <c:pt idx="3">
                  <c:v>0</c:v>
                </c:pt>
                <c:pt idx="4">
                  <c:v>0.38314176245210702</c:v>
                </c:pt>
                <c:pt idx="5">
                  <c:v>0.76628352490421492</c:v>
                </c:pt>
                <c:pt idx="6">
                  <c:v>0.25542784163473803</c:v>
                </c:pt>
                <c:pt idx="7">
                  <c:v>1.1494252873563218</c:v>
                </c:pt>
                <c:pt idx="8">
                  <c:v>1.4048531289910702</c:v>
                </c:pt>
                <c:pt idx="9">
                  <c:v>1.1494252873563218</c:v>
                </c:pt>
                <c:pt idx="10">
                  <c:v>0.76628352490421492</c:v>
                </c:pt>
                <c:pt idx="11">
                  <c:v>0.76628352490421492</c:v>
                </c:pt>
                <c:pt idx="12">
                  <c:v>0.38314176245210702</c:v>
                </c:pt>
                <c:pt idx="13">
                  <c:v>0.51085568326948316</c:v>
                </c:pt>
                <c:pt idx="14">
                  <c:v>0.25542784163473803</c:v>
                </c:pt>
                <c:pt idx="15">
                  <c:v>0.51085568326948316</c:v>
                </c:pt>
                <c:pt idx="16">
                  <c:v>0.127713920817371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C-8EBA-42F2-9AAB-B419A77AFF71}"/>
            </c:ext>
          </c:extLst>
        </c:ser>
        <c:ser>
          <c:idx val="13"/>
          <c:order val="13"/>
          <c:tx>
            <c:strRef>
              <c:f>'NUE-5nt'!$A$75</c:f>
              <c:strCache>
                <c:ptCount val="1"/>
                <c:pt idx="0">
                  <c:v>AUGUA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75:$R$75</c:f>
              <c:numCache>
                <c:formatCode>General</c:formatCode>
                <c:ptCount val="17"/>
                <c:pt idx="0">
                  <c:v>0.38314176245210702</c:v>
                </c:pt>
                <c:pt idx="1">
                  <c:v>0.25542784163473803</c:v>
                </c:pt>
                <c:pt idx="2">
                  <c:v>0.12771392081737104</c:v>
                </c:pt>
                <c:pt idx="3">
                  <c:v>0.76628352490421492</c:v>
                </c:pt>
                <c:pt idx="4">
                  <c:v>0.63856960408684604</c:v>
                </c:pt>
                <c:pt idx="5">
                  <c:v>0.51085568326948316</c:v>
                </c:pt>
                <c:pt idx="6">
                  <c:v>1.2771392081736788</c:v>
                </c:pt>
                <c:pt idx="7">
                  <c:v>1.021711366538953</c:v>
                </c:pt>
                <c:pt idx="8">
                  <c:v>1.021711366538953</c:v>
                </c:pt>
                <c:pt idx="9">
                  <c:v>1.021711366538953</c:v>
                </c:pt>
                <c:pt idx="10">
                  <c:v>0.51085568326948316</c:v>
                </c:pt>
                <c:pt idx="11">
                  <c:v>0</c:v>
                </c:pt>
                <c:pt idx="12">
                  <c:v>0.12771392081737104</c:v>
                </c:pt>
                <c:pt idx="13">
                  <c:v>0.38314176245210702</c:v>
                </c:pt>
                <c:pt idx="14">
                  <c:v>0.25542784163473803</c:v>
                </c:pt>
                <c:pt idx="15">
                  <c:v>0.12771392081737104</c:v>
                </c:pt>
                <c:pt idx="16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D-8EBA-42F2-9AAB-B419A77AFF71}"/>
            </c:ext>
          </c:extLst>
        </c:ser>
        <c:ser>
          <c:idx val="14"/>
          <c:order val="14"/>
          <c:tx>
            <c:strRef>
              <c:f>'NUE-5nt'!$A$76</c:f>
              <c:strCache>
                <c:ptCount val="1"/>
                <c:pt idx="0">
                  <c:v>UAACA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76:$R$76</c:f>
              <c:numCache>
                <c:formatCode>General</c:formatCode>
                <c:ptCount val="17"/>
                <c:pt idx="0">
                  <c:v>0.12771392081737104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.12771392081737104</c:v>
                </c:pt>
                <c:pt idx="5">
                  <c:v>0.38314176245210702</c:v>
                </c:pt>
                <c:pt idx="6">
                  <c:v>0.12771392081737104</c:v>
                </c:pt>
                <c:pt idx="7">
                  <c:v>0.38314176245210702</c:v>
                </c:pt>
                <c:pt idx="8">
                  <c:v>0.76628352490421492</c:v>
                </c:pt>
                <c:pt idx="9">
                  <c:v>0.63856960408684604</c:v>
                </c:pt>
                <c:pt idx="10">
                  <c:v>1.2771392081736788</c:v>
                </c:pt>
                <c:pt idx="11">
                  <c:v>0.76628352490421492</c:v>
                </c:pt>
                <c:pt idx="12">
                  <c:v>0.63856960408684604</c:v>
                </c:pt>
                <c:pt idx="13">
                  <c:v>0.76628352490421492</c:v>
                </c:pt>
                <c:pt idx="14">
                  <c:v>1.021711366538953</c:v>
                </c:pt>
                <c:pt idx="15">
                  <c:v>0.63856960408684604</c:v>
                </c:pt>
                <c:pt idx="16">
                  <c:v>0.638569604086846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E-8EBA-42F2-9AAB-B419A77AFF71}"/>
            </c:ext>
          </c:extLst>
        </c:ser>
        <c:ser>
          <c:idx val="15"/>
          <c:order val="15"/>
          <c:tx>
            <c:strRef>
              <c:f>'NUE-5nt'!$A$77</c:f>
              <c:strCache>
                <c:ptCount val="1"/>
                <c:pt idx="0">
                  <c:v>UAAUC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77:$R$77</c:f>
              <c:numCache>
                <c:formatCode>General</c:formatCode>
                <c:ptCount val="17"/>
                <c:pt idx="0">
                  <c:v>0.12771392081737104</c:v>
                </c:pt>
                <c:pt idx="1">
                  <c:v>0.12771392081737104</c:v>
                </c:pt>
                <c:pt idx="2">
                  <c:v>0</c:v>
                </c:pt>
                <c:pt idx="3">
                  <c:v>0.12771392081737104</c:v>
                </c:pt>
                <c:pt idx="4">
                  <c:v>0.12771392081737104</c:v>
                </c:pt>
                <c:pt idx="5">
                  <c:v>0.25542784163473803</c:v>
                </c:pt>
                <c:pt idx="6">
                  <c:v>1.021711366538953</c:v>
                </c:pt>
                <c:pt idx="7">
                  <c:v>0.51085568326948316</c:v>
                </c:pt>
                <c:pt idx="8">
                  <c:v>0.63856960408684604</c:v>
                </c:pt>
                <c:pt idx="9">
                  <c:v>1.2771392081736788</c:v>
                </c:pt>
                <c:pt idx="10">
                  <c:v>0.63856960408684604</c:v>
                </c:pt>
                <c:pt idx="11">
                  <c:v>0.89399744572158402</c:v>
                </c:pt>
                <c:pt idx="12">
                  <c:v>0.63856960408684604</c:v>
                </c:pt>
                <c:pt idx="13">
                  <c:v>0.12771392081737104</c:v>
                </c:pt>
                <c:pt idx="14">
                  <c:v>0.25542784163473803</c:v>
                </c:pt>
                <c:pt idx="15">
                  <c:v>0.63856960408684604</c:v>
                </c:pt>
                <c:pt idx="16">
                  <c:v>0.638569604086846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F-8EBA-42F2-9AAB-B419A77AFF71}"/>
            </c:ext>
          </c:extLst>
        </c:ser>
        <c:ser>
          <c:idx val="16"/>
          <c:order val="16"/>
          <c:tx>
            <c:strRef>
              <c:f>'NUE-5nt'!$A$78</c:f>
              <c:strCache>
                <c:ptCount val="1"/>
                <c:pt idx="0">
                  <c:v>UCAAU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78:$R$78</c:f>
              <c:numCache>
                <c:formatCode>General</c:formatCode>
                <c:ptCount val="17"/>
                <c:pt idx="0">
                  <c:v>0.25542784163473803</c:v>
                </c:pt>
                <c:pt idx="1">
                  <c:v>0.25542784163473803</c:v>
                </c:pt>
                <c:pt idx="2">
                  <c:v>0.12771392081737104</c:v>
                </c:pt>
                <c:pt idx="3">
                  <c:v>0.51085568326948316</c:v>
                </c:pt>
                <c:pt idx="4">
                  <c:v>0.25542784163473803</c:v>
                </c:pt>
                <c:pt idx="5">
                  <c:v>0.51085568326948316</c:v>
                </c:pt>
                <c:pt idx="6">
                  <c:v>0.51085568326948316</c:v>
                </c:pt>
                <c:pt idx="7">
                  <c:v>1.021711366538953</c:v>
                </c:pt>
                <c:pt idx="8">
                  <c:v>0.63856960408684604</c:v>
                </c:pt>
                <c:pt idx="9">
                  <c:v>0.51085568326948316</c:v>
                </c:pt>
                <c:pt idx="10">
                  <c:v>1.021711366538953</c:v>
                </c:pt>
                <c:pt idx="11">
                  <c:v>0.51085568326948316</c:v>
                </c:pt>
                <c:pt idx="12">
                  <c:v>0.63856960408684604</c:v>
                </c:pt>
                <c:pt idx="13">
                  <c:v>0.51085568326948316</c:v>
                </c:pt>
                <c:pt idx="14">
                  <c:v>0.51085568326948316</c:v>
                </c:pt>
                <c:pt idx="15">
                  <c:v>0</c:v>
                </c:pt>
                <c:pt idx="16">
                  <c:v>0.127713920817371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0-8EBA-42F2-9AAB-B419A77AFF71}"/>
            </c:ext>
          </c:extLst>
        </c:ser>
        <c:ser>
          <c:idx val="17"/>
          <c:order val="17"/>
          <c:tx>
            <c:strRef>
              <c:f>'NUE-5nt'!$A$79</c:f>
              <c:strCache>
                <c:ptCount val="1"/>
                <c:pt idx="0">
                  <c:v>AUUUU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79:$R$79</c:f>
              <c:numCache>
                <c:formatCode>General</c:formatCode>
                <c:ptCount val="17"/>
                <c:pt idx="0">
                  <c:v>0.38314176245210702</c:v>
                </c:pt>
                <c:pt idx="1">
                  <c:v>0.25542784163473803</c:v>
                </c:pt>
                <c:pt idx="2">
                  <c:v>0.63856960408684604</c:v>
                </c:pt>
                <c:pt idx="3">
                  <c:v>1.021711366538953</c:v>
                </c:pt>
                <c:pt idx="4">
                  <c:v>0.89399744572158402</c:v>
                </c:pt>
                <c:pt idx="5">
                  <c:v>0.51085568326948316</c:v>
                </c:pt>
                <c:pt idx="6">
                  <c:v>0.89399744572158402</c:v>
                </c:pt>
                <c:pt idx="7">
                  <c:v>0.76628352490421492</c:v>
                </c:pt>
                <c:pt idx="8">
                  <c:v>0</c:v>
                </c:pt>
                <c:pt idx="9">
                  <c:v>0.12771392081737104</c:v>
                </c:pt>
                <c:pt idx="10">
                  <c:v>0.38314176245210702</c:v>
                </c:pt>
                <c:pt idx="11">
                  <c:v>0.25542784163473803</c:v>
                </c:pt>
                <c:pt idx="12">
                  <c:v>0.63856960408684604</c:v>
                </c:pt>
                <c:pt idx="13">
                  <c:v>0.51085568326948316</c:v>
                </c:pt>
                <c:pt idx="14">
                  <c:v>0</c:v>
                </c:pt>
                <c:pt idx="15">
                  <c:v>0.12771392081737104</c:v>
                </c:pt>
                <c:pt idx="16">
                  <c:v>0.127713920817371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1-8EBA-42F2-9AAB-B419A77AFF71}"/>
            </c:ext>
          </c:extLst>
        </c:ser>
        <c:ser>
          <c:idx val="18"/>
          <c:order val="18"/>
          <c:tx>
            <c:strRef>
              <c:f>'NUE-5nt'!$A$80</c:f>
              <c:strCache>
                <c:ptCount val="1"/>
                <c:pt idx="0">
                  <c:v>AAUAU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80:$R$80</c:f>
              <c:numCache>
                <c:formatCode>General</c:formatCode>
                <c:ptCount val="17"/>
                <c:pt idx="0">
                  <c:v>0.12771392081737104</c:v>
                </c:pt>
                <c:pt idx="1">
                  <c:v>0</c:v>
                </c:pt>
                <c:pt idx="2">
                  <c:v>0</c:v>
                </c:pt>
                <c:pt idx="3">
                  <c:v>0.12771392081737104</c:v>
                </c:pt>
                <c:pt idx="4">
                  <c:v>0.12771392081737104</c:v>
                </c:pt>
                <c:pt idx="5">
                  <c:v>0.12771392081737104</c:v>
                </c:pt>
                <c:pt idx="6">
                  <c:v>0.12771392081737104</c:v>
                </c:pt>
                <c:pt idx="7">
                  <c:v>0.25542784163473803</c:v>
                </c:pt>
                <c:pt idx="8">
                  <c:v>0.89399744572158402</c:v>
                </c:pt>
                <c:pt idx="9">
                  <c:v>1.1494252873563218</c:v>
                </c:pt>
                <c:pt idx="10">
                  <c:v>0.76628352490421492</c:v>
                </c:pt>
                <c:pt idx="11">
                  <c:v>0.89399744572158402</c:v>
                </c:pt>
                <c:pt idx="12">
                  <c:v>0.63856960408684604</c:v>
                </c:pt>
                <c:pt idx="13">
                  <c:v>0.63856960408684604</c:v>
                </c:pt>
                <c:pt idx="14">
                  <c:v>0.51085568326948316</c:v>
                </c:pt>
                <c:pt idx="15">
                  <c:v>0.51085568326948316</c:v>
                </c:pt>
                <c:pt idx="16">
                  <c:v>0.383141762452107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2-8EBA-42F2-9AAB-B419A77AFF71}"/>
            </c:ext>
          </c:extLst>
        </c:ser>
        <c:ser>
          <c:idx val="19"/>
          <c:order val="19"/>
          <c:tx>
            <c:strRef>
              <c:f>'NUE-5nt'!$A$81</c:f>
              <c:strCache>
                <c:ptCount val="1"/>
                <c:pt idx="0">
                  <c:v>UAAAA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81:$R$81</c:f>
              <c:numCache>
                <c:formatCode>General</c:formatCode>
                <c:ptCount val="17"/>
                <c:pt idx="0">
                  <c:v>0.38314176245210702</c:v>
                </c:pt>
                <c:pt idx="1">
                  <c:v>0.38314176245210702</c:v>
                </c:pt>
                <c:pt idx="2">
                  <c:v>0.12771392081737104</c:v>
                </c:pt>
                <c:pt idx="3">
                  <c:v>0.38314176245210702</c:v>
                </c:pt>
                <c:pt idx="4">
                  <c:v>0</c:v>
                </c:pt>
                <c:pt idx="5">
                  <c:v>0.25542784163473803</c:v>
                </c:pt>
                <c:pt idx="6">
                  <c:v>0.12771392081737104</c:v>
                </c:pt>
                <c:pt idx="7">
                  <c:v>0.12771392081737104</c:v>
                </c:pt>
                <c:pt idx="8">
                  <c:v>0.76628352490421492</c:v>
                </c:pt>
                <c:pt idx="9">
                  <c:v>1.021711366538953</c:v>
                </c:pt>
                <c:pt idx="10">
                  <c:v>0.25542784163473803</c:v>
                </c:pt>
                <c:pt idx="11">
                  <c:v>0.76628352490421492</c:v>
                </c:pt>
                <c:pt idx="12">
                  <c:v>0.63856960408684604</c:v>
                </c:pt>
                <c:pt idx="13">
                  <c:v>0.63856960408684604</c:v>
                </c:pt>
                <c:pt idx="14">
                  <c:v>0.51085568326948316</c:v>
                </c:pt>
                <c:pt idx="15">
                  <c:v>0.38314176245210702</c:v>
                </c:pt>
                <c:pt idx="16">
                  <c:v>0.5108556832694831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3-8EBA-42F2-9AAB-B419A77AFF71}"/>
            </c:ext>
          </c:extLst>
        </c:ser>
        <c:ser>
          <c:idx val="20"/>
          <c:order val="20"/>
          <c:tx>
            <c:strRef>
              <c:f>'NUE-5nt'!$A$82</c:f>
              <c:strCache>
                <c:ptCount val="1"/>
                <c:pt idx="0">
                  <c:v>GUAAC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82:$R$82</c:f>
              <c:numCache>
                <c:formatCode>General</c:formatCode>
                <c:ptCount val="17"/>
                <c:pt idx="0">
                  <c:v>0.12771392081737104</c:v>
                </c:pt>
                <c:pt idx="1">
                  <c:v>0</c:v>
                </c:pt>
                <c:pt idx="2">
                  <c:v>0</c:v>
                </c:pt>
                <c:pt idx="3">
                  <c:v>0.12771392081737104</c:v>
                </c:pt>
                <c:pt idx="4">
                  <c:v>0.12771392081737104</c:v>
                </c:pt>
                <c:pt idx="5">
                  <c:v>0.38314176245210702</c:v>
                </c:pt>
                <c:pt idx="6">
                  <c:v>0.38314176245210702</c:v>
                </c:pt>
                <c:pt idx="7">
                  <c:v>1.1494252873563218</c:v>
                </c:pt>
                <c:pt idx="8">
                  <c:v>0.63856960408684604</c:v>
                </c:pt>
                <c:pt idx="9">
                  <c:v>1.2771392081736788</c:v>
                </c:pt>
                <c:pt idx="10">
                  <c:v>0.63856960408684604</c:v>
                </c:pt>
                <c:pt idx="11">
                  <c:v>0.51085568326948316</c:v>
                </c:pt>
                <c:pt idx="12">
                  <c:v>0.63856960408684604</c:v>
                </c:pt>
                <c:pt idx="13">
                  <c:v>0.51085568326948316</c:v>
                </c:pt>
                <c:pt idx="14">
                  <c:v>0.12771392081737104</c:v>
                </c:pt>
                <c:pt idx="15">
                  <c:v>0.25542784163473803</c:v>
                </c:pt>
                <c:pt idx="16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4-8EBA-42F2-9AAB-B419A77AFF71}"/>
            </c:ext>
          </c:extLst>
        </c:ser>
        <c:ser>
          <c:idx val="21"/>
          <c:order val="21"/>
          <c:tx>
            <c:strRef>
              <c:f>'NUE-5nt'!$A$83</c:f>
              <c:strCache>
                <c:ptCount val="1"/>
                <c:pt idx="0">
                  <c:v>AAUCA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83:$R$83</c:f>
              <c:numCache>
                <c:formatCode>General</c:formatCode>
                <c:ptCount val="17"/>
                <c:pt idx="0">
                  <c:v>0.12771392081737104</c:v>
                </c:pt>
                <c:pt idx="1">
                  <c:v>0</c:v>
                </c:pt>
                <c:pt idx="2">
                  <c:v>0.12771392081737104</c:v>
                </c:pt>
                <c:pt idx="3">
                  <c:v>0.12771392081737104</c:v>
                </c:pt>
                <c:pt idx="4">
                  <c:v>0.25542784163473803</c:v>
                </c:pt>
                <c:pt idx="5">
                  <c:v>0.12771392081737104</c:v>
                </c:pt>
                <c:pt idx="6">
                  <c:v>0</c:v>
                </c:pt>
                <c:pt idx="7">
                  <c:v>0.51085568326948316</c:v>
                </c:pt>
                <c:pt idx="8">
                  <c:v>0.51085568326948316</c:v>
                </c:pt>
                <c:pt idx="9">
                  <c:v>0.51085568326948316</c:v>
                </c:pt>
                <c:pt idx="10">
                  <c:v>0.76628352490421492</c:v>
                </c:pt>
                <c:pt idx="11">
                  <c:v>0.63856960408684604</c:v>
                </c:pt>
                <c:pt idx="12">
                  <c:v>1.1494252873563218</c:v>
                </c:pt>
                <c:pt idx="13">
                  <c:v>0.38314176245210702</c:v>
                </c:pt>
                <c:pt idx="14">
                  <c:v>0.25542784163473803</c:v>
                </c:pt>
                <c:pt idx="15">
                  <c:v>0.25542784163473803</c:v>
                </c:pt>
                <c:pt idx="16">
                  <c:v>0.893997445721584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5-8EBA-42F2-9AAB-B419A77AFF71}"/>
            </c:ext>
          </c:extLst>
        </c:ser>
        <c:ser>
          <c:idx val="22"/>
          <c:order val="22"/>
          <c:tx>
            <c:strRef>
              <c:f>'NUE-5nt'!$A$84</c:f>
              <c:strCache>
                <c:ptCount val="1"/>
                <c:pt idx="0">
                  <c:v>AAAAU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84:$R$84</c:f>
              <c:numCache>
                <c:formatCode>General</c:formatCode>
                <c:ptCount val="17"/>
                <c:pt idx="0">
                  <c:v>0.25542784163473803</c:v>
                </c:pt>
                <c:pt idx="1">
                  <c:v>0.76628352490421492</c:v>
                </c:pt>
                <c:pt idx="2">
                  <c:v>0.38314176245210702</c:v>
                </c:pt>
                <c:pt idx="3">
                  <c:v>0.25542784163473803</c:v>
                </c:pt>
                <c:pt idx="4">
                  <c:v>0.25542784163473803</c:v>
                </c:pt>
                <c:pt idx="5">
                  <c:v>0.25542784163473803</c:v>
                </c:pt>
                <c:pt idx="6">
                  <c:v>0.51085568326948316</c:v>
                </c:pt>
                <c:pt idx="7">
                  <c:v>0</c:v>
                </c:pt>
                <c:pt idx="8">
                  <c:v>0.12771392081737104</c:v>
                </c:pt>
                <c:pt idx="9">
                  <c:v>0.51085568326948316</c:v>
                </c:pt>
                <c:pt idx="10">
                  <c:v>0.51085568326948316</c:v>
                </c:pt>
                <c:pt idx="11">
                  <c:v>0.12771392081737104</c:v>
                </c:pt>
                <c:pt idx="12">
                  <c:v>0.51085568326948316</c:v>
                </c:pt>
                <c:pt idx="13">
                  <c:v>0.51085568326948316</c:v>
                </c:pt>
                <c:pt idx="14">
                  <c:v>0.51085568326948316</c:v>
                </c:pt>
                <c:pt idx="15">
                  <c:v>0.89399744572158402</c:v>
                </c:pt>
                <c:pt idx="16">
                  <c:v>0.255427841634738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6-8EBA-42F2-9AAB-B419A77AFF71}"/>
            </c:ext>
          </c:extLst>
        </c:ser>
        <c:ser>
          <c:idx val="23"/>
          <c:order val="23"/>
          <c:tx>
            <c:strRef>
              <c:f>'NUE-5nt'!$A$85</c:f>
              <c:strCache>
                <c:ptCount val="1"/>
                <c:pt idx="0">
                  <c:v>AUGAA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85:$R$85</c:f>
              <c:numCache>
                <c:formatCode>General</c:formatCode>
                <c:ptCount val="17"/>
                <c:pt idx="0">
                  <c:v>0</c:v>
                </c:pt>
                <c:pt idx="1">
                  <c:v>0.12771392081737104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.76628352490421492</c:v>
                </c:pt>
                <c:pt idx="7">
                  <c:v>0</c:v>
                </c:pt>
                <c:pt idx="8">
                  <c:v>0.38314176245210702</c:v>
                </c:pt>
                <c:pt idx="9">
                  <c:v>0.51085568326948316</c:v>
                </c:pt>
                <c:pt idx="10">
                  <c:v>0.51085568326948316</c:v>
                </c:pt>
                <c:pt idx="11">
                  <c:v>0.63856960408684604</c:v>
                </c:pt>
                <c:pt idx="12">
                  <c:v>0.51085568326948316</c:v>
                </c:pt>
                <c:pt idx="13">
                  <c:v>0.89399744572158402</c:v>
                </c:pt>
                <c:pt idx="14">
                  <c:v>0.76628352490421492</c:v>
                </c:pt>
                <c:pt idx="15">
                  <c:v>0.51085568326948316</c:v>
                </c:pt>
                <c:pt idx="16">
                  <c:v>0.7662835249042149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7-8EBA-42F2-9AAB-B419A77AFF71}"/>
            </c:ext>
          </c:extLst>
        </c:ser>
        <c:ser>
          <c:idx val="24"/>
          <c:order val="24"/>
          <c:tx>
            <c:strRef>
              <c:f>'NUE-5nt'!$A$86</c:f>
              <c:strCache>
                <c:ptCount val="1"/>
                <c:pt idx="0">
                  <c:v>AAUAC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86:$R$86</c:f>
              <c:numCache>
                <c:formatCode>General</c:formatCode>
                <c:ptCount val="17"/>
                <c:pt idx="0">
                  <c:v>0.12771392081737104</c:v>
                </c:pt>
                <c:pt idx="1">
                  <c:v>0</c:v>
                </c:pt>
                <c:pt idx="2">
                  <c:v>0.12771392081737104</c:v>
                </c:pt>
                <c:pt idx="3">
                  <c:v>0</c:v>
                </c:pt>
                <c:pt idx="4">
                  <c:v>0.12771392081737104</c:v>
                </c:pt>
                <c:pt idx="5">
                  <c:v>0</c:v>
                </c:pt>
                <c:pt idx="6">
                  <c:v>0.51085568326948316</c:v>
                </c:pt>
                <c:pt idx="7">
                  <c:v>0.63856960408684604</c:v>
                </c:pt>
                <c:pt idx="8">
                  <c:v>0.25542784163473803</c:v>
                </c:pt>
                <c:pt idx="9">
                  <c:v>1.9157088122605359</c:v>
                </c:pt>
                <c:pt idx="10">
                  <c:v>0.63856960408684604</c:v>
                </c:pt>
                <c:pt idx="11">
                  <c:v>0.51085568326948316</c:v>
                </c:pt>
                <c:pt idx="12">
                  <c:v>0.25542784163473803</c:v>
                </c:pt>
                <c:pt idx="13">
                  <c:v>0.25542784163473803</c:v>
                </c:pt>
                <c:pt idx="14">
                  <c:v>0.38314176245210702</c:v>
                </c:pt>
                <c:pt idx="15">
                  <c:v>0.25542784163473803</c:v>
                </c:pt>
                <c:pt idx="16">
                  <c:v>0.383141762452107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8-8EBA-42F2-9AAB-B419A77AFF71}"/>
            </c:ext>
          </c:extLst>
        </c:ser>
        <c:ser>
          <c:idx val="25"/>
          <c:order val="25"/>
          <c:tx>
            <c:strRef>
              <c:f>'NUE-5nt'!$A$87</c:f>
              <c:strCache>
                <c:ptCount val="1"/>
                <c:pt idx="0">
                  <c:v>AACAA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87:$R$87</c:f>
              <c:numCache>
                <c:formatCode>General</c:formatCode>
                <c:ptCount val="17"/>
                <c:pt idx="0">
                  <c:v>0.12771392081737104</c:v>
                </c:pt>
                <c:pt idx="1">
                  <c:v>0.25542784163473803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.12771392081737104</c:v>
                </c:pt>
                <c:pt idx="6">
                  <c:v>0.12771392081737104</c:v>
                </c:pt>
                <c:pt idx="7">
                  <c:v>0.12771392081737104</c:v>
                </c:pt>
                <c:pt idx="8">
                  <c:v>0.25542784163473803</c:v>
                </c:pt>
                <c:pt idx="9">
                  <c:v>0.76628352490421492</c:v>
                </c:pt>
                <c:pt idx="10">
                  <c:v>0.51085568326948316</c:v>
                </c:pt>
                <c:pt idx="11">
                  <c:v>0.89399744572158402</c:v>
                </c:pt>
                <c:pt idx="12">
                  <c:v>0.25542784163473803</c:v>
                </c:pt>
                <c:pt idx="13">
                  <c:v>0.76628352490421492</c:v>
                </c:pt>
                <c:pt idx="14">
                  <c:v>0.51085568326948316</c:v>
                </c:pt>
                <c:pt idx="15">
                  <c:v>0.89399744572158402</c:v>
                </c:pt>
                <c:pt idx="16">
                  <c:v>0.7662835249042149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9-8EBA-42F2-9AAB-B419A77AFF71}"/>
            </c:ext>
          </c:extLst>
        </c:ser>
        <c:ser>
          <c:idx val="26"/>
          <c:order val="26"/>
          <c:tx>
            <c:strRef>
              <c:f>'NUE-5nt'!$A$88</c:f>
              <c:strCache>
                <c:ptCount val="1"/>
                <c:pt idx="0">
                  <c:v>CUUGU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88:$R$88</c:f>
              <c:numCache>
                <c:formatCode>General</c:formatCode>
                <c:ptCount val="17"/>
                <c:pt idx="0">
                  <c:v>0.12771392081737104</c:v>
                </c:pt>
                <c:pt idx="1">
                  <c:v>0.12771392081737104</c:v>
                </c:pt>
                <c:pt idx="2">
                  <c:v>0.38314176245210702</c:v>
                </c:pt>
                <c:pt idx="3">
                  <c:v>0.63856960408684604</c:v>
                </c:pt>
                <c:pt idx="4">
                  <c:v>0.63856960408684604</c:v>
                </c:pt>
                <c:pt idx="5">
                  <c:v>0.76628352490421492</c:v>
                </c:pt>
                <c:pt idx="6">
                  <c:v>0.63856960408684604</c:v>
                </c:pt>
                <c:pt idx="7">
                  <c:v>0.89399744572158402</c:v>
                </c:pt>
                <c:pt idx="8">
                  <c:v>0.63856960408684604</c:v>
                </c:pt>
                <c:pt idx="9">
                  <c:v>0.25542784163473803</c:v>
                </c:pt>
                <c:pt idx="10">
                  <c:v>0.38314176245210702</c:v>
                </c:pt>
                <c:pt idx="11">
                  <c:v>0.12771392081737104</c:v>
                </c:pt>
                <c:pt idx="12">
                  <c:v>0.51085568326948316</c:v>
                </c:pt>
                <c:pt idx="13">
                  <c:v>0.25542784163473803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A-8EBA-42F2-9AAB-B419A77AFF71}"/>
            </c:ext>
          </c:extLst>
        </c:ser>
        <c:ser>
          <c:idx val="27"/>
          <c:order val="27"/>
          <c:tx>
            <c:strRef>
              <c:f>'NUE-5nt'!$A$89</c:f>
              <c:strCache>
                <c:ptCount val="1"/>
                <c:pt idx="0">
                  <c:v>UUUUG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89:$R$89</c:f>
              <c:numCache>
                <c:formatCode>General</c:formatCode>
                <c:ptCount val="17"/>
                <c:pt idx="0">
                  <c:v>0.38314176245210702</c:v>
                </c:pt>
                <c:pt idx="1">
                  <c:v>0.51085568326948316</c:v>
                </c:pt>
                <c:pt idx="2">
                  <c:v>0.38314176245210702</c:v>
                </c:pt>
                <c:pt idx="3">
                  <c:v>1.021711366538953</c:v>
                </c:pt>
                <c:pt idx="4">
                  <c:v>0.76628352490421492</c:v>
                </c:pt>
                <c:pt idx="5">
                  <c:v>0.89399744572158402</c:v>
                </c:pt>
                <c:pt idx="6">
                  <c:v>0.76628352490421492</c:v>
                </c:pt>
                <c:pt idx="7">
                  <c:v>0.38314176245210702</c:v>
                </c:pt>
                <c:pt idx="8">
                  <c:v>0.38314176245210702</c:v>
                </c:pt>
                <c:pt idx="9">
                  <c:v>0.25542784163473803</c:v>
                </c:pt>
                <c:pt idx="10">
                  <c:v>0.25542784163473803</c:v>
                </c:pt>
                <c:pt idx="11">
                  <c:v>0.12771392081737104</c:v>
                </c:pt>
                <c:pt idx="12">
                  <c:v>0</c:v>
                </c:pt>
                <c:pt idx="13">
                  <c:v>0</c:v>
                </c:pt>
                <c:pt idx="14">
                  <c:v>0.12771392081737104</c:v>
                </c:pt>
                <c:pt idx="15">
                  <c:v>0.12771392081737104</c:v>
                </c:pt>
                <c:pt idx="16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B-8EBA-42F2-9AAB-B419A77AFF71}"/>
            </c:ext>
          </c:extLst>
        </c:ser>
        <c:ser>
          <c:idx val="28"/>
          <c:order val="28"/>
          <c:tx>
            <c:strRef>
              <c:f>'NUE-5nt'!$A$90</c:f>
              <c:strCache>
                <c:ptCount val="1"/>
                <c:pt idx="0">
                  <c:v>AUCAA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90:$R$90</c:f>
              <c:numCache>
                <c:formatCode>General</c:formatCode>
                <c:ptCount val="17"/>
                <c:pt idx="0">
                  <c:v>0.38314176245210702</c:v>
                </c:pt>
                <c:pt idx="1">
                  <c:v>0.12771392081737104</c:v>
                </c:pt>
                <c:pt idx="2">
                  <c:v>0.12771392081737104</c:v>
                </c:pt>
                <c:pt idx="3">
                  <c:v>0.12771392081737104</c:v>
                </c:pt>
                <c:pt idx="4">
                  <c:v>0.25542784163473803</c:v>
                </c:pt>
                <c:pt idx="5">
                  <c:v>0.38314176245210702</c:v>
                </c:pt>
                <c:pt idx="6">
                  <c:v>0.25542784163473803</c:v>
                </c:pt>
                <c:pt idx="7">
                  <c:v>0</c:v>
                </c:pt>
                <c:pt idx="8">
                  <c:v>0.38314176245210702</c:v>
                </c:pt>
                <c:pt idx="9">
                  <c:v>0.76628352490421492</c:v>
                </c:pt>
                <c:pt idx="10">
                  <c:v>0.38314176245210702</c:v>
                </c:pt>
                <c:pt idx="11">
                  <c:v>1.021711366538953</c:v>
                </c:pt>
                <c:pt idx="12">
                  <c:v>0.63856960408684604</c:v>
                </c:pt>
                <c:pt idx="13">
                  <c:v>0.63856960408684604</c:v>
                </c:pt>
                <c:pt idx="14">
                  <c:v>0.38314176245210702</c:v>
                </c:pt>
                <c:pt idx="15">
                  <c:v>0.12771392081737104</c:v>
                </c:pt>
                <c:pt idx="16">
                  <c:v>0.255427841634738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C-8EBA-42F2-9AAB-B419A77AFF71}"/>
            </c:ext>
          </c:extLst>
        </c:ser>
        <c:ser>
          <c:idx val="29"/>
          <c:order val="29"/>
          <c:tx>
            <c:strRef>
              <c:f>'NUE-5nt'!$A$91</c:f>
              <c:strCache>
                <c:ptCount val="1"/>
                <c:pt idx="0">
                  <c:v>UAAAU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91:$R$91</c:f>
              <c:numCache>
                <c:formatCode>General</c:formatCode>
                <c:ptCount val="17"/>
                <c:pt idx="0">
                  <c:v>0</c:v>
                </c:pt>
                <c:pt idx="1">
                  <c:v>0</c:v>
                </c:pt>
                <c:pt idx="2">
                  <c:v>0.12771392081737104</c:v>
                </c:pt>
                <c:pt idx="3">
                  <c:v>0.38314176245210702</c:v>
                </c:pt>
                <c:pt idx="4">
                  <c:v>0.25542784163473803</c:v>
                </c:pt>
                <c:pt idx="5">
                  <c:v>0.25542784163473803</c:v>
                </c:pt>
                <c:pt idx="6">
                  <c:v>0.63856960408684604</c:v>
                </c:pt>
                <c:pt idx="7">
                  <c:v>0.38314176245210702</c:v>
                </c:pt>
                <c:pt idx="8">
                  <c:v>0.51085568326948316</c:v>
                </c:pt>
                <c:pt idx="9">
                  <c:v>0.76628352490421492</c:v>
                </c:pt>
                <c:pt idx="10">
                  <c:v>0.76628352490421492</c:v>
                </c:pt>
                <c:pt idx="11">
                  <c:v>0.38314176245210702</c:v>
                </c:pt>
                <c:pt idx="12">
                  <c:v>0.51085568326948316</c:v>
                </c:pt>
                <c:pt idx="13">
                  <c:v>0.12771392081737104</c:v>
                </c:pt>
                <c:pt idx="14">
                  <c:v>0.12771392081737104</c:v>
                </c:pt>
                <c:pt idx="15">
                  <c:v>0.51085568326948316</c:v>
                </c:pt>
                <c:pt idx="16">
                  <c:v>0.383141762452107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D-8EBA-42F2-9AAB-B419A77AFF71}"/>
            </c:ext>
          </c:extLst>
        </c:ser>
        <c:ser>
          <c:idx val="30"/>
          <c:order val="30"/>
          <c:tx>
            <c:strRef>
              <c:f>'NUE-5nt'!$A$92</c:f>
              <c:strCache>
                <c:ptCount val="1"/>
                <c:pt idx="0">
                  <c:v>UUGUU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92:$R$92</c:f>
              <c:numCache>
                <c:formatCode>General</c:formatCode>
                <c:ptCount val="17"/>
                <c:pt idx="0">
                  <c:v>0</c:v>
                </c:pt>
                <c:pt idx="1">
                  <c:v>0.12771392081737104</c:v>
                </c:pt>
                <c:pt idx="2">
                  <c:v>1.021711366538953</c:v>
                </c:pt>
                <c:pt idx="3">
                  <c:v>1.021711366538953</c:v>
                </c:pt>
                <c:pt idx="4">
                  <c:v>0.63856960408684604</c:v>
                </c:pt>
                <c:pt idx="5">
                  <c:v>0.63856960408684604</c:v>
                </c:pt>
                <c:pt idx="6">
                  <c:v>0.76628352490421492</c:v>
                </c:pt>
                <c:pt idx="7">
                  <c:v>0.25542784163473803</c:v>
                </c:pt>
                <c:pt idx="8">
                  <c:v>0.63856960408684604</c:v>
                </c:pt>
                <c:pt idx="9">
                  <c:v>0.12771392081737104</c:v>
                </c:pt>
                <c:pt idx="10">
                  <c:v>0.12771392081737104</c:v>
                </c:pt>
                <c:pt idx="11">
                  <c:v>0.25542784163473803</c:v>
                </c:pt>
                <c:pt idx="12">
                  <c:v>0.12771392081737104</c:v>
                </c:pt>
                <c:pt idx="13">
                  <c:v>0.12771392081737104</c:v>
                </c:pt>
                <c:pt idx="14">
                  <c:v>0.12771392081737104</c:v>
                </c:pt>
                <c:pt idx="15">
                  <c:v>0.12771392081737104</c:v>
                </c:pt>
                <c:pt idx="16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E-8EBA-42F2-9AAB-B419A77AFF71}"/>
            </c:ext>
          </c:extLst>
        </c:ser>
        <c:ser>
          <c:idx val="31"/>
          <c:order val="31"/>
          <c:tx>
            <c:strRef>
              <c:f>'NUE-5nt'!$A$93</c:f>
              <c:strCache>
                <c:ptCount val="1"/>
                <c:pt idx="0">
                  <c:v>AAUGA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93:$R$93</c:f>
              <c:numCache>
                <c:formatCode>General</c:formatCode>
                <c:ptCount val="17"/>
                <c:pt idx="0">
                  <c:v>0</c:v>
                </c:pt>
                <c:pt idx="1">
                  <c:v>0</c:v>
                </c:pt>
                <c:pt idx="2">
                  <c:v>0.12771392081737104</c:v>
                </c:pt>
                <c:pt idx="3">
                  <c:v>0</c:v>
                </c:pt>
                <c:pt idx="4">
                  <c:v>0.25542784163473803</c:v>
                </c:pt>
                <c:pt idx="5">
                  <c:v>0.51085568326948316</c:v>
                </c:pt>
                <c:pt idx="6">
                  <c:v>0</c:v>
                </c:pt>
                <c:pt idx="7">
                  <c:v>0.12771392081737104</c:v>
                </c:pt>
                <c:pt idx="8">
                  <c:v>0.51085568326948316</c:v>
                </c:pt>
                <c:pt idx="9">
                  <c:v>0.38314176245210702</c:v>
                </c:pt>
                <c:pt idx="10">
                  <c:v>0.38314176245210702</c:v>
                </c:pt>
                <c:pt idx="11">
                  <c:v>0.63856960408684604</c:v>
                </c:pt>
                <c:pt idx="12">
                  <c:v>0.76628352490421492</c:v>
                </c:pt>
                <c:pt idx="13">
                  <c:v>0.76628352490421492</c:v>
                </c:pt>
                <c:pt idx="14">
                  <c:v>0.51085568326948316</c:v>
                </c:pt>
                <c:pt idx="15">
                  <c:v>0.63856960408684604</c:v>
                </c:pt>
                <c:pt idx="16">
                  <c:v>0.383141762452107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F-8EBA-42F2-9AAB-B419A77AFF71}"/>
            </c:ext>
          </c:extLst>
        </c:ser>
        <c:ser>
          <c:idx val="32"/>
          <c:order val="32"/>
          <c:tx>
            <c:strRef>
              <c:f>'NUE-5nt'!$A$94</c:f>
              <c:strCache>
                <c:ptCount val="1"/>
                <c:pt idx="0">
                  <c:v>GUGUA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94:$R$94</c:f>
              <c:numCache>
                <c:formatCode>General</c:formatCode>
                <c:ptCount val="17"/>
                <c:pt idx="0">
                  <c:v>0.25542784163473803</c:v>
                </c:pt>
                <c:pt idx="1">
                  <c:v>0.25542784163473803</c:v>
                </c:pt>
                <c:pt idx="2">
                  <c:v>0.25542784163473803</c:v>
                </c:pt>
                <c:pt idx="3">
                  <c:v>0.76628352490421492</c:v>
                </c:pt>
                <c:pt idx="4">
                  <c:v>0.51085568326948316</c:v>
                </c:pt>
                <c:pt idx="5">
                  <c:v>0.76628352490421492</c:v>
                </c:pt>
                <c:pt idx="6">
                  <c:v>0.51085568326948316</c:v>
                </c:pt>
                <c:pt idx="7">
                  <c:v>0.89399744572158402</c:v>
                </c:pt>
                <c:pt idx="8">
                  <c:v>0.76628352490421492</c:v>
                </c:pt>
                <c:pt idx="9">
                  <c:v>0.38314176245210702</c:v>
                </c:pt>
                <c:pt idx="10">
                  <c:v>0.25542784163473803</c:v>
                </c:pt>
                <c:pt idx="11">
                  <c:v>0</c:v>
                </c:pt>
                <c:pt idx="12">
                  <c:v>0.12771392081737104</c:v>
                </c:pt>
                <c:pt idx="13">
                  <c:v>0.12771392081737104</c:v>
                </c:pt>
                <c:pt idx="14">
                  <c:v>0</c:v>
                </c:pt>
                <c:pt idx="15">
                  <c:v>0.12771392081737104</c:v>
                </c:pt>
                <c:pt idx="16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0-8EBA-42F2-9AAB-B419A77AFF71}"/>
            </c:ext>
          </c:extLst>
        </c:ser>
        <c:ser>
          <c:idx val="33"/>
          <c:order val="33"/>
          <c:tx>
            <c:strRef>
              <c:f>'NUE-5nt'!$A$95</c:f>
              <c:strCache>
                <c:ptCount val="1"/>
                <c:pt idx="0">
                  <c:v>UGAAA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95:$R$95</c:f>
              <c:numCache>
                <c:formatCode>General</c:formatCode>
                <c:ptCount val="17"/>
                <c:pt idx="0">
                  <c:v>0.38314176245210702</c:v>
                </c:pt>
                <c:pt idx="1">
                  <c:v>0.25542784163473803</c:v>
                </c:pt>
                <c:pt idx="2">
                  <c:v>0.38314176245210702</c:v>
                </c:pt>
                <c:pt idx="3">
                  <c:v>0</c:v>
                </c:pt>
                <c:pt idx="4">
                  <c:v>0.38314176245210702</c:v>
                </c:pt>
                <c:pt idx="5">
                  <c:v>0.25542784163473803</c:v>
                </c:pt>
                <c:pt idx="6">
                  <c:v>0.38314176245210702</c:v>
                </c:pt>
                <c:pt idx="7">
                  <c:v>0.89399744572158402</c:v>
                </c:pt>
                <c:pt idx="8">
                  <c:v>0.25542784163473803</c:v>
                </c:pt>
                <c:pt idx="9">
                  <c:v>0.63856960408684604</c:v>
                </c:pt>
                <c:pt idx="10">
                  <c:v>0.38314176245210702</c:v>
                </c:pt>
                <c:pt idx="11">
                  <c:v>0.25542784163473803</c:v>
                </c:pt>
                <c:pt idx="12">
                  <c:v>0.51085568326948316</c:v>
                </c:pt>
                <c:pt idx="13">
                  <c:v>0.38314176245210702</c:v>
                </c:pt>
                <c:pt idx="14">
                  <c:v>0.12771392081737104</c:v>
                </c:pt>
                <c:pt idx="15">
                  <c:v>0.38314176245210702</c:v>
                </c:pt>
                <c:pt idx="16">
                  <c:v>0.127713920817371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1-8EBA-42F2-9AAB-B419A77AFF71}"/>
            </c:ext>
          </c:extLst>
        </c:ser>
        <c:ser>
          <c:idx val="34"/>
          <c:order val="34"/>
          <c:tx>
            <c:strRef>
              <c:f>'NUE-5nt'!$A$96</c:f>
              <c:strCache>
                <c:ptCount val="1"/>
                <c:pt idx="0">
                  <c:v>CAAUA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96:$R$96</c:f>
              <c:numCache>
                <c:formatCode>General</c:formatCode>
                <c:ptCount val="17"/>
                <c:pt idx="0">
                  <c:v>0</c:v>
                </c:pt>
                <c:pt idx="1">
                  <c:v>0.38314176245210702</c:v>
                </c:pt>
                <c:pt idx="2">
                  <c:v>0.12771392081737104</c:v>
                </c:pt>
                <c:pt idx="3">
                  <c:v>0</c:v>
                </c:pt>
                <c:pt idx="4">
                  <c:v>0</c:v>
                </c:pt>
                <c:pt idx="5">
                  <c:v>0.25542784163473803</c:v>
                </c:pt>
                <c:pt idx="6">
                  <c:v>0.89399744572158402</c:v>
                </c:pt>
                <c:pt idx="7">
                  <c:v>0.76628352490421492</c:v>
                </c:pt>
                <c:pt idx="8">
                  <c:v>0.89399744572158402</c:v>
                </c:pt>
                <c:pt idx="9">
                  <c:v>0.51085568326948316</c:v>
                </c:pt>
                <c:pt idx="10">
                  <c:v>0.25542784163473803</c:v>
                </c:pt>
                <c:pt idx="11">
                  <c:v>0.63856960408684604</c:v>
                </c:pt>
                <c:pt idx="12">
                  <c:v>0.51085568326948316</c:v>
                </c:pt>
                <c:pt idx="13">
                  <c:v>0.38314176245210702</c:v>
                </c:pt>
                <c:pt idx="14">
                  <c:v>0</c:v>
                </c:pt>
                <c:pt idx="15">
                  <c:v>0.12771392081737104</c:v>
                </c:pt>
                <c:pt idx="16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2-8EBA-42F2-9AAB-B419A77AFF71}"/>
            </c:ext>
          </c:extLst>
        </c:ser>
        <c:ser>
          <c:idx val="35"/>
          <c:order val="35"/>
          <c:tx>
            <c:strRef>
              <c:f>'NUE-5nt'!$A$97</c:f>
              <c:strCache>
                <c:ptCount val="1"/>
                <c:pt idx="0">
                  <c:v>AUUGU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97:$R$97</c:f>
              <c:numCache>
                <c:formatCode>General</c:formatCode>
                <c:ptCount val="17"/>
                <c:pt idx="0">
                  <c:v>0.12771392081737104</c:v>
                </c:pt>
                <c:pt idx="1">
                  <c:v>0.12771392081737104</c:v>
                </c:pt>
                <c:pt idx="2">
                  <c:v>0.51085568326948316</c:v>
                </c:pt>
                <c:pt idx="3">
                  <c:v>0.38314176245210702</c:v>
                </c:pt>
                <c:pt idx="4">
                  <c:v>1.021711366538953</c:v>
                </c:pt>
                <c:pt idx="5">
                  <c:v>0.38314176245210702</c:v>
                </c:pt>
                <c:pt idx="6">
                  <c:v>1.1494252873563218</c:v>
                </c:pt>
                <c:pt idx="7">
                  <c:v>0.25542784163473803</c:v>
                </c:pt>
                <c:pt idx="8">
                  <c:v>0.25542784163473803</c:v>
                </c:pt>
                <c:pt idx="9">
                  <c:v>0.38314176245210702</c:v>
                </c:pt>
                <c:pt idx="10">
                  <c:v>0.12771392081737104</c:v>
                </c:pt>
                <c:pt idx="11">
                  <c:v>0.25542784163473803</c:v>
                </c:pt>
                <c:pt idx="12">
                  <c:v>0.51085568326948316</c:v>
                </c:pt>
                <c:pt idx="13">
                  <c:v>0.12771392081737104</c:v>
                </c:pt>
                <c:pt idx="14">
                  <c:v>0.12771392081737104</c:v>
                </c:pt>
                <c:pt idx="15">
                  <c:v>0</c:v>
                </c:pt>
                <c:pt idx="16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3-8EBA-42F2-9AAB-B419A77AFF71}"/>
            </c:ext>
          </c:extLst>
        </c:ser>
        <c:ser>
          <c:idx val="36"/>
          <c:order val="36"/>
          <c:tx>
            <c:strRef>
              <c:f>'NUE-5nt'!$A$98</c:f>
              <c:strCache>
                <c:ptCount val="1"/>
                <c:pt idx="0">
                  <c:v>UGAAU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98:$R$98</c:f>
              <c:numCache>
                <c:formatCode>General</c:formatCode>
                <c:ptCount val="17"/>
                <c:pt idx="0">
                  <c:v>0.25542784163473803</c:v>
                </c:pt>
                <c:pt idx="1">
                  <c:v>0.12771392081737104</c:v>
                </c:pt>
                <c:pt idx="2">
                  <c:v>0.25542784163473803</c:v>
                </c:pt>
                <c:pt idx="3">
                  <c:v>0</c:v>
                </c:pt>
                <c:pt idx="4">
                  <c:v>0.12771392081737104</c:v>
                </c:pt>
                <c:pt idx="5">
                  <c:v>0</c:v>
                </c:pt>
                <c:pt idx="6">
                  <c:v>0.25542784163473803</c:v>
                </c:pt>
                <c:pt idx="7">
                  <c:v>0.76628352490421492</c:v>
                </c:pt>
                <c:pt idx="8">
                  <c:v>0.38314176245210702</c:v>
                </c:pt>
                <c:pt idx="9">
                  <c:v>0.38314176245210702</c:v>
                </c:pt>
                <c:pt idx="10">
                  <c:v>0.63856960408684604</c:v>
                </c:pt>
                <c:pt idx="11">
                  <c:v>0.38314176245210702</c:v>
                </c:pt>
                <c:pt idx="12">
                  <c:v>0.12771392081737104</c:v>
                </c:pt>
                <c:pt idx="13">
                  <c:v>0.38314176245210702</c:v>
                </c:pt>
                <c:pt idx="14">
                  <c:v>0.76628352490421492</c:v>
                </c:pt>
                <c:pt idx="15">
                  <c:v>0.51085568326948316</c:v>
                </c:pt>
                <c:pt idx="16">
                  <c:v>0.383141762452107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4-8EBA-42F2-9AAB-B419A77AFF71}"/>
            </c:ext>
          </c:extLst>
        </c:ser>
        <c:ser>
          <c:idx val="37"/>
          <c:order val="37"/>
          <c:tx>
            <c:strRef>
              <c:f>'NUE-5nt'!$A$99</c:f>
              <c:strCache>
                <c:ptCount val="1"/>
                <c:pt idx="0">
                  <c:v>GUUUU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99:$R$99</c:f>
              <c:numCache>
                <c:formatCode>General</c:formatCode>
                <c:ptCount val="17"/>
                <c:pt idx="0">
                  <c:v>0.25542784163473803</c:v>
                </c:pt>
                <c:pt idx="1">
                  <c:v>0.51085568326948316</c:v>
                </c:pt>
                <c:pt idx="2">
                  <c:v>0.25542784163473803</c:v>
                </c:pt>
                <c:pt idx="3">
                  <c:v>0.89399744572158402</c:v>
                </c:pt>
                <c:pt idx="4">
                  <c:v>1.5325670498084301</c:v>
                </c:pt>
                <c:pt idx="5">
                  <c:v>0.63856960408684604</c:v>
                </c:pt>
                <c:pt idx="6">
                  <c:v>0.51085568326948316</c:v>
                </c:pt>
                <c:pt idx="7">
                  <c:v>0.25542784163473803</c:v>
                </c:pt>
                <c:pt idx="8">
                  <c:v>0.38314176245210702</c:v>
                </c:pt>
                <c:pt idx="9">
                  <c:v>0.12771392081737104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.25542784163473803</c:v>
                </c:pt>
                <c:pt idx="14">
                  <c:v>0</c:v>
                </c:pt>
                <c:pt idx="15">
                  <c:v>0</c:v>
                </c:pt>
                <c:pt idx="16">
                  <c:v>0.127713920817371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5-8EBA-42F2-9AAB-B419A77AFF71}"/>
            </c:ext>
          </c:extLst>
        </c:ser>
        <c:ser>
          <c:idx val="38"/>
          <c:order val="38"/>
          <c:tx>
            <c:strRef>
              <c:f>'NUE-5nt'!$A$100</c:f>
              <c:strCache>
                <c:ptCount val="1"/>
                <c:pt idx="0">
                  <c:v>AAUCU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100:$R$100</c:f>
              <c:numCache>
                <c:formatCode>General</c:formatCode>
                <c:ptCount val="17"/>
                <c:pt idx="0">
                  <c:v>0</c:v>
                </c:pt>
                <c:pt idx="1">
                  <c:v>0</c:v>
                </c:pt>
                <c:pt idx="2">
                  <c:v>0.12771392081737104</c:v>
                </c:pt>
                <c:pt idx="3">
                  <c:v>0.25542784163473803</c:v>
                </c:pt>
                <c:pt idx="4">
                  <c:v>0.25542784163473803</c:v>
                </c:pt>
                <c:pt idx="5">
                  <c:v>0.12771392081737104</c:v>
                </c:pt>
                <c:pt idx="6">
                  <c:v>0.25542784163473803</c:v>
                </c:pt>
                <c:pt idx="7">
                  <c:v>0.25542784163473803</c:v>
                </c:pt>
                <c:pt idx="8">
                  <c:v>0.38314176245210702</c:v>
                </c:pt>
                <c:pt idx="9">
                  <c:v>0.63856960408684604</c:v>
                </c:pt>
                <c:pt idx="10">
                  <c:v>0.76628352490421492</c:v>
                </c:pt>
                <c:pt idx="11">
                  <c:v>0.38314176245210702</c:v>
                </c:pt>
                <c:pt idx="12">
                  <c:v>0.63856960408684604</c:v>
                </c:pt>
                <c:pt idx="13">
                  <c:v>0.38314176245210702</c:v>
                </c:pt>
                <c:pt idx="14">
                  <c:v>0.12771392081737104</c:v>
                </c:pt>
                <c:pt idx="15">
                  <c:v>0.38314176245210702</c:v>
                </c:pt>
                <c:pt idx="16">
                  <c:v>0.5108556832694831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6-8EBA-42F2-9AAB-B419A77AFF71}"/>
            </c:ext>
          </c:extLst>
        </c:ser>
        <c:ser>
          <c:idx val="39"/>
          <c:order val="39"/>
          <c:tx>
            <c:strRef>
              <c:f>'NUE-5nt'!$A$101</c:f>
              <c:strCache>
                <c:ptCount val="1"/>
                <c:pt idx="0">
                  <c:v>AUUAA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101:$R$101</c:f>
              <c:numCache>
                <c:formatCode>General</c:formatCode>
                <c:ptCount val="17"/>
                <c:pt idx="0">
                  <c:v>0</c:v>
                </c:pt>
                <c:pt idx="1">
                  <c:v>0</c:v>
                </c:pt>
                <c:pt idx="2">
                  <c:v>0.12771392081737104</c:v>
                </c:pt>
                <c:pt idx="3">
                  <c:v>0.12771392081737104</c:v>
                </c:pt>
                <c:pt idx="4">
                  <c:v>0.38314176245210702</c:v>
                </c:pt>
                <c:pt idx="5">
                  <c:v>0.25542784163473803</c:v>
                </c:pt>
                <c:pt idx="6">
                  <c:v>0.89399744572158402</c:v>
                </c:pt>
                <c:pt idx="7">
                  <c:v>0</c:v>
                </c:pt>
                <c:pt idx="8">
                  <c:v>0.38314176245210702</c:v>
                </c:pt>
                <c:pt idx="9">
                  <c:v>0.38314176245210702</c:v>
                </c:pt>
                <c:pt idx="10">
                  <c:v>0.76628352490421492</c:v>
                </c:pt>
                <c:pt idx="11">
                  <c:v>0.25542784163473803</c:v>
                </c:pt>
                <c:pt idx="12">
                  <c:v>0.38314176245210702</c:v>
                </c:pt>
                <c:pt idx="13">
                  <c:v>0.76628352490421492</c:v>
                </c:pt>
                <c:pt idx="14">
                  <c:v>0.38314176245210702</c:v>
                </c:pt>
                <c:pt idx="15">
                  <c:v>0.12771392081737104</c:v>
                </c:pt>
                <c:pt idx="16">
                  <c:v>0.255427841634738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7-8EBA-42F2-9AAB-B419A77AFF71}"/>
            </c:ext>
          </c:extLst>
        </c:ser>
        <c:ser>
          <c:idx val="40"/>
          <c:order val="40"/>
          <c:tx>
            <c:strRef>
              <c:f>'NUE-5nt'!$A$102</c:f>
              <c:strCache>
                <c:ptCount val="1"/>
                <c:pt idx="0">
                  <c:v>AUAAA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102:$R$102</c:f>
              <c:numCache>
                <c:formatCode>General</c:formatCode>
                <c:ptCount val="17"/>
                <c:pt idx="0">
                  <c:v>0.12771392081737104</c:v>
                </c:pt>
                <c:pt idx="1">
                  <c:v>0.12771392081737104</c:v>
                </c:pt>
                <c:pt idx="2">
                  <c:v>0</c:v>
                </c:pt>
                <c:pt idx="3">
                  <c:v>0.25542784163473803</c:v>
                </c:pt>
                <c:pt idx="4">
                  <c:v>0</c:v>
                </c:pt>
                <c:pt idx="5">
                  <c:v>0.12771392081737104</c:v>
                </c:pt>
                <c:pt idx="6">
                  <c:v>0.12771392081737104</c:v>
                </c:pt>
                <c:pt idx="7">
                  <c:v>0.12771392081737104</c:v>
                </c:pt>
                <c:pt idx="8">
                  <c:v>0.89399744572158402</c:v>
                </c:pt>
                <c:pt idx="9">
                  <c:v>0.51085568326948316</c:v>
                </c:pt>
                <c:pt idx="10">
                  <c:v>1.1494252873563218</c:v>
                </c:pt>
                <c:pt idx="11">
                  <c:v>0.51085568326948316</c:v>
                </c:pt>
                <c:pt idx="12">
                  <c:v>0.51085568326948316</c:v>
                </c:pt>
                <c:pt idx="13">
                  <c:v>0.25542784163473803</c:v>
                </c:pt>
                <c:pt idx="14">
                  <c:v>0.51085568326948316</c:v>
                </c:pt>
                <c:pt idx="15">
                  <c:v>0.12771392081737104</c:v>
                </c:pt>
                <c:pt idx="16">
                  <c:v>0.127713920817371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8-8EBA-42F2-9AAB-B419A77AFF71}"/>
            </c:ext>
          </c:extLst>
        </c:ser>
        <c:ser>
          <c:idx val="41"/>
          <c:order val="41"/>
          <c:tx>
            <c:strRef>
              <c:f>'NUE-5nt'!$A$103</c:f>
              <c:strCache>
                <c:ptCount val="1"/>
                <c:pt idx="0">
                  <c:v>UGUAU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103:$R$103</c:f>
              <c:numCache>
                <c:formatCode>General</c:formatCode>
                <c:ptCount val="17"/>
                <c:pt idx="0">
                  <c:v>0.12771392081737104</c:v>
                </c:pt>
                <c:pt idx="1">
                  <c:v>0.25542784163473803</c:v>
                </c:pt>
                <c:pt idx="2">
                  <c:v>0.12771392081737104</c:v>
                </c:pt>
                <c:pt idx="3">
                  <c:v>0.12771392081737104</c:v>
                </c:pt>
                <c:pt idx="4">
                  <c:v>0.38314176245210702</c:v>
                </c:pt>
                <c:pt idx="5">
                  <c:v>0.63856960408684604</c:v>
                </c:pt>
                <c:pt idx="6">
                  <c:v>0.76628352490421492</c:v>
                </c:pt>
                <c:pt idx="7">
                  <c:v>0.76628352490421492</c:v>
                </c:pt>
                <c:pt idx="8">
                  <c:v>0.63856960408684604</c:v>
                </c:pt>
                <c:pt idx="9">
                  <c:v>0.63856960408684604</c:v>
                </c:pt>
                <c:pt idx="10">
                  <c:v>0.38314176245210702</c:v>
                </c:pt>
                <c:pt idx="11">
                  <c:v>0.12771392081737104</c:v>
                </c:pt>
                <c:pt idx="12">
                  <c:v>0</c:v>
                </c:pt>
                <c:pt idx="13">
                  <c:v>0.12771392081737104</c:v>
                </c:pt>
                <c:pt idx="14">
                  <c:v>0.25542784163473803</c:v>
                </c:pt>
                <c:pt idx="15">
                  <c:v>0.12771392081737104</c:v>
                </c:pt>
                <c:pt idx="16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9-8EBA-42F2-9AAB-B419A77AFF71}"/>
            </c:ext>
          </c:extLst>
        </c:ser>
        <c:ser>
          <c:idx val="42"/>
          <c:order val="42"/>
          <c:tx>
            <c:strRef>
              <c:f>'NUE-5nt'!$A$104</c:f>
              <c:strCache>
                <c:ptCount val="1"/>
                <c:pt idx="0">
                  <c:v>UUUCA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104:$R$104</c:f>
              <c:numCache>
                <c:formatCode>General</c:formatCode>
                <c:ptCount val="17"/>
                <c:pt idx="0">
                  <c:v>0.12771392081737104</c:v>
                </c:pt>
                <c:pt idx="1">
                  <c:v>0.25542784163473803</c:v>
                </c:pt>
                <c:pt idx="2">
                  <c:v>0.25542784163473803</c:v>
                </c:pt>
                <c:pt idx="3">
                  <c:v>0.12771392081737104</c:v>
                </c:pt>
                <c:pt idx="4">
                  <c:v>0.25542784163473803</c:v>
                </c:pt>
                <c:pt idx="5">
                  <c:v>0.63856960408684604</c:v>
                </c:pt>
                <c:pt idx="6">
                  <c:v>0.89399744572158402</c:v>
                </c:pt>
                <c:pt idx="7">
                  <c:v>0.12771392081737104</c:v>
                </c:pt>
                <c:pt idx="8">
                  <c:v>0.38314176245210702</c:v>
                </c:pt>
                <c:pt idx="9">
                  <c:v>0.38314176245210702</c:v>
                </c:pt>
                <c:pt idx="10">
                  <c:v>0.25542784163473803</c:v>
                </c:pt>
                <c:pt idx="11">
                  <c:v>0.38314176245210702</c:v>
                </c:pt>
                <c:pt idx="12">
                  <c:v>0.12771392081737104</c:v>
                </c:pt>
                <c:pt idx="13">
                  <c:v>0.38314176245210702</c:v>
                </c:pt>
                <c:pt idx="14">
                  <c:v>0.38314176245210702</c:v>
                </c:pt>
                <c:pt idx="15">
                  <c:v>0.25542784163473803</c:v>
                </c:pt>
                <c:pt idx="16">
                  <c:v>0.127713920817371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A-8EBA-42F2-9AAB-B419A77AFF71}"/>
            </c:ext>
          </c:extLst>
        </c:ser>
        <c:ser>
          <c:idx val="43"/>
          <c:order val="43"/>
          <c:tx>
            <c:strRef>
              <c:f>'NUE-5nt'!$A$105</c:f>
              <c:strCache>
                <c:ptCount val="1"/>
                <c:pt idx="0">
                  <c:v>ACAAC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105:$R$105</c:f>
              <c:numCache>
                <c:formatCode>General</c:formatCode>
                <c:ptCount val="17"/>
                <c:pt idx="0">
                  <c:v>0.12771392081737104</c:v>
                </c:pt>
                <c:pt idx="1">
                  <c:v>0.38314176245210702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.25542784163473803</c:v>
                </c:pt>
                <c:pt idx="6">
                  <c:v>0</c:v>
                </c:pt>
                <c:pt idx="7">
                  <c:v>0.25542784163473803</c:v>
                </c:pt>
                <c:pt idx="8">
                  <c:v>0</c:v>
                </c:pt>
                <c:pt idx="9">
                  <c:v>0.38314176245210702</c:v>
                </c:pt>
                <c:pt idx="10">
                  <c:v>0.63856960408684604</c:v>
                </c:pt>
                <c:pt idx="11">
                  <c:v>0.51085568326948316</c:v>
                </c:pt>
                <c:pt idx="12">
                  <c:v>1.021711366538953</c:v>
                </c:pt>
                <c:pt idx="13">
                  <c:v>0.38314176245210702</c:v>
                </c:pt>
                <c:pt idx="14">
                  <c:v>0.38314176245210702</c:v>
                </c:pt>
                <c:pt idx="15">
                  <c:v>0.12771392081737104</c:v>
                </c:pt>
                <c:pt idx="16">
                  <c:v>0.893997445721584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B-8EBA-42F2-9AAB-B419A77AFF71}"/>
            </c:ext>
          </c:extLst>
        </c:ser>
        <c:ser>
          <c:idx val="44"/>
          <c:order val="44"/>
          <c:tx>
            <c:strRef>
              <c:f>'NUE-5nt'!$A$106</c:f>
              <c:strCache>
                <c:ptCount val="1"/>
                <c:pt idx="0">
                  <c:v>CUGUA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106:$R$106</c:f>
              <c:numCache>
                <c:formatCode>General</c:formatCode>
                <c:ptCount val="17"/>
                <c:pt idx="0">
                  <c:v>0.12771392081737104</c:v>
                </c:pt>
                <c:pt idx="1">
                  <c:v>0</c:v>
                </c:pt>
                <c:pt idx="2">
                  <c:v>0.51085568326948316</c:v>
                </c:pt>
                <c:pt idx="3">
                  <c:v>0.25542784163473803</c:v>
                </c:pt>
                <c:pt idx="4">
                  <c:v>0.38314176245210702</c:v>
                </c:pt>
                <c:pt idx="5">
                  <c:v>0.76628352490421492</c:v>
                </c:pt>
                <c:pt idx="6">
                  <c:v>0.38314176245210702</c:v>
                </c:pt>
                <c:pt idx="7">
                  <c:v>0.89399744572158402</c:v>
                </c:pt>
                <c:pt idx="8">
                  <c:v>0.38314176245210702</c:v>
                </c:pt>
                <c:pt idx="9">
                  <c:v>0.38314176245210702</c:v>
                </c:pt>
                <c:pt idx="10">
                  <c:v>0.12771392081737104</c:v>
                </c:pt>
                <c:pt idx="11">
                  <c:v>0.51085568326948316</c:v>
                </c:pt>
                <c:pt idx="12">
                  <c:v>0.12771392081737104</c:v>
                </c:pt>
                <c:pt idx="13">
                  <c:v>0.25542784163473803</c:v>
                </c:pt>
                <c:pt idx="14">
                  <c:v>0.12771392081737104</c:v>
                </c:pt>
                <c:pt idx="15">
                  <c:v>0.12771392081737104</c:v>
                </c:pt>
                <c:pt idx="16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C-8EBA-42F2-9AAB-B419A77AFF71}"/>
            </c:ext>
          </c:extLst>
        </c:ser>
        <c:ser>
          <c:idx val="45"/>
          <c:order val="45"/>
          <c:tx>
            <c:strRef>
              <c:f>'NUE-5nt'!$A$107</c:f>
              <c:strCache>
                <c:ptCount val="1"/>
                <c:pt idx="0">
                  <c:v>AAAUC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107:$R$107</c:f>
              <c:numCache>
                <c:formatCode>General</c:formatCode>
                <c:ptCount val="17"/>
                <c:pt idx="0">
                  <c:v>0.38314176245210702</c:v>
                </c:pt>
                <c:pt idx="1">
                  <c:v>0.38314176245210702</c:v>
                </c:pt>
                <c:pt idx="2">
                  <c:v>0.25542784163473803</c:v>
                </c:pt>
                <c:pt idx="3">
                  <c:v>0.12771392081737104</c:v>
                </c:pt>
                <c:pt idx="4">
                  <c:v>0.12771392081737104</c:v>
                </c:pt>
                <c:pt idx="5">
                  <c:v>0</c:v>
                </c:pt>
                <c:pt idx="6">
                  <c:v>0.12771392081737104</c:v>
                </c:pt>
                <c:pt idx="7">
                  <c:v>0.38314176245210702</c:v>
                </c:pt>
                <c:pt idx="8">
                  <c:v>0.25542784163473803</c:v>
                </c:pt>
                <c:pt idx="9">
                  <c:v>0.51085568326948316</c:v>
                </c:pt>
                <c:pt idx="10">
                  <c:v>0.76628352490421492</c:v>
                </c:pt>
                <c:pt idx="11">
                  <c:v>0.51085568326948316</c:v>
                </c:pt>
                <c:pt idx="12">
                  <c:v>0</c:v>
                </c:pt>
                <c:pt idx="13">
                  <c:v>0.38314176245210702</c:v>
                </c:pt>
                <c:pt idx="14">
                  <c:v>0.12771392081737104</c:v>
                </c:pt>
                <c:pt idx="15">
                  <c:v>0.51085568326948316</c:v>
                </c:pt>
                <c:pt idx="16">
                  <c:v>0.5108556832694831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D-8EBA-42F2-9AAB-B419A77AFF71}"/>
            </c:ext>
          </c:extLst>
        </c:ser>
        <c:ser>
          <c:idx val="46"/>
          <c:order val="46"/>
          <c:tx>
            <c:strRef>
              <c:f>'NUE-5nt'!$A$108</c:f>
              <c:strCache>
                <c:ptCount val="1"/>
                <c:pt idx="0">
                  <c:v>UAUUA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108:$R$108</c:f>
              <c:numCache>
                <c:formatCode>General</c:formatCode>
                <c:ptCount val="17"/>
                <c:pt idx="0">
                  <c:v>0</c:v>
                </c:pt>
                <c:pt idx="1">
                  <c:v>0.38314176245210702</c:v>
                </c:pt>
                <c:pt idx="2">
                  <c:v>0.12771392081737104</c:v>
                </c:pt>
                <c:pt idx="3">
                  <c:v>0.38314176245210702</c:v>
                </c:pt>
                <c:pt idx="4">
                  <c:v>0.12771392081737104</c:v>
                </c:pt>
                <c:pt idx="5">
                  <c:v>0.38314176245210702</c:v>
                </c:pt>
                <c:pt idx="6">
                  <c:v>0.12771392081737104</c:v>
                </c:pt>
                <c:pt idx="7">
                  <c:v>0.51085568326948316</c:v>
                </c:pt>
                <c:pt idx="8">
                  <c:v>0.38314176245210702</c:v>
                </c:pt>
                <c:pt idx="9">
                  <c:v>0.38314176245210702</c:v>
                </c:pt>
                <c:pt idx="10">
                  <c:v>0.38314176245210702</c:v>
                </c:pt>
                <c:pt idx="11">
                  <c:v>1.021711366538953</c:v>
                </c:pt>
                <c:pt idx="12">
                  <c:v>0.63856960408684604</c:v>
                </c:pt>
                <c:pt idx="13">
                  <c:v>0.25542784163473803</c:v>
                </c:pt>
                <c:pt idx="14">
                  <c:v>0.12771392081737104</c:v>
                </c:pt>
                <c:pt idx="15">
                  <c:v>0</c:v>
                </c:pt>
                <c:pt idx="16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E-8EBA-42F2-9AAB-B419A77AFF71}"/>
            </c:ext>
          </c:extLst>
        </c:ser>
        <c:ser>
          <c:idx val="47"/>
          <c:order val="47"/>
          <c:tx>
            <c:strRef>
              <c:f>'NUE-5nt'!$A$109</c:f>
              <c:strCache>
                <c:ptCount val="1"/>
                <c:pt idx="0">
                  <c:v>GAUGU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109:$R$109</c:f>
              <c:numCache>
                <c:formatCode>General</c:formatCode>
                <c:ptCount val="17"/>
                <c:pt idx="0">
                  <c:v>0.38314176245210702</c:v>
                </c:pt>
                <c:pt idx="1">
                  <c:v>0.38314176245210702</c:v>
                </c:pt>
                <c:pt idx="2">
                  <c:v>0.76628352490421492</c:v>
                </c:pt>
                <c:pt idx="3">
                  <c:v>0.38314176245210702</c:v>
                </c:pt>
                <c:pt idx="4">
                  <c:v>0.38314176245210702</c:v>
                </c:pt>
                <c:pt idx="5">
                  <c:v>0.89399744572158402</c:v>
                </c:pt>
                <c:pt idx="6">
                  <c:v>0.25542784163473803</c:v>
                </c:pt>
                <c:pt idx="7">
                  <c:v>0.12771392081737104</c:v>
                </c:pt>
                <c:pt idx="8">
                  <c:v>0.38314176245210702</c:v>
                </c:pt>
                <c:pt idx="9">
                  <c:v>0.25542784163473803</c:v>
                </c:pt>
                <c:pt idx="10">
                  <c:v>0</c:v>
                </c:pt>
                <c:pt idx="11">
                  <c:v>0</c:v>
                </c:pt>
                <c:pt idx="12">
                  <c:v>0.38314176245210702</c:v>
                </c:pt>
                <c:pt idx="13">
                  <c:v>0.38314176245210702</c:v>
                </c:pt>
                <c:pt idx="14">
                  <c:v>0</c:v>
                </c:pt>
                <c:pt idx="15">
                  <c:v>0</c:v>
                </c:pt>
                <c:pt idx="16">
                  <c:v>0.255427841634738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F-8EBA-42F2-9AAB-B419A77AFF71}"/>
            </c:ext>
          </c:extLst>
        </c:ser>
        <c:ser>
          <c:idx val="48"/>
          <c:order val="48"/>
          <c:tx>
            <c:strRef>
              <c:f>'NUE-5nt'!$A$110</c:f>
              <c:strCache>
                <c:ptCount val="1"/>
                <c:pt idx="0">
                  <c:v>AUUUA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110:$R$110</c:f>
              <c:numCache>
                <c:formatCode>General</c:formatCode>
                <c:ptCount val="17"/>
                <c:pt idx="0">
                  <c:v>0.25542784163473803</c:v>
                </c:pt>
                <c:pt idx="1">
                  <c:v>0.12771392081737104</c:v>
                </c:pt>
                <c:pt idx="2">
                  <c:v>0.12771392081737104</c:v>
                </c:pt>
                <c:pt idx="3">
                  <c:v>0.25542784163473803</c:v>
                </c:pt>
                <c:pt idx="4">
                  <c:v>0.25542784163473803</c:v>
                </c:pt>
                <c:pt idx="5">
                  <c:v>0.38314176245210702</c:v>
                </c:pt>
                <c:pt idx="6">
                  <c:v>0.12771392081737104</c:v>
                </c:pt>
                <c:pt idx="7">
                  <c:v>0.38314176245210702</c:v>
                </c:pt>
                <c:pt idx="8">
                  <c:v>0.25542784163473803</c:v>
                </c:pt>
                <c:pt idx="9">
                  <c:v>0.63856960408684604</c:v>
                </c:pt>
                <c:pt idx="10">
                  <c:v>0.25542784163473803</c:v>
                </c:pt>
                <c:pt idx="11">
                  <c:v>0.38314176245210702</c:v>
                </c:pt>
                <c:pt idx="12">
                  <c:v>0.38314176245210702</c:v>
                </c:pt>
                <c:pt idx="13">
                  <c:v>0.63856960408684604</c:v>
                </c:pt>
                <c:pt idx="14">
                  <c:v>0.25542784163473803</c:v>
                </c:pt>
                <c:pt idx="15">
                  <c:v>0.12771392081737104</c:v>
                </c:pt>
                <c:pt idx="16">
                  <c:v>0.383141762452107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0-8EBA-42F2-9AAB-B419A77AFF71}"/>
            </c:ext>
          </c:extLst>
        </c:ser>
        <c:ser>
          <c:idx val="49"/>
          <c:order val="49"/>
          <c:tx>
            <c:strRef>
              <c:f>'NUE-5nt'!$A$111</c:f>
              <c:strCache>
                <c:ptCount val="1"/>
                <c:pt idx="0">
                  <c:v>AAAUU</c:v>
                </c:pt>
              </c:strCache>
            </c:strRef>
          </c:tx>
          <c:marker>
            <c:symbol val="none"/>
          </c:marker>
          <c:cat>
            <c:numRef>
              <c:f>'NUE-5nt'!$B$61:$R$61</c:f>
              <c:numCache>
                <c:formatCode>General</c:formatCode>
                <c:ptCount val="17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</c:numCache>
            </c:numRef>
          </c:cat>
          <c:val>
            <c:numRef>
              <c:f>'NUE-5nt'!$B$111:$R$111</c:f>
              <c:numCache>
                <c:formatCode>General</c:formatCode>
                <c:ptCount val="17"/>
                <c:pt idx="0">
                  <c:v>0.25542784163473803</c:v>
                </c:pt>
                <c:pt idx="1">
                  <c:v>0.25542784163473803</c:v>
                </c:pt>
                <c:pt idx="2">
                  <c:v>0.25542784163473803</c:v>
                </c:pt>
                <c:pt idx="3">
                  <c:v>0.38314176245210702</c:v>
                </c:pt>
                <c:pt idx="4">
                  <c:v>0.38314176245210702</c:v>
                </c:pt>
                <c:pt idx="5">
                  <c:v>0</c:v>
                </c:pt>
                <c:pt idx="6">
                  <c:v>0.25542784163473803</c:v>
                </c:pt>
                <c:pt idx="7">
                  <c:v>0.25542784163473803</c:v>
                </c:pt>
                <c:pt idx="8">
                  <c:v>0.12771392081737104</c:v>
                </c:pt>
                <c:pt idx="9">
                  <c:v>0.25542784163473803</c:v>
                </c:pt>
                <c:pt idx="10">
                  <c:v>0.25542784163473803</c:v>
                </c:pt>
                <c:pt idx="11">
                  <c:v>0.89399744572158402</c:v>
                </c:pt>
                <c:pt idx="12">
                  <c:v>0.38314176245210702</c:v>
                </c:pt>
                <c:pt idx="13">
                  <c:v>0.12771392081737104</c:v>
                </c:pt>
                <c:pt idx="14">
                  <c:v>0.38314176245210702</c:v>
                </c:pt>
                <c:pt idx="15">
                  <c:v>0.51085568326948316</c:v>
                </c:pt>
                <c:pt idx="16">
                  <c:v>0.255427841634738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1-8EBA-42F2-9AAB-B419A77AFF7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82664832"/>
        <c:axId val="82678912"/>
      </c:lineChart>
      <c:catAx>
        <c:axId val="826648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zh-CN"/>
            </a:pPr>
            <a:endParaRPr lang="en-US"/>
          </a:p>
        </c:txPr>
        <c:crossAx val="82678912"/>
        <c:crosses val="autoZero"/>
        <c:auto val="1"/>
        <c:lblAlgn val="ctr"/>
        <c:lblOffset val="100"/>
        <c:noMultiLvlLbl val="0"/>
      </c:catAx>
      <c:valAx>
        <c:axId val="8267891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zh-CN"/>
            </a:pPr>
            <a:endParaRPr lang="en-US"/>
          </a:p>
        </c:txPr>
        <c:crossAx val="8266483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2.4464831804281309E-3"/>
          <c:y val="0.64396093870619109"/>
          <c:w val="0.993235474006116"/>
          <c:h val="0.35504940558900705"/>
        </c:manualLayout>
      </c:layout>
      <c:overlay val="0"/>
      <c:txPr>
        <a:bodyPr/>
        <a:lstStyle/>
        <a:p>
          <a:pPr>
            <a:defRPr lang="zh-CN" sz="600" baseline="0"/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4.2408407890619504E-2"/>
          <c:y val="8.6578061836611334E-2"/>
          <c:w val="0.95759159210938116"/>
          <c:h val="0.39738399621212211"/>
        </c:manualLayout>
      </c:layout>
      <c:lineChart>
        <c:grouping val="standard"/>
        <c:varyColors val="0"/>
        <c:ser>
          <c:idx val="0"/>
          <c:order val="0"/>
          <c:tx>
            <c:strRef>
              <c:f>'4nt'!$A$92</c:f>
              <c:strCache>
                <c:ptCount val="1"/>
                <c:pt idx="0">
                  <c:v>UAAA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92:$S$92</c:f>
              <c:numCache>
                <c:formatCode>General</c:formatCode>
                <c:ptCount val="18"/>
                <c:pt idx="0">
                  <c:v>1.9354838709677502</c:v>
                </c:pt>
                <c:pt idx="1">
                  <c:v>3.2258064516129052</c:v>
                </c:pt>
                <c:pt idx="2">
                  <c:v>3.2258064516129052</c:v>
                </c:pt>
                <c:pt idx="3">
                  <c:v>2.5806451612903221</c:v>
                </c:pt>
                <c:pt idx="4">
                  <c:v>3.2258064516129052</c:v>
                </c:pt>
                <c:pt idx="5">
                  <c:v>4.5161290322580703</c:v>
                </c:pt>
                <c:pt idx="6">
                  <c:v>5.8064516129032304</c:v>
                </c:pt>
                <c:pt idx="7">
                  <c:v>9.0322580645161068</c:v>
                </c:pt>
                <c:pt idx="8">
                  <c:v>12.90322580645161</c:v>
                </c:pt>
                <c:pt idx="9">
                  <c:v>10.322580645161382</c:v>
                </c:pt>
                <c:pt idx="10">
                  <c:v>12.258064516129082</c:v>
                </c:pt>
                <c:pt idx="11">
                  <c:v>7.0967741935483923</c:v>
                </c:pt>
                <c:pt idx="12">
                  <c:v>8.3870967741935498</c:v>
                </c:pt>
                <c:pt idx="13">
                  <c:v>2.5806451612903221</c:v>
                </c:pt>
                <c:pt idx="14">
                  <c:v>0.64516129032258618</c:v>
                </c:pt>
                <c:pt idx="15">
                  <c:v>0</c:v>
                </c:pt>
                <c:pt idx="16">
                  <c:v>0.64516129032258618</c:v>
                </c:pt>
                <c:pt idx="1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810-4B29-A9E8-B4B5DDC71C7B}"/>
            </c:ext>
          </c:extLst>
        </c:ser>
        <c:ser>
          <c:idx val="1"/>
          <c:order val="1"/>
          <c:tx>
            <c:strRef>
              <c:f>'4nt'!$A$93</c:f>
              <c:strCache>
                <c:ptCount val="1"/>
                <c:pt idx="0">
                  <c:v>GUAA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93:$S$93</c:f>
              <c:numCache>
                <c:formatCode>General</c:formatCode>
                <c:ptCount val="18"/>
                <c:pt idx="0">
                  <c:v>0.64516129032258618</c:v>
                </c:pt>
                <c:pt idx="1">
                  <c:v>1.290322580645161</c:v>
                </c:pt>
                <c:pt idx="2">
                  <c:v>1.290322580645161</c:v>
                </c:pt>
                <c:pt idx="3">
                  <c:v>2.5806451612903221</c:v>
                </c:pt>
                <c:pt idx="4">
                  <c:v>3.2258064516129052</c:v>
                </c:pt>
                <c:pt idx="5">
                  <c:v>2.5806451612903221</c:v>
                </c:pt>
                <c:pt idx="6">
                  <c:v>5.8064516129032304</c:v>
                </c:pt>
                <c:pt idx="7">
                  <c:v>5.1612903225806503</c:v>
                </c:pt>
                <c:pt idx="8">
                  <c:v>4.5161290322580703</c:v>
                </c:pt>
                <c:pt idx="9">
                  <c:v>6.4516129032258114</c:v>
                </c:pt>
                <c:pt idx="10">
                  <c:v>3.8709677419355013</c:v>
                </c:pt>
                <c:pt idx="11">
                  <c:v>3.8709677419355013</c:v>
                </c:pt>
                <c:pt idx="12">
                  <c:v>1.9354838709677502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.64516129032258618</c:v>
                </c:pt>
                <c:pt idx="1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810-4B29-A9E8-B4B5DDC71C7B}"/>
            </c:ext>
          </c:extLst>
        </c:ser>
        <c:ser>
          <c:idx val="2"/>
          <c:order val="2"/>
          <c:tx>
            <c:strRef>
              <c:f>'4nt'!$A$94</c:f>
              <c:strCache>
                <c:ptCount val="1"/>
                <c:pt idx="0">
                  <c:v>AAAC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94:$S$94</c:f>
              <c:numCache>
                <c:formatCode>General</c:formatCode>
                <c:ptCount val="18"/>
                <c:pt idx="0">
                  <c:v>0.64516129032258618</c:v>
                </c:pt>
                <c:pt idx="1">
                  <c:v>0</c:v>
                </c:pt>
                <c:pt idx="2">
                  <c:v>1.9354838709677502</c:v>
                </c:pt>
                <c:pt idx="3">
                  <c:v>1.290322580645161</c:v>
                </c:pt>
                <c:pt idx="4">
                  <c:v>1.290322580645161</c:v>
                </c:pt>
                <c:pt idx="5">
                  <c:v>1.290322580645161</c:v>
                </c:pt>
                <c:pt idx="6">
                  <c:v>1.290322580645161</c:v>
                </c:pt>
                <c:pt idx="7">
                  <c:v>3.2258064516129052</c:v>
                </c:pt>
                <c:pt idx="8">
                  <c:v>2.5806451612903221</c:v>
                </c:pt>
                <c:pt idx="9">
                  <c:v>3.2258064516129052</c:v>
                </c:pt>
                <c:pt idx="10">
                  <c:v>5.1612903225806503</c:v>
                </c:pt>
                <c:pt idx="11">
                  <c:v>5.8064516129032304</c:v>
                </c:pt>
                <c:pt idx="12">
                  <c:v>6.4516129032258114</c:v>
                </c:pt>
                <c:pt idx="13">
                  <c:v>3.2258064516129052</c:v>
                </c:pt>
                <c:pt idx="14">
                  <c:v>1.290322580645161</c:v>
                </c:pt>
                <c:pt idx="15">
                  <c:v>0.64516129032258618</c:v>
                </c:pt>
                <c:pt idx="16">
                  <c:v>0.64516129032258618</c:v>
                </c:pt>
                <c:pt idx="17">
                  <c:v>1.29032258064516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8810-4B29-A9E8-B4B5DDC71C7B}"/>
            </c:ext>
          </c:extLst>
        </c:ser>
        <c:ser>
          <c:idx val="3"/>
          <c:order val="3"/>
          <c:tx>
            <c:strRef>
              <c:f>'4nt'!$A$95</c:f>
              <c:strCache>
                <c:ptCount val="1"/>
                <c:pt idx="0">
                  <c:v>AAAG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95:$S$95</c:f>
              <c:numCache>
                <c:formatCode>General</c:formatCode>
                <c:ptCount val="18"/>
                <c:pt idx="0">
                  <c:v>1.290322580645161</c:v>
                </c:pt>
                <c:pt idx="1">
                  <c:v>1.290322580645161</c:v>
                </c:pt>
                <c:pt idx="2">
                  <c:v>1.290322580645161</c:v>
                </c:pt>
                <c:pt idx="3">
                  <c:v>2.5806451612903221</c:v>
                </c:pt>
                <c:pt idx="4">
                  <c:v>2.5806451612903221</c:v>
                </c:pt>
                <c:pt idx="5">
                  <c:v>1.290322580645161</c:v>
                </c:pt>
                <c:pt idx="6">
                  <c:v>1.290322580645161</c:v>
                </c:pt>
                <c:pt idx="7">
                  <c:v>1.290322580645161</c:v>
                </c:pt>
                <c:pt idx="8">
                  <c:v>3.8709677419355013</c:v>
                </c:pt>
                <c:pt idx="9">
                  <c:v>5.8064516129032304</c:v>
                </c:pt>
                <c:pt idx="10">
                  <c:v>5.1612903225806503</c:v>
                </c:pt>
                <c:pt idx="11">
                  <c:v>5.1612903225806503</c:v>
                </c:pt>
                <c:pt idx="12">
                  <c:v>1.290322580645161</c:v>
                </c:pt>
                <c:pt idx="13">
                  <c:v>3.2258064516129052</c:v>
                </c:pt>
                <c:pt idx="14">
                  <c:v>0.64516129032258618</c:v>
                </c:pt>
                <c:pt idx="15">
                  <c:v>1.9354838709677502</c:v>
                </c:pt>
                <c:pt idx="16">
                  <c:v>0</c:v>
                </c:pt>
                <c:pt idx="17">
                  <c:v>1.29032258064516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8810-4B29-A9E8-B4B5DDC71C7B}"/>
            </c:ext>
          </c:extLst>
        </c:ser>
        <c:ser>
          <c:idx val="4"/>
          <c:order val="4"/>
          <c:tx>
            <c:strRef>
              <c:f>'4nt'!$A$96</c:f>
              <c:strCache>
                <c:ptCount val="1"/>
                <c:pt idx="0">
                  <c:v>AAAA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96:$S$96</c:f>
              <c:numCache>
                <c:formatCode>General</c:formatCode>
                <c:ptCount val="18"/>
                <c:pt idx="0">
                  <c:v>0</c:v>
                </c:pt>
                <c:pt idx="1">
                  <c:v>0.64516129032258618</c:v>
                </c:pt>
                <c:pt idx="2">
                  <c:v>0.64516129032258618</c:v>
                </c:pt>
                <c:pt idx="3">
                  <c:v>1.9354838709677502</c:v>
                </c:pt>
                <c:pt idx="4">
                  <c:v>0.64516129032258618</c:v>
                </c:pt>
                <c:pt idx="5">
                  <c:v>0.64516129032258618</c:v>
                </c:pt>
                <c:pt idx="6">
                  <c:v>1.290322580645161</c:v>
                </c:pt>
                <c:pt idx="7">
                  <c:v>1.9354838709677502</c:v>
                </c:pt>
                <c:pt idx="8">
                  <c:v>3.8709677419355013</c:v>
                </c:pt>
                <c:pt idx="9">
                  <c:v>4.5161290322580703</c:v>
                </c:pt>
                <c:pt idx="10">
                  <c:v>1.9354838709677502</c:v>
                </c:pt>
                <c:pt idx="11">
                  <c:v>3.8709677419355013</c:v>
                </c:pt>
                <c:pt idx="12">
                  <c:v>1.290322580645161</c:v>
                </c:pt>
                <c:pt idx="13">
                  <c:v>1.9354838709677502</c:v>
                </c:pt>
                <c:pt idx="14">
                  <c:v>1.290322580645161</c:v>
                </c:pt>
                <c:pt idx="15">
                  <c:v>0</c:v>
                </c:pt>
                <c:pt idx="16">
                  <c:v>0.64516129032258618</c:v>
                </c:pt>
                <c:pt idx="1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8810-4B29-A9E8-B4B5DDC71C7B}"/>
            </c:ext>
          </c:extLst>
        </c:ser>
        <c:ser>
          <c:idx val="5"/>
          <c:order val="5"/>
          <c:tx>
            <c:strRef>
              <c:f>'4nt'!$A$97</c:f>
              <c:strCache>
                <c:ptCount val="1"/>
                <c:pt idx="0">
                  <c:v>AUAA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97:$S$97</c:f>
              <c:numCache>
                <c:formatCode>General</c:formatCode>
                <c:ptCount val="18"/>
                <c:pt idx="0">
                  <c:v>1.9354838709677502</c:v>
                </c:pt>
                <c:pt idx="1">
                  <c:v>1.290322580645161</c:v>
                </c:pt>
                <c:pt idx="2">
                  <c:v>0.64516129032258618</c:v>
                </c:pt>
                <c:pt idx="3">
                  <c:v>0.64516129032258618</c:v>
                </c:pt>
                <c:pt idx="4">
                  <c:v>0.64516129032258618</c:v>
                </c:pt>
                <c:pt idx="5">
                  <c:v>1.290322580645161</c:v>
                </c:pt>
                <c:pt idx="6">
                  <c:v>2.5806451612903221</c:v>
                </c:pt>
                <c:pt idx="7">
                  <c:v>4.5161290322580703</c:v>
                </c:pt>
                <c:pt idx="8">
                  <c:v>1.9354838709677502</c:v>
                </c:pt>
                <c:pt idx="9">
                  <c:v>3.2258064516129052</c:v>
                </c:pt>
                <c:pt idx="10">
                  <c:v>3.2258064516129052</c:v>
                </c:pt>
                <c:pt idx="11">
                  <c:v>1.9354838709677502</c:v>
                </c:pt>
                <c:pt idx="12">
                  <c:v>0</c:v>
                </c:pt>
                <c:pt idx="13">
                  <c:v>0.64516129032258618</c:v>
                </c:pt>
                <c:pt idx="14">
                  <c:v>0</c:v>
                </c:pt>
                <c:pt idx="15">
                  <c:v>0.64516129032258618</c:v>
                </c:pt>
                <c:pt idx="16">
                  <c:v>0.64516129032258618</c:v>
                </c:pt>
                <c:pt idx="1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8810-4B29-A9E8-B4B5DDC71C7B}"/>
            </c:ext>
          </c:extLst>
        </c:ser>
        <c:ser>
          <c:idx val="6"/>
          <c:order val="6"/>
          <c:tx>
            <c:strRef>
              <c:f>'4nt'!$A$98</c:f>
              <c:strCache>
                <c:ptCount val="1"/>
                <c:pt idx="0">
                  <c:v>AAAU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98:$S$98</c:f>
              <c:numCache>
                <c:formatCode>General</c:formatCode>
                <c:ptCount val="18"/>
                <c:pt idx="0">
                  <c:v>0.64516129032258618</c:v>
                </c:pt>
                <c:pt idx="1">
                  <c:v>0.64516129032258618</c:v>
                </c:pt>
                <c:pt idx="2">
                  <c:v>1.290322580645161</c:v>
                </c:pt>
                <c:pt idx="3">
                  <c:v>0</c:v>
                </c:pt>
                <c:pt idx="4">
                  <c:v>0</c:v>
                </c:pt>
                <c:pt idx="5">
                  <c:v>1.9354838709677502</c:v>
                </c:pt>
                <c:pt idx="6">
                  <c:v>1.290322580645161</c:v>
                </c:pt>
                <c:pt idx="7">
                  <c:v>1.290322580645161</c:v>
                </c:pt>
                <c:pt idx="8">
                  <c:v>1.290322580645161</c:v>
                </c:pt>
                <c:pt idx="9">
                  <c:v>3.2258064516129052</c:v>
                </c:pt>
                <c:pt idx="10">
                  <c:v>1.9354838709677502</c:v>
                </c:pt>
                <c:pt idx="11">
                  <c:v>2.5806451612903221</c:v>
                </c:pt>
                <c:pt idx="12">
                  <c:v>2.5806451612903221</c:v>
                </c:pt>
                <c:pt idx="13">
                  <c:v>1.290322580645161</c:v>
                </c:pt>
                <c:pt idx="14">
                  <c:v>1.290322580645161</c:v>
                </c:pt>
                <c:pt idx="15">
                  <c:v>0.64516129032258618</c:v>
                </c:pt>
                <c:pt idx="16">
                  <c:v>0.64516129032258618</c:v>
                </c:pt>
                <c:pt idx="1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8810-4B29-A9E8-B4B5DDC71C7B}"/>
            </c:ext>
          </c:extLst>
        </c:ser>
        <c:ser>
          <c:idx val="7"/>
          <c:order val="7"/>
          <c:tx>
            <c:strRef>
              <c:f>'4nt'!$A$99</c:f>
              <c:strCache>
                <c:ptCount val="1"/>
                <c:pt idx="0">
                  <c:v>CGUA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99:$S$99</c:f>
              <c:numCache>
                <c:formatCode>General</c:formatCode>
                <c:ptCount val="18"/>
                <c:pt idx="0">
                  <c:v>1.290322580645161</c:v>
                </c:pt>
                <c:pt idx="1">
                  <c:v>0.64516129032258618</c:v>
                </c:pt>
                <c:pt idx="2">
                  <c:v>1.9354838709677502</c:v>
                </c:pt>
                <c:pt idx="3">
                  <c:v>1.9354838709677502</c:v>
                </c:pt>
                <c:pt idx="4">
                  <c:v>1.290322580645161</c:v>
                </c:pt>
                <c:pt idx="5">
                  <c:v>3.2258064516129052</c:v>
                </c:pt>
                <c:pt idx="6">
                  <c:v>3.2258064516129052</c:v>
                </c:pt>
                <c:pt idx="7">
                  <c:v>3.8709677419355013</c:v>
                </c:pt>
                <c:pt idx="8">
                  <c:v>1.9354838709677502</c:v>
                </c:pt>
                <c:pt idx="9">
                  <c:v>1.290322580645161</c:v>
                </c:pt>
                <c:pt idx="10">
                  <c:v>0.64516129032258618</c:v>
                </c:pt>
                <c:pt idx="11">
                  <c:v>1.290322580645161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8810-4B29-A9E8-B4B5DDC71C7B}"/>
            </c:ext>
          </c:extLst>
        </c:ser>
        <c:ser>
          <c:idx val="8"/>
          <c:order val="8"/>
          <c:tx>
            <c:strRef>
              <c:f>'4nt'!$A$100</c:f>
              <c:strCache>
                <c:ptCount val="1"/>
                <c:pt idx="0">
                  <c:v>AACA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100:$S$100</c:f>
              <c:numCache>
                <c:formatCode>General</c:formatCode>
                <c:ptCount val="18"/>
                <c:pt idx="0">
                  <c:v>1.290322580645161</c:v>
                </c:pt>
                <c:pt idx="1">
                  <c:v>0</c:v>
                </c:pt>
                <c:pt idx="2">
                  <c:v>0</c:v>
                </c:pt>
                <c:pt idx="3">
                  <c:v>1.9354838709677502</c:v>
                </c:pt>
                <c:pt idx="4">
                  <c:v>0</c:v>
                </c:pt>
                <c:pt idx="5">
                  <c:v>0</c:v>
                </c:pt>
                <c:pt idx="6">
                  <c:v>1.290322580645161</c:v>
                </c:pt>
                <c:pt idx="7">
                  <c:v>0</c:v>
                </c:pt>
                <c:pt idx="8">
                  <c:v>1.9354838709677502</c:v>
                </c:pt>
                <c:pt idx="9">
                  <c:v>0.64516129032258618</c:v>
                </c:pt>
                <c:pt idx="10">
                  <c:v>1.290322580645161</c:v>
                </c:pt>
                <c:pt idx="11">
                  <c:v>0.64516129032258618</c:v>
                </c:pt>
                <c:pt idx="12">
                  <c:v>3.2258064516129052</c:v>
                </c:pt>
                <c:pt idx="13">
                  <c:v>1.290322580645161</c:v>
                </c:pt>
                <c:pt idx="14">
                  <c:v>1.9354838709677502</c:v>
                </c:pt>
                <c:pt idx="15">
                  <c:v>1.9354838709677502</c:v>
                </c:pt>
                <c:pt idx="16">
                  <c:v>0.64516129032258618</c:v>
                </c:pt>
                <c:pt idx="17">
                  <c:v>0.6451612903225861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8810-4B29-A9E8-B4B5DDC71C7B}"/>
            </c:ext>
          </c:extLst>
        </c:ser>
        <c:ser>
          <c:idx val="9"/>
          <c:order val="9"/>
          <c:tx>
            <c:strRef>
              <c:f>'4nt'!$A$101</c:f>
              <c:strCache>
                <c:ptCount val="1"/>
                <c:pt idx="0">
                  <c:v>AAGC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101:$S$101</c:f>
              <c:numCache>
                <c:formatCode>General</c:formatCode>
                <c:ptCount val="18"/>
                <c:pt idx="0">
                  <c:v>1.290322580645161</c:v>
                </c:pt>
                <c:pt idx="1">
                  <c:v>1.9354838709677502</c:v>
                </c:pt>
                <c:pt idx="2">
                  <c:v>0</c:v>
                </c:pt>
                <c:pt idx="3">
                  <c:v>1.9354838709677502</c:v>
                </c:pt>
                <c:pt idx="4">
                  <c:v>0.64516129032258618</c:v>
                </c:pt>
                <c:pt idx="5">
                  <c:v>0</c:v>
                </c:pt>
                <c:pt idx="6">
                  <c:v>0.64516129032258618</c:v>
                </c:pt>
                <c:pt idx="7">
                  <c:v>0.64516129032258618</c:v>
                </c:pt>
                <c:pt idx="8">
                  <c:v>0</c:v>
                </c:pt>
                <c:pt idx="9">
                  <c:v>1.9354838709677502</c:v>
                </c:pt>
                <c:pt idx="10">
                  <c:v>3.2258064516129052</c:v>
                </c:pt>
                <c:pt idx="11">
                  <c:v>3.2258064516129052</c:v>
                </c:pt>
                <c:pt idx="12">
                  <c:v>1.9354838709677502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.64516129032258618</c:v>
                </c:pt>
                <c:pt idx="1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8810-4B29-A9E8-B4B5DDC71C7B}"/>
            </c:ext>
          </c:extLst>
        </c:ser>
        <c:ser>
          <c:idx val="10"/>
          <c:order val="10"/>
          <c:tx>
            <c:strRef>
              <c:f>'4nt'!$A$102</c:f>
              <c:strCache>
                <c:ptCount val="1"/>
                <c:pt idx="0">
                  <c:v>AAGU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102:$S$102</c:f>
              <c:numCache>
                <c:formatCode>General</c:formatCode>
                <c:ptCount val="18"/>
                <c:pt idx="0">
                  <c:v>0.64516129032258618</c:v>
                </c:pt>
                <c:pt idx="1">
                  <c:v>0</c:v>
                </c:pt>
                <c:pt idx="2">
                  <c:v>0</c:v>
                </c:pt>
                <c:pt idx="3">
                  <c:v>0.64516129032258618</c:v>
                </c:pt>
                <c:pt idx="4">
                  <c:v>1.290322580645161</c:v>
                </c:pt>
                <c:pt idx="5">
                  <c:v>1.290322580645161</c:v>
                </c:pt>
                <c:pt idx="6">
                  <c:v>0.64516129032258618</c:v>
                </c:pt>
                <c:pt idx="7">
                  <c:v>0.64516129032258618</c:v>
                </c:pt>
                <c:pt idx="8">
                  <c:v>1.290322580645161</c:v>
                </c:pt>
                <c:pt idx="9">
                  <c:v>1.9354838709677502</c:v>
                </c:pt>
                <c:pt idx="10">
                  <c:v>1.9354838709677502</c:v>
                </c:pt>
                <c:pt idx="11">
                  <c:v>0.64516129032258618</c:v>
                </c:pt>
                <c:pt idx="12">
                  <c:v>1.9354838709677502</c:v>
                </c:pt>
                <c:pt idx="13">
                  <c:v>0.64516129032258618</c:v>
                </c:pt>
                <c:pt idx="14">
                  <c:v>1.9354838709677502</c:v>
                </c:pt>
                <c:pt idx="15">
                  <c:v>0</c:v>
                </c:pt>
                <c:pt idx="16">
                  <c:v>0.64516129032258618</c:v>
                </c:pt>
                <c:pt idx="1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8810-4B29-A9E8-B4B5DDC71C7B}"/>
            </c:ext>
          </c:extLst>
        </c:ser>
        <c:ser>
          <c:idx val="11"/>
          <c:order val="11"/>
          <c:tx>
            <c:strRef>
              <c:f>'4nt'!$A$103</c:f>
              <c:strCache>
                <c:ptCount val="1"/>
                <c:pt idx="0">
                  <c:v>AACG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103:$S$103</c:f>
              <c:numCache>
                <c:formatCode>General</c:formatCode>
                <c:ptCount val="18"/>
                <c:pt idx="0">
                  <c:v>0</c:v>
                </c:pt>
                <c:pt idx="1">
                  <c:v>0.64516129032258618</c:v>
                </c:pt>
                <c:pt idx="2">
                  <c:v>0.64516129032258618</c:v>
                </c:pt>
                <c:pt idx="3">
                  <c:v>0</c:v>
                </c:pt>
                <c:pt idx="4">
                  <c:v>0</c:v>
                </c:pt>
                <c:pt idx="5">
                  <c:v>1.290322580645161</c:v>
                </c:pt>
                <c:pt idx="6">
                  <c:v>0</c:v>
                </c:pt>
                <c:pt idx="7">
                  <c:v>0.64516129032258618</c:v>
                </c:pt>
                <c:pt idx="8">
                  <c:v>1.290322580645161</c:v>
                </c:pt>
                <c:pt idx="9">
                  <c:v>1.290322580645161</c:v>
                </c:pt>
                <c:pt idx="10">
                  <c:v>0</c:v>
                </c:pt>
                <c:pt idx="11">
                  <c:v>3.2258064516129052</c:v>
                </c:pt>
                <c:pt idx="12">
                  <c:v>1.290322580645161</c:v>
                </c:pt>
                <c:pt idx="13">
                  <c:v>2.5806451612903221</c:v>
                </c:pt>
                <c:pt idx="14">
                  <c:v>1.290322580645161</c:v>
                </c:pt>
                <c:pt idx="15">
                  <c:v>0.64516129032258618</c:v>
                </c:pt>
                <c:pt idx="16">
                  <c:v>1.290322580645161</c:v>
                </c:pt>
                <c:pt idx="1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8810-4B29-A9E8-B4B5DDC71C7B}"/>
            </c:ext>
          </c:extLst>
        </c:ser>
        <c:ser>
          <c:idx val="12"/>
          <c:order val="12"/>
          <c:tx>
            <c:strRef>
              <c:f>'4nt'!$A$104</c:f>
              <c:strCache>
                <c:ptCount val="1"/>
                <c:pt idx="0">
                  <c:v>AACU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104:$S$104</c:f>
              <c:numCache>
                <c:formatCode>General</c:formatCode>
                <c:ptCount val="18"/>
                <c:pt idx="0">
                  <c:v>1.290322580645161</c:v>
                </c:pt>
                <c:pt idx="1">
                  <c:v>1.290322580645161</c:v>
                </c:pt>
                <c:pt idx="2">
                  <c:v>0</c:v>
                </c:pt>
                <c:pt idx="3">
                  <c:v>0.64516129032258618</c:v>
                </c:pt>
                <c:pt idx="4">
                  <c:v>1.290322580645161</c:v>
                </c:pt>
                <c:pt idx="5">
                  <c:v>0</c:v>
                </c:pt>
                <c:pt idx="6">
                  <c:v>0.64516129032258618</c:v>
                </c:pt>
                <c:pt idx="7">
                  <c:v>0</c:v>
                </c:pt>
                <c:pt idx="8">
                  <c:v>0.64516129032258618</c:v>
                </c:pt>
                <c:pt idx="9">
                  <c:v>0.64516129032258618</c:v>
                </c:pt>
                <c:pt idx="10">
                  <c:v>1.9354838709677502</c:v>
                </c:pt>
                <c:pt idx="11">
                  <c:v>0</c:v>
                </c:pt>
                <c:pt idx="12">
                  <c:v>1.9354838709677502</c:v>
                </c:pt>
                <c:pt idx="13">
                  <c:v>1.9354838709677502</c:v>
                </c:pt>
                <c:pt idx="14">
                  <c:v>0</c:v>
                </c:pt>
                <c:pt idx="15">
                  <c:v>1.290322580645161</c:v>
                </c:pt>
                <c:pt idx="16">
                  <c:v>1.290322580645161</c:v>
                </c:pt>
                <c:pt idx="17">
                  <c:v>0.6451612903225861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C-8810-4B29-A9E8-B4B5DDC71C7B}"/>
            </c:ext>
          </c:extLst>
        </c:ser>
        <c:ser>
          <c:idx val="13"/>
          <c:order val="13"/>
          <c:tx>
            <c:strRef>
              <c:f>'4nt'!$A$105</c:f>
              <c:strCache>
                <c:ptCount val="1"/>
                <c:pt idx="0">
                  <c:v>AAUG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105:$S$105</c:f>
              <c:numCache>
                <c:formatCode>General</c:formatCode>
                <c:ptCount val="18"/>
                <c:pt idx="0">
                  <c:v>0.64516129032258618</c:v>
                </c:pt>
                <c:pt idx="1">
                  <c:v>0</c:v>
                </c:pt>
                <c:pt idx="2">
                  <c:v>1.290322580645161</c:v>
                </c:pt>
                <c:pt idx="3">
                  <c:v>0.64516129032258618</c:v>
                </c:pt>
                <c:pt idx="4">
                  <c:v>0.64516129032258618</c:v>
                </c:pt>
                <c:pt idx="5">
                  <c:v>0.64516129032258618</c:v>
                </c:pt>
                <c:pt idx="6">
                  <c:v>0.64516129032258618</c:v>
                </c:pt>
                <c:pt idx="7">
                  <c:v>0.64516129032258618</c:v>
                </c:pt>
                <c:pt idx="8">
                  <c:v>0.64516129032258618</c:v>
                </c:pt>
                <c:pt idx="9">
                  <c:v>0</c:v>
                </c:pt>
                <c:pt idx="10">
                  <c:v>1.290322580645161</c:v>
                </c:pt>
                <c:pt idx="11">
                  <c:v>1.290322580645161</c:v>
                </c:pt>
                <c:pt idx="12">
                  <c:v>2.5806451612903221</c:v>
                </c:pt>
                <c:pt idx="13">
                  <c:v>0.64516129032258618</c:v>
                </c:pt>
                <c:pt idx="14">
                  <c:v>0.64516129032258618</c:v>
                </c:pt>
                <c:pt idx="15">
                  <c:v>1.290322580645161</c:v>
                </c:pt>
                <c:pt idx="16">
                  <c:v>0.64516129032258618</c:v>
                </c:pt>
                <c:pt idx="17">
                  <c:v>0.6451612903225861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D-8810-4B29-A9E8-B4B5DDC71C7B}"/>
            </c:ext>
          </c:extLst>
        </c:ser>
        <c:ser>
          <c:idx val="14"/>
          <c:order val="14"/>
          <c:tx>
            <c:strRef>
              <c:f>'4nt'!$A$106</c:f>
              <c:strCache>
                <c:ptCount val="1"/>
                <c:pt idx="0">
                  <c:v>ACGU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106:$S$106</c:f>
              <c:numCache>
                <c:formatCode>General</c:formatCode>
                <c:ptCount val="18"/>
                <c:pt idx="0">
                  <c:v>0</c:v>
                </c:pt>
                <c:pt idx="1">
                  <c:v>1.290322580645161</c:v>
                </c:pt>
                <c:pt idx="2">
                  <c:v>1.290322580645161</c:v>
                </c:pt>
                <c:pt idx="3">
                  <c:v>0.64516129032258618</c:v>
                </c:pt>
                <c:pt idx="4">
                  <c:v>1.290322580645161</c:v>
                </c:pt>
                <c:pt idx="5">
                  <c:v>2.5806451612903221</c:v>
                </c:pt>
                <c:pt idx="6">
                  <c:v>1.9354838709677502</c:v>
                </c:pt>
                <c:pt idx="7">
                  <c:v>0.64516129032258618</c:v>
                </c:pt>
                <c:pt idx="8">
                  <c:v>0.64516129032258618</c:v>
                </c:pt>
                <c:pt idx="9">
                  <c:v>0</c:v>
                </c:pt>
                <c:pt idx="10">
                  <c:v>0.64516129032258618</c:v>
                </c:pt>
                <c:pt idx="11">
                  <c:v>0</c:v>
                </c:pt>
                <c:pt idx="12">
                  <c:v>1.290322580645161</c:v>
                </c:pt>
                <c:pt idx="13">
                  <c:v>0</c:v>
                </c:pt>
                <c:pt idx="14">
                  <c:v>0.64516129032258618</c:v>
                </c:pt>
                <c:pt idx="15">
                  <c:v>0.64516129032258618</c:v>
                </c:pt>
                <c:pt idx="16">
                  <c:v>0.64516129032258618</c:v>
                </c:pt>
                <c:pt idx="1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E-8810-4B29-A9E8-B4B5DDC71C7B}"/>
            </c:ext>
          </c:extLst>
        </c:ser>
        <c:ser>
          <c:idx val="15"/>
          <c:order val="15"/>
          <c:tx>
            <c:strRef>
              <c:f>'4nt'!$A$107</c:f>
              <c:strCache>
                <c:ptCount val="1"/>
                <c:pt idx="0">
                  <c:v>CGAA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107:$S$107</c:f>
              <c:numCache>
                <c:formatCode>General</c:formatCode>
                <c:ptCount val="18"/>
                <c:pt idx="0">
                  <c:v>1.290322580645161</c:v>
                </c:pt>
                <c:pt idx="1">
                  <c:v>0.64516129032258618</c:v>
                </c:pt>
                <c:pt idx="2">
                  <c:v>1.9354838709677502</c:v>
                </c:pt>
                <c:pt idx="3">
                  <c:v>1.9354838709677502</c:v>
                </c:pt>
                <c:pt idx="4">
                  <c:v>1.290322580645161</c:v>
                </c:pt>
                <c:pt idx="5">
                  <c:v>0.64516129032258618</c:v>
                </c:pt>
                <c:pt idx="6">
                  <c:v>1.290322580645161</c:v>
                </c:pt>
                <c:pt idx="7">
                  <c:v>0.64516129032258618</c:v>
                </c:pt>
                <c:pt idx="8">
                  <c:v>0</c:v>
                </c:pt>
                <c:pt idx="9">
                  <c:v>0.64516129032258618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1.290322580645161</c:v>
                </c:pt>
                <c:pt idx="14">
                  <c:v>0.64516129032258618</c:v>
                </c:pt>
                <c:pt idx="15">
                  <c:v>1.290322580645161</c:v>
                </c:pt>
                <c:pt idx="16">
                  <c:v>0</c:v>
                </c:pt>
                <c:pt idx="1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F-8810-4B29-A9E8-B4B5DDC71C7B}"/>
            </c:ext>
          </c:extLst>
        </c:ser>
        <c:ser>
          <c:idx val="16"/>
          <c:order val="16"/>
          <c:tx>
            <c:strRef>
              <c:f>'4nt'!$A$108</c:f>
              <c:strCache>
                <c:ptCount val="1"/>
                <c:pt idx="0">
                  <c:v>CUAA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108:$S$108</c:f>
              <c:numCache>
                <c:formatCode>General</c:formatCode>
                <c:ptCount val="18"/>
                <c:pt idx="0">
                  <c:v>0.64516129032258618</c:v>
                </c:pt>
                <c:pt idx="1">
                  <c:v>0.64516129032258618</c:v>
                </c:pt>
                <c:pt idx="2">
                  <c:v>0.64516129032258618</c:v>
                </c:pt>
                <c:pt idx="3">
                  <c:v>0</c:v>
                </c:pt>
                <c:pt idx="4">
                  <c:v>0.64516129032258618</c:v>
                </c:pt>
                <c:pt idx="5">
                  <c:v>0.64516129032258618</c:v>
                </c:pt>
                <c:pt idx="6">
                  <c:v>0.64516129032258618</c:v>
                </c:pt>
                <c:pt idx="7">
                  <c:v>2.5806451612903221</c:v>
                </c:pt>
                <c:pt idx="8">
                  <c:v>2.5806451612903221</c:v>
                </c:pt>
                <c:pt idx="9">
                  <c:v>1.290322580645161</c:v>
                </c:pt>
                <c:pt idx="10">
                  <c:v>0</c:v>
                </c:pt>
                <c:pt idx="11">
                  <c:v>1.290322580645161</c:v>
                </c:pt>
                <c:pt idx="12">
                  <c:v>0.64516129032258618</c:v>
                </c:pt>
                <c:pt idx="13">
                  <c:v>0</c:v>
                </c:pt>
                <c:pt idx="14">
                  <c:v>0</c:v>
                </c:pt>
                <c:pt idx="15">
                  <c:v>0.64516129032258618</c:v>
                </c:pt>
                <c:pt idx="16">
                  <c:v>0</c:v>
                </c:pt>
                <c:pt idx="1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0-8810-4B29-A9E8-B4B5DDC71C7B}"/>
            </c:ext>
          </c:extLst>
        </c:ser>
        <c:ser>
          <c:idx val="17"/>
          <c:order val="17"/>
          <c:tx>
            <c:strRef>
              <c:f>'4nt'!$A$109</c:f>
              <c:strCache>
                <c:ptCount val="1"/>
                <c:pt idx="0">
                  <c:v>AUCG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109:$S$109</c:f>
              <c:numCache>
                <c:formatCode>General</c:formatCode>
                <c:ptCount val="18"/>
                <c:pt idx="0">
                  <c:v>1.9354838709677502</c:v>
                </c:pt>
                <c:pt idx="1">
                  <c:v>0.64516129032258618</c:v>
                </c:pt>
                <c:pt idx="2">
                  <c:v>1.290322580645161</c:v>
                </c:pt>
                <c:pt idx="3">
                  <c:v>0.64516129032258618</c:v>
                </c:pt>
                <c:pt idx="4">
                  <c:v>1.290322580645161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.64516129032258618</c:v>
                </c:pt>
                <c:pt idx="10">
                  <c:v>0</c:v>
                </c:pt>
                <c:pt idx="11">
                  <c:v>0.64516129032258618</c:v>
                </c:pt>
                <c:pt idx="12">
                  <c:v>0</c:v>
                </c:pt>
                <c:pt idx="13">
                  <c:v>1.290322580645161</c:v>
                </c:pt>
                <c:pt idx="14">
                  <c:v>0</c:v>
                </c:pt>
                <c:pt idx="15">
                  <c:v>1.290322580645161</c:v>
                </c:pt>
                <c:pt idx="16">
                  <c:v>0.64516129032258618</c:v>
                </c:pt>
                <c:pt idx="17">
                  <c:v>1.29032258064516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1-8810-4B29-A9E8-B4B5DDC71C7B}"/>
            </c:ext>
          </c:extLst>
        </c:ser>
        <c:ser>
          <c:idx val="18"/>
          <c:order val="18"/>
          <c:tx>
            <c:strRef>
              <c:f>'4nt'!$A$110</c:f>
              <c:strCache>
                <c:ptCount val="1"/>
                <c:pt idx="0">
                  <c:v>AAGA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110:$S$110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1.290322580645161</c:v>
                </c:pt>
                <c:pt idx="3">
                  <c:v>0</c:v>
                </c:pt>
                <c:pt idx="4">
                  <c:v>0</c:v>
                </c:pt>
                <c:pt idx="5">
                  <c:v>1.290322580645161</c:v>
                </c:pt>
                <c:pt idx="6">
                  <c:v>0.64516129032258618</c:v>
                </c:pt>
                <c:pt idx="7">
                  <c:v>0</c:v>
                </c:pt>
                <c:pt idx="8">
                  <c:v>0</c:v>
                </c:pt>
                <c:pt idx="9">
                  <c:v>0.64516129032258618</c:v>
                </c:pt>
                <c:pt idx="10">
                  <c:v>0.64516129032258618</c:v>
                </c:pt>
                <c:pt idx="11">
                  <c:v>1.290322580645161</c:v>
                </c:pt>
                <c:pt idx="12">
                  <c:v>1.9354838709677502</c:v>
                </c:pt>
                <c:pt idx="13">
                  <c:v>1.290322580645161</c:v>
                </c:pt>
                <c:pt idx="14">
                  <c:v>0</c:v>
                </c:pt>
                <c:pt idx="15">
                  <c:v>0.64516129032258618</c:v>
                </c:pt>
                <c:pt idx="16">
                  <c:v>1.290322580645161</c:v>
                </c:pt>
                <c:pt idx="17">
                  <c:v>0.6451612903225861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2-8810-4B29-A9E8-B4B5DDC71C7B}"/>
            </c:ext>
          </c:extLst>
        </c:ser>
        <c:ser>
          <c:idx val="19"/>
          <c:order val="19"/>
          <c:tx>
            <c:strRef>
              <c:f>'4nt'!$A$111</c:f>
              <c:strCache>
                <c:ptCount val="1"/>
                <c:pt idx="0">
                  <c:v>UCGU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111:$S$111</c:f>
              <c:numCache>
                <c:formatCode>General</c:formatCode>
                <c:ptCount val="18"/>
                <c:pt idx="0">
                  <c:v>1.290322580645161</c:v>
                </c:pt>
                <c:pt idx="1">
                  <c:v>0.64516129032258618</c:v>
                </c:pt>
                <c:pt idx="2">
                  <c:v>0</c:v>
                </c:pt>
                <c:pt idx="3">
                  <c:v>1.290322580645161</c:v>
                </c:pt>
                <c:pt idx="4">
                  <c:v>0.64516129032258618</c:v>
                </c:pt>
                <c:pt idx="5">
                  <c:v>1.290322580645161</c:v>
                </c:pt>
                <c:pt idx="6">
                  <c:v>1.9354838709677502</c:v>
                </c:pt>
                <c:pt idx="7">
                  <c:v>0</c:v>
                </c:pt>
                <c:pt idx="8">
                  <c:v>0.64516129032258618</c:v>
                </c:pt>
                <c:pt idx="9">
                  <c:v>0</c:v>
                </c:pt>
                <c:pt idx="10">
                  <c:v>0.64516129032258618</c:v>
                </c:pt>
                <c:pt idx="11">
                  <c:v>0</c:v>
                </c:pt>
                <c:pt idx="12">
                  <c:v>0.64516129032258618</c:v>
                </c:pt>
                <c:pt idx="13">
                  <c:v>0</c:v>
                </c:pt>
                <c:pt idx="14">
                  <c:v>0.64516129032258618</c:v>
                </c:pt>
                <c:pt idx="15">
                  <c:v>0</c:v>
                </c:pt>
                <c:pt idx="16">
                  <c:v>1.290322580645161</c:v>
                </c:pt>
                <c:pt idx="17">
                  <c:v>0.6451612903225861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3-8810-4B29-A9E8-B4B5DDC71C7B}"/>
            </c:ext>
          </c:extLst>
        </c:ser>
        <c:ser>
          <c:idx val="20"/>
          <c:order val="20"/>
          <c:tx>
            <c:strRef>
              <c:f>'4nt'!$A$112</c:f>
              <c:strCache>
                <c:ptCount val="1"/>
                <c:pt idx="0">
                  <c:v>CACG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112:$S$112</c:f>
              <c:numCache>
                <c:formatCode>General</c:formatCode>
                <c:ptCount val="18"/>
                <c:pt idx="0">
                  <c:v>1.290322580645161</c:v>
                </c:pt>
                <c:pt idx="1">
                  <c:v>1.290322580645161</c:v>
                </c:pt>
                <c:pt idx="2">
                  <c:v>0.64516129032258618</c:v>
                </c:pt>
                <c:pt idx="3">
                  <c:v>1.290322580645161</c:v>
                </c:pt>
                <c:pt idx="4">
                  <c:v>1.290322580645161</c:v>
                </c:pt>
                <c:pt idx="5">
                  <c:v>1.290322580645161</c:v>
                </c:pt>
                <c:pt idx="6">
                  <c:v>0.64516129032258618</c:v>
                </c:pt>
                <c:pt idx="7">
                  <c:v>0.64516129032258618</c:v>
                </c:pt>
                <c:pt idx="8">
                  <c:v>0.64516129032258618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1.290322580645161</c:v>
                </c:pt>
                <c:pt idx="15">
                  <c:v>0</c:v>
                </c:pt>
                <c:pt idx="16">
                  <c:v>0</c:v>
                </c:pt>
                <c:pt idx="17">
                  <c:v>0.6451612903225861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4-8810-4B29-A9E8-B4B5DDC71C7B}"/>
            </c:ext>
          </c:extLst>
        </c:ser>
        <c:ser>
          <c:idx val="21"/>
          <c:order val="21"/>
          <c:tx>
            <c:strRef>
              <c:f>'4nt'!$A$113</c:f>
              <c:strCache>
                <c:ptCount val="1"/>
                <c:pt idx="0">
                  <c:v>AGUA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113:$S$113</c:f>
              <c:numCache>
                <c:formatCode>General</c:formatCode>
                <c:ptCount val="18"/>
                <c:pt idx="0">
                  <c:v>0</c:v>
                </c:pt>
                <c:pt idx="1">
                  <c:v>0.64516129032258618</c:v>
                </c:pt>
                <c:pt idx="2">
                  <c:v>0</c:v>
                </c:pt>
                <c:pt idx="3">
                  <c:v>0</c:v>
                </c:pt>
                <c:pt idx="4">
                  <c:v>1.290322580645161</c:v>
                </c:pt>
                <c:pt idx="5">
                  <c:v>0.64516129032258618</c:v>
                </c:pt>
                <c:pt idx="6">
                  <c:v>1.290322580645161</c:v>
                </c:pt>
                <c:pt idx="7">
                  <c:v>0.64516129032258618</c:v>
                </c:pt>
                <c:pt idx="8">
                  <c:v>0.64516129032258618</c:v>
                </c:pt>
                <c:pt idx="9">
                  <c:v>0.64516129032258618</c:v>
                </c:pt>
                <c:pt idx="10">
                  <c:v>1.9354838709677502</c:v>
                </c:pt>
                <c:pt idx="11">
                  <c:v>1.290322580645161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.64516129032258618</c:v>
                </c:pt>
                <c:pt idx="16">
                  <c:v>0.64516129032258618</c:v>
                </c:pt>
                <c:pt idx="17">
                  <c:v>0.6451612903225861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5-8810-4B29-A9E8-B4B5DDC71C7B}"/>
            </c:ext>
          </c:extLst>
        </c:ser>
        <c:ser>
          <c:idx val="22"/>
          <c:order val="22"/>
          <c:tx>
            <c:strRef>
              <c:f>'4nt'!$A$114</c:f>
              <c:strCache>
                <c:ptCount val="1"/>
                <c:pt idx="0">
                  <c:v>CGUU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114:$S$114</c:f>
              <c:numCache>
                <c:formatCode>General</c:formatCode>
                <c:ptCount val="18"/>
                <c:pt idx="0">
                  <c:v>0.64516129032258618</c:v>
                </c:pt>
                <c:pt idx="1">
                  <c:v>0.64516129032258618</c:v>
                </c:pt>
                <c:pt idx="2">
                  <c:v>0.64516129032258618</c:v>
                </c:pt>
                <c:pt idx="3">
                  <c:v>0.64516129032258618</c:v>
                </c:pt>
                <c:pt idx="4">
                  <c:v>0.64516129032258618</c:v>
                </c:pt>
                <c:pt idx="5">
                  <c:v>0.64516129032258618</c:v>
                </c:pt>
                <c:pt idx="6">
                  <c:v>0.64516129032258618</c:v>
                </c:pt>
                <c:pt idx="7">
                  <c:v>0.64516129032258618</c:v>
                </c:pt>
                <c:pt idx="8">
                  <c:v>0</c:v>
                </c:pt>
                <c:pt idx="9">
                  <c:v>0.64516129032258618</c:v>
                </c:pt>
                <c:pt idx="10">
                  <c:v>0</c:v>
                </c:pt>
                <c:pt idx="11">
                  <c:v>0.64516129032258618</c:v>
                </c:pt>
                <c:pt idx="12">
                  <c:v>0.64516129032258618</c:v>
                </c:pt>
                <c:pt idx="13">
                  <c:v>1.290322580645161</c:v>
                </c:pt>
                <c:pt idx="14">
                  <c:v>0</c:v>
                </c:pt>
                <c:pt idx="15">
                  <c:v>1.290322580645161</c:v>
                </c:pt>
                <c:pt idx="16">
                  <c:v>0.64516129032258618</c:v>
                </c:pt>
                <c:pt idx="17">
                  <c:v>0.6451612903225861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6-8810-4B29-A9E8-B4B5DDC71C7B}"/>
            </c:ext>
          </c:extLst>
        </c:ser>
        <c:ser>
          <c:idx val="23"/>
          <c:order val="23"/>
          <c:tx>
            <c:strRef>
              <c:f>'4nt'!$A$115</c:f>
              <c:strCache>
                <c:ptCount val="1"/>
                <c:pt idx="0">
                  <c:v>GGAA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115:$S$115</c:f>
              <c:numCache>
                <c:formatCode>General</c:formatCode>
                <c:ptCount val="18"/>
                <c:pt idx="0">
                  <c:v>1.9354838709677502</c:v>
                </c:pt>
                <c:pt idx="1">
                  <c:v>1.290322580645161</c:v>
                </c:pt>
                <c:pt idx="2">
                  <c:v>0</c:v>
                </c:pt>
                <c:pt idx="3">
                  <c:v>1.290322580645161</c:v>
                </c:pt>
                <c:pt idx="4">
                  <c:v>0.64516129032258618</c:v>
                </c:pt>
                <c:pt idx="5">
                  <c:v>0.64516129032258618</c:v>
                </c:pt>
                <c:pt idx="6">
                  <c:v>0.64516129032258618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.64516129032258618</c:v>
                </c:pt>
                <c:pt idx="11">
                  <c:v>0.64516129032258618</c:v>
                </c:pt>
                <c:pt idx="12">
                  <c:v>0</c:v>
                </c:pt>
                <c:pt idx="13">
                  <c:v>0.64516129032258618</c:v>
                </c:pt>
                <c:pt idx="14">
                  <c:v>1.290322580645161</c:v>
                </c:pt>
                <c:pt idx="15">
                  <c:v>0</c:v>
                </c:pt>
                <c:pt idx="16">
                  <c:v>0.64516129032258618</c:v>
                </c:pt>
                <c:pt idx="17">
                  <c:v>0.6451612903225861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7-8810-4B29-A9E8-B4B5DDC71C7B}"/>
            </c:ext>
          </c:extLst>
        </c:ser>
        <c:ser>
          <c:idx val="24"/>
          <c:order val="24"/>
          <c:tx>
            <c:strRef>
              <c:f>'4nt'!$A$116</c:f>
              <c:strCache>
                <c:ptCount val="1"/>
                <c:pt idx="0">
                  <c:v>UAUA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116:$S$116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.64516129032258618</c:v>
                </c:pt>
                <c:pt idx="3">
                  <c:v>0.64516129032258618</c:v>
                </c:pt>
                <c:pt idx="4">
                  <c:v>0.64516129032258618</c:v>
                </c:pt>
                <c:pt idx="5">
                  <c:v>1.290322580645161</c:v>
                </c:pt>
                <c:pt idx="6">
                  <c:v>1.290322580645161</c:v>
                </c:pt>
                <c:pt idx="7">
                  <c:v>0</c:v>
                </c:pt>
                <c:pt idx="8">
                  <c:v>1.290322580645161</c:v>
                </c:pt>
                <c:pt idx="9">
                  <c:v>1.290322580645161</c:v>
                </c:pt>
                <c:pt idx="10">
                  <c:v>1.290322580645161</c:v>
                </c:pt>
                <c:pt idx="11">
                  <c:v>0</c:v>
                </c:pt>
                <c:pt idx="12">
                  <c:v>0.64516129032258618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1.29032258064516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8-8810-4B29-A9E8-B4B5DDC71C7B}"/>
            </c:ext>
          </c:extLst>
        </c:ser>
        <c:ser>
          <c:idx val="25"/>
          <c:order val="25"/>
          <c:tx>
            <c:strRef>
              <c:f>'4nt'!$A$117</c:f>
              <c:strCache>
                <c:ptCount val="1"/>
                <c:pt idx="0">
                  <c:v>GAAC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117:$S$117</c:f>
              <c:numCache>
                <c:formatCode>General</c:formatCode>
                <c:ptCount val="18"/>
                <c:pt idx="0">
                  <c:v>0</c:v>
                </c:pt>
                <c:pt idx="1">
                  <c:v>0.64516129032258618</c:v>
                </c:pt>
                <c:pt idx="2">
                  <c:v>0.64516129032258618</c:v>
                </c:pt>
                <c:pt idx="3">
                  <c:v>0.64516129032258618</c:v>
                </c:pt>
                <c:pt idx="4">
                  <c:v>0.64516129032258618</c:v>
                </c:pt>
                <c:pt idx="5">
                  <c:v>0.64516129032258618</c:v>
                </c:pt>
                <c:pt idx="6">
                  <c:v>0</c:v>
                </c:pt>
                <c:pt idx="7">
                  <c:v>0.64516129032258618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.64516129032258618</c:v>
                </c:pt>
                <c:pt idx="12">
                  <c:v>0.64516129032258618</c:v>
                </c:pt>
                <c:pt idx="13">
                  <c:v>0</c:v>
                </c:pt>
                <c:pt idx="14">
                  <c:v>3.2258064516129052</c:v>
                </c:pt>
                <c:pt idx="15">
                  <c:v>0.64516129032258618</c:v>
                </c:pt>
                <c:pt idx="16">
                  <c:v>0.64516129032258618</c:v>
                </c:pt>
                <c:pt idx="17">
                  <c:v>0.6451612903225861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9-8810-4B29-A9E8-B4B5DDC71C7B}"/>
            </c:ext>
          </c:extLst>
        </c:ser>
        <c:ser>
          <c:idx val="26"/>
          <c:order val="26"/>
          <c:tx>
            <c:strRef>
              <c:f>'4nt'!$A$118</c:f>
              <c:strCache>
                <c:ptCount val="1"/>
                <c:pt idx="0">
                  <c:v>GAAA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118:$S$118</c:f>
              <c:numCache>
                <c:formatCode>General</c:formatCode>
                <c:ptCount val="18"/>
                <c:pt idx="0">
                  <c:v>0.64516129032258618</c:v>
                </c:pt>
                <c:pt idx="1">
                  <c:v>1.290322580645161</c:v>
                </c:pt>
                <c:pt idx="2">
                  <c:v>1.290322580645161</c:v>
                </c:pt>
                <c:pt idx="3">
                  <c:v>0</c:v>
                </c:pt>
                <c:pt idx="4">
                  <c:v>1.290322580645161</c:v>
                </c:pt>
                <c:pt idx="5">
                  <c:v>0</c:v>
                </c:pt>
                <c:pt idx="6">
                  <c:v>0.64516129032258618</c:v>
                </c:pt>
                <c:pt idx="7">
                  <c:v>1.9354838709677502</c:v>
                </c:pt>
                <c:pt idx="8">
                  <c:v>0</c:v>
                </c:pt>
                <c:pt idx="9">
                  <c:v>0</c:v>
                </c:pt>
                <c:pt idx="10">
                  <c:v>0.64516129032258618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1.290322580645161</c:v>
                </c:pt>
                <c:pt idx="15">
                  <c:v>1.290322580645161</c:v>
                </c:pt>
                <c:pt idx="16">
                  <c:v>0</c:v>
                </c:pt>
                <c:pt idx="1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A-8810-4B29-A9E8-B4B5DDC71C7B}"/>
            </c:ext>
          </c:extLst>
        </c:ser>
        <c:ser>
          <c:idx val="27"/>
          <c:order val="27"/>
          <c:tx>
            <c:strRef>
              <c:f>'4nt'!$A$119</c:f>
              <c:strCache>
                <c:ptCount val="1"/>
                <c:pt idx="0">
                  <c:v>CAUA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119:$S$119</c:f>
              <c:numCache>
                <c:formatCode>General</c:formatCode>
                <c:ptCount val="18"/>
                <c:pt idx="0">
                  <c:v>0.64516129032258618</c:v>
                </c:pt>
                <c:pt idx="1">
                  <c:v>0.64516129032258618</c:v>
                </c:pt>
                <c:pt idx="2">
                  <c:v>0.64516129032258618</c:v>
                </c:pt>
                <c:pt idx="3">
                  <c:v>0</c:v>
                </c:pt>
                <c:pt idx="4">
                  <c:v>0.64516129032258618</c:v>
                </c:pt>
                <c:pt idx="5">
                  <c:v>1.290322580645161</c:v>
                </c:pt>
                <c:pt idx="6">
                  <c:v>0.64516129032258618</c:v>
                </c:pt>
                <c:pt idx="7">
                  <c:v>0.64516129032258618</c:v>
                </c:pt>
                <c:pt idx="8">
                  <c:v>1.290322580645161</c:v>
                </c:pt>
                <c:pt idx="9">
                  <c:v>1.290322580645161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.64516129032258618</c:v>
                </c:pt>
                <c:pt idx="15">
                  <c:v>0.64516129032258618</c:v>
                </c:pt>
                <c:pt idx="16">
                  <c:v>0.64516129032258618</c:v>
                </c:pt>
                <c:pt idx="17">
                  <c:v>0.6451612903225861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B-8810-4B29-A9E8-B4B5DDC71C7B}"/>
            </c:ext>
          </c:extLst>
        </c:ser>
        <c:ser>
          <c:idx val="28"/>
          <c:order val="28"/>
          <c:tx>
            <c:strRef>
              <c:f>'4nt'!$A$120</c:f>
              <c:strCache>
                <c:ptCount val="1"/>
                <c:pt idx="0">
                  <c:v>ACUG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120:$S$120</c:f>
              <c:numCache>
                <c:formatCode>General</c:formatCode>
                <c:ptCount val="18"/>
                <c:pt idx="0">
                  <c:v>0</c:v>
                </c:pt>
                <c:pt idx="1">
                  <c:v>0.64516129032258618</c:v>
                </c:pt>
                <c:pt idx="2">
                  <c:v>0</c:v>
                </c:pt>
                <c:pt idx="3">
                  <c:v>0</c:v>
                </c:pt>
                <c:pt idx="4">
                  <c:v>0.64516129032258618</c:v>
                </c:pt>
                <c:pt idx="5">
                  <c:v>0.64516129032258618</c:v>
                </c:pt>
                <c:pt idx="6">
                  <c:v>0</c:v>
                </c:pt>
                <c:pt idx="7">
                  <c:v>0.64516129032258618</c:v>
                </c:pt>
                <c:pt idx="8">
                  <c:v>0.64516129032258618</c:v>
                </c:pt>
                <c:pt idx="9">
                  <c:v>0</c:v>
                </c:pt>
                <c:pt idx="10">
                  <c:v>0</c:v>
                </c:pt>
                <c:pt idx="11">
                  <c:v>1.290322580645161</c:v>
                </c:pt>
                <c:pt idx="12">
                  <c:v>0</c:v>
                </c:pt>
                <c:pt idx="13">
                  <c:v>0.64516129032258618</c:v>
                </c:pt>
                <c:pt idx="14">
                  <c:v>1.9354838709677502</c:v>
                </c:pt>
                <c:pt idx="15">
                  <c:v>0</c:v>
                </c:pt>
                <c:pt idx="16">
                  <c:v>1.9354838709677502</c:v>
                </c:pt>
                <c:pt idx="17">
                  <c:v>1.29032258064516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C-8810-4B29-A9E8-B4B5DDC71C7B}"/>
            </c:ext>
          </c:extLst>
        </c:ser>
        <c:ser>
          <c:idx val="29"/>
          <c:order val="29"/>
          <c:tx>
            <c:strRef>
              <c:f>'4nt'!$A$121</c:f>
              <c:strCache>
                <c:ptCount val="1"/>
                <c:pt idx="0">
                  <c:v>ACAU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121:$S$121</c:f>
              <c:numCache>
                <c:formatCode>General</c:formatCode>
                <c:ptCount val="18"/>
                <c:pt idx="0">
                  <c:v>0</c:v>
                </c:pt>
                <c:pt idx="1">
                  <c:v>0.64516129032258618</c:v>
                </c:pt>
                <c:pt idx="2">
                  <c:v>0</c:v>
                </c:pt>
                <c:pt idx="3">
                  <c:v>0.64516129032258618</c:v>
                </c:pt>
                <c:pt idx="4">
                  <c:v>0.64516129032258618</c:v>
                </c:pt>
                <c:pt idx="5">
                  <c:v>0</c:v>
                </c:pt>
                <c:pt idx="6">
                  <c:v>0.64516129032258618</c:v>
                </c:pt>
                <c:pt idx="7">
                  <c:v>0.64516129032258618</c:v>
                </c:pt>
                <c:pt idx="8">
                  <c:v>1.290322580645161</c:v>
                </c:pt>
                <c:pt idx="9">
                  <c:v>1.9354838709677502</c:v>
                </c:pt>
                <c:pt idx="10">
                  <c:v>0</c:v>
                </c:pt>
                <c:pt idx="11">
                  <c:v>0.64516129032258618</c:v>
                </c:pt>
                <c:pt idx="12">
                  <c:v>0</c:v>
                </c:pt>
                <c:pt idx="13">
                  <c:v>1.290322580645161</c:v>
                </c:pt>
                <c:pt idx="14">
                  <c:v>0.64516129032258618</c:v>
                </c:pt>
                <c:pt idx="15">
                  <c:v>0.64516129032258618</c:v>
                </c:pt>
                <c:pt idx="16">
                  <c:v>0.64516129032258618</c:v>
                </c:pt>
                <c:pt idx="1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D-8810-4B29-A9E8-B4B5DDC71C7B}"/>
            </c:ext>
          </c:extLst>
        </c:ser>
        <c:ser>
          <c:idx val="30"/>
          <c:order val="30"/>
          <c:tx>
            <c:strRef>
              <c:f>'4nt'!$A$122</c:f>
              <c:strCache>
                <c:ptCount val="1"/>
                <c:pt idx="0">
                  <c:v>CAUC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122:$S$122</c:f>
              <c:numCache>
                <c:formatCode>General</c:formatCode>
                <c:ptCount val="18"/>
                <c:pt idx="0">
                  <c:v>0.64516129032258618</c:v>
                </c:pt>
                <c:pt idx="1">
                  <c:v>0.64516129032258618</c:v>
                </c:pt>
                <c:pt idx="2">
                  <c:v>0.64516129032258618</c:v>
                </c:pt>
                <c:pt idx="3">
                  <c:v>1.290322580645161</c:v>
                </c:pt>
                <c:pt idx="4">
                  <c:v>1.9354838709677502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1.290322580645161</c:v>
                </c:pt>
                <c:pt idx="11">
                  <c:v>0</c:v>
                </c:pt>
                <c:pt idx="12">
                  <c:v>1.290322580645161</c:v>
                </c:pt>
                <c:pt idx="13">
                  <c:v>0</c:v>
                </c:pt>
                <c:pt idx="14">
                  <c:v>1.290322580645161</c:v>
                </c:pt>
                <c:pt idx="15">
                  <c:v>0</c:v>
                </c:pt>
                <c:pt idx="16">
                  <c:v>0.64516129032258618</c:v>
                </c:pt>
                <c:pt idx="17">
                  <c:v>0.6451612903225861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E-8810-4B29-A9E8-B4B5DDC71C7B}"/>
            </c:ext>
          </c:extLst>
        </c:ser>
        <c:ser>
          <c:idx val="31"/>
          <c:order val="31"/>
          <c:tx>
            <c:strRef>
              <c:f>'4nt'!$A$123</c:f>
              <c:strCache>
                <c:ptCount val="1"/>
                <c:pt idx="0">
                  <c:v>GCGG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123:$S$123</c:f>
              <c:numCache>
                <c:formatCode>General</c:formatCode>
                <c:ptCount val="18"/>
                <c:pt idx="0">
                  <c:v>0</c:v>
                </c:pt>
                <c:pt idx="1">
                  <c:v>0.64516129032258618</c:v>
                </c:pt>
                <c:pt idx="2">
                  <c:v>0</c:v>
                </c:pt>
                <c:pt idx="3">
                  <c:v>2.5806451612903221</c:v>
                </c:pt>
                <c:pt idx="4">
                  <c:v>0.64516129032258618</c:v>
                </c:pt>
                <c:pt idx="5">
                  <c:v>0.64516129032258618</c:v>
                </c:pt>
                <c:pt idx="6">
                  <c:v>0.64516129032258618</c:v>
                </c:pt>
                <c:pt idx="7">
                  <c:v>0</c:v>
                </c:pt>
                <c:pt idx="8">
                  <c:v>1.290322580645161</c:v>
                </c:pt>
                <c:pt idx="9">
                  <c:v>0</c:v>
                </c:pt>
                <c:pt idx="10">
                  <c:v>0.64516129032258618</c:v>
                </c:pt>
                <c:pt idx="11">
                  <c:v>0.64516129032258618</c:v>
                </c:pt>
                <c:pt idx="12">
                  <c:v>0.64516129032258618</c:v>
                </c:pt>
                <c:pt idx="13">
                  <c:v>1.290322580645161</c:v>
                </c:pt>
                <c:pt idx="14">
                  <c:v>0.64516129032258618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F-8810-4B29-A9E8-B4B5DDC71C7B}"/>
            </c:ext>
          </c:extLst>
        </c:ser>
        <c:ser>
          <c:idx val="32"/>
          <c:order val="32"/>
          <c:tx>
            <c:strRef>
              <c:f>'4nt'!$A$124</c:f>
              <c:strCache>
                <c:ptCount val="1"/>
                <c:pt idx="0">
                  <c:v>UGUA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124:$S$124</c:f>
              <c:numCache>
                <c:formatCode>General</c:formatCode>
                <c:ptCount val="18"/>
                <c:pt idx="0">
                  <c:v>0.64516129032258618</c:v>
                </c:pt>
                <c:pt idx="1">
                  <c:v>0</c:v>
                </c:pt>
                <c:pt idx="2">
                  <c:v>0.64516129032258618</c:v>
                </c:pt>
                <c:pt idx="3">
                  <c:v>1.290322580645161</c:v>
                </c:pt>
                <c:pt idx="4">
                  <c:v>0.64516129032258618</c:v>
                </c:pt>
                <c:pt idx="5">
                  <c:v>0.64516129032258618</c:v>
                </c:pt>
                <c:pt idx="6">
                  <c:v>1.290322580645161</c:v>
                </c:pt>
                <c:pt idx="7">
                  <c:v>0</c:v>
                </c:pt>
                <c:pt idx="8">
                  <c:v>0.64516129032258618</c:v>
                </c:pt>
                <c:pt idx="9">
                  <c:v>1.9354838709677502</c:v>
                </c:pt>
                <c:pt idx="10">
                  <c:v>1.290322580645161</c:v>
                </c:pt>
                <c:pt idx="11">
                  <c:v>0</c:v>
                </c:pt>
                <c:pt idx="12">
                  <c:v>0</c:v>
                </c:pt>
                <c:pt idx="13">
                  <c:v>0.64516129032258618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0-8810-4B29-A9E8-B4B5DDC71C7B}"/>
            </c:ext>
          </c:extLst>
        </c:ser>
        <c:ser>
          <c:idx val="33"/>
          <c:order val="33"/>
          <c:tx>
            <c:strRef>
              <c:f>'4nt'!$A$125</c:f>
              <c:strCache>
                <c:ptCount val="1"/>
                <c:pt idx="0">
                  <c:v>ACAG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125:$S$125</c:f>
              <c:numCache>
                <c:formatCode>General</c:formatCode>
                <c:ptCount val="18"/>
                <c:pt idx="0">
                  <c:v>0.64516129032258618</c:v>
                </c:pt>
                <c:pt idx="1">
                  <c:v>0.64516129032258618</c:v>
                </c:pt>
                <c:pt idx="2">
                  <c:v>0</c:v>
                </c:pt>
                <c:pt idx="3">
                  <c:v>0</c:v>
                </c:pt>
                <c:pt idx="4">
                  <c:v>0.64516129032258618</c:v>
                </c:pt>
                <c:pt idx="5">
                  <c:v>0.64516129032258618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1.290322580645161</c:v>
                </c:pt>
                <c:pt idx="10">
                  <c:v>1.290322580645161</c:v>
                </c:pt>
                <c:pt idx="11">
                  <c:v>0</c:v>
                </c:pt>
                <c:pt idx="12">
                  <c:v>0.64516129032258618</c:v>
                </c:pt>
                <c:pt idx="13">
                  <c:v>1.290322580645161</c:v>
                </c:pt>
                <c:pt idx="14">
                  <c:v>0</c:v>
                </c:pt>
                <c:pt idx="15">
                  <c:v>1.290322580645161</c:v>
                </c:pt>
                <c:pt idx="16">
                  <c:v>0.64516129032258618</c:v>
                </c:pt>
                <c:pt idx="17">
                  <c:v>0.6451612903225861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1-8810-4B29-A9E8-B4B5DDC71C7B}"/>
            </c:ext>
          </c:extLst>
        </c:ser>
        <c:ser>
          <c:idx val="34"/>
          <c:order val="34"/>
          <c:tx>
            <c:strRef>
              <c:f>'4nt'!$A$126</c:f>
              <c:strCache>
                <c:ptCount val="1"/>
                <c:pt idx="0">
                  <c:v>AUGC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126:$S$126</c:f>
              <c:numCache>
                <c:formatCode>General</c:formatCode>
                <c:ptCount val="18"/>
                <c:pt idx="0">
                  <c:v>0</c:v>
                </c:pt>
                <c:pt idx="1">
                  <c:v>2.5806451612903221</c:v>
                </c:pt>
                <c:pt idx="2">
                  <c:v>0</c:v>
                </c:pt>
                <c:pt idx="3">
                  <c:v>0.64516129032258618</c:v>
                </c:pt>
                <c:pt idx="4">
                  <c:v>0</c:v>
                </c:pt>
                <c:pt idx="5">
                  <c:v>1.290322580645161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.64516129032258618</c:v>
                </c:pt>
                <c:pt idx="10">
                  <c:v>0</c:v>
                </c:pt>
                <c:pt idx="11">
                  <c:v>0.64516129032258618</c:v>
                </c:pt>
                <c:pt idx="12">
                  <c:v>1.290322580645161</c:v>
                </c:pt>
                <c:pt idx="13">
                  <c:v>1.290322580645161</c:v>
                </c:pt>
                <c:pt idx="14">
                  <c:v>0.64516129032258618</c:v>
                </c:pt>
                <c:pt idx="15">
                  <c:v>0.64516129032258618</c:v>
                </c:pt>
                <c:pt idx="16">
                  <c:v>0</c:v>
                </c:pt>
                <c:pt idx="1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2-8810-4B29-A9E8-B4B5DDC71C7B}"/>
            </c:ext>
          </c:extLst>
        </c:ser>
        <c:ser>
          <c:idx val="35"/>
          <c:order val="35"/>
          <c:tx>
            <c:strRef>
              <c:f>'4nt'!$A$127</c:f>
              <c:strCache>
                <c:ptCount val="1"/>
                <c:pt idx="0">
                  <c:v>UGAU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127:$S$127</c:f>
              <c:numCache>
                <c:formatCode>General</c:formatCode>
                <c:ptCount val="18"/>
                <c:pt idx="0">
                  <c:v>1.935483870967750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.64516129032258618</c:v>
                </c:pt>
                <c:pt idx="5">
                  <c:v>0</c:v>
                </c:pt>
                <c:pt idx="6">
                  <c:v>0.64516129032258618</c:v>
                </c:pt>
                <c:pt idx="7">
                  <c:v>0</c:v>
                </c:pt>
                <c:pt idx="8">
                  <c:v>0</c:v>
                </c:pt>
                <c:pt idx="9">
                  <c:v>0.64516129032258618</c:v>
                </c:pt>
                <c:pt idx="10">
                  <c:v>0</c:v>
                </c:pt>
                <c:pt idx="11">
                  <c:v>0</c:v>
                </c:pt>
                <c:pt idx="12">
                  <c:v>0.64516129032258618</c:v>
                </c:pt>
                <c:pt idx="13">
                  <c:v>1.290322580645161</c:v>
                </c:pt>
                <c:pt idx="14">
                  <c:v>0.64516129032258618</c:v>
                </c:pt>
                <c:pt idx="15">
                  <c:v>1.290322580645161</c:v>
                </c:pt>
                <c:pt idx="16">
                  <c:v>0.64516129032258618</c:v>
                </c:pt>
                <c:pt idx="17">
                  <c:v>1.29032258064516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3-8810-4B29-A9E8-B4B5DDC71C7B}"/>
            </c:ext>
          </c:extLst>
        </c:ser>
        <c:ser>
          <c:idx val="36"/>
          <c:order val="36"/>
          <c:tx>
            <c:strRef>
              <c:f>'4nt'!$A$128</c:f>
              <c:strCache>
                <c:ptCount val="1"/>
                <c:pt idx="0">
                  <c:v>ACGC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128:$S$128</c:f>
              <c:numCache>
                <c:formatCode>General</c:formatCode>
                <c:ptCount val="18"/>
                <c:pt idx="0">
                  <c:v>1.290322580645161</c:v>
                </c:pt>
                <c:pt idx="1">
                  <c:v>1.9354838709677502</c:v>
                </c:pt>
                <c:pt idx="2">
                  <c:v>0</c:v>
                </c:pt>
                <c:pt idx="3">
                  <c:v>0.64516129032258618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.64516129032258618</c:v>
                </c:pt>
                <c:pt idx="10">
                  <c:v>0</c:v>
                </c:pt>
                <c:pt idx="11">
                  <c:v>0</c:v>
                </c:pt>
                <c:pt idx="12">
                  <c:v>0.64516129032258618</c:v>
                </c:pt>
                <c:pt idx="13">
                  <c:v>0.64516129032258618</c:v>
                </c:pt>
                <c:pt idx="14">
                  <c:v>0.64516129032258618</c:v>
                </c:pt>
                <c:pt idx="15">
                  <c:v>1.290322580645161</c:v>
                </c:pt>
                <c:pt idx="16">
                  <c:v>1.290322580645161</c:v>
                </c:pt>
                <c:pt idx="17">
                  <c:v>0.6451612903225861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4-8810-4B29-A9E8-B4B5DDC71C7B}"/>
            </c:ext>
          </c:extLst>
        </c:ser>
        <c:ser>
          <c:idx val="37"/>
          <c:order val="37"/>
          <c:tx>
            <c:strRef>
              <c:f>'4nt'!$A$129</c:f>
              <c:strCache>
                <c:ptCount val="1"/>
                <c:pt idx="0">
                  <c:v>AAUA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129:$S$129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.64516129032258618</c:v>
                </c:pt>
                <c:pt idx="3">
                  <c:v>0.64516129032258618</c:v>
                </c:pt>
                <c:pt idx="4">
                  <c:v>1.290322580645161</c:v>
                </c:pt>
                <c:pt idx="5">
                  <c:v>0</c:v>
                </c:pt>
                <c:pt idx="6">
                  <c:v>1.9354838709677502</c:v>
                </c:pt>
                <c:pt idx="7">
                  <c:v>1.290322580645161</c:v>
                </c:pt>
                <c:pt idx="8">
                  <c:v>0.64516129032258618</c:v>
                </c:pt>
                <c:pt idx="9">
                  <c:v>0.64516129032258618</c:v>
                </c:pt>
                <c:pt idx="10">
                  <c:v>0.64516129032258618</c:v>
                </c:pt>
                <c:pt idx="11">
                  <c:v>0</c:v>
                </c:pt>
                <c:pt idx="12">
                  <c:v>0</c:v>
                </c:pt>
                <c:pt idx="13">
                  <c:v>1.290322580645161</c:v>
                </c:pt>
                <c:pt idx="14">
                  <c:v>0.64516129032258618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5-8810-4B29-A9E8-B4B5DDC71C7B}"/>
            </c:ext>
          </c:extLst>
        </c:ser>
        <c:ser>
          <c:idx val="38"/>
          <c:order val="38"/>
          <c:tx>
            <c:strRef>
              <c:f>'4nt'!$A$130</c:f>
              <c:strCache>
                <c:ptCount val="1"/>
                <c:pt idx="0">
                  <c:v>UGCC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130:$S$130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1.9354838709677502</c:v>
                </c:pt>
                <c:pt idx="3">
                  <c:v>0</c:v>
                </c:pt>
                <c:pt idx="4">
                  <c:v>0.64516129032258618</c:v>
                </c:pt>
                <c:pt idx="5">
                  <c:v>0</c:v>
                </c:pt>
                <c:pt idx="6">
                  <c:v>1.290322580645161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.64516129032258618</c:v>
                </c:pt>
                <c:pt idx="12">
                  <c:v>0</c:v>
                </c:pt>
                <c:pt idx="13">
                  <c:v>1.290322580645161</c:v>
                </c:pt>
                <c:pt idx="14">
                  <c:v>1.290322580645161</c:v>
                </c:pt>
                <c:pt idx="15">
                  <c:v>1.9354838709677502</c:v>
                </c:pt>
                <c:pt idx="16">
                  <c:v>0.64516129032258618</c:v>
                </c:pt>
                <c:pt idx="1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6-8810-4B29-A9E8-B4B5DDC71C7B}"/>
            </c:ext>
          </c:extLst>
        </c:ser>
        <c:ser>
          <c:idx val="39"/>
          <c:order val="39"/>
          <c:tx>
            <c:strRef>
              <c:f>'4nt'!$A$131</c:f>
              <c:strCache>
                <c:ptCount val="1"/>
                <c:pt idx="0">
                  <c:v>UCGA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131:$S$131</c:f>
              <c:numCache>
                <c:formatCode>General</c:formatCode>
                <c:ptCount val="18"/>
                <c:pt idx="0">
                  <c:v>1.9354838709677502</c:v>
                </c:pt>
                <c:pt idx="1">
                  <c:v>1.290322580645161</c:v>
                </c:pt>
                <c:pt idx="2">
                  <c:v>1.290322580645161</c:v>
                </c:pt>
                <c:pt idx="3">
                  <c:v>0.64516129032258618</c:v>
                </c:pt>
                <c:pt idx="4">
                  <c:v>0.64516129032258618</c:v>
                </c:pt>
                <c:pt idx="5">
                  <c:v>0.64516129032258618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.64516129032258618</c:v>
                </c:pt>
                <c:pt idx="10">
                  <c:v>0.64516129032258618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.64516129032258618</c:v>
                </c:pt>
                <c:pt idx="16">
                  <c:v>0.64516129032258618</c:v>
                </c:pt>
                <c:pt idx="17">
                  <c:v>0.6451612903225861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7-8810-4B29-A9E8-B4B5DDC71C7B}"/>
            </c:ext>
          </c:extLst>
        </c:ser>
        <c:ser>
          <c:idx val="40"/>
          <c:order val="40"/>
          <c:tx>
            <c:strRef>
              <c:f>'4nt'!$A$132</c:f>
              <c:strCache>
                <c:ptCount val="1"/>
                <c:pt idx="0">
                  <c:v>ACAC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132:$S$132</c:f>
              <c:numCache>
                <c:formatCode>General</c:formatCode>
                <c:ptCount val="18"/>
                <c:pt idx="0">
                  <c:v>0.64516129032258618</c:v>
                </c:pt>
                <c:pt idx="1">
                  <c:v>0</c:v>
                </c:pt>
                <c:pt idx="2">
                  <c:v>1.290322580645161</c:v>
                </c:pt>
                <c:pt idx="3">
                  <c:v>0.64516129032258618</c:v>
                </c:pt>
                <c:pt idx="4">
                  <c:v>1.290322580645161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.64516129032258618</c:v>
                </c:pt>
                <c:pt idx="10">
                  <c:v>0</c:v>
                </c:pt>
                <c:pt idx="11">
                  <c:v>0</c:v>
                </c:pt>
                <c:pt idx="12">
                  <c:v>0.64516129032258618</c:v>
                </c:pt>
                <c:pt idx="13">
                  <c:v>2.5806451612903221</c:v>
                </c:pt>
                <c:pt idx="14">
                  <c:v>0.64516129032258618</c:v>
                </c:pt>
                <c:pt idx="15">
                  <c:v>0</c:v>
                </c:pt>
                <c:pt idx="16">
                  <c:v>1.290322580645161</c:v>
                </c:pt>
                <c:pt idx="1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8-8810-4B29-A9E8-B4B5DDC71C7B}"/>
            </c:ext>
          </c:extLst>
        </c:ser>
        <c:ser>
          <c:idx val="41"/>
          <c:order val="41"/>
          <c:tx>
            <c:strRef>
              <c:f>'4nt'!$A$133</c:f>
              <c:strCache>
                <c:ptCount val="1"/>
                <c:pt idx="0">
                  <c:v>GUUU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133:$S$133</c:f>
              <c:numCache>
                <c:formatCode>General</c:formatCode>
                <c:ptCount val="18"/>
                <c:pt idx="0">
                  <c:v>0.64516129032258618</c:v>
                </c:pt>
                <c:pt idx="1">
                  <c:v>0</c:v>
                </c:pt>
                <c:pt idx="2">
                  <c:v>0.64516129032258618</c:v>
                </c:pt>
                <c:pt idx="3">
                  <c:v>1.290322580645161</c:v>
                </c:pt>
                <c:pt idx="4">
                  <c:v>0</c:v>
                </c:pt>
                <c:pt idx="5">
                  <c:v>0.64516129032258618</c:v>
                </c:pt>
                <c:pt idx="6">
                  <c:v>0</c:v>
                </c:pt>
                <c:pt idx="7">
                  <c:v>0.64516129032258618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.64516129032258618</c:v>
                </c:pt>
                <c:pt idx="13">
                  <c:v>0</c:v>
                </c:pt>
                <c:pt idx="14">
                  <c:v>1.290322580645161</c:v>
                </c:pt>
                <c:pt idx="15">
                  <c:v>0.64516129032258618</c:v>
                </c:pt>
                <c:pt idx="16">
                  <c:v>1.9354838709677502</c:v>
                </c:pt>
                <c:pt idx="17">
                  <c:v>1.29032258064516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9-8810-4B29-A9E8-B4B5DDC71C7B}"/>
            </c:ext>
          </c:extLst>
        </c:ser>
        <c:ser>
          <c:idx val="42"/>
          <c:order val="42"/>
          <c:tx>
            <c:strRef>
              <c:f>'4nt'!$A$134</c:f>
              <c:strCache>
                <c:ptCount val="1"/>
                <c:pt idx="0">
                  <c:v>AGCG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134:$S$134</c:f>
              <c:numCache>
                <c:formatCode>General</c:formatCode>
                <c:ptCount val="18"/>
                <c:pt idx="0">
                  <c:v>0.64516129032258618</c:v>
                </c:pt>
                <c:pt idx="1">
                  <c:v>0.64516129032258618</c:v>
                </c:pt>
                <c:pt idx="2">
                  <c:v>1.290322580645161</c:v>
                </c:pt>
                <c:pt idx="3">
                  <c:v>1.290322580645161</c:v>
                </c:pt>
                <c:pt idx="4">
                  <c:v>1.290322580645161</c:v>
                </c:pt>
                <c:pt idx="5">
                  <c:v>0.64516129032258618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.64516129032258618</c:v>
                </c:pt>
                <c:pt idx="11">
                  <c:v>1.290322580645161</c:v>
                </c:pt>
                <c:pt idx="12">
                  <c:v>1.290322580645161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.64516129032258618</c:v>
                </c:pt>
                <c:pt idx="1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A-8810-4B29-A9E8-B4B5DDC71C7B}"/>
            </c:ext>
          </c:extLst>
        </c:ser>
        <c:ser>
          <c:idx val="43"/>
          <c:order val="43"/>
          <c:tx>
            <c:strRef>
              <c:f>'4nt'!$A$135</c:f>
              <c:strCache>
                <c:ptCount val="1"/>
                <c:pt idx="0">
                  <c:v>CCGU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135:$S$135</c:f>
              <c:numCache>
                <c:formatCode>General</c:formatCode>
                <c:ptCount val="18"/>
                <c:pt idx="0">
                  <c:v>0.64516129032258618</c:v>
                </c:pt>
                <c:pt idx="1">
                  <c:v>0.64516129032258618</c:v>
                </c:pt>
                <c:pt idx="2">
                  <c:v>0</c:v>
                </c:pt>
                <c:pt idx="3">
                  <c:v>0</c:v>
                </c:pt>
                <c:pt idx="4">
                  <c:v>1.290322580645161</c:v>
                </c:pt>
                <c:pt idx="5">
                  <c:v>0.64516129032258618</c:v>
                </c:pt>
                <c:pt idx="6">
                  <c:v>1.9354838709677502</c:v>
                </c:pt>
                <c:pt idx="7">
                  <c:v>1.290322580645161</c:v>
                </c:pt>
                <c:pt idx="8">
                  <c:v>1.9354838709677502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.64516129032258618</c:v>
                </c:pt>
                <c:pt idx="15">
                  <c:v>0</c:v>
                </c:pt>
                <c:pt idx="16">
                  <c:v>0</c:v>
                </c:pt>
                <c:pt idx="17">
                  <c:v>0.6451612903225861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B-8810-4B29-A9E8-B4B5DDC71C7B}"/>
            </c:ext>
          </c:extLst>
        </c:ser>
        <c:ser>
          <c:idx val="44"/>
          <c:order val="44"/>
          <c:tx>
            <c:strRef>
              <c:f>'4nt'!$A$136</c:f>
              <c:strCache>
                <c:ptCount val="1"/>
                <c:pt idx="0">
                  <c:v>GACG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136:$S$136</c:f>
              <c:numCache>
                <c:formatCode>General</c:formatCode>
                <c:ptCount val="18"/>
                <c:pt idx="0">
                  <c:v>1.9354838709677502</c:v>
                </c:pt>
                <c:pt idx="1">
                  <c:v>0</c:v>
                </c:pt>
                <c:pt idx="2">
                  <c:v>1.290322580645161</c:v>
                </c:pt>
                <c:pt idx="3">
                  <c:v>0</c:v>
                </c:pt>
                <c:pt idx="4">
                  <c:v>1.9354838709677502</c:v>
                </c:pt>
                <c:pt idx="5">
                  <c:v>0.64516129032258618</c:v>
                </c:pt>
                <c:pt idx="6">
                  <c:v>0</c:v>
                </c:pt>
                <c:pt idx="7">
                  <c:v>0</c:v>
                </c:pt>
                <c:pt idx="8">
                  <c:v>0.64516129032258618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.64516129032258618</c:v>
                </c:pt>
                <c:pt idx="15">
                  <c:v>1.290322580645161</c:v>
                </c:pt>
                <c:pt idx="16">
                  <c:v>0</c:v>
                </c:pt>
                <c:pt idx="17">
                  <c:v>0.6451612903225861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C-8810-4B29-A9E8-B4B5DDC71C7B}"/>
            </c:ext>
          </c:extLst>
        </c:ser>
        <c:ser>
          <c:idx val="45"/>
          <c:order val="45"/>
          <c:tx>
            <c:strRef>
              <c:f>'4nt'!$A$137</c:f>
              <c:strCache>
                <c:ptCount val="1"/>
                <c:pt idx="0">
                  <c:v>CUGU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137:$S$137</c:f>
              <c:numCache>
                <c:formatCode>General</c:formatCode>
                <c:ptCount val="18"/>
                <c:pt idx="0">
                  <c:v>0.64516129032258618</c:v>
                </c:pt>
                <c:pt idx="1">
                  <c:v>0</c:v>
                </c:pt>
                <c:pt idx="2">
                  <c:v>0.64516129032258618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.64516129032258618</c:v>
                </c:pt>
                <c:pt idx="8">
                  <c:v>0.64516129032258618</c:v>
                </c:pt>
                <c:pt idx="9">
                  <c:v>0.64516129032258618</c:v>
                </c:pt>
                <c:pt idx="10">
                  <c:v>0</c:v>
                </c:pt>
                <c:pt idx="11">
                  <c:v>0</c:v>
                </c:pt>
                <c:pt idx="12">
                  <c:v>0.64516129032258618</c:v>
                </c:pt>
                <c:pt idx="13">
                  <c:v>0</c:v>
                </c:pt>
                <c:pt idx="14">
                  <c:v>1.290322580645161</c:v>
                </c:pt>
                <c:pt idx="15">
                  <c:v>0</c:v>
                </c:pt>
                <c:pt idx="16">
                  <c:v>0</c:v>
                </c:pt>
                <c:pt idx="17">
                  <c:v>3.870967741935501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D-8810-4B29-A9E8-B4B5DDC71C7B}"/>
            </c:ext>
          </c:extLst>
        </c:ser>
        <c:ser>
          <c:idx val="46"/>
          <c:order val="46"/>
          <c:tx>
            <c:strRef>
              <c:f>'4nt'!$A$138</c:f>
              <c:strCache>
                <c:ptCount val="1"/>
                <c:pt idx="0">
                  <c:v>GAUA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138:$S$138</c:f>
              <c:numCache>
                <c:formatCode>General</c:formatCode>
                <c:ptCount val="18"/>
                <c:pt idx="0">
                  <c:v>1.9354838709677502</c:v>
                </c:pt>
                <c:pt idx="1">
                  <c:v>0.64516129032258618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.64516129032258618</c:v>
                </c:pt>
                <c:pt idx="7">
                  <c:v>0.64516129032258618</c:v>
                </c:pt>
                <c:pt idx="8">
                  <c:v>0.64516129032258618</c:v>
                </c:pt>
                <c:pt idx="9">
                  <c:v>0.64516129032258618</c:v>
                </c:pt>
                <c:pt idx="10">
                  <c:v>0.64516129032258618</c:v>
                </c:pt>
                <c:pt idx="11">
                  <c:v>0.64516129032258618</c:v>
                </c:pt>
                <c:pt idx="12">
                  <c:v>0</c:v>
                </c:pt>
                <c:pt idx="13">
                  <c:v>0</c:v>
                </c:pt>
                <c:pt idx="14">
                  <c:v>0.64516129032258618</c:v>
                </c:pt>
                <c:pt idx="15">
                  <c:v>1.290322580645161</c:v>
                </c:pt>
                <c:pt idx="16">
                  <c:v>0</c:v>
                </c:pt>
                <c:pt idx="17">
                  <c:v>0.6451612903225861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E-8810-4B29-A9E8-B4B5DDC71C7B}"/>
            </c:ext>
          </c:extLst>
        </c:ser>
        <c:ser>
          <c:idx val="47"/>
          <c:order val="47"/>
          <c:tx>
            <c:strRef>
              <c:f>'4nt'!$A$139</c:f>
              <c:strCache>
                <c:ptCount val="1"/>
                <c:pt idx="0">
                  <c:v>UCAU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139:$S$139</c:f>
              <c:numCache>
                <c:formatCode>General</c:formatCode>
                <c:ptCount val="18"/>
                <c:pt idx="0">
                  <c:v>0</c:v>
                </c:pt>
                <c:pt idx="1">
                  <c:v>1.290322580645161</c:v>
                </c:pt>
                <c:pt idx="2">
                  <c:v>0</c:v>
                </c:pt>
                <c:pt idx="3">
                  <c:v>2.5806451612903221</c:v>
                </c:pt>
                <c:pt idx="4">
                  <c:v>0.64516129032258618</c:v>
                </c:pt>
                <c:pt idx="5">
                  <c:v>0.64516129032258618</c:v>
                </c:pt>
                <c:pt idx="6">
                  <c:v>0.64516129032258618</c:v>
                </c:pt>
                <c:pt idx="7">
                  <c:v>0.64516129032258618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.64516129032258618</c:v>
                </c:pt>
                <c:pt idx="12">
                  <c:v>0.64516129032258618</c:v>
                </c:pt>
                <c:pt idx="13">
                  <c:v>0.64516129032258618</c:v>
                </c:pt>
                <c:pt idx="14">
                  <c:v>0</c:v>
                </c:pt>
                <c:pt idx="15">
                  <c:v>0.64516129032258618</c:v>
                </c:pt>
                <c:pt idx="16">
                  <c:v>0</c:v>
                </c:pt>
                <c:pt idx="1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F-8810-4B29-A9E8-B4B5DDC71C7B}"/>
            </c:ext>
          </c:extLst>
        </c:ser>
        <c:ser>
          <c:idx val="48"/>
          <c:order val="48"/>
          <c:tx>
            <c:strRef>
              <c:f>'4nt'!$A$140</c:f>
              <c:strCache>
                <c:ptCount val="1"/>
                <c:pt idx="0">
                  <c:v>AGGA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140:$S$140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1.290322580645161</c:v>
                </c:pt>
                <c:pt idx="3">
                  <c:v>1.9354838709677502</c:v>
                </c:pt>
                <c:pt idx="4">
                  <c:v>0</c:v>
                </c:pt>
                <c:pt idx="5">
                  <c:v>0</c:v>
                </c:pt>
                <c:pt idx="6">
                  <c:v>1.290322580645161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.64516129032258618</c:v>
                </c:pt>
                <c:pt idx="12">
                  <c:v>0.64516129032258618</c:v>
                </c:pt>
                <c:pt idx="13">
                  <c:v>0.64516129032258618</c:v>
                </c:pt>
                <c:pt idx="14">
                  <c:v>0.64516129032258618</c:v>
                </c:pt>
                <c:pt idx="15">
                  <c:v>0</c:v>
                </c:pt>
                <c:pt idx="16">
                  <c:v>1.290322580645161</c:v>
                </c:pt>
                <c:pt idx="17">
                  <c:v>0.6451612903225861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0-8810-4B29-A9E8-B4B5DDC71C7B}"/>
            </c:ext>
          </c:extLst>
        </c:ser>
        <c:ser>
          <c:idx val="49"/>
          <c:order val="49"/>
          <c:tx>
            <c:strRef>
              <c:f>'4nt'!$A$141</c:f>
              <c:strCache>
                <c:ptCount val="1"/>
                <c:pt idx="0">
                  <c:v>UUUU</c:v>
                </c:pt>
              </c:strCache>
            </c:strRef>
          </c:tx>
          <c:marker>
            <c:symbol val="none"/>
          </c:marker>
          <c:cat>
            <c:numRef>
              <c:f>'4nt'!$B$91:$S$91</c:f>
              <c:numCache>
                <c:formatCode>General</c:formatCode>
                <c:ptCount val="18"/>
                <c:pt idx="0">
                  <c:v>-30</c:v>
                </c:pt>
                <c:pt idx="1">
                  <c:v>-29</c:v>
                </c:pt>
                <c:pt idx="2">
                  <c:v>-28</c:v>
                </c:pt>
                <c:pt idx="3">
                  <c:v>-27</c:v>
                </c:pt>
                <c:pt idx="4">
                  <c:v>-26</c:v>
                </c:pt>
                <c:pt idx="5">
                  <c:v>-25</c:v>
                </c:pt>
                <c:pt idx="6">
                  <c:v>-24</c:v>
                </c:pt>
                <c:pt idx="7">
                  <c:v>-23</c:v>
                </c:pt>
                <c:pt idx="8">
                  <c:v>-22</c:v>
                </c:pt>
                <c:pt idx="9">
                  <c:v>-21</c:v>
                </c:pt>
                <c:pt idx="10">
                  <c:v>-20</c:v>
                </c:pt>
                <c:pt idx="11">
                  <c:v>-19</c:v>
                </c:pt>
                <c:pt idx="12">
                  <c:v>-18</c:v>
                </c:pt>
                <c:pt idx="13">
                  <c:v>-17</c:v>
                </c:pt>
                <c:pt idx="14">
                  <c:v>-16</c:v>
                </c:pt>
                <c:pt idx="15">
                  <c:v>-15</c:v>
                </c:pt>
                <c:pt idx="16">
                  <c:v>-14</c:v>
                </c:pt>
                <c:pt idx="17">
                  <c:v>-13</c:v>
                </c:pt>
              </c:numCache>
            </c:numRef>
          </c:cat>
          <c:val>
            <c:numRef>
              <c:f>'4nt'!$B$141:$S$141</c:f>
              <c:numCache>
                <c:formatCode>General</c:formatCode>
                <c:ptCount val="18"/>
                <c:pt idx="0">
                  <c:v>0.64516129032258618</c:v>
                </c:pt>
                <c:pt idx="1">
                  <c:v>1.290322580645161</c:v>
                </c:pt>
                <c:pt idx="2">
                  <c:v>0.64516129032258618</c:v>
                </c:pt>
                <c:pt idx="3">
                  <c:v>0.64516129032258618</c:v>
                </c:pt>
                <c:pt idx="4">
                  <c:v>0</c:v>
                </c:pt>
                <c:pt idx="5">
                  <c:v>0</c:v>
                </c:pt>
                <c:pt idx="6">
                  <c:v>1.290322580645161</c:v>
                </c:pt>
                <c:pt idx="7">
                  <c:v>1.9354838709677502</c:v>
                </c:pt>
                <c:pt idx="8">
                  <c:v>0</c:v>
                </c:pt>
                <c:pt idx="9">
                  <c:v>0.64516129032258618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.64516129032258618</c:v>
                </c:pt>
                <c:pt idx="16">
                  <c:v>0.64516129032258618</c:v>
                </c:pt>
                <c:pt idx="17">
                  <c:v>0.6451612903225861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1-8810-4B29-A9E8-B4B5DDC71C7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88518016"/>
        <c:axId val="88532096"/>
      </c:lineChart>
      <c:catAx>
        <c:axId val="885180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zh-CN"/>
            </a:pPr>
            <a:endParaRPr lang="en-US"/>
          </a:p>
        </c:txPr>
        <c:crossAx val="88532096"/>
        <c:crosses val="autoZero"/>
        <c:auto val="1"/>
        <c:lblAlgn val="ctr"/>
        <c:lblOffset val="100"/>
        <c:noMultiLvlLbl val="0"/>
      </c:catAx>
      <c:valAx>
        <c:axId val="885320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zh-CN"/>
            </a:pPr>
            <a:endParaRPr lang="en-US"/>
          </a:p>
        </c:txPr>
        <c:crossAx val="8851801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6.9801833776989106E-4"/>
          <c:y val="0.65761226183201793"/>
          <c:w val="0.99930198166222484"/>
          <c:h val="0.34238772320317007"/>
        </c:manualLayout>
      </c:layout>
      <c:overlay val="0"/>
      <c:txPr>
        <a:bodyPr/>
        <a:lstStyle/>
        <a:p>
          <a:pPr>
            <a:defRPr lang="zh-CN" sz="600" baseline="0"/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  <c:userShapes r:id="rId2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4.7519943505638602E-2"/>
          <c:y val="7.6404795991410215E-2"/>
          <c:w val="0.95248005649436207"/>
          <c:h val="0.3424155618686871"/>
        </c:manualLayout>
      </c:layout>
      <c:lineChart>
        <c:grouping val="standard"/>
        <c:varyColors val="0"/>
        <c:ser>
          <c:idx val="0"/>
          <c:order val="0"/>
          <c:tx>
            <c:strRef>
              <c:f>'6nt'!$A$292</c:f>
              <c:strCache>
                <c:ptCount val="1"/>
                <c:pt idx="0">
                  <c:v>AAUAAA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292:$P$292</c:f>
              <c:numCache>
                <c:formatCode>General</c:formatCode>
                <c:ptCount val="15"/>
                <c:pt idx="0">
                  <c:v>0.17621145374449607</c:v>
                </c:pt>
                <c:pt idx="1">
                  <c:v>0.29735682819383608</c:v>
                </c:pt>
                <c:pt idx="2">
                  <c:v>0.209251101321586</c:v>
                </c:pt>
                <c:pt idx="3">
                  <c:v>0.37444933920705309</c:v>
                </c:pt>
                <c:pt idx="4">
                  <c:v>0.506607929515419</c:v>
                </c:pt>
                <c:pt idx="5">
                  <c:v>0.58370044052863401</c:v>
                </c:pt>
                <c:pt idx="6">
                  <c:v>0.57268722466960409</c:v>
                </c:pt>
                <c:pt idx="7">
                  <c:v>0.77092511013216514</c:v>
                </c:pt>
                <c:pt idx="8">
                  <c:v>0.68281938325991198</c:v>
                </c:pt>
                <c:pt idx="9">
                  <c:v>0.88105726872245882</c:v>
                </c:pt>
                <c:pt idx="10">
                  <c:v>0.75991189427313921</c:v>
                </c:pt>
                <c:pt idx="11">
                  <c:v>0.82599118942731298</c:v>
                </c:pt>
                <c:pt idx="12">
                  <c:v>0.55066079295154202</c:v>
                </c:pt>
                <c:pt idx="13">
                  <c:v>0.506607929515419</c:v>
                </c:pt>
                <c:pt idx="14">
                  <c:v>0.3193832599118980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907-46CE-80C0-3C9A1DF7A847}"/>
            </c:ext>
          </c:extLst>
        </c:ser>
        <c:ser>
          <c:idx val="1"/>
          <c:order val="1"/>
          <c:tx>
            <c:strRef>
              <c:f>'6nt'!$A$293</c:f>
              <c:strCache>
                <c:ptCount val="1"/>
                <c:pt idx="0">
                  <c:v>AAAUAA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293:$P$293</c:f>
              <c:numCache>
                <c:formatCode>General</c:formatCode>
                <c:ptCount val="15"/>
                <c:pt idx="0">
                  <c:v>0.19823788546255502</c:v>
                </c:pt>
                <c:pt idx="1">
                  <c:v>0.15418502202643203</c:v>
                </c:pt>
                <c:pt idx="2">
                  <c:v>0.23127753303964799</c:v>
                </c:pt>
                <c:pt idx="3">
                  <c:v>0.3414096916299611</c:v>
                </c:pt>
                <c:pt idx="4">
                  <c:v>0.451541850220264</c:v>
                </c:pt>
                <c:pt idx="5">
                  <c:v>0.36343612334802006</c:v>
                </c:pt>
                <c:pt idx="6">
                  <c:v>0.46255506607929503</c:v>
                </c:pt>
                <c:pt idx="7">
                  <c:v>0.48458149779736209</c:v>
                </c:pt>
                <c:pt idx="8">
                  <c:v>0.58370044052863401</c:v>
                </c:pt>
                <c:pt idx="9">
                  <c:v>0.5396475770925121</c:v>
                </c:pt>
                <c:pt idx="10">
                  <c:v>0.56167400881058016</c:v>
                </c:pt>
                <c:pt idx="11">
                  <c:v>0.40748898678414713</c:v>
                </c:pt>
                <c:pt idx="12">
                  <c:v>0.37444933920705309</c:v>
                </c:pt>
                <c:pt idx="13">
                  <c:v>0.27533039647577101</c:v>
                </c:pt>
                <c:pt idx="14">
                  <c:v>0.341409691629961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4907-46CE-80C0-3C9A1DF7A847}"/>
            </c:ext>
          </c:extLst>
        </c:ser>
        <c:ser>
          <c:idx val="2"/>
          <c:order val="2"/>
          <c:tx>
            <c:strRef>
              <c:f>'6nt'!$A$294</c:f>
              <c:strCache>
                <c:ptCount val="1"/>
                <c:pt idx="0">
                  <c:v>AAAGAA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294:$P$294</c:f>
              <c:numCache>
                <c:formatCode>General</c:formatCode>
                <c:ptCount val="15"/>
                <c:pt idx="0">
                  <c:v>0.27533039647577101</c:v>
                </c:pt>
                <c:pt idx="1">
                  <c:v>0.26431718061674003</c:v>
                </c:pt>
                <c:pt idx="2">
                  <c:v>0.3414096916299611</c:v>
                </c:pt>
                <c:pt idx="3">
                  <c:v>0.26431718061674003</c:v>
                </c:pt>
                <c:pt idx="4">
                  <c:v>0.38546255506608307</c:v>
                </c:pt>
                <c:pt idx="5">
                  <c:v>0.48458149779736209</c:v>
                </c:pt>
                <c:pt idx="6">
                  <c:v>0.31938325991189809</c:v>
                </c:pt>
                <c:pt idx="7">
                  <c:v>0.33039647577093112</c:v>
                </c:pt>
                <c:pt idx="8">
                  <c:v>0.33039647577093112</c:v>
                </c:pt>
                <c:pt idx="9">
                  <c:v>0.42951541850220304</c:v>
                </c:pt>
                <c:pt idx="10">
                  <c:v>0.48458149779736209</c:v>
                </c:pt>
                <c:pt idx="11">
                  <c:v>0.47356828193832906</c:v>
                </c:pt>
                <c:pt idx="12">
                  <c:v>0.56167400881058016</c:v>
                </c:pt>
                <c:pt idx="13">
                  <c:v>0.48458149779736209</c:v>
                </c:pt>
                <c:pt idx="14">
                  <c:v>0.3193832599118980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4907-46CE-80C0-3C9A1DF7A847}"/>
            </c:ext>
          </c:extLst>
        </c:ser>
        <c:ser>
          <c:idx val="3"/>
          <c:order val="3"/>
          <c:tx>
            <c:strRef>
              <c:f>'6nt'!$A$295</c:f>
              <c:strCache>
                <c:ptCount val="1"/>
                <c:pt idx="0">
                  <c:v>AUAAAA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295:$P$295</c:f>
              <c:numCache>
                <c:formatCode>General</c:formatCode>
                <c:ptCount val="15"/>
                <c:pt idx="0">
                  <c:v>0.18722466960352399</c:v>
                </c:pt>
                <c:pt idx="1">
                  <c:v>0.14317180616740102</c:v>
                </c:pt>
                <c:pt idx="2">
                  <c:v>0.2863436123348071</c:v>
                </c:pt>
                <c:pt idx="3">
                  <c:v>0.15418502202643203</c:v>
                </c:pt>
                <c:pt idx="4">
                  <c:v>0.26431718061674003</c:v>
                </c:pt>
                <c:pt idx="5">
                  <c:v>0.33039647577093112</c:v>
                </c:pt>
                <c:pt idx="6">
                  <c:v>0.40748898678414713</c:v>
                </c:pt>
                <c:pt idx="7">
                  <c:v>0.47356828193832906</c:v>
                </c:pt>
                <c:pt idx="8">
                  <c:v>0.58370044052863401</c:v>
                </c:pt>
                <c:pt idx="9">
                  <c:v>0.506607929515419</c:v>
                </c:pt>
                <c:pt idx="10">
                  <c:v>0.58370044052863401</c:v>
                </c:pt>
                <c:pt idx="11">
                  <c:v>0.47356828193832906</c:v>
                </c:pt>
                <c:pt idx="12">
                  <c:v>0.56167400881058016</c:v>
                </c:pt>
                <c:pt idx="13">
                  <c:v>0.37444933920705309</c:v>
                </c:pt>
                <c:pt idx="14">
                  <c:v>0.3634361233480200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4907-46CE-80C0-3C9A1DF7A847}"/>
            </c:ext>
          </c:extLst>
        </c:ser>
        <c:ser>
          <c:idx val="4"/>
          <c:order val="4"/>
          <c:tx>
            <c:strRef>
              <c:f>'6nt'!$A$296</c:f>
              <c:strCache>
                <c:ptCount val="1"/>
                <c:pt idx="0">
                  <c:v>AAGAAA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296:$P$296</c:f>
              <c:numCache>
                <c:formatCode>General</c:formatCode>
                <c:ptCount val="15"/>
                <c:pt idx="0">
                  <c:v>0.23127753303964799</c:v>
                </c:pt>
                <c:pt idx="1">
                  <c:v>0.26431718061674003</c:v>
                </c:pt>
                <c:pt idx="2">
                  <c:v>0.22026431718061701</c:v>
                </c:pt>
                <c:pt idx="3">
                  <c:v>0.37444933920705309</c:v>
                </c:pt>
                <c:pt idx="4">
                  <c:v>0.3414096916299611</c:v>
                </c:pt>
                <c:pt idx="5">
                  <c:v>0.36343612334802006</c:v>
                </c:pt>
                <c:pt idx="6">
                  <c:v>0.451541850220264</c:v>
                </c:pt>
                <c:pt idx="7">
                  <c:v>0.38546255506608307</c:v>
                </c:pt>
                <c:pt idx="8">
                  <c:v>0.40748898678414713</c:v>
                </c:pt>
                <c:pt idx="9">
                  <c:v>0.37444933920705309</c:v>
                </c:pt>
                <c:pt idx="10">
                  <c:v>0.33039647577093112</c:v>
                </c:pt>
                <c:pt idx="11">
                  <c:v>0.451541850220264</c:v>
                </c:pt>
                <c:pt idx="12">
                  <c:v>0.3964757709251151</c:v>
                </c:pt>
                <c:pt idx="13">
                  <c:v>0.27533039647577101</c:v>
                </c:pt>
                <c:pt idx="14">
                  <c:v>0.341409691629961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4907-46CE-80C0-3C9A1DF7A847}"/>
            </c:ext>
          </c:extLst>
        </c:ser>
        <c:ser>
          <c:idx val="5"/>
          <c:order val="5"/>
          <c:tx>
            <c:strRef>
              <c:f>'6nt'!$A$297</c:f>
              <c:strCache>
                <c:ptCount val="1"/>
                <c:pt idx="0">
                  <c:v>AAAAAA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297:$P$297</c:f>
              <c:numCache>
                <c:formatCode>General</c:formatCode>
                <c:ptCount val="15"/>
                <c:pt idx="0">
                  <c:v>0.13215859030836999</c:v>
                </c:pt>
                <c:pt idx="1">
                  <c:v>0.22026431718061701</c:v>
                </c:pt>
                <c:pt idx="2">
                  <c:v>0.12114537444934001</c:v>
                </c:pt>
                <c:pt idx="3">
                  <c:v>0.209251101321586</c:v>
                </c:pt>
                <c:pt idx="4">
                  <c:v>0.16519823788546606</c:v>
                </c:pt>
                <c:pt idx="5">
                  <c:v>0.27533039647577101</c:v>
                </c:pt>
                <c:pt idx="6">
                  <c:v>0.61674008810573311</c:v>
                </c:pt>
                <c:pt idx="7">
                  <c:v>0.19823788546255502</c:v>
                </c:pt>
                <c:pt idx="8">
                  <c:v>0.209251101321586</c:v>
                </c:pt>
                <c:pt idx="9">
                  <c:v>0.33039647577093112</c:v>
                </c:pt>
                <c:pt idx="10">
                  <c:v>0.36343612334802006</c:v>
                </c:pt>
                <c:pt idx="11">
                  <c:v>0.38546255506608307</c:v>
                </c:pt>
                <c:pt idx="12">
                  <c:v>0.40748898678414713</c:v>
                </c:pt>
                <c:pt idx="13">
                  <c:v>0.78193832599118895</c:v>
                </c:pt>
                <c:pt idx="14">
                  <c:v>0.550660792951542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4907-46CE-80C0-3C9A1DF7A847}"/>
            </c:ext>
          </c:extLst>
        </c:ser>
        <c:ser>
          <c:idx val="6"/>
          <c:order val="6"/>
          <c:tx>
            <c:strRef>
              <c:f>'6nt'!$A$298</c:f>
              <c:strCache>
                <c:ptCount val="1"/>
                <c:pt idx="0">
                  <c:v>UAAAAA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298:$P$298</c:f>
              <c:numCache>
                <c:formatCode>General</c:formatCode>
                <c:ptCount val="15"/>
                <c:pt idx="0">
                  <c:v>0.13215859030836999</c:v>
                </c:pt>
                <c:pt idx="1">
                  <c:v>0.15418502202643203</c:v>
                </c:pt>
                <c:pt idx="2">
                  <c:v>0.19823788546255502</c:v>
                </c:pt>
                <c:pt idx="3">
                  <c:v>0.24229074889867802</c:v>
                </c:pt>
                <c:pt idx="4">
                  <c:v>0.18722466960352399</c:v>
                </c:pt>
                <c:pt idx="5">
                  <c:v>0.24229074889867802</c:v>
                </c:pt>
                <c:pt idx="6">
                  <c:v>0.25330396475771205</c:v>
                </c:pt>
                <c:pt idx="7">
                  <c:v>0.3414096916299611</c:v>
                </c:pt>
                <c:pt idx="8">
                  <c:v>0.3414096916299611</c:v>
                </c:pt>
                <c:pt idx="9">
                  <c:v>0.48458149779736209</c:v>
                </c:pt>
                <c:pt idx="10">
                  <c:v>0.48458149779736209</c:v>
                </c:pt>
                <c:pt idx="11">
                  <c:v>0.52863436123348106</c:v>
                </c:pt>
                <c:pt idx="12">
                  <c:v>0.36343612334802006</c:v>
                </c:pt>
                <c:pt idx="13">
                  <c:v>0.3964757709251151</c:v>
                </c:pt>
                <c:pt idx="14">
                  <c:v>0.231277533039647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4907-46CE-80C0-3C9A1DF7A847}"/>
            </c:ext>
          </c:extLst>
        </c:ser>
        <c:ser>
          <c:idx val="7"/>
          <c:order val="7"/>
          <c:tx>
            <c:strRef>
              <c:f>'6nt'!$A$299</c:f>
              <c:strCache>
                <c:ptCount val="1"/>
                <c:pt idx="0">
                  <c:v>UAAUAA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299:$P$299</c:f>
              <c:numCache>
                <c:formatCode>General</c:formatCode>
                <c:ptCount val="15"/>
                <c:pt idx="0">
                  <c:v>0.18722466960352399</c:v>
                </c:pt>
                <c:pt idx="1">
                  <c:v>0.14317180616740102</c:v>
                </c:pt>
                <c:pt idx="2">
                  <c:v>0.16519823788546606</c:v>
                </c:pt>
                <c:pt idx="3">
                  <c:v>0.24229074889867802</c:v>
                </c:pt>
                <c:pt idx="4">
                  <c:v>0.209251101321586</c:v>
                </c:pt>
                <c:pt idx="5">
                  <c:v>0.35242290748899008</c:v>
                </c:pt>
                <c:pt idx="6">
                  <c:v>0.41850220264317201</c:v>
                </c:pt>
                <c:pt idx="7">
                  <c:v>0.25330396475771205</c:v>
                </c:pt>
                <c:pt idx="8">
                  <c:v>0.36343612334802006</c:v>
                </c:pt>
                <c:pt idx="9">
                  <c:v>0.46255506607929503</c:v>
                </c:pt>
                <c:pt idx="10">
                  <c:v>0.33039647577093112</c:v>
                </c:pt>
                <c:pt idx="11">
                  <c:v>0.36343612334802006</c:v>
                </c:pt>
                <c:pt idx="12">
                  <c:v>0.2863436123348071</c:v>
                </c:pt>
                <c:pt idx="13">
                  <c:v>0.14317180616740102</c:v>
                </c:pt>
                <c:pt idx="14">
                  <c:v>0.110132158590307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4907-46CE-80C0-3C9A1DF7A847}"/>
            </c:ext>
          </c:extLst>
        </c:ser>
        <c:ser>
          <c:idx val="8"/>
          <c:order val="8"/>
          <c:tx>
            <c:strRef>
              <c:f>'6nt'!$A$300</c:f>
              <c:strCache>
                <c:ptCount val="1"/>
                <c:pt idx="0">
                  <c:v>AAAAGA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300:$P$300</c:f>
              <c:numCache>
                <c:formatCode>General</c:formatCode>
                <c:ptCount val="15"/>
                <c:pt idx="0">
                  <c:v>0.17621145374449607</c:v>
                </c:pt>
                <c:pt idx="1">
                  <c:v>0.19823788546255502</c:v>
                </c:pt>
                <c:pt idx="2">
                  <c:v>0.17621145374449607</c:v>
                </c:pt>
                <c:pt idx="3">
                  <c:v>0.24229074889867802</c:v>
                </c:pt>
                <c:pt idx="4">
                  <c:v>0.26431718061674003</c:v>
                </c:pt>
                <c:pt idx="5">
                  <c:v>0.12114537444934001</c:v>
                </c:pt>
                <c:pt idx="6">
                  <c:v>0.23127753303964799</c:v>
                </c:pt>
                <c:pt idx="7">
                  <c:v>0.209251101321586</c:v>
                </c:pt>
                <c:pt idx="8">
                  <c:v>0.37444933920705309</c:v>
                </c:pt>
                <c:pt idx="9">
                  <c:v>0.27533039647577101</c:v>
                </c:pt>
                <c:pt idx="10">
                  <c:v>0.33039647577093112</c:v>
                </c:pt>
                <c:pt idx="11">
                  <c:v>0.42951541850220304</c:v>
                </c:pt>
                <c:pt idx="12">
                  <c:v>0.3964757709251151</c:v>
                </c:pt>
                <c:pt idx="13">
                  <c:v>0.30837004405286911</c:v>
                </c:pt>
                <c:pt idx="14">
                  <c:v>0.2973568281938360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4907-46CE-80C0-3C9A1DF7A847}"/>
            </c:ext>
          </c:extLst>
        </c:ser>
        <c:ser>
          <c:idx val="9"/>
          <c:order val="9"/>
          <c:tx>
            <c:strRef>
              <c:f>'6nt'!$A$301</c:f>
              <c:strCache>
                <c:ptCount val="1"/>
                <c:pt idx="0">
                  <c:v>AAAAAU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301:$P$301</c:f>
              <c:numCache>
                <c:formatCode>General</c:formatCode>
                <c:ptCount val="15"/>
                <c:pt idx="0">
                  <c:v>0.13215859030836999</c:v>
                </c:pt>
                <c:pt idx="1">
                  <c:v>0.23127753303964799</c:v>
                </c:pt>
                <c:pt idx="2">
                  <c:v>0.24229074889867802</c:v>
                </c:pt>
                <c:pt idx="3">
                  <c:v>0.17621145374449607</c:v>
                </c:pt>
                <c:pt idx="4">
                  <c:v>0.26431718061674003</c:v>
                </c:pt>
                <c:pt idx="5">
                  <c:v>0.13215859030836999</c:v>
                </c:pt>
                <c:pt idx="6">
                  <c:v>0.25330396475771205</c:v>
                </c:pt>
                <c:pt idx="7">
                  <c:v>0.26431718061674003</c:v>
                </c:pt>
                <c:pt idx="8">
                  <c:v>0.25330396475771205</c:v>
                </c:pt>
                <c:pt idx="9">
                  <c:v>0.23127753303964799</c:v>
                </c:pt>
                <c:pt idx="10">
                  <c:v>0.3414096916299611</c:v>
                </c:pt>
                <c:pt idx="11">
                  <c:v>0.26431718061674003</c:v>
                </c:pt>
                <c:pt idx="12">
                  <c:v>0.31938325991189809</c:v>
                </c:pt>
                <c:pt idx="13">
                  <c:v>0.30837004405286911</c:v>
                </c:pt>
                <c:pt idx="14">
                  <c:v>0.3524229074889900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4907-46CE-80C0-3C9A1DF7A847}"/>
            </c:ext>
          </c:extLst>
        </c:ser>
        <c:ser>
          <c:idx val="10"/>
          <c:order val="10"/>
          <c:tx>
            <c:strRef>
              <c:f>'6nt'!$A$302</c:f>
              <c:strCache>
                <c:ptCount val="1"/>
                <c:pt idx="0">
                  <c:v>AGAAAA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302:$P$302</c:f>
              <c:numCache>
                <c:formatCode>General</c:formatCode>
                <c:ptCount val="15"/>
                <c:pt idx="0">
                  <c:v>9.911894273127872E-2</c:v>
                </c:pt>
                <c:pt idx="1">
                  <c:v>0.209251101321586</c:v>
                </c:pt>
                <c:pt idx="2">
                  <c:v>0.19823788546255502</c:v>
                </c:pt>
                <c:pt idx="3">
                  <c:v>0.15418502202643203</c:v>
                </c:pt>
                <c:pt idx="4">
                  <c:v>0.29735682819383608</c:v>
                </c:pt>
                <c:pt idx="5">
                  <c:v>0.2863436123348071</c:v>
                </c:pt>
                <c:pt idx="6">
                  <c:v>0.24229074889867802</c:v>
                </c:pt>
                <c:pt idx="7">
                  <c:v>0.36343612334802006</c:v>
                </c:pt>
                <c:pt idx="8">
                  <c:v>0.29735682819383608</c:v>
                </c:pt>
                <c:pt idx="9">
                  <c:v>0.31938325991189809</c:v>
                </c:pt>
                <c:pt idx="10">
                  <c:v>0.25330396475771205</c:v>
                </c:pt>
                <c:pt idx="11">
                  <c:v>0.19823788546255502</c:v>
                </c:pt>
                <c:pt idx="12">
                  <c:v>0.23127753303964799</c:v>
                </c:pt>
                <c:pt idx="13">
                  <c:v>0.25330396475771205</c:v>
                </c:pt>
                <c:pt idx="14">
                  <c:v>0.231277533039647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4907-46CE-80C0-3C9A1DF7A847}"/>
            </c:ext>
          </c:extLst>
        </c:ser>
        <c:ser>
          <c:idx val="11"/>
          <c:order val="11"/>
          <c:tx>
            <c:strRef>
              <c:f>'6nt'!$A$303</c:f>
              <c:strCache>
                <c:ptCount val="1"/>
                <c:pt idx="0">
                  <c:v>AAUAUA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303:$P$303</c:f>
              <c:numCache>
                <c:formatCode>General</c:formatCode>
                <c:ptCount val="15"/>
                <c:pt idx="0">
                  <c:v>0.13215859030836999</c:v>
                </c:pt>
                <c:pt idx="1">
                  <c:v>0.13215859030836999</c:v>
                </c:pt>
                <c:pt idx="2">
                  <c:v>0.15418502202643203</c:v>
                </c:pt>
                <c:pt idx="3">
                  <c:v>0.19823788546255502</c:v>
                </c:pt>
                <c:pt idx="4">
                  <c:v>0.209251101321586</c:v>
                </c:pt>
                <c:pt idx="5">
                  <c:v>0.26431718061674003</c:v>
                </c:pt>
                <c:pt idx="6">
                  <c:v>0.19823788546255502</c:v>
                </c:pt>
                <c:pt idx="7">
                  <c:v>0.19823788546255502</c:v>
                </c:pt>
                <c:pt idx="8">
                  <c:v>0.37444933920705309</c:v>
                </c:pt>
                <c:pt idx="9">
                  <c:v>0.3414096916299611</c:v>
                </c:pt>
                <c:pt idx="10">
                  <c:v>0.26431718061674003</c:v>
                </c:pt>
                <c:pt idx="11">
                  <c:v>0.2863436123348071</c:v>
                </c:pt>
                <c:pt idx="12">
                  <c:v>0.29735682819383608</c:v>
                </c:pt>
                <c:pt idx="13">
                  <c:v>0.27533039647577101</c:v>
                </c:pt>
                <c:pt idx="14">
                  <c:v>0.20925110132158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4907-46CE-80C0-3C9A1DF7A847}"/>
            </c:ext>
          </c:extLst>
        </c:ser>
        <c:ser>
          <c:idx val="12"/>
          <c:order val="12"/>
          <c:tx>
            <c:strRef>
              <c:f>'6nt'!$A$304</c:f>
              <c:strCache>
                <c:ptCount val="1"/>
                <c:pt idx="0">
                  <c:v>GAAAAA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304:$P$304</c:f>
              <c:numCache>
                <c:formatCode>General</c:formatCode>
                <c:ptCount val="15"/>
                <c:pt idx="0">
                  <c:v>0.18722466960352399</c:v>
                </c:pt>
                <c:pt idx="1">
                  <c:v>0.209251101321586</c:v>
                </c:pt>
                <c:pt idx="2">
                  <c:v>0.16519823788546606</c:v>
                </c:pt>
                <c:pt idx="3">
                  <c:v>0.11013215859030799</c:v>
                </c:pt>
                <c:pt idx="4">
                  <c:v>0.24229074889867802</c:v>
                </c:pt>
                <c:pt idx="5">
                  <c:v>0.22026431718061701</c:v>
                </c:pt>
                <c:pt idx="6">
                  <c:v>0.17621145374449607</c:v>
                </c:pt>
                <c:pt idx="7">
                  <c:v>0.26431718061674003</c:v>
                </c:pt>
                <c:pt idx="8">
                  <c:v>0.29735682819383608</c:v>
                </c:pt>
                <c:pt idx="9">
                  <c:v>0.30837004405286911</c:v>
                </c:pt>
                <c:pt idx="10">
                  <c:v>0.2863436123348071</c:v>
                </c:pt>
                <c:pt idx="11">
                  <c:v>0.2863436123348071</c:v>
                </c:pt>
                <c:pt idx="12">
                  <c:v>0.23127753303964799</c:v>
                </c:pt>
                <c:pt idx="13">
                  <c:v>0.24229074889867802</c:v>
                </c:pt>
                <c:pt idx="14">
                  <c:v>0.1762114537444960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C-4907-46CE-80C0-3C9A1DF7A847}"/>
            </c:ext>
          </c:extLst>
        </c:ser>
        <c:ser>
          <c:idx val="13"/>
          <c:order val="13"/>
          <c:tx>
            <c:strRef>
              <c:f>'6nt'!$A$305</c:f>
              <c:strCache>
                <c:ptCount val="1"/>
                <c:pt idx="0">
                  <c:v>AAAAAG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305:$P$305</c:f>
              <c:numCache>
                <c:formatCode>General</c:formatCode>
                <c:ptCount val="15"/>
                <c:pt idx="0">
                  <c:v>0.14317180616740102</c:v>
                </c:pt>
                <c:pt idx="1">
                  <c:v>0.13215859030836999</c:v>
                </c:pt>
                <c:pt idx="2">
                  <c:v>8.8105726872246728E-2</c:v>
                </c:pt>
                <c:pt idx="3">
                  <c:v>0.15418502202643203</c:v>
                </c:pt>
                <c:pt idx="4">
                  <c:v>7.7092511013217221E-2</c:v>
                </c:pt>
                <c:pt idx="5">
                  <c:v>0.13215859030836999</c:v>
                </c:pt>
                <c:pt idx="6">
                  <c:v>0.209251101321586</c:v>
                </c:pt>
                <c:pt idx="7">
                  <c:v>0.209251101321586</c:v>
                </c:pt>
                <c:pt idx="8">
                  <c:v>0.16519823788546606</c:v>
                </c:pt>
                <c:pt idx="9">
                  <c:v>0.27533039647577101</c:v>
                </c:pt>
                <c:pt idx="10">
                  <c:v>0.31938325991189809</c:v>
                </c:pt>
                <c:pt idx="11">
                  <c:v>0.37444933920705309</c:v>
                </c:pt>
                <c:pt idx="12">
                  <c:v>0.30837004405286911</c:v>
                </c:pt>
                <c:pt idx="13">
                  <c:v>0.42951541850220304</c:v>
                </c:pt>
                <c:pt idx="14">
                  <c:v>0.3303964757709311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D-4907-46CE-80C0-3C9A1DF7A847}"/>
            </c:ext>
          </c:extLst>
        </c:ser>
        <c:ser>
          <c:idx val="14"/>
          <c:order val="14"/>
          <c:tx>
            <c:strRef>
              <c:f>'6nt'!$A$306</c:f>
              <c:strCache>
                <c:ptCount val="1"/>
                <c:pt idx="0">
                  <c:v>UAUAAA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306:$P$306</c:f>
              <c:numCache>
                <c:formatCode>General</c:formatCode>
                <c:ptCount val="15"/>
                <c:pt idx="0">
                  <c:v>0.14317180616740102</c:v>
                </c:pt>
                <c:pt idx="1">
                  <c:v>0.22026431718061701</c:v>
                </c:pt>
                <c:pt idx="2">
                  <c:v>0.22026431718061701</c:v>
                </c:pt>
                <c:pt idx="3">
                  <c:v>0.16519823788546606</c:v>
                </c:pt>
                <c:pt idx="4">
                  <c:v>0.17621145374449607</c:v>
                </c:pt>
                <c:pt idx="5">
                  <c:v>0.22026431718061701</c:v>
                </c:pt>
                <c:pt idx="6">
                  <c:v>0.14317180616740102</c:v>
                </c:pt>
                <c:pt idx="7">
                  <c:v>0.209251101321586</c:v>
                </c:pt>
                <c:pt idx="8">
                  <c:v>0.22026431718061701</c:v>
                </c:pt>
                <c:pt idx="9">
                  <c:v>0.33039647577093112</c:v>
                </c:pt>
                <c:pt idx="10">
                  <c:v>0.31938325991189809</c:v>
                </c:pt>
                <c:pt idx="11">
                  <c:v>0.31938325991189809</c:v>
                </c:pt>
                <c:pt idx="12">
                  <c:v>0.22026431718061701</c:v>
                </c:pt>
                <c:pt idx="13">
                  <c:v>0.26431718061674003</c:v>
                </c:pt>
                <c:pt idx="14">
                  <c:v>0.154185022026432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E-4907-46CE-80C0-3C9A1DF7A847}"/>
            </c:ext>
          </c:extLst>
        </c:ser>
        <c:ser>
          <c:idx val="15"/>
          <c:order val="15"/>
          <c:tx>
            <c:strRef>
              <c:f>'6nt'!$A$307</c:f>
              <c:strCache>
                <c:ptCount val="1"/>
                <c:pt idx="0">
                  <c:v>UAAAUA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307:$P$307</c:f>
              <c:numCache>
                <c:formatCode>General</c:formatCode>
                <c:ptCount val="15"/>
                <c:pt idx="0">
                  <c:v>0.12114537444934001</c:v>
                </c:pt>
                <c:pt idx="1">
                  <c:v>0.14317180616740102</c:v>
                </c:pt>
                <c:pt idx="2">
                  <c:v>0.18722466960352399</c:v>
                </c:pt>
                <c:pt idx="3">
                  <c:v>0.26431718061674003</c:v>
                </c:pt>
                <c:pt idx="4">
                  <c:v>0.2863436123348071</c:v>
                </c:pt>
                <c:pt idx="5">
                  <c:v>0.25330396475771205</c:v>
                </c:pt>
                <c:pt idx="6">
                  <c:v>0.19823788546255502</c:v>
                </c:pt>
                <c:pt idx="7">
                  <c:v>0.27533039647577101</c:v>
                </c:pt>
                <c:pt idx="8">
                  <c:v>0.2863436123348071</c:v>
                </c:pt>
                <c:pt idx="9">
                  <c:v>0.26431718061674003</c:v>
                </c:pt>
                <c:pt idx="10">
                  <c:v>0.15418502202643203</c:v>
                </c:pt>
                <c:pt idx="11">
                  <c:v>0.2863436123348071</c:v>
                </c:pt>
                <c:pt idx="12">
                  <c:v>0.16519823788546606</c:v>
                </c:pt>
                <c:pt idx="13">
                  <c:v>0.2863436123348071</c:v>
                </c:pt>
                <c:pt idx="14">
                  <c:v>0.154185022026432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F-4907-46CE-80C0-3C9A1DF7A847}"/>
            </c:ext>
          </c:extLst>
        </c:ser>
        <c:ser>
          <c:idx val="16"/>
          <c:order val="16"/>
          <c:tx>
            <c:strRef>
              <c:f>'6nt'!$A$308</c:f>
              <c:strCache>
                <c:ptCount val="1"/>
                <c:pt idx="0">
                  <c:v>AAAAUA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308:$P$308</c:f>
              <c:numCache>
                <c:formatCode>General</c:formatCode>
                <c:ptCount val="15"/>
                <c:pt idx="0">
                  <c:v>6.6079295154184994E-2</c:v>
                </c:pt>
                <c:pt idx="1">
                  <c:v>0.13215859030836999</c:v>
                </c:pt>
                <c:pt idx="2">
                  <c:v>0.19823788546255502</c:v>
                </c:pt>
                <c:pt idx="3">
                  <c:v>0.24229074889867802</c:v>
                </c:pt>
                <c:pt idx="4">
                  <c:v>0.23127753303964799</c:v>
                </c:pt>
                <c:pt idx="5">
                  <c:v>0.18722466960352399</c:v>
                </c:pt>
                <c:pt idx="6">
                  <c:v>0.209251101321586</c:v>
                </c:pt>
                <c:pt idx="7">
                  <c:v>0.27533039647577101</c:v>
                </c:pt>
                <c:pt idx="8">
                  <c:v>0.35242290748899008</c:v>
                </c:pt>
                <c:pt idx="9">
                  <c:v>0.30837004405286911</c:v>
                </c:pt>
                <c:pt idx="10">
                  <c:v>0.22026431718061701</c:v>
                </c:pt>
                <c:pt idx="11">
                  <c:v>0.22026431718061701</c:v>
                </c:pt>
                <c:pt idx="12">
                  <c:v>0.19823788546255502</c:v>
                </c:pt>
                <c:pt idx="13">
                  <c:v>0.19823788546255502</c:v>
                </c:pt>
                <c:pt idx="14">
                  <c:v>0.1762114537444960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0-4907-46CE-80C0-3C9A1DF7A847}"/>
            </c:ext>
          </c:extLst>
        </c:ser>
        <c:ser>
          <c:idx val="17"/>
          <c:order val="17"/>
          <c:tx>
            <c:strRef>
              <c:f>'6nt'!$A$309</c:f>
              <c:strCache>
                <c:ptCount val="1"/>
                <c:pt idx="0">
                  <c:v>AUAAUA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309:$P$309</c:f>
              <c:numCache>
                <c:formatCode>General</c:formatCode>
                <c:ptCount val="15"/>
                <c:pt idx="0">
                  <c:v>0.16519823788546606</c:v>
                </c:pt>
                <c:pt idx="1">
                  <c:v>7.7092511013217221E-2</c:v>
                </c:pt>
                <c:pt idx="2">
                  <c:v>0.15418502202643203</c:v>
                </c:pt>
                <c:pt idx="3">
                  <c:v>0.16519823788546606</c:v>
                </c:pt>
                <c:pt idx="4">
                  <c:v>0.25330396475771205</c:v>
                </c:pt>
                <c:pt idx="5">
                  <c:v>0.30837004405286911</c:v>
                </c:pt>
                <c:pt idx="6">
                  <c:v>0.26431718061674003</c:v>
                </c:pt>
                <c:pt idx="7">
                  <c:v>0.25330396475771205</c:v>
                </c:pt>
                <c:pt idx="8">
                  <c:v>0.29735682819383608</c:v>
                </c:pt>
                <c:pt idx="9">
                  <c:v>0.22026431718061701</c:v>
                </c:pt>
                <c:pt idx="10">
                  <c:v>0.29735682819383608</c:v>
                </c:pt>
                <c:pt idx="11">
                  <c:v>0.33039647577093112</c:v>
                </c:pt>
                <c:pt idx="12">
                  <c:v>0.13215859030836999</c:v>
                </c:pt>
                <c:pt idx="13">
                  <c:v>0.15418502202643203</c:v>
                </c:pt>
                <c:pt idx="14">
                  <c:v>0.143171806167401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1-4907-46CE-80C0-3C9A1DF7A847}"/>
            </c:ext>
          </c:extLst>
        </c:ser>
        <c:ser>
          <c:idx val="18"/>
          <c:order val="18"/>
          <c:tx>
            <c:strRef>
              <c:f>'6nt'!$A$310</c:f>
              <c:strCache>
                <c:ptCount val="1"/>
                <c:pt idx="0">
                  <c:v>AUAAAU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310:$P$310</c:f>
              <c:numCache>
                <c:formatCode>General</c:formatCode>
                <c:ptCount val="15"/>
                <c:pt idx="0">
                  <c:v>7.7092511013217221E-2</c:v>
                </c:pt>
                <c:pt idx="1">
                  <c:v>0.14317180616740102</c:v>
                </c:pt>
                <c:pt idx="2">
                  <c:v>0.16519823788546606</c:v>
                </c:pt>
                <c:pt idx="3">
                  <c:v>0.24229074889867802</c:v>
                </c:pt>
                <c:pt idx="4">
                  <c:v>0.25330396475771205</c:v>
                </c:pt>
                <c:pt idx="5">
                  <c:v>0.23127753303964799</c:v>
                </c:pt>
                <c:pt idx="6">
                  <c:v>0.27533039647577101</c:v>
                </c:pt>
                <c:pt idx="7">
                  <c:v>0.15418502202643203</c:v>
                </c:pt>
                <c:pt idx="8">
                  <c:v>0.31938325991189809</c:v>
                </c:pt>
                <c:pt idx="9">
                  <c:v>0.16519823788546606</c:v>
                </c:pt>
                <c:pt idx="10">
                  <c:v>0.33039647577093112</c:v>
                </c:pt>
                <c:pt idx="11">
                  <c:v>0.24229074889867802</c:v>
                </c:pt>
                <c:pt idx="12">
                  <c:v>0.24229074889867802</c:v>
                </c:pt>
                <c:pt idx="13">
                  <c:v>0.209251101321586</c:v>
                </c:pt>
                <c:pt idx="14">
                  <c:v>0.1651982378854660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2-4907-46CE-80C0-3C9A1DF7A847}"/>
            </c:ext>
          </c:extLst>
        </c:ser>
        <c:ser>
          <c:idx val="19"/>
          <c:order val="19"/>
          <c:tx>
            <c:strRef>
              <c:f>'6nt'!$A$311</c:f>
              <c:strCache>
                <c:ptCount val="1"/>
                <c:pt idx="0">
                  <c:v>AAUAAU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311:$P$311</c:f>
              <c:numCache>
                <c:formatCode>General</c:formatCode>
                <c:ptCount val="15"/>
                <c:pt idx="0">
                  <c:v>7.7092511013217221E-2</c:v>
                </c:pt>
                <c:pt idx="1">
                  <c:v>0.13215859030836999</c:v>
                </c:pt>
                <c:pt idx="2">
                  <c:v>0.14317180616740102</c:v>
                </c:pt>
                <c:pt idx="3">
                  <c:v>0.15418502202643203</c:v>
                </c:pt>
                <c:pt idx="4">
                  <c:v>0.25330396475771205</c:v>
                </c:pt>
                <c:pt idx="5">
                  <c:v>0.2863436123348071</c:v>
                </c:pt>
                <c:pt idx="6">
                  <c:v>0.24229074889867802</c:v>
                </c:pt>
                <c:pt idx="7">
                  <c:v>0.30837004405286911</c:v>
                </c:pt>
                <c:pt idx="8">
                  <c:v>0.26431718061674003</c:v>
                </c:pt>
                <c:pt idx="9">
                  <c:v>0.26431718061674003</c:v>
                </c:pt>
                <c:pt idx="10">
                  <c:v>0.29735682819383608</c:v>
                </c:pt>
                <c:pt idx="11">
                  <c:v>0.22026431718061701</c:v>
                </c:pt>
                <c:pt idx="12">
                  <c:v>0.17621145374449607</c:v>
                </c:pt>
                <c:pt idx="13">
                  <c:v>0.19823788546255502</c:v>
                </c:pt>
                <c:pt idx="14">
                  <c:v>0.12114537444934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3-4907-46CE-80C0-3C9A1DF7A847}"/>
            </c:ext>
          </c:extLst>
        </c:ser>
        <c:ser>
          <c:idx val="20"/>
          <c:order val="20"/>
          <c:tx>
            <c:strRef>
              <c:f>'6nt'!$A$312</c:f>
              <c:strCache>
                <c:ptCount val="1"/>
                <c:pt idx="0">
                  <c:v>AAACAA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312:$P$312</c:f>
              <c:numCache>
                <c:formatCode>General</c:formatCode>
                <c:ptCount val="15"/>
                <c:pt idx="0">
                  <c:v>0.19823788546255502</c:v>
                </c:pt>
                <c:pt idx="1">
                  <c:v>0.12114537444934001</c:v>
                </c:pt>
                <c:pt idx="2">
                  <c:v>0.17621145374449607</c:v>
                </c:pt>
                <c:pt idx="3">
                  <c:v>0.15418502202643203</c:v>
                </c:pt>
                <c:pt idx="4">
                  <c:v>0.24229074889867802</c:v>
                </c:pt>
                <c:pt idx="5">
                  <c:v>0.15418502202643203</c:v>
                </c:pt>
                <c:pt idx="6">
                  <c:v>0.19823788546255502</c:v>
                </c:pt>
                <c:pt idx="7">
                  <c:v>0.17621145374449607</c:v>
                </c:pt>
                <c:pt idx="8">
                  <c:v>0.23127753303964799</c:v>
                </c:pt>
                <c:pt idx="9">
                  <c:v>0.23127753303964799</c:v>
                </c:pt>
                <c:pt idx="10">
                  <c:v>0.30837004405286911</c:v>
                </c:pt>
                <c:pt idx="11">
                  <c:v>0.209251101321586</c:v>
                </c:pt>
                <c:pt idx="12">
                  <c:v>0.24229074889867802</c:v>
                </c:pt>
                <c:pt idx="13">
                  <c:v>0.23127753303964799</c:v>
                </c:pt>
                <c:pt idx="14">
                  <c:v>0.198237885462555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4-4907-46CE-80C0-3C9A1DF7A847}"/>
            </c:ext>
          </c:extLst>
        </c:ser>
        <c:ser>
          <c:idx val="21"/>
          <c:order val="21"/>
          <c:tx>
            <c:strRef>
              <c:f>'6nt'!$A$313</c:f>
              <c:strCache>
                <c:ptCount val="1"/>
                <c:pt idx="0">
                  <c:v>AUCAAA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313:$P$313</c:f>
              <c:numCache>
                <c:formatCode>General</c:formatCode>
                <c:ptCount val="15"/>
                <c:pt idx="0">
                  <c:v>0.13215859030836999</c:v>
                </c:pt>
                <c:pt idx="1">
                  <c:v>0.15418502202643203</c:v>
                </c:pt>
                <c:pt idx="2">
                  <c:v>0.13215859030836999</c:v>
                </c:pt>
                <c:pt idx="3">
                  <c:v>0.17621145374449607</c:v>
                </c:pt>
                <c:pt idx="4">
                  <c:v>0.17621145374449607</c:v>
                </c:pt>
                <c:pt idx="5">
                  <c:v>0.17621145374449607</c:v>
                </c:pt>
                <c:pt idx="6">
                  <c:v>0.209251101321586</c:v>
                </c:pt>
                <c:pt idx="7">
                  <c:v>0.30837004405286911</c:v>
                </c:pt>
                <c:pt idx="8">
                  <c:v>0.31938325991189809</c:v>
                </c:pt>
                <c:pt idx="9">
                  <c:v>0.27533039647577101</c:v>
                </c:pt>
                <c:pt idx="10">
                  <c:v>0.22026431718061701</c:v>
                </c:pt>
                <c:pt idx="11">
                  <c:v>0.18722466960352399</c:v>
                </c:pt>
                <c:pt idx="12">
                  <c:v>0.19823788546255502</c:v>
                </c:pt>
                <c:pt idx="13">
                  <c:v>0.22026431718061701</c:v>
                </c:pt>
                <c:pt idx="14">
                  <c:v>0.1762114537444960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5-4907-46CE-80C0-3C9A1DF7A847}"/>
            </c:ext>
          </c:extLst>
        </c:ser>
        <c:ser>
          <c:idx val="22"/>
          <c:order val="22"/>
          <c:tx>
            <c:strRef>
              <c:f>'6nt'!$A$314</c:f>
              <c:strCache>
                <c:ptCount val="1"/>
                <c:pt idx="0">
                  <c:v>AUAUAU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314:$P$314</c:f>
              <c:numCache>
                <c:formatCode>General</c:formatCode>
                <c:ptCount val="15"/>
                <c:pt idx="0">
                  <c:v>8.8105726872246728E-2</c:v>
                </c:pt>
                <c:pt idx="1">
                  <c:v>0.13215859030836999</c:v>
                </c:pt>
                <c:pt idx="2">
                  <c:v>0.14317180616740102</c:v>
                </c:pt>
                <c:pt idx="3">
                  <c:v>0.16519823788546606</c:v>
                </c:pt>
                <c:pt idx="4">
                  <c:v>0.16519823788546606</c:v>
                </c:pt>
                <c:pt idx="5">
                  <c:v>0.19823788546255502</c:v>
                </c:pt>
                <c:pt idx="6">
                  <c:v>0.31938325991189809</c:v>
                </c:pt>
                <c:pt idx="7">
                  <c:v>0.18722466960352399</c:v>
                </c:pt>
                <c:pt idx="8">
                  <c:v>0.19823788546255502</c:v>
                </c:pt>
                <c:pt idx="9">
                  <c:v>0.33039647577093112</c:v>
                </c:pt>
                <c:pt idx="10">
                  <c:v>0.25330396475771205</c:v>
                </c:pt>
                <c:pt idx="11">
                  <c:v>0.18722466960352399</c:v>
                </c:pt>
                <c:pt idx="12">
                  <c:v>0.209251101321586</c:v>
                </c:pt>
                <c:pt idx="13">
                  <c:v>0.26431718061674003</c:v>
                </c:pt>
                <c:pt idx="14">
                  <c:v>0.220264317180617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6-4907-46CE-80C0-3C9A1DF7A847}"/>
            </c:ext>
          </c:extLst>
        </c:ser>
        <c:ser>
          <c:idx val="23"/>
          <c:order val="23"/>
          <c:tx>
            <c:strRef>
              <c:f>'6nt'!$A$315</c:f>
              <c:strCache>
                <c:ptCount val="1"/>
                <c:pt idx="0">
                  <c:v>GAAUAA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315:$P$315</c:f>
              <c:numCache>
                <c:formatCode>General</c:formatCode>
                <c:ptCount val="15"/>
                <c:pt idx="0">
                  <c:v>5.5066079295154204E-2</c:v>
                </c:pt>
                <c:pt idx="1">
                  <c:v>0.11013215859030799</c:v>
                </c:pt>
                <c:pt idx="2">
                  <c:v>0.18722466960352399</c:v>
                </c:pt>
                <c:pt idx="3">
                  <c:v>0.26431718061674003</c:v>
                </c:pt>
                <c:pt idx="4">
                  <c:v>0.30837004405286911</c:v>
                </c:pt>
                <c:pt idx="5">
                  <c:v>0.27533039647577101</c:v>
                </c:pt>
                <c:pt idx="6">
                  <c:v>0.31938325991189809</c:v>
                </c:pt>
                <c:pt idx="7">
                  <c:v>0.24229074889867802</c:v>
                </c:pt>
                <c:pt idx="8">
                  <c:v>0.26431718061674003</c:v>
                </c:pt>
                <c:pt idx="9">
                  <c:v>0.25330396475771205</c:v>
                </c:pt>
                <c:pt idx="10">
                  <c:v>0.23127753303964799</c:v>
                </c:pt>
                <c:pt idx="11">
                  <c:v>0.17621145374449607</c:v>
                </c:pt>
                <c:pt idx="12">
                  <c:v>0.19823788546255502</c:v>
                </c:pt>
                <c:pt idx="13">
                  <c:v>0.11013215859030799</c:v>
                </c:pt>
                <c:pt idx="14">
                  <c:v>4.4052863436123517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7-4907-46CE-80C0-3C9A1DF7A847}"/>
            </c:ext>
          </c:extLst>
        </c:ser>
        <c:ser>
          <c:idx val="24"/>
          <c:order val="24"/>
          <c:tx>
            <c:strRef>
              <c:f>'6nt'!$A$316</c:f>
              <c:strCache>
                <c:ptCount val="1"/>
                <c:pt idx="0">
                  <c:v>UAUAUA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316:$P$316</c:f>
              <c:numCache>
                <c:formatCode>General</c:formatCode>
                <c:ptCount val="15"/>
                <c:pt idx="0">
                  <c:v>0.23127753303964799</c:v>
                </c:pt>
                <c:pt idx="1">
                  <c:v>0.14317180616740102</c:v>
                </c:pt>
                <c:pt idx="2">
                  <c:v>0.19823788546255502</c:v>
                </c:pt>
                <c:pt idx="3">
                  <c:v>0.17621145374449607</c:v>
                </c:pt>
                <c:pt idx="4">
                  <c:v>0.15418502202643203</c:v>
                </c:pt>
                <c:pt idx="5">
                  <c:v>0.30837004405286911</c:v>
                </c:pt>
                <c:pt idx="6">
                  <c:v>0.23127753303964799</c:v>
                </c:pt>
                <c:pt idx="7">
                  <c:v>0.15418502202643203</c:v>
                </c:pt>
                <c:pt idx="8">
                  <c:v>0.19823788546255502</c:v>
                </c:pt>
                <c:pt idx="9">
                  <c:v>0.16519823788546606</c:v>
                </c:pt>
                <c:pt idx="10">
                  <c:v>0.22026431718061701</c:v>
                </c:pt>
                <c:pt idx="11">
                  <c:v>0.19823788546255502</c:v>
                </c:pt>
                <c:pt idx="12">
                  <c:v>0.25330396475771205</c:v>
                </c:pt>
                <c:pt idx="13">
                  <c:v>0.24229074889867802</c:v>
                </c:pt>
                <c:pt idx="14">
                  <c:v>0.154185022026432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8-4907-46CE-80C0-3C9A1DF7A847}"/>
            </c:ext>
          </c:extLst>
        </c:ser>
        <c:ser>
          <c:idx val="25"/>
          <c:order val="25"/>
          <c:tx>
            <c:strRef>
              <c:f>'6nt'!$A$317</c:f>
              <c:strCache>
                <c:ptCount val="1"/>
                <c:pt idx="0">
                  <c:v>AAUCAA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317:$P$317</c:f>
              <c:numCache>
                <c:formatCode>General</c:formatCode>
                <c:ptCount val="15"/>
                <c:pt idx="0">
                  <c:v>0.15418502202643203</c:v>
                </c:pt>
                <c:pt idx="1">
                  <c:v>0.13215859030836999</c:v>
                </c:pt>
                <c:pt idx="2">
                  <c:v>0.11013215859030799</c:v>
                </c:pt>
                <c:pt idx="3">
                  <c:v>0.209251101321586</c:v>
                </c:pt>
                <c:pt idx="4">
                  <c:v>0.15418502202643203</c:v>
                </c:pt>
                <c:pt idx="5">
                  <c:v>0.26431718061674003</c:v>
                </c:pt>
                <c:pt idx="6">
                  <c:v>0.209251101321586</c:v>
                </c:pt>
                <c:pt idx="7">
                  <c:v>0.25330396475771205</c:v>
                </c:pt>
                <c:pt idx="8">
                  <c:v>0.31938325991189809</c:v>
                </c:pt>
                <c:pt idx="9">
                  <c:v>0.26431718061674003</c:v>
                </c:pt>
                <c:pt idx="10">
                  <c:v>0.22026431718061701</c:v>
                </c:pt>
                <c:pt idx="11">
                  <c:v>0.209251101321586</c:v>
                </c:pt>
                <c:pt idx="12">
                  <c:v>0.24229074889867802</c:v>
                </c:pt>
                <c:pt idx="13">
                  <c:v>0.17621145374449607</c:v>
                </c:pt>
                <c:pt idx="14">
                  <c:v>0.110132158590307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9-4907-46CE-80C0-3C9A1DF7A847}"/>
            </c:ext>
          </c:extLst>
        </c:ser>
        <c:ser>
          <c:idx val="26"/>
          <c:order val="26"/>
          <c:tx>
            <c:strRef>
              <c:f>'6nt'!$A$318</c:f>
              <c:strCache>
                <c:ptCount val="1"/>
                <c:pt idx="0">
                  <c:v>UUUAAA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318:$P$318</c:f>
              <c:numCache>
                <c:formatCode>General</c:formatCode>
                <c:ptCount val="15"/>
                <c:pt idx="0">
                  <c:v>0.18722466960352399</c:v>
                </c:pt>
                <c:pt idx="1">
                  <c:v>0.17621145374449607</c:v>
                </c:pt>
                <c:pt idx="2">
                  <c:v>0.22026431718061701</c:v>
                </c:pt>
                <c:pt idx="3">
                  <c:v>0.24229074889867802</c:v>
                </c:pt>
                <c:pt idx="4">
                  <c:v>0.17621145374449607</c:v>
                </c:pt>
                <c:pt idx="5">
                  <c:v>9.911894273127872E-2</c:v>
                </c:pt>
                <c:pt idx="6">
                  <c:v>0.30837004405286911</c:v>
                </c:pt>
                <c:pt idx="7">
                  <c:v>0.15418502202643203</c:v>
                </c:pt>
                <c:pt idx="8">
                  <c:v>0.30837004405286911</c:v>
                </c:pt>
                <c:pt idx="9">
                  <c:v>0.41850220264317201</c:v>
                </c:pt>
                <c:pt idx="10">
                  <c:v>0.15418502202643203</c:v>
                </c:pt>
                <c:pt idx="11">
                  <c:v>0.13215859030836999</c:v>
                </c:pt>
                <c:pt idx="12">
                  <c:v>0.12114537444934001</c:v>
                </c:pt>
                <c:pt idx="13">
                  <c:v>0.15418502202643203</c:v>
                </c:pt>
                <c:pt idx="14">
                  <c:v>0.110132158590307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A-4907-46CE-80C0-3C9A1DF7A847}"/>
            </c:ext>
          </c:extLst>
        </c:ser>
        <c:ser>
          <c:idx val="27"/>
          <c:order val="27"/>
          <c:tx>
            <c:strRef>
              <c:f>'6nt'!$A$319</c:f>
              <c:strCache>
                <c:ptCount val="1"/>
                <c:pt idx="0">
                  <c:v>AUAUAA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319:$P$319</c:f>
              <c:numCache>
                <c:formatCode>General</c:formatCode>
                <c:ptCount val="15"/>
                <c:pt idx="0">
                  <c:v>0.15418502202643203</c:v>
                </c:pt>
                <c:pt idx="1">
                  <c:v>0.22026431718061701</c:v>
                </c:pt>
                <c:pt idx="2">
                  <c:v>9.911894273127872E-2</c:v>
                </c:pt>
                <c:pt idx="3">
                  <c:v>0.16519823788546606</c:v>
                </c:pt>
                <c:pt idx="4">
                  <c:v>0.22026431718061701</c:v>
                </c:pt>
                <c:pt idx="5">
                  <c:v>0.16519823788546606</c:v>
                </c:pt>
                <c:pt idx="6">
                  <c:v>0.24229074889867802</c:v>
                </c:pt>
                <c:pt idx="7">
                  <c:v>0.13215859030836999</c:v>
                </c:pt>
                <c:pt idx="8">
                  <c:v>0.18722466960352399</c:v>
                </c:pt>
                <c:pt idx="9">
                  <c:v>0.29735682819383608</c:v>
                </c:pt>
                <c:pt idx="10">
                  <c:v>0.23127753303964799</c:v>
                </c:pt>
                <c:pt idx="11">
                  <c:v>0.209251101321586</c:v>
                </c:pt>
                <c:pt idx="12">
                  <c:v>0.26431718061674003</c:v>
                </c:pt>
                <c:pt idx="13">
                  <c:v>0.19823788546255502</c:v>
                </c:pt>
                <c:pt idx="14">
                  <c:v>0.143171806167401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B-4907-46CE-80C0-3C9A1DF7A847}"/>
            </c:ext>
          </c:extLst>
        </c:ser>
        <c:ser>
          <c:idx val="28"/>
          <c:order val="28"/>
          <c:tx>
            <c:strRef>
              <c:f>'6nt'!$A$320</c:f>
              <c:strCache>
                <c:ptCount val="1"/>
                <c:pt idx="0">
                  <c:v>AACAAA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320:$P$320</c:f>
              <c:numCache>
                <c:formatCode>General</c:formatCode>
                <c:ptCount val="15"/>
                <c:pt idx="0">
                  <c:v>0.15418502202643203</c:v>
                </c:pt>
                <c:pt idx="1">
                  <c:v>0.17621145374449607</c:v>
                </c:pt>
                <c:pt idx="2">
                  <c:v>5.5066079295154204E-2</c:v>
                </c:pt>
                <c:pt idx="3">
                  <c:v>0.18722466960352399</c:v>
                </c:pt>
                <c:pt idx="4">
                  <c:v>0.18722466960352399</c:v>
                </c:pt>
                <c:pt idx="5">
                  <c:v>0.24229074889867802</c:v>
                </c:pt>
                <c:pt idx="6">
                  <c:v>0.209251101321586</c:v>
                </c:pt>
                <c:pt idx="7">
                  <c:v>0.16519823788546606</c:v>
                </c:pt>
                <c:pt idx="8">
                  <c:v>0.13215859030836999</c:v>
                </c:pt>
                <c:pt idx="9">
                  <c:v>0.22026431718061701</c:v>
                </c:pt>
                <c:pt idx="10">
                  <c:v>0.2863436123348071</c:v>
                </c:pt>
                <c:pt idx="11">
                  <c:v>0.2863436123348071</c:v>
                </c:pt>
                <c:pt idx="12">
                  <c:v>0.17621145374449607</c:v>
                </c:pt>
                <c:pt idx="13">
                  <c:v>0.18722466960352399</c:v>
                </c:pt>
                <c:pt idx="14">
                  <c:v>0.1762114537444960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C-4907-46CE-80C0-3C9A1DF7A847}"/>
            </c:ext>
          </c:extLst>
        </c:ser>
        <c:ser>
          <c:idx val="29"/>
          <c:order val="29"/>
          <c:tx>
            <c:strRef>
              <c:f>'6nt'!$A$321</c:f>
              <c:strCache>
                <c:ptCount val="1"/>
                <c:pt idx="0">
                  <c:v>AAUGAA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321:$P$321</c:f>
              <c:numCache>
                <c:formatCode>General</c:formatCode>
                <c:ptCount val="15"/>
                <c:pt idx="0">
                  <c:v>0.13215859030836999</c:v>
                </c:pt>
                <c:pt idx="1">
                  <c:v>9.911894273127872E-2</c:v>
                </c:pt>
                <c:pt idx="2">
                  <c:v>0.13215859030836999</c:v>
                </c:pt>
                <c:pt idx="3">
                  <c:v>6.6079295154184994E-2</c:v>
                </c:pt>
                <c:pt idx="4">
                  <c:v>0.24229074889867802</c:v>
                </c:pt>
                <c:pt idx="5">
                  <c:v>0.25330396475771205</c:v>
                </c:pt>
                <c:pt idx="6">
                  <c:v>0.24229074889867802</c:v>
                </c:pt>
                <c:pt idx="7">
                  <c:v>0.13215859030836999</c:v>
                </c:pt>
                <c:pt idx="8">
                  <c:v>0.23127753303964799</c:v>
                </c:pt>
                <c:pt idx="9">
                  <c:v>0.18722466960352399</c:v>
                </c:pt>
                <c:pt idx="10">
                  <c:v>0.209251101321586</c:v>
                </c:pt>
                <c:pt idx="11">
                  <c:v>0.209251101321586</c:v>
                </c:pt>
                <c:pt idx="12">
                  <c:v>0.22026431718061701</c:v>
                </c:pt>
                <c:pt idx="13">
                  <c:v>0.27533039647577101</c:v>
                </c:pt>
                <c:pt idx="14">
                  <c:v>6.6079295154184994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D-4907-46CE-80C0-3C9A1DF7A847}"/>
            </c:ext>
          </c:extLst>
        </c:ser>
        <c:ser>
          <c:idx val="30"/>
          <c:order val="30"/>
          <c:tx>
            <c:strRef>
              <c:f>'6nt'!$A$322</c:f>
              <c:strCache>
                <c:ptCount val="1"/>
                <c:pt idx="0">
                  <c:v>AUAAAG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322:$P$322</c:f>
              <c:numCache>
                <c:formatCode>General</c:formatCode>
                <c:ptCount val="15"/>
                <c:pt idx="0">
                  <c:v>7.7092511013217221E-2</c:v>
                </c:pt>
                <c:pt idx="1">
                  <c:v>5.5066079295154204E-2</c:v>
                </c:pt>
                <c:pt idx="2">
                  <c:v>0.14317180616740102</c:v>
                </c:pt>
                <c:pt idx="3">
                  <c:v>5.5066079295154204E-2</c:v>
                </c:pt>
                <c:pt idx="4">
                  <c:v>0.15418502202643203</c:v>
                </c:pt>
                <c:pt idx="5">
                  <c:v>0.16519823788546606</c:v>
                </c:pt>
                <c:pt idx="6">
                  <c:v>0.17621145374449607</c:v>
                </c:pt>
                <c:pt idx="7">
                  <c:v>0.15418502202643203</c:v>
                </c:pt>
                <c:pt idx="8">
                  <c:v>0.15418502202643203</c:v>
                </c:pt>
                <c:pt idx="9">
                  <c:v>0.23127753303964799</c:v>
                </c:pt>
                <c:pt idx="10">
                  <c:v>0.30837004405286911</c:v>
                </c:pt>
                <c:pt idx="11">
                  <c:v>0.3964757709251151</c:v>
                </c:pt>
                <c:pt idx="12">
                  <c:v>0.26431718061674003</c:v>
                </c:pt>
                <c:pt idx="13">
                  <c:v>0.12114537444934001</c:v>
                </c:pt>
                <c:pt idx="14">
                  <c:v>0.20925110132158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E-4907-46CE-80C0-3C9A1DF7A847}"/>
            </c:ext>
          </c:extLst>
        </c:ser>
        <c:ser>
          <c:idx val="31"/>
          <c:order val="31"/>
          <c:tx>
            <c:strRef>
              <c:f>'6nt'!$A$323</c:f>
              <c:strCache>
                <c:ptCount val="1"/>
                <c:pt idx="0">
                  <c:v>UUUUAA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323:$P$323</c:f>
              <c:numCache>
                <c:formatCode>General</c:formatCode>
                <c:ptCount val="15"/>
                <c:pt idx="0">
                  <c:v>0.19823788546255502</c:v>
                </c:pt>
                <c:pt idx="1">
                  <c:v>0.209251101321586</c:v>
                </c:pt>
                <c:pt idx="2">
                  <c:v>0.25330396475771205</c:v>
                </c:pt>
                <c:pt idx="3">
                  <c:v>0.22026431718061701</c:v>
                </c:pt>
                <c:pt idx="4">
                  <c:v>0.18722466960352399</c:v>
                </c:pt>
                <c:pt idx="5">
                  <c:v>0.3964757709251151</c:v>
                </c:pt>
                <c:pt idx="6">
                  <c:v>0.19823788546255502</c:v>
                </c:pt>
                <c:pt idx="7">
                  <c:v>0.27533039647577101</c:v>
                </c:pt>
                <c:pt idx="8">
                  <c:v>0.25330396475771205</c:v>
                </c:pt>
                <c:pt idx="9">
                  <c:v>0.14317180616740102</c:v>
                </c:pt>
                <c:pt idx="10">
                  <c:v>0.12114537444934001</c:v>
                </c:pt>
                <c:pt idx="11">
                  <c:v>4.4052863436123517E-2</c:v>
                </c:pt>
                <c:pt idx="12">
                  <c:v>5.5066079295154204E-2</c:v>
                </c:pt>
                <c:pt idx="13">
                  <c:v>4.4052863436123517E-2</c:v>
                </c:pt>
                <c:pt idx="14">
                  <c:v>3.3039647577092907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F-4907-46CE-80C0-3C9A1DF7A847}"/>
            </c:ext>
          </c:extLst>
        </c:ser>
        <c:ser>
          <c:idx val="32"/>
          <c:order val="32"/>
          <c:tx>
            <c:strRef>
              <c:f>'6nt'!$A$324</c:f>
              <c:strCache>
                <c:ptCount val="1"/>
                <c:pt idx="0">
                  <c:v>UUAAAA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324:$P$324</c:f>
              <c:numCache>
                <c:formatCode>General</c:formatCode>
                <c:ptCount val="15"/>
                <c:pt idx="0">
                  <c:v>0.12114537444934001</c:v>
                </c:pt>
                <c:pt idx="1">
                  <c:v>0.15418502202643203</c:v>
                </c:pt>
                <c:pt idx="2">
                  <c:v>0.16519823788546606</c:v>
                </c:pt>
                <c:pt idx="3">
                  <c:v>0.15418502202643203</c:v>
                </c:pt>
                <c:pt idx="4">
                  <c:v>0.18722466960352399</c:v>
                </c:pt>
                <c:pt idx="5">
                  <c:v>0.12114537444934001</c:v>
                </c:pt>
                <c:pt idx="6">
                  <c:v>0.17621145374449607</c:v>
                </c:pt>
                <c:pt idx="7">
                  <c:v>0.209251101321586</c:v>
                </c:pt>
                <c:pt idx="8">
                  <c:v>0.13215859030836999</c:v>
                </c:pt>
                <c:pt idx="9">
                  <c:v>0.209251101321586</c:v>
                </c:pt>
                <c:pt idx="10">
                  <c:v>0.29735682819383608</c:v>
                </c:pt>
                <c:pt idx="11">
                  <c:v>0.18722466960352399</c:v>
                </c:pt>
                <c:pt idx="12">
                  <c:v>0.13215859030836999</c:v>
                </c:pt>
                <c:pt idx="13">
                  <c:v>0.17621145374449607</c:v>
                </c:pt>
                <c:pt idx="14">
                  <c:v>0.187224669603523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0-4907-46CE-80C0-3C9A1DF7A847}"/>
            </c:ext>
          </c:extLst>
        </c:ser>
        <c:ser>
          <c:idx val="33"/>
          <c:order val="33"/>
          <c:tx>
            <c:strRef>
              <c:f>'6nt'!$A$325</c:f>
              <c:strCache>
                <c:ptCount val="1"/>
                <c:pt idx="0">
                  <c:v>AAAAAC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325:$P$325</c:f>
              <c:numCache>
                <c:formatCode>General</c:formatCode>
                <c:ptCount val="15"/>
                <c:pt idx="0">
                  <c:v>8.8105726872246728E-2</c:v>
                </c:pt>
                <c:pt idx="1">
                  <c:v>6.6079295154184994E-2</c:v>
                </c:pt>
                <c:pt idx="2">
                  <c:v>0.16519823788546606</c:v>
                </c:pt>
                <c:pt idx="3">
                  <c:v>8.8105726872246728E-2</c:v>
                </c:pt>
                <c:pt idx="4">
                  <c:v>0.13215859030836999</c:v>
                </c:pt>
                <c:pt idx="5">
                  <c:v>0.14317180616740102</c:v>
                </c:pt>
                <c:pt idx="6">
                  <c:v>0.16519823788546606</c:v>
                </c:pt>
                <c:pt idx="7">
                  <c:v>0.13215859030836999</c:v>
                </c:pt>
                <c:pt idx="8">
                  <c:v>0.18722466960352399</c:v>
                </c:pt>
                <c:pt idx="9">
                  <c:v>0.209251101321586</c:v>
                </c:pt>
                <c:pt idx="10">
                  <c:v>0.23127753303964799</c:v>
                </c:pt>
                <c:pt idx="11">
                  <c:v>0.27533039647577101</c:v>
                </c:pt>
                <c:pt idx="12">
                  <c:v>0.23127753303964799</c:v>
                </c:pt>
                <c:pt idx="13">
                  <c:v>0.18722466960352399</c:v>
                </c:pt>
                <c:pt idx="14">
                  <c:v>0.286343612334807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1-4907-46CE-80C0-3C9A1DF7A847}"/>
            </c:ext>
          </c:extLst>
        </c:ser>
        <c:ser>
          <c:idx val="34"/>
          <c:order val="34"/>
          <c:tx>
            <c:strRef>
              <c:f>'6nt'!$A$326</c:f>
              <c:strCache>
                <c:ptCount val="1"/>
                <c:pt idx="0">
                  <c:v>GAAAGA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326:$P$326</c:f>
              <c:numCache>
                <c:formatCode>General</c:formatCode>
                <c:ptCount val="15"/>
                <c:pt idx="0">
                  <c:v>0.15418502202643203</c:v>
                </c:pt>
                <c:pt idx="1">
                  <c:v>0.13215859030836999</c:v>
                </c:pt>
                <c:pt idx="2">
                  <c:v>0.11013215859030799</c:v>
                </c:pt>
                <c:pt idx="3">
                  <c:v>0.18722466960352399</c:v>
                </c:pt>
                <c:pt idx="4">
                  <c:v>0.17621145374449607</c:v>
                </c:pt>
                <c:pt idx="5">
                  <c:v>0.14317180616740102</c:v>
                </c:pt>
                <c:pt idx="6">
                  <c:v>0.13215859030836999</c:v>
                </c:pt>
                <c:pt idx="7">
                  <c:v>0.14317180616740102</c:v>
                </c:pt>
                <c:pt idx="8">
                  <c:v>0.16519823788546606</c:v>
                </c:pt>
                <c:pt idx="9">
                  <c:v>0.29735682819383608</c:v>
                </c:pt>
                <c:pt idx="10">
                  <c:v>0.18722466960352399</c:v>
                </c:pt>
                <c:pt idx="11">
                  <c:v>0.25330396475771205</c:v>
                </c:pt>
                <c:pt idx="12">
                  <c:v>0.15418502202643203</c:v>
                </c:pt>
                <c:pt idx="13">
                  <c:v>0.17621145374449607</c:v>
                </c:pt>
                <c:pt idx="14">
                  <c:v>0.143171806167401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2-4907-46CE-80C0-3C9A1DF7A847}"/>
            </c:ext>
          </c:extLst>
        </c:ser>
        <c:ser>
          <c:idx val="35"/>
          <c:order val="35"/>
          <c:tx>
            <c:strRef>
              <c:f>'6nt'!$A$327</c:f>
              <c:strCache>
                <c:ptCount val="1"/>
                <c:pt idx="0">
                  <c:v>UAAAAU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327:$P$327</c:f>
              <c:numCache>
                <c:formatCode>General</c:formatCode>
                <c:ptCount val="15"/>
                <c:pt idx="0">
                  <c:v>5.5066079295154204E-2</c:v>
                </c:pt>
                <c:pt idx="1">
                  <c:v>0.13215859030836999</c:v>
                </c:pt>
                <c:pt idx="2">
                  <c:v>7.7092511013217221E-2</c:v>
                </c:pt>
                <c:pt idx="3">
                  <c:v>0.17621145374449607</c:v>
                </c:pt>
                <c:pt idx="4">
                  <c:v>0.12114537444934001</c:v>
                </c:pt>
                <c:pt idx="5">
                  <c:v>0.12114537444934001</c:v>
                </c:pt>
                <c:pt idx="6">
                  <c:v>0.16519823788546606</c:v>
                </c:pt>
                <c:pt idx="7">
                  <c:v>0.31938325991189809</c:v>
                </c:pt>
                <c:pt idx="8">
                  <c:v>0.22026431718061701</c:v>
                </c:pt>
                <c:pt idx="9">
                  <c:v>0.24229074889867802</c:v>
                </c:pt>
                <c:pt idx="10">
                  <c:v>0.19823788546255502</c:v>
                </c:pt>
                <c:pt idx="11">
                  <c:v>0.16519823788546606</c:v>
                </c:pt>
                <c:pt idx="12">
                  <c:v>0.209251101321586</c:v>
                </c:pt>
                <c:pt idx="13">
                  <c:v>0.14317180616740102</c:v>
                </c:pt>
                <c:pt idx="14">
                  <c:v>0.187224669603523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3-4907-46CE-80C0-3C9A1DF7A847}"/>
            </c:ext>
          </c:extLst>
        </c:ser>
        <c:ser>
          <c:idx val="36"/>
          <c:order val="36"/>
          <c:tx>
            <c:strRef>
              <c:f>'6nt'!$A$328</c:f>
              <c:strCache>
                <c:ptCount val="1"/>
                <c:pt idx="0">
                  <c:v>AAAUUU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328:$P$328</c:f>
              <c:numCache>
                <c:formatCode>General</c:formatCode>
                <c:ptCount val="15"/>
                <c:pt idx="0">
                  <c:v>0.22026431718061701</c:v>
                </c:pt>
                <c:pt idx="1">
                  <c:v>8.8105726872246728E-2</c:v>
                </c:pt>
                <c:pt idx="2">
                  <c:v>9.911894273127872E-2</c:v>
                </c:pt>
                <c:pt idx="3">
                  <c:v>0.15418502202643203</c:v>
                </c:pt>
                <c:pt idx="4">
                  <c:v>7.7092511013217221E-2</c:v>
                </c:pt>
                <c:pt idx="5">
                  <c:v>0.12114537444934001</c:v>
                </c:pt>
                <c:pt idx="6">
                  <c:v>0.19823788546255502</c:v>
                </c:pt>
                <c:pt idx="7">
                  <c:v>0.16519823788546606</c:v>
                </c:pt>
                <c:pt idx="8">
                  <c:v>0.17621145374449607</c:v>
                </c:pt>
                <c:pt idx="9">
                  <c:v>0.18722466960352399</c:v>
                </c:pt>
                <c:pt idx="10">
                  <c:v>0.15418502202643203</c:v>
                </c:pt>
                <c:pt idx="11">
                  <c:v>0.18722466960352399</c:v>
                </c:pt>
                <c:pt idx="12">
                  <c:v>0.27533039647577101</c:v>
                </c:pt>
                <c:pt idx="13">
                  <c:v>0.18722466960352399</c:v>
                </c:pt>
                <c:pt idx="14">
                  <c:v>0.231277533039647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4-4907-46CE-80C0-3C9A1DF7A847}"/>
            </c:ext>
          </c:extLst>
        </c:ser>
        <c:ser>
          <c:idx val="37"/>
          <c:order val="37"/>
          <c:tx>
            <c:strRef>
              <c:f>'6nt'!$A$329</c:f>
              <c:strCache>
                <c:ptCount val="1"/>
                <c:pt idx="0">
                  <c:v>AAAUAU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329:$P$329</c:f>
              <c:numCache>
                <c:formatCode>General</c:formatCode>
                <c:ptCount val="15"/>
                <c:pt idx="0">
                  <c:v>7.7092511013217221E-2</c:v>
                </c:pt>
                <c:pt idx="1">
                  <c:v>0.15418502202643203</c:v>
                </c:pt>
                <c:pt idx="2">
                  <c:v>0.14317180616740102</c:v>
                </c:pt>
                <c:pt idx="3">
                  <c:v>0.17621145374449607</c:v>
                </c:pt>
                <c:pt idx="4">
                  <c:v>0.209251101321586</c:v>
                </c:pt>
                <c:pt idx="5">
                  <c:v>0.209251101321586</c:v>
                </c:pt>
                <c:pt idx="6">
                  <c:v>0.11013215859030799</c:v>
                </c:pt>
                <c:pt idx="7">
                  <c:v>0.15418502202643203</c:v>
                </c:pt>
                <c:pt idx="8">
                  <c:v>0.15418502202643203</c:v>
                </c:pt>
                <c:pt idx="9">
                  <c:v>0.15418502202643203</c:v>
                </c:pt>
                <c:pt idx="10">
                  <c:v>0.24229074889867802</c:v>
                </c:pt>
                <c:pt idx="11">
                  <c:v>0.12114537444934001</c:v>
                </c:pt>
                <c:pt idx="12">
                  <c:v>0.24229074889867802</c:v>
                </c:pt>
                <c:pt idx="13">
                  <c:v>0.13215859030836999</c:v>
                </c:pt>
                <c:pt idx="14">
                  <c:v>0.143171806167401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5-4907-46CE-80C0-3C9A1DF7A847}"/>
            </c:ext>
          </c:extLst>
        </c:ser>
        <c:ser>
          <c:idx val="38"/>
          <c:order val="38"/>
          <c:tx>
            <c:strRef>
              <c:f>'6nt'!$A$330</c:f>
              <c:strCache>
                <c:ptCount val="1"/>
                <c:pt idx="0">
                  <c:v>AAGAAU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330:$P$330</c:f>
              <c:numCache>
                <c:formatCode>General</c:formatCode>
                <c:ptCount val="15"/>
                <c:pt idx="0">
                  <c:v>0.14317180616740102</c:v>
                </c:pt>
                <c:pt idx="1">
                  <c:v>0.16519823788546606</c:v>
                </c:pt>
                <c:pt idx="2">
                  <c:v>0.14317180616740102</c:v>
                </c:pt>
                <c:pt idx="3">
                  <c:v>0.15418502202643203</c:v>
                </c:pt>
                <c:pt idx="4">
                  <c:v>0.18722466960352399</c:v>
                </c:pt>
                <c:pt idx="5">
                  <c:v>0.13215859030836999</c:v>
                </c:pt>
                <c:pt idx="6">
                  <c:v>0.16519823788546606</c:v>
                </c:pt>
                <c:pt idx="7">
                  <c:v>9.911894273127872E-2</c:v>
                </c:pt>
                <c:pt idx="8">
                  <c:v>0.16519823788546606</c:v>
                </c:pt>
                <c:pt idx="9">
                  <c:v>0.14317180616740102</c:v>
                </c:pt>
                <c:pt idx="10">
                  <c:v>0.16519823788546606</c:v>
                </c:pt>
                <c:pt idx="11">
                  <c:v>0.16519823788546606</c:v>
                </c:pt>
                <c:pt idx="12">
                  <c:v>0.25330396475771205</c:v>
                </c:pt>
                <c:pt idx="13">
                  <c:v>0.13215859030836999</c:v>
                </c:pt>
                <c:pt idx="14">
                  <c:v>0.198237885462555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6-4907-46CE-80C0-3C9A1DF7A847}"/>
            </c:ext>
          </c:extLst>
        </c:ser>
        <c:ser>
          <c:idx val="39"/>
          <c:order val="39"/>
          <c:tx>
            <c:strRef>
              <c:f>'6nt'!$A$331</c:f>
              <c:strCache>
                <c:ptCount val="1"/>
                <c:pt idx="0">
                  <c:v>AAUAAG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331:$P$331</c:f>
              <c:numCache>
                <c:formatCode>General</c:formatCode>
                <c:ptCount val="15"/>
                <c:pt idx="0">
                  <c:v>9.911894273127872E-2</c:v>
                </c:pt>
                <c:pt idx="1">
                  <c:v>2.2026431718061706E-2</c:v>
                </c:pt>
                <c:pt idx="2">
                  <c:v>4.4052863436123517E-2</c:v>
                </c:pt>
                <c:pt idx="3">
                  <c:v>0.15418502202643203</c:v>
                </c:pt>
                <c:pt idx="4">
                  <c:v>0.16519823788546606</c:v>
                </c:pt>
                <c:pt idx="5">
                  <c:v>0.16519823788546606</c:v>
                </c:pt>
                <c:pt idx="6">
                  <c:v>0.15418502202643203</c:v>
                </c:pt>
                <c:pt idx="7">
                  <c:v>0.14317180616740102</c:v>
                </c:pt>
                <c:pt idx="8">
                  <c:v>0.15418502202643203</c:v>
                </c:pt>
                <c:pt idx="9">
                  <c:v>0.22026431718061701</c:v>
                </c:pt>
                <c:pt idx="10">
                  <c:v>0.29735682819383608</c:v>
                </c:pt>
                <c:pt idx="11">
                  <c:v>0.27533039647577101</c:v>
                </c:pt>
                <c:pt idx="12">
                  <c:v>0.209251101321586</c:v>
                </c:pt>
                <c:pt idx="13">
                  <c:v>0.15418502202643203</c:v>
                </c:pt>
                <c:pt idx="14">
                  <c:v>0.110132158590307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7-4907-46CE-80C0-3C9A1DF7A847}"/>
            </c:ext>
          </c:extLst>
        </c:ser>
        <c:ser>
          <c:idx val="40"/>
          <c:order val="40"/>
          <c:tx>
            <c:strRef>
              <c:f>'6nt'!$A$332</c:f>
              <c:strCache>
                <c:ptCount val="1"/>
                <c:pt idx="0">
                  <c:v>AAAAUU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332:$P$332</c:f>
              <c:numCache>
                <c:formatCode>General</c:formatCode>
                <c:ptCount val="15"/>
                <c:pt idx="0">
                  <c:v>0.11013215859030799</c:v>
                </c:pt>
                <c:pt idx="1">
                  <c:v>0.11013215859030799</c:v>
                </c:pt>
                <c:pt idx="2">
                  <c:v>0.22026431718061701</c:v>
                </c:pt>
                <c:pt idx="3">
                  <c:v>5.5066079295154204E-2</c:v>
                </c:pt>
                <c:pt idx="4">
                  <c:v>0.11013215859030799</c:v>
                </c:pt>
                <c:pt idx="5">
                  <c:v>0.16519823788546606</c:v>
                </c:pt>
                <c:pt idx="6">
                  <c:v>9.911894273127872E-2</c:v>
                </c:pt>
                <c:pt idx="7">
                  <c:v>0.16519823788546606</c:v>
                </c:pt>
                <c:pt idx="8">
                  <c:v>0.17621145374449607</c:v>
                </c:pt>
                <c:pt idx="9">
                  <c:v>0.17621145374449607</c:v>
                </c:pt>
                <c:pt idx="10">
                  <c:v>0.18722466960352399</c:v>
                </c:pt>
                <c:pt idx="11">
                  <c:v>0.27533039647577101</c:v>
                </c:pt>
                <c:pt idx="12">
                  <c:v>0.15418502202643203</c:v>
                </c:pt>
                <c:pt idx="13">
                  <c:v>0.15418502202643203</c:v>
                </c:pt>
                <c:pt idx="14">
                  <c:v>0.198237885462555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8-4907-46CE-80C0-3C9A1DF7A847}"/>
            </c:ext>
          </c:extLst>
        </c:ser>
        <c:ser>
          <c:idx val="41"/>
          <c:order val="41"/>
          <c:tx>
            <c:strRef>
              <c:f>'6nt'!$A$333</c:f>
              <c:strCache>
                <c:ptCount val="1"/>
                <c:pt idx="0">
                  <c:v>CAAUAA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333:$P$333</c:f>
              <c:numCache>
                <c:formatCode>General</c:formatCode>
                <c:ptCount val="15"/>
                <c:pt idx="0">
                  <c:v>6.6079295154184994E-2</c:v>
                </c:pt>
                <c:pt idx="1">
                  <c:v>4.4052863436123517E-2</c:v>
                </c:pt>
                <c:pt idx="2">
                  <c:v>0.11013215859030799</c:v>
                </c:pt>
                <c:pt idx="3">
                  <c:v>0.13215859030836999</c:v>
                </c:pt>
                <c:pt idx="4">
                  <c:v>0.17621145374449607</c:v>
                </c:pt>
                <c:pt idx="5">
                  <c:v>0.14317180616740102</c:v>
                </c:pt>
                <c:pt idx="6">
                  <c:v>0.209251101321586</c:v>
                </c:pt>
                <c:pt idx="7">
                  <c:v>0.22026431718061701</c:v>
                </c:pt>
                <c:pt idx="8">
                  <c:v>0.24229074889867802</c:v>
                </c:pt>
                <c:pt idx="9">
                  <c:v>0.2863436123348071</c:v>
                </c:pt>
                <c:pt idx="10">
                  <c:v>0.30837004405286911</c:v>
                </c:pt>
                <c:pt idx="11">
                  <c:v>0.14317180616740102</c:v>
                </c:pt>
                <c:pt idx="12">
                  <c:v>0.13215859030836999</c:v>
                </c:pt>
                <c:pt idx="13">
                  <c:v>6.6079295154184994E-2</c:v>
                </c:pt>
                <c:pt idx="14">
                  <c:v>6.6079295154184994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9-4907-46CE-80C0-3C9A1DF7A847}"/>
            </c:ext>
          </c:extLst>
        </c:ser>
        <c:ser>
          <c:idx val="42"/>
          <c:order val="42"/>
          <c:tx>
            <c:strRef>
              <c:f>'6nt'!$A$334</c:f>
              <c:strCache>
                <c:ptCount val="1"/>
                <c:pt idx="0">
                  <c:v>UUUAAU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334:$P$334</c:f>
              <c:numCache>
                <c:formatCode>General</c:formatCode>
                <c:ptCount val="15"/>
                <c:pt idx="0">
                  <c:v>0.13215859030836999</c:v>
                </c:pt>
                <c:pt idx="1">
                  <c:v>0.22026431718061701</c:v>
                </c:pt>
                <c:pt idx="2">
                  <c:v>0.18722466960352399</c:v>
                </c:pt>
                <c:pt idx="3">
                  <c:v>0.17621145374449607</c:v>
                </c:pt>
                <c:pt idx="4">
                  <c:v>0.27533039647577101</c:v>
                </c:pt>
                <c:pt idx="5">
                  <c:v>0.18722466960352399</c:v>
                </c:pt>
                <c:pt idx="6">
                  <c:v>0.23127753303964799</c:v>
                </c:pt>
                <c:pt idx="7">
                  <c:v>0.16519823788546606</c:v>
                </c:pt>
                <c:pt idx="8">
                  <c:v>0.23127753303964799</c:v>
                </c:pt>
                <c:pt idx="9">
                  <c:v>0.11013215859030799</c:v>
                </c:pt>
                <c:pt idx="10">
                  <c:v>9.911894273127872E-2</c:v>
                </c:pt>
                <c:pt idx="11">
                  <c:v>5.5066079295154204E-2</c:v>
                </c:pt>
                <c:pt idx="12">
                  <c:v>7.7092511013217221E-2</c:v>
                </c:pt>
                <c:pt idx="13">
                  <c:v>4.4052863436123517E-2</c:v>
                </c:pt>
                <c:pt idx="14">
                  <c:v>0.110132158590307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A-4907-46CE-80C0-3C9A1DF7A847}"/>
            </c:ext>
          </c:extLst>
        </c:ser>
        <c:ser>
          <c:idx val="43"/>
          <c:order val="43"/>
          <c:tx>
            <c:strRef>
              <c:f>'6nt'!$A$335</c:f>
              <c:strCache>
                <c:ptCount val="1"/>
                <c:pt idx="0">
                  <c:v>UUAAAU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335:$P$335</c:f>
              <c:numCache>
                <c:formatCode>General</c:formatCode>
                <c:ptCount val="15"/>
                <c:pt idx="0">
                  <c:v>7.7092511013217221E-2</c:v>
                </c:pt>
                <c:pt idx="1">
                  <c:v>0.11013215859030799</c:v>
                </c:pt>
                <c:pt idx="2">
                  <c:v>0.19823788546255502</c:v>
                </c:pt>
                <c:pt idx="3">
                  <c:v>0.13215859030836999</c:v>
                </c:pt>
                <c:pt idx="4">
                  <c:v>0.15418502202643203</c:v>
                </c:pt>
                <c:pt idx="5">
                  <c:v>0.14317180616740102</c:v>
                </c:pt>
                <c:pt idx="6">
                  <c:v>0.16519823788546606</c:v>
                </c:pt>
                <c:pt idx="7">
                  <c:v>0.2863436123348071</c:v>
                </c:pt>
                <c:pt idx="8">
                  <c:v>0.14317180616740102</c:v>
                </c:pt>
                <c:pt idx="9">
                  <c:v>0.25330396475771205</c:v>
                </c:pt>
                <c:pt idx="10">
                  <c:v>0.17621145374449607</c:v>
                </c:pt>
                <c:pt idx="11">
                  <c:v>7.7092511013217221E-2</c:v>
                </c:pt>
                <c:pt idx="12">
                  <c:v>0.12114537444934001</c:v>
                </c:pt>
                <c:pt idx="13">
                  <c:v>9.911894273127872E-2</c:v>
                </c:pt>
                <c:pt idx="14">
                  <c:v>0.110132158590307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B-4907-46CE-80C0-3C9A1DF7A847}"/>
            </c:ext>
          </c:extLst>
        </c:ser>
        <c:ser>
          <c:idx val="44"/>
          <c:order val="44"/>
          <c:tx>
            <c:strRef>
              <c:f>'6nt'!$A$336</c:f>
              <c:strCache>
                <c:ptCount val="1"/>
                <c:pt idx="0">
                  <c:v>AUCAAU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336:$P$336</c:f>
              <c:numCache>
                <c:formatCode>General</c:formatCode>
                <c:ptCount val="15"/>
                <c:pt idx="0">
                  <c:v>8.8105726872246728E-2</c:v>
                </c:pt>
                <c:pt idx="1">
                  <c:v>0.19823788546255502</c:v>
                </c:pt>
                <c:pt idx="2">
                  <c:v>0.12114537444934001</c:v>
                </c:pt>
                <c:pt idx="3">
                  <c:v>0.22026431718061701</c:v>
                </c:pt>
                <c:pt idx="4">
                  <c:v>0.19823788546255502</c:v>
                </c:pt>
                <c:pt idx="5">
                  <c:v>0.19823788546255502</c:v>
                </c:pt>
                <c:pt idx="6">
                  <c:v>0.19823788546255502</c:v>
                </c:pt>
                <c:pt idx="7">
                  <c:v>0.18722466960352399</c:v>
                </c:pt>
                <c:pt idx="8">
                  <c:v>0.16519823788546606</c:v>
                </c:pt>
                <c:pt idx="9">
                  <c:v>0.22026431718061701</c:v>
                </c:pt>
                <c:pt idx="10">
                  <c:v>0.11013215859030799</c:v>
                </c:pt>
                <c:pt idx="11">
                  <c:v>0.11013215859030799</c:v>
                </c:pt>
                <c:pt idx="12">
                  <c:v>9.911894273127872E-2</c:v>
                </c:pt>
                <c:pt idx="13">
                  <c:v>4.4052863436123517E-2</c:v>
                </c:pt>
                <c:pt idx="14">
                  <c:v>6.6079295154184994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C-4907-46CE-80C0-3C9A1DF7A847}"/>
            </c:ext>
          </c:extLst>
        </c:ser>
        <c:ser>
          <c:idx val="45"/>
          <c:order val="45"/>
          <c:tx>
            <c:strRef>
              <c:f>'6nt'!$A$337</c:f>
              <c:strCache>
                <c:ptCount val="1"/>
                <c:pt idx="0">
                  <c:v>AUGAAA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337:$P$337</c:f>
              <c:numCache>
                <c:formatCode>General</c:formatCode>
                <c:ptCount val="15"/>
                <c:pt idx="0">
                  <c:v>0.17621145374449607</c:v>
                </c:pt>
                <c:pt idx="1">
                  <c:v>0.12114537444934001</c:v>
                </c:pt>
                <c:pt idx="2">
                  <c:v>0.15418502202643203</c:v>
                </c:pt>
                <c:pt idx="3">
                  <c:v>0.14317180616740102</c:v>
                </c:pt>
                <c:pt idx="4">
                  <c:v>8.8105726872246728E-2</c:v>
                </c:pt>
                <c:pt idx="5">
                  <c:v>0.17621145374449607</c:v>
                </c:pt>
                <c:pt idx="6">
                  <c:v>0.18722466960352399</c:v>
                </c:pt>
                <c:pt idx="7">
                  <c:v>0.16519823788546606</c:v>
                </c:pt>
                <c:pt idx="8">
                  <c:v>0.13215859030836999</c:v>
                </c:pt>
                <c:pt idx="9">
                  <c:v>0.13215859030836999</c:v>
                </c:pt>
                <c:pt idx="10">
                  <c:v>0.12114537444934001</c:v>
                </c:pt>
                <c:pt idx="11">
                  <c:v>0.14317180616740102</c:v>
                </c:pt>
                <c:pt idx="12">
                  <c:v>0.19823788546255502</c:v>
                </c:pt>
                <c:pt idx="13">
                  <c:v>0.13215859030836999</c:v>
                </c:pt>
                <c:pt idx="14">
                  <c:v>0.13215859030836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D-4907-46CE-80C0-3C9A1DF7A847}"/>
            </c:ext>
          </c:extLst>
        </c:ser>
        <c:ser>
          <c:idx val="46"/>
          <c:order val="46"/>
          <c:tx>
            <c:strRef>
              <c:f>'6nt'!$A$338</c:f>
              <c:strCache>
                <c:ptCount val="1"/>
                <c:pt idx="0">
                  <c:v>GAAAUA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338:$P$338</c:f>
              <c:numCache>
                <c:formatCode>General</c:formatCode>
                <c:ptCount val="15"/>
                <c:pt idx="0">
                  <c:v>0.11013215859030799</c:v>
                </c:pt>
                <c:pt idx="1">
                  <c:v>6.6079295154184994E-2</c:v>
                </c:pt>
                <c:pt idx="2">
                  <c:v>9.911894273127872E-2</c:v>
                </c:pt>
                <c:pt idx="3">
                  <c:v>0.18722466960352399</c:v>
                </c:pt>
                <c:pt idx="4">
                  <c:v>0.12114537444934001</c:v>
                </c:pt>
                <c:pt idx="5">
                  <c:v>0.209251101321586</c:v>
                </c:pt>
                <c:pt idx="6">
                  <c:v>0.15418502202643203</c:v>
                </c:pt>
                <c:pt idx="7">
                  <c:v>0.16519823788546606</c:v>
                </c:pt>
                <c:pt idx="8">
                  <c:v>0.18722466960352399</c:v>
                </c:pt>
                <c:pt idx="9">
                  <c:v>0.26431718061674003</c:v>
                </c:pt>
                <c:pt idx="10">
                  <c:v>0.17621145374449607</c:v>
                </c:pt>
                <c:pt idx="11">
                  <c:v>0.22026431718061701</c:v>
                </c:pt>
                <c:pt idx="12">
                  <c:v>7.7092511013217221E-2</c:v>
                </c:pt>
                <c:pt idx="13">
                  <c:v>4.4052863436123517E-2</c:v>
                </c:pt>
                <c:pt idx="14">
                  <c:v>0.110132158590307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E-4907-46CE-80C0-3C9A1DF7A847}"/>
            </c:ext>
          </c:extLst>
        </c:ser>
        <c:ser>
          <c:idx val="47"/>
          <c:order val="47"/>
          <c:tx>
            <c:strRef>
              <c:f>'6nt'!$A$339</c:f>
              <c:strCache>
                <c:ptCount val="1"/>
                <c:pt idx="0">
                  <c:v>UAAAAG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339:$P$339</c:f>
              <c:numCache>
                <c:formatCode>General</c:formatCode>
                <c:ptCount val="15"/>
                <c:pt idx="0">
                  <c:v>0.11013215859030799</c:v>
                </c:pt>
                <c:pt idx="1">
                  <c:v>8.8105726872246728E-2</c:v>
                </c:pt>
                <c:pt idx="2">
                  <c:v>0.11013215859030799</c:v>
                </c:pt>
                <c:pt idx="3">
                  <c:v>0.17621145374449607</c:v>
                </c:pt>
                <c:pt idx="4">
                  <c:v>9.911894273127872E-2</c:v>
                </c:pt>
                <c:pt idx="5">
                  <c:v>0.15418502202643203</c:v>
                </c:pt>
                <c:pt idx="6">
                  <c:v>8.8105726872246728E-2</c:v>
                </c:pt>
                <c:pt idx="7">
                  <c:v>0.15418502202643203</c:v>
                </c:pt>
                <c:pt idx="8">
                  <c:v>0.16519823788546606</c:v>
                </c:pt>
                <c:pt idx="9">
                  <c:v>0.13215859030836999</c:v>
                </c:pt>
                <c:pt idx="10">
                  <c:v>0.16519823788546606</c:v>
                </c:pt>
                <c:pt idx="11">
                  <c:v>0.23127753303964799</c:v>
                </c:pt>
                <c:pt idx="12">
                  <c:v>0.13215859030836999</c:v>
                </c:pt>
                <c:pt idx="13">
                  <c:v>0.209251101321586</c:v>
                </c:pt>
                <c:pt idx="14">
                  <c:v>0.1762114537444960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F-4907-46CE-80C0-3C9A1DF7A847}"/>
            </c:ext>
          </c:extLst>
        </c:ser>
        <c:ser>
          <c:idx val="48"/>
          <c:order val="48"/>
          <c:tx>
            <c:strRef>
              <c:f>'6nt'!$A$340</c:f>
              <c:strCache>
                <c:ptCount val="1"/>
                <c:pt idx="0">
                  <c:v>GAAGAA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340:$P$340</c:f>
              <c:numCache>
                <c:formatCode>General</c:formatCode>
                <c:ptCount val="15"/>
                <c:pt idx="0">
                  <c:v>0.16519823788546606</c:v>
                </c:pt>
                <c:pt idx="1">
                  <c:v>5.5066079295154204E-2</c:v>
                </c:pt>
                <c:pt idx="2">
                  <c:v>0.12114537444934001</c:v>
                </c:pt>
                <c:pt idx="3">
                  <c:v>0.13215859030836999</c:v>
                </c:pt>
                <c:pt idx="4">
                  <c:v>0.11013215859030799</c:v>
                </c:pt>
                <c:pt idx="5">
                  <c:v>0.18722466960352399</c:v>
                </c:pt>
                <c:pt idx="6">
                  <c:v>0.18722466960352399</c:v>
                </c:pt>
                <c:pt idx="7">
                  <c:v>0.12114537444934001</c:v>
                </c:pt>
                <c:pt idx="8">
                  <c:v>0.19823788546255502</c:v>
                </c:pt>
                <c:pt idx="9">
                  <c:v>0.11013215859030799</c:v>
                </c:pt>
                <c:pt idx="10">
                  <c:v>0.15418502202643203</c:v>
                </c:pt>
                <c:pt idx="11">
                  <c:v>0.18722466960352399</c:v>
                </c:pt>
                <c:pt idx="12">
                  <c:v>8.8105726872246728E-2</c:v>
                </c:pt>
                <c:pt idx="13">
                  <c:v>0.17621145374449607</c:v>
                </c:pt>
                <c:pt idx="14">
                  <c:v>0.1762114537444960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0-4907-46CE-80C0-3C9A1DF7A847}"/>
            </c:ext>
          </c:extLst>
        </c:ser>
        <c:ser>
          <c:idx val="49"/>
          <c:order val="49"/>
          <c:tx>
            <c:strRef>
              <c:f>'6nt'!$A$341</c:f>
              <c:strCache>
                <c:ptCount val="1"/>
                <c:pt idx="0">
                  <c:v>UAAAGA</c:v>
                </c:pt>
              </c:strCache>
            </c:strRef>
          </c:tx>
          <c:marker>
            <c:symbol val="none"/>
          </c:marker>
          <c:cat>
            <c:numRef>
              <c:f>'6nt'!$B$291:$P$291</c:f>
              <c:numCache>
                <c:formatCode>General</c:formatCode>
                <c:ptCount val="15"/>
                <c:pt idx="0">
                  <c:v>-32</c:v>
                </c:pt>
                <c:pt idx="1">
                  <c:v>-31</c:v>
                </c:pt>
                <c:pt idx="2">
                  <c:v>-30</c:v>
                </c:pt>
                <c:pt idx="3">
                  <c:v>-29</c:v>
                </c:pt>
                <c:pt idx="4">
                  <c:v>-28</c:v>
                </c:pt>
                <c:pt idx="5">
                  <c:v>-27</c:v>
                </c:pt>
                <c:pt idx="6">
                  <c:v>-26</c:v>
                </c:pt>
                <c:pt idx="7">
                  <c:v>-25</c:v>
                </c:pt>
                <c:pt idx="8">
                  <c:v>-24</c:v>
                </c:pt>
                <c:pt idx="9">
                  <c:v>-23</c:v>
                </c:pt>
                <c:pt idx="10">
                  <c:v>-22</c:v>
                </c:pt>
                <c:pt idx="11">
                  <c:v>-21</c:v>
                </c:pt>
                <c:pt idx="12">
                  <c:v>-20</c:v>
                </c:pt>
                <c:pt idx="13">
                  <c:v>-19</c:v>
                </c:pt>
                <c:pt idx="14">
                  <c:v>-18</c:v>
                </c:pt>
              </c:numCache>
            </c:numRef>
          </c:cat>
          <c:val>
            <c:numRef>
              <c:f>'6nt'!$B$341:$P$341</c:f>
              <c:numCache>
                <c:formatCode>General</c:formatCode>
                <c:ptCount val="15"/>
                <c:pt idx="0">
                  <c:v>7.7092511013217221E-2</c:v>
                </c:pt>
                <c:pt idx="1">
                  <c:v>8.8105726872246728E-2</c:v>
                </c:pt>
                <c:pt idx="2">
                  <c:v>9.911894273127872E-2</c:v>
                </c:pt>
                <c:pt idx="3">
                  <c:v>7.7092511013217221E-2</c:v>
                </c:pt>
                <c:pt idx="4">
                  <c:v>0.11013215859030799</c:v>
                </c:pt>
                <c:pt idx="5">
                  <c:v>0.12114537444934001</c:v>
                </c:pt>
                <c:pt idx="6">
                  <c:v>0.12114537444934001</c:v>
                </c:pt>
                <c:pt idx="7">
                  <c:v>0.13215859030836999</c:v>
                </c:pt>
                <c:pt idx="8">
                  <c:v>0.209251101321586</c:v>
                </c:pt>
                <c:pt idx="9">
                  <c:v>0.18722466960352399</c:v>
                </c:pt>
                <c:pt idx="10">
                  <c:v>0.19823788546255502</c:v>
                </c:pt>
                <c:pt idx="11">
                  <c:v>0.18722466960352399</c:v>
                </c:pt>
                <c:pt idx="12">
                  <c:v>0.29735682819383608</c:v>
                </c:pt>
                <c:pt idx="13">
                  <c:v>0.12114537444934001</c:v>
                </c:pt>
                <c:pt idx="14">
                  <c:v>0.143171806167401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1-4907-46CE-80C0-3C9A1DF7A84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88894848"/>
        <c:axId val="88929408"/>
      </c:lineChart>
      <c:catAx>
        <c:axId val="888948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zh-CN"/>
            </a:pPr>
            <a:endParaRPr lang="en-US"/>
          </a:p>
        </c:txPr>
        <c:crossAx val="88929408"/>
        <c:crosses val="autoZero"/>
        <c:auto val="1"/>
        <c:lblAlgn val="ctr"/>
        <c:lblOffset val="100"/>
        <c:noMultiLvlLbl val="0"/>
      </c:catAx>
      <c:valAx>
        <c:axId val="889294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zh-CN"/>
            </a:pPr>
            <a:endParaRPr lang="en-US"/>
          </a:p>
        </c:txPr>
        <c:crossAx val="8889484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"/>
          <c:y val="0.61182195975503106"/>
          <c:w val="0.9898465316144911"/>
          <c:h val="0.37745168217609204"/>
        </c:manualLayout>
      </c:layout>
      <c:overlay val="0"/>
      <c:txPr>
        <a:bodyPr/>
        <a:lstStyle/>
        <a:p>
          <a:pPr>
            <a:defRPr lang="zh-CN" sz="600" baseline="0"/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9461954048196808E-2"/>
          <c:y val="7.0091664678278917E-2"/>
          <c:w val="0.95515919000690896"/>
          <c:h val="0.34672348484848503"/>
        </c:manualLayout>
      </c:layout>
      <c:lineChart>
        <c:grouping val="standard"/>
        <c:varyColors val="0"/>
        <c:ser>
          <c:idx val="0"/>
          <c:order val="0"/>
          <c:tx>
            <c:strRef>
              <c:f>'6nt'!$A$202</c:f>
              <c:strCache>
                <c:ptCount val="1"/>
                <c:pt idx="0">
                  <c:v>AAUAAA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02:$S$202</c:f>
              <c:numCache>
                <c:formatCode>General</c:formatCode>
                <c:ptCount val="18"/>
                <c:pt idx="0">
                  <c:v>0.21390374331550802</c:v>
                </c:pt>
                <c:pt idx="1">
                  <c:v>0.29708853238265714</c:v>
                </c:pt>
                <c:pt idx="2">
                  <c:v>0.22578728461081402</c:v>
                </c:pt>
                <c:pt idx="3">
                  <c:v>0.26143790849672893</c:v>
                </c:pt>
                <c:pt idx="4">
                  <c:v>0.28520499108734909</c:v>
                </c:pt>
                <c:pt idx="5">
                  <c:v>0.34462269756387809</c:v>
                </c:pt>
                <c:pt idx="6">
                  <c:v>0.55852644087938197</c:v>
                </c:pt>
                <c:pt idx="7">
                  <c:v>0.48722519310755008</c:v>
                </c:pt>
                <c:pt idx="8">
                  <c:v>0.43969102792632198</c:v>
                </c:pt>
                <c:pt idx="9">
                  <c:v>0.40404040404040403</c:v>
                </c:pt>
                <c:pt idx="10">
                  <c:v>0.65359477124183107</c:v>
                </c:pt>
                <c:pt idx="11">
                  <c:v>0.53475935828877919</c:v>
                </c:pt>
                <c:pt idx="12">
                  <c:v>0.66547831253714418</c:v>
                </c:pt>
                <c:pt idx="13">
                  <c:v>0.51099227569815908</c:v>
                </c:pt>
                <c:pt idx="14">
                  <c:v>0.55852644087938197</c:v>
                </c:pt>
                <c:pt idx="15">
                  <c:v>0.5228758169934753</c:v>
                </c:pt>
                <c:pt idx="16">
                  <c:v>0.24955436720142804</c:v>
                </c:pt>
                <c:pt idx="17">
                  <c:v>0.225787284610814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0A3-40A5-9261-2323BFE7E4E5}"/>
            </c:ext>
          </c:extLst>
        </c:ser>
        <c:ser>
          <c:idx val="1"/>
          <c:order val="1"/>
          <c:tx>
            <c:strRef>
              <c:f>'6nt'!$A$203</c:f>
              <c:strCache>
                <c:ptCount val="1"/>
                <c:pt idx="0">
                  <c:v>AAAUAA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03:$S$203</c:f>
              <c:numCache>
                <c:formatCode>General</c:formatCode>
                <c:ptCount val="18"/>
                <c:pt idx="0">
                  <c:v>0.10695187165775399</c:v>
                </c:pt>
                <c:pt idx="1">
                  <c:v>0.20202020202020202</c:v>
                </c:pt>
                <c:pt idx="2">
                  <c:v>0.10695187165775399</c:v>
                </c:pt>
                <c:pt idx="3">
                  <c:v>0.20202020202020202</c:v>
                </c:pt>
                <c:pt idx="4">
                  <c:v>0.20202020202020202</c:v>
                </c:pt>
                <c:pt idx="5">
                  <c:v>0.23767082590611796</c:v>
                </c:pt>
                <c:pt idx="6">
                  <c:v>0.34462269756387809</c:v>
                </c:pt>
                <c:pt idx="7">
                  <c:v>0.27332144979203804</c:v>
                </c:pt>
                <c:pt idx="8">
                  <c:v>0.27332144979203804</c:v>
                </c:pt>
                <c:pt idx="9">
                  <c:v>0.33273915626856798</c:v>
                </c:pt>
                <c:pt idx="10">
                  <c:v>0.21390374331550802</c:v>
                </c:pt>
                <c:pt idx="11">
                  <c:v>0.32085561497326609</c:v>
                </c:pt>
                <c:pt idx="12">
                  <c:v>0.19013666072489599</c:v>
                </c:pt>
                <c:pt idx="13">
                  <c:v>0.32085561497326609</c:v>
                </c:pt>
                <c:pt idx="14">
                  <c:v>0.20202020202020202</c:v>
                </c:pt>
                <c:pt idx="15">
                  <c:v>0.13071895424836602</c:v>
                </c:pt>
                <c:pt idx="16">
                  <c:v>8.3184789067142023E-2</c:v>
                </c:pt>
                <c:pt idx="17">
                  <c:v>0.106951871657753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0A3-40A5-9261-2323BFE7E4E5}"/>
            </c:ext>
          </c:extLst>
        </c:ser>
        <c:ser>
          <c:idx val="2"/>
          <c:order val="2"/>
          <c:tx>
            <c:strRef>
              <c:f>'6nt'!$A$204</c:f>
              <c:strCache>
                <c:ptCount val="1"/>
                <c:pt idx="0">
                  <c:v>AUAAAA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04:$S$204</c:f>
              <c:numCache>
                <c:formatCode>General</c:formatCode>
                <c:ptCount val="18"/>
                <c:pt idx="0">
                  <c:v>4.7534165181224004E-2</c:v>
                </c:pt>
                <c:pt idx="1">
                  <c:v>0.13071895424836602</c:v>
                </c:pt>
                <c:pt idx="2">
                  <c:v>0.15448603683898005</c:v>
                </c:pt>
                <c:pt idx="3">
                  <c:v>0.15448603683898005</c:v>
                </c:pt>
                <c:pt idx="4">
                  <c:v>0.11883541295306001</c:v>
                </c:pt>
                <c:pt idx="5">
                  <c:v>0.13071895424836602</c:v>
                </c:pt>
                <c:pt idx="6">
                  <c:v>0.13071895424836602</c:v>
                </c:pt>
                <c:pt idx="7">
                  <c:v>0.20202020202020202</c:v>
                </c:pt>
                <c:pt idx="8">
                  <c:v>0.26143790849672893</c:v>
                </c:pt>
                <c:pt idx="9">
                  <c:v>0.19013666072489599</c:v>
                </c:pt>
                <c:pt idx="10">
                  <c:v>0.24955436720142804</c:v>
                </c:pt>
                <c:pt idx="11">
                  <c:v>0.33273915626856798</c:v>
                </c:pt>
                <c:pt idx="12">
                  <c:v>0.22578728461081402</c:v>
                </c:pt>
                <c:pt idx="13">
                  <c:v>0.26143790849672893</c:v>
                </c:pt>
                <c:pt idx="14">
                  <c:v>0.15448603683898005</c:v>
                </c:pt>
                <c:pt idx="15">
                  <c:v>0.24955436720142804</c:v>
                </c:pt>
                <c:pt idx="16">
                  <c:v>0.17825311942959002</c:v>
                </c:pt>
                <c:pt idx="17">
                  <c:v>0.1544860368389800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E0A3-40A5-9261-2323BFE7E4E5}"/>
            </c:ext>
          </c:extLst>
        </c:ser>
        <c:ser>
          <c:idx val="3"/>
          <c:order val="3"/>
          <c:tx>
            <c:strRef>
              <c:f>'6nt'!$A$205</c:f>
              <c:strCache>
                <c:ptCount val="1"/>
                <c:pt idx="0">
                  <c:v>AUAAAU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05:$S$205</c:f>
              <c:numCache>
                <c:formatCode>General</c:formatCode>
                <c:ptCount val="18"/>
                <c:pt idx="0">
                  <c:v>0.11883541295306001</c:v>
                </c:pt>
                <c:pt idx="1">
                  <c:v>0.15448603683898005</c:v>
                </c:pt>
                <c:pt idx="2">
                  <c:v>0.11883541295306001</c:v>
                </c:pt>
                <c:pt idx="3">
                  <c:v>0.10695187165775399</c:v>
                </c:pt>
                <c:pt idx="4">
                  <c:v>0.14260249554367202</c:v>
                </c:pt>
                <c:pt idx="5">
                  <c:v>0.20202020202020202</c:v>
                </c:pt>
                <c:pt idx="6">
                  <c:v>0.21390374331550802</c:v>
                </c:pt>
                <c:pt idx="7">
                  <c:v>0.19013666072489599</c:v>
                </c:pt>
                <c:pt idx="8">
                  <c:v>0.19013666072489599</c:v>
                </c:pt>
                <c:pt idx="9">
                  <c:v>0.22578728461081402</c:v>
                </c:pt>
                <c:pt idx="10">
                  <c:v>0.30897207367796314</c:v>
                </c:pt>
                <c:pt idx="11">
                  <c:v>0.17825311942959002</c:v>
                </c:pt>
                <c:pt idx="12">
                  <c:v>0.17825311942959002</c:v>
                </c:pt>
                <c:pt idx="13">
                  <c:v>0.26143790849672893</c:v>
                </c:pt>
                <c:pt idx="14">
                  <c:v>0.17825311942959002</c:v>
                </c:pt>
                <c:pt idx="15">
                  <c:v>0.19013666072489599</c:v>
                </c:pt>
                <c:pt idx="16">
                  <c:v>0.23767082590611796</c:v>
                </c:pt>
                <c:pt idx="17">
                  <c:v>9.5068330362449202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E0A3-40A5-9261-2323BFE7E4E5}"/>
            </c:ext>
          </c:extLst>
        </c:ser>
        <c:ser>
          <c:idx val="4"/>
          <c:order val="4"/>
          <c:tx>
            <c:strRef>
              <c:f>'6nt'!$A$206</c:f>
              <c:strCache>
                <c:ptCount val="1"/>
                <c:pt idx="0">
                  <c:v>AAUGAA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06:$S$206</c:f>
              <c:numCache>
                <c:formatCode>General</c:formatCode>
                <c:ptCount val="18"/>
                <c:pt idx="0">
                  <c:v>0.10695187165775399</c:v>
                </c:pt>
                <c:pt idx="1">
                  <c:v>0.19013666072489599</c:v>
                </c:pt>
                <c:pt idx="2">
                  <c:v>0.20202020202020202</c:v>
                </c:pt>
                <c:pt idx="3">
                  <c:v>9.5068330362449202E-2</c:v>
                </c:pt>
                <c:pt idx="4">
                  <c:v>0.15448603683898005</c:v>
                </c:pt>
                <c:pt idx="5">
                  <c:v>0.11883541295306001</c:v>
                </c:pt>
                <c:pt idx="6">
                  <c:v>0.19013666072489599</c:v>
                </c:pt>
                <c:pt idx="7">
                  <c:v>0.20202020202020202</c:v>
                </c:pt>
                <c:pt idx="8">
                  <c:v>0.21390374331550802</c:v>
                </c:pt>
                <c:pt idx="9">
                  <c:v>0.23767082590611796</c:v>
                </c:pt>
                <c:pt idx="10">
                  <c:v>0.21390374331550802</c:v>
                </c:pt>
                <c:pt idx="11">
                  <c:v>0.29708853238265714</c:v>
                </c:pt>
                <c:pt idx="12">
                  <c:v>0.24955436720142804</c:v>
                </c:pt>
                <c:pt idx="13">
                  <c:v>0.23767082590611796</c:v>
                </c:pt>
                <c:pt idx="14">
                  <c:v>0.21390374331550802</c:v>
                </c:pt>
                <c:pt idx="15">
                  <c:v>0.13071895424836602</c:v>
                </c:pt>
                <c:pt idx="16">
                  <c:v>0.10695187165775399</c:v>
                </c:pt>
                <c:pt idx="17">
                  <c:v>0.130718954248366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E0A3-40A5-9261-2323BFE7E4E5}"/>
            </c:ext>
          </c:extLst>
        </c:ser>
        <c:ser>
          <c:idx val="5"/>
          <c:order val="5"/>
          <c:tx>
            <c:strRef>
              <c:f>'6nt'!$A$207</c:f>
              <c:strCache>
                <c:ptCount val="1"/>
                <c:pt idx="0">
                  <c:v>UGAAAU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07:$S$207</c:f>
              <c:numCache>
                <c:formatCode>General</c:formatCode>
                <c:ptCount val="18"/>
                <c:pt idx="0">
                  <c:v>0.23767082590611796</c:v>
                </c:pt>
                <c:pt idx="1">
                  <c:v>0.20202020202020202</c:v>
                </c:pt>
                <c:pt idx="2">
                  <c:v>0.19013666072489599</c:v>
                </c:pt>
                <c:pt idx="3">
                  <c:v>0.16636957813428399</c:v>
                </c:pt>
                <c:pt idx="4">
                  <c:v>0.32085561497326609</c:v>
                </c:pt>
                <c:pt idx="5">
                  <c:v>0.17825311942959002</c:v>
                </c:pt>
                <c:pt idx="6">
                  <c:v>0.14260249554367202</c:v>
                </c:pt>
                <c:pt idx="7">
                  <c:v>0.17825311942959002</c:v>
                </c:pt>
                <c:pt idx="8">
                  <c:v>0.26143790849672893</c:v>
                </c:pt>
                <c:pt idx="9">
                  <c:v>0.34462269756387809</c:v>
                </c:pt>
                <c:pt idx="10">
                  <c:v>0.16636957813428399</c:v>
                </c:pt>
                <c:pt idx="11">
                  <c:v>0.17825311942959002</c:v>
                </c:pt>
                <c:pt idx="12">
                  <c:v>0.17825311942959002</c:v>
                </c:pt>
                <c:pt idx="13">
                  <c:v>0.11883541295306001</c:v>
                </c:pt>
                <c:pt idx="14">
                  <c:v>0.11883541295306001</c:v>
                </c:pt>
                <c:pt idx="15">
                  <c:v>0.15448603683898005</c:v>
                </c:pt>
                <c:pt idx="16">
                  <c:v>8.3184789067142023E-2</c:v>
                </c:pt>
                <c:pt idx="17">
                  <c:v>4.7534165181224004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E0A3-40A5-9261-2323BFE7E4E5}"/>
            </c:ext>
          </c:extLst>
        </c:ser>
        <c:ser>
          <c:idx val="6"/>
          <c:order val="6"/>
          <c:tx>
            <c:strRef>
              <c:f>'6nt'!$A$208</c:f>
              <c:strCache>
                <c:ptCount val="1"/>
                <c:pt idx="0">
                  <c:v>UUUUAA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08:$S$208</c:f>
              <c:numCache>
                <c:formatCode>General</c:formatCode>
                <c:ptCount val="18"/>
                <c:pt idx="0">
                  <c:v>0.26143790849672893</c:v>
                </c:pt>
                <c:pt idx="1">
                  <c:v>0.20202020202020202</c:v>
                </c:pt>
                <c:pt idx="2">
                  <c:v>0.11883541295306001</c:v>
                </c:pt>
                <c:pt idx="3">
                  <c:v>0.19013666072489599</c:v>
                </c:pt>
                <c:pt idx="4">
                  <c:v>0.11883541295306001</c:v>
                </c:pt>
                <c:pt idx="5">
                  <c:v>0.27332144979203804</c:v>
                </c:pt>
                <c:pt idx="6">
                  <c:v>0.22578728461081402</c:v>
                </c:pt>
                <c:pt idx="7">
                  <c:v>0.19013666072489599</c:v>
                </c:pt>
                <c:pt idx="8">
                  <c:v>0.24955436720142804</c:v>
                </c:pt>
                <c:pt idx="9">
                  <c:v>0.27332144979203804</c:v>
                </c:pt>
                <c:pt idx="10">
                  <c:v>0.19013666072489599</c:v>
                </c:pt>
                <c:pt idx="11">
                  <c:v>0.20202020202020202</c:v>
                </c:pt>
                <c:pt idx="12">
                  <c:v>0.16636957813428399</c:v>
                </c:pt>
                <c:pt idx="13">
                  <c:v>0.10695187165775399</c:v>
                </c:pt>
                <c:pt idx="14">
                  <c:v>9.5068330362449202E-2</c:v>
                </c:pt>
                <c:pt idx="15">
                  <c:v>7.1301247771836024E-2</c:v>
                </c:pt>
                <c:pt idx="16">
                  <c:v>0.10695187165775399</c:v>
                </c:pt>
                <c:pt idx="17">
                  <c:v>0.142602495543672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E0A3-40A5-9261-2323BFE7E4E5}"/>
            </c:ext>
          </c:extLst>
        </c:ser>
        <c:ser>
          <c:idx val="7"/>
          <c:order val="7"/>
          <c:tx>
            <c:strRef>
              <c:f>'6nt'!$A$209</c:f>
              <c:strCache>
                <c:ptCount val="1"/>
                <c:pt idx="0">
                  <c:v>UUUAAU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09:$S$209</c:f>
              <c:numCache>
                <c:formatCode>General</c:formatCode>
                <c:ptCount val="18"/>
                <c:pt idx="0">
                  <c:v>0.10695187165775399</c:v>
                </c:pt>
                <c:pt idx="1">
                  <c:v>0.21390374331550802</c:v>
                </c:pt>
                <c:pt idx="2">
                  <c:v>0.16636957813428399</c:v>
                </c:pt>
                <c:pt idx="3">
                  <c:v>0.19013666072489599</c:v>
                </c:pt>
                <c:pt idx="4">
                  <c:v>0.27332144979203804</c:v>
                </c:pt>
                <c:pt idx="5">
                  <c:v>0.20202020202020202</c:v>
                </c:pt>
                <c:pt idx="6">
                  <c:v>0.24955436720142804</c:v>
                </c:pt>
                <c:pt idx="7">
                  <c:v>0.23767082590611796</c:v>
                </c:pt>
                <c:pt idx="8">
                  <c:v>0.27332144979203804</c:v>
                </c:pt>
                <c:pt idx="9">
                  <c:v>0.19013666072489599</c:v>
                </c:pt>
                <c:pt idx="10">
                  <c:v>0.28520499108734909</c:v>
                </c:pt>
                <c:pt idx="11">
                  <c:v>0.21390374331550802</c:v>
                </c:pt>
                <c:pt idx="12">
                  <c:v>0.16636957813428399</c:v>
                </c:pt>
                <c:pt idx="13">
                  <c:v>9.5068330362449202E-2</c:v>
                </c:pt>
                <c:pt idx="14">
                  <c:v>0.14260249554367202</c:v>
                </c:pt>
                <c:pt idx="15">
                  <c:v>3.5650623885918012E-2</c:v>
                </c:pt>
                <c:pt idx="16">
                  <c:v>4.7534165181224004E-2</c:v>
                </c:pt>
                <c:pt idx="17">
                  <c:v>5.9417706476530496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E0A3-40A5-9261-2323BFE7E4E5}"/>
            </c:ext>
          </c:extLst>
        </c:ser>
        <c:ser>
          <c:idx val="8"/>
          <c:order val="8"/>
          <c:tx>
            <c:strRef>
              <c:f>'6nt'!$A$210</c:f>
              <c:strCache>
                <c:ptCount val="1"/>
                <c:pt idx="0">
                  <c:v>AAUUUU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10:$S$210</c:f>
              <c:numCache>
                <c:formatCode>General</c:formatCode>
                <c:ptCount val="18"/>
                <c:pt idx="0">
                  <c:v>0.15448603683898005</c:v>
                </c:pt>
                <c:pt idx="1">
                  <c:v>0.15448603683898005</c:v>
                </c:pt>
                <c:pt idx="2">
                  <c:v>0.16636957813428399</c:v>
                </c:pt>
                <c:pt idx="3">
                  <c:v>0.17825311942959002</c:v>
                </c:pt>
                <c:pt idx="4">
                  <c:v>0.28520499108734909</c:v>
                </c:pt>
                <c:pt idx="5">
                  <c:v>0.11883541295306001</c:v>
                </c:pt>
                <c:pt idx="6">
                  <c:v>0.16636957813428399</c:v>
                </c:pt>
                <c:pt idx="7">
                  <c:v>0.17825311942959002</c:v>
                </c:pt>
                <c:pt idx="8">
                  <c:v>0.10695187165775399</c:v>
                </c:pt>
                <c:pt idx="9">
                  <c:v>0.15448603683898005</c:v>
                </c:pt>
                <c:pt idx="10">
                  <c:v>0.16636957813428399</c:v>
                </c:pt>
                <c:pt idx="11">
                  <c:v>5.9417706476530496E-2</c:v>
                </c:pt>
                <c:pt idx="12">
                  <c:v>0.23767082590611796</c:v>
                </c:pt>
                <c:pt idx="13">
                  <c:v>0.16636957813428399</c:v>
                </c:pt>
                <c:pt idx="14">
                  <c:v>0.21390374331550802</c:v>
                </c:pt>
                <c:pt idx="15">
                  <c:v>0.20202020202020202</c:v>
                </c:pt>
                <c:pt idx="16">
                  <c:v>0.19013666072489599</c:v>
                </c:pt>
                <c:pt idx="17">
                  <c:v>0.213903743315508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E0A3-40A5-9261-2323BFE7E4E5}"/>
            </c:ext>
          </c:extLst>
        </c:ser>
        <c:ser>
          <c:idx val="9"/>
          <c:order val="9"/>
          <c:tx>
            <c:strRef>
              <c:f>'6nt'!$A$211</c:f>
              <c:strCache>
                <c:ptCount val="1"/>
                <c:pt idx="0">
                  <c:v>AUUUUU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11:$S$211</c:f>
              <c:numCache>
                <c:formatCode>General</c:formatCode>
                <c:ptCount val="18"/>
                <c:pt idx="0">
                  <c:v>0.26143790849672893</c:v>
                </c:pt>
                <c:pt idx="1">
                  <c:v>0.20202020202020202</c:v>
                </c:pt>
                <c:pt idx="2">
                  <c:v>0.19013666072489599</c:v>
                </c:pt>
                <c:pt idx="3">
                  <c:v>0.17825311942959002</c:v>
                </c:pt>
                <c:pt idx="4">
                  <c:v>0.14260249554367202</c:v>
                </c:pt>
                <c:pt idx="5">
                  <c:v>0.20202020202020202</c:v>
                </c:pt>
                <c:pt idx="6">
                  <c:v>0.16636957813428399</c:v>
                </c:pt>
                <c:pt idx="7">
                  <c:v>0.20202020202020202</c:v>
                </c:pt>
                <c:pt idx="8">
                  <c:v>7.1301247771836024E-2</c:v>
                </c:pt>
                <c:pt idx="9">
                  <c:v>0.13071895424836602</c:v>
                </c:pt>
                <c:pt idx="10">
                  <c:v>0.10695187165775399</c:v>
                </c:pt>
                <c:pt idx="11">
                  <c:v>0.11883541295306001</c:v>
                </c:pt>
                <c:pt idx="12">
                  <c:v>0.14260249554367202</c:v>
                </c:pt>
                <c:pt idx="13">
                  <c:v>4.7534165181224004E-2</c:v>
                </c:pt>
                <c:pt idx="14">
                  <c:v>0.19013666072489599</c:v>
                </c:pt>
                <c:pt idx="15">
                  <c:v>0.14260249554367202</c:v>
                </c:pt>
                <c:pt idx="16">
                  <c:v>0.24955436720142804</c:v>
                </c:pt>
                <c:pt idx="17">
                  <c:v>0.2614379084967289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E0A3-40A5-9261-2323BFE7E4E5}"/>
            </c:ext>
          </c:extLst>
        </c:ser>
        <c:ser>
          <c:idx val="10"/>
          <c:order val="10"/>
          <c:tx>
            <c:strRef>
              <c:f>'6nt'!$A$212</c:f>
              <c:strCache>
                <c:ptCount val="1"/>
                <c:pt idx="0">
                  <c:v>UAAUAA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12:$S$212</c:f>
              <c:numCache>
                <c:formatCode>General</c:formatCode>
                <c:ptCount val="18"/>
                <c:pt idx="0">
                  <c:v>0.10695187165775399</c:v>
                </c:pt>
                <c:pt idx="1">
                  <c:v>8.3184789067142023E-2</c:v>
                </c:pt>
                <c:pt idx="2">
                  <c:v>0.10695187165775399</c:v>
                </c:pt>
                <c:pt idx="3">
                  <c:v>0.13071895424836602</c:v>
                </c:pt>
                <c:pt idx="4">
                  <c:v>0.14260249554367202</c:v>
                </c:pt>
                <c:pt idx="5">
                  <c:v>0.23767082590611796</c:v>
                </c:pt>
                <c:pt idx="6">
                  <c:v>0.16636957813428399</c:v>
                </c:pt>
                <c:pt idx="7">
                  <c:v>0.16636957813428399</c:v>
                </c:pt>
                <c:pt idx="8">
                  <c:v>0.20202020202020202</c:v>
                </c:pt>
                <c:pt idx="9">
                  <c:v>0.22578728461081402</c:v>
                </c:pt>
                <c:pt idx="10">
                  <c:v>0.28520499108734909</c:v>
                </c:pt>
                <c:pt idx="11">
                  <c:v>0.29708853238265714</c:v>
                </c:pt>
                <c:pt idx="12">
                  <c:v>0.23767082590611796</c:v>
                </c:pt>
                <c:pt idx="13">
                  <c:v>0.21390374331550802</c:v>
                </c:pt>
                <c:pt idx="14">
                  <c:v>0.14260249554367202</c:v>
                </c:pt>
                <c:pt idx="15">
                  <c:v>5.9417706476530496E-2</c:v>
                </c:pt>
                <c:pt idx="16">
                  <c:v>9.5068330362449202E-2</c:v>
                </c:pt>
                <c:pt idx="17">
                  <c:v>3.5650623885918012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E0A3-40A5-9261-2323BFE7E4E5}"/>
            </c:ext>
          </c:extLst>
        </c:ser>
        <c:ser>
          <c:idx val="11"/>
          <c:order val="11"/>
          <c:tx>
            <c:strRef>
              <c:f>'6nt'!$A$213</c:f>
              <c:strCache>
                <c:ptCount val="1"/>
                <c:pt idx="0">
                  <c:v>UUUGAA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13:$S$213</c:f>
              <c:numCache>
                <c:formatCode>General</c:formatCode>
                <c:ptCount val="18"/>
                <c:pt idx="0">
                  <c:v>0.21390374331550802</c:v>
                </c:pt>
                <c:pt idx="1">
                  <c:v>0.19013666072489599</c:v>
                </c:pt>
                <c:pt idx="2">
                  <c:v>0.22578728461081402</c:v>
                </c:pt>
                <c:pt idx="3">
                  <c:v>0.23767082590611796</c:v>
                </c:pt>
                <c:pt idx="4">
                  <c:v>0.16636957813428399</c:v>
                </c:pt>
                <c:pt idx="5">
                  <c:v>0.11883541295306001</c:v>
                </c:pt>
                <c:pt idx="6">
                  <c:v>0.14260249554367202</c:v>
                </c:pt>
                <c:pt idx="7">
                  <c:v>0.10695187165775399</c:v>
                </c:pt>
                <c:pt idx="8">
                  <c:v>0.17825311942959002</c:v>
                </c:pt>
                <c:pt idx="9">
                  <c:v>0.14260249554367202</c:v>
                </c:pt>
                <c:pt idx="10">
                  <c:v>0.13071895424836602</c:v>
                </c:pt>
                <c:pt idx="11">
                  <c:v>0.17825311942959002</c:v>
                </c:pt>
                <c:pt idx="12">
                  <c:v>0.14260249554367202</c:v>
                </c:pt>
                <c:pt idx="13">
                  <c:v>0.11883541295306001</c:v>
                </c:pt>
                <c:pt idx="14">
                  <c:v>9.5068330362449202E-2</c:v>
                </c:pt>
                <c:pt idx="15">
                  <c:v>0.11883541295306001</c:v>
                </c:pt>
                <c:pt idx="16">
                  <c:v>8.3184789067142023E-2</c:v>
                </c:pt>
                <c:pt idx="17">
                  <c:v>0.142602495543672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E0A3-40A5-9261-2323BFE7E4E5}"/>
            </c:ext>
          </c:extLst>
        </c:ser>
        <c:ser>
          <c:idx val="12"/>
          <c:order val="12"/>
          <c:tx>
            <c:strRef>
              <c:f>'6nt'!$A$214</c:f>
              <c:strCache>
                <c:ptCount val="1"/>
                <c:pt idx="0">
                  <c:v>AGUAAA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14:$S$214</c:f>
              <c:numCache>
                <c:formatCode>General</c:formatCode>
                <c:ptCount val="18"/>
                <c:pt idx="0">
                  <c:v>8.3184789067142023E-2</c:v>
                </c:pt>
                <c:pt idx="1">
                  <c:v>8.3184789067142023E-2</c:v>
                </c:pt>
                <c:pt idx="2">
                  <c:v>9.5068330362449202E-2</c:v>
                </c:pt>
                <c:pt idx="3">
                  <c:v>0.16636957813428399</c:v>
                </c:pt>
                <c:pt idx="4">
                  <c:v>0.14260249554367202</c:v>
                </c:pt>
                <c:pt idx="5">
                  <c:v>0.17825311942959002</c:v>
                </c:pt>
                <c:pt idx="6">
                  <c:v>0.23767082590611796</c:v>
                </c:pt>
                <c:pt idx="7">
                  <c:v>0.16636957813428399</c:v>
                </c:pt>
                <c:pt idx="8">
                  <c:v>0.22578728461081402</c:v>
                </c:pt>
                <c:pt idx="9">
                  <c:v>0.15448603683898005</c:v>
                </c:pt>
                <c:pt idx="10">
                  <c:v>0.28520499108734909</c:v>
                </c:pt>
                <c:pt idx="11">
                  <c:v>0.20202020202020202</c:v>
                </c:pt>
                <c:pt idx="12">
                  <c:v>0.15448603683898005</c:v>
                </c:pt>
                <c:pt idx="13">
                  <c:v>0.16636957813428399</c:v>
                </c:pt>
                <c:pt idx="14">
                  <c:v>0.15448603683898005</c:v>
                </c:pt>
                <c:pt idx="15">
                  <c:v>9.5068330362449202E-2</c:v>
                </c:pt>
                <c:pt idx="16">
                  <c:v>4.7534165181224004E-2</c:v>
                </c:pt>
                <c:pt idx="17">
                  <c:v>9.5068330362449202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C-E0A3-40A5-9261-2323BFE7E4E5}"/>
            </c:ext>
          </c:extLst>
        </c:ser>
        <c:ser>
          <c:idx val="13"/>
          <c:order val="13"/>
          <c:tx>
            <c:strRef>
              <c:f>'6nt'!$A$215</c:f>
              <c:strCache>
                <c:ptCount val="1"/>
                <c:pt idx="0">
                  <c:v>AAAUUU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15:$S$215</c:f>
              <c:numCache>
                <c:formatCode>General</c:formatCode>
                <c:ptCount val="18"/>
                <c:pt idx="0">
                  <c:v>0.13071895424836602</c:v>
                </c:pt>
                <c:pt idx="1">
                  <c:v>0.19013666072489599</c:v>
                </c:pt>
                <c:pt idx="2">
                  <c:v>0.20202020202020202</c:v>
                </c:pt>
                <c:pt idx="3">
                  <c:v>0.13071895424836602</c:v>
                </c:pt>
                <c:pt idx="4">
                  <c:v>4.7534165181224004E-2</c:v>
                </c:pt>
                <c:pt idx="5">
                  <c:v>8.3184789067142023E-2</c:v>
                </c:pt>
                <c:pt idx="6">
                  <c:v>0.19013666072489599</c:v>
                </c:pt>
                <c:pt idx="7">
                  <c:v>0.16636957813428399</c:v>
                </c:pt>
                <c:pt idx="8">
                  <c:v>0.10695187165775399</c:v>
                </c:pt>
                <c:pt idx="9">
                  <c:v>0.15448603683898005</c:v>
                </c:pt>
                <c:pt idx="10">
                  <c:v>8.3184789067142023E-2</c:v>
                </c:pt>
                <c:pt idx="11">
                  <c:v>0.32085561497326609</c:v>
                </c:pt>
                <c:pt idx="12">
                  <c:v>0.19013666072489599</c:v>
                </c:pt>
                <c:pt idx="13">
                  <c:v>0.10695187165775399</c:v>
                </c:pt>
                <c:pt idx="14">
                  <c:v>0.22578728461081402</c:v>
                </c:pt>
                <c:pt idx="15">
                  <c:v>0.10695187165775399</c:v>
                </c:pt>
                <c:pt idx="16">
                  <c:v>0.14260249554367202</c:v>
                </c:pt>
                <c:pt idx="17">
                  <c:v>0.142602495543672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D-E0A3-40A5-9261-2323BFE7E4E5}"/>
            </c:ext>
          </c:extLst>
        </c:ser>
        <c:ser>
          <c:idx val="14"/>
          <c:order val="14"/>
          <c:tx>
            <c:strRef>
              <c:f>'6nt'!$A$216</c:f>
              <c:strCache>
                <c:ptCount val="1"/>
                <c:pt idx="0">
                  <c:v>UAAAUA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16:$S$216</c:f>
              <c:numCache>
                <c:formatCode>General</c:formatCode>
                <c:ptCount val="18"/>
                <c:pt idx="0">
                  <c:v>7.1301247771836024E-2</c:v>
                </c:pt>
                <c:pt idx="1">
                  <c:v>8.3184789067142023E-2</c:v>
                </c:pt>
                <c:pt idx="2">
                  <c:v>0.20202020202020202</c:v>
                </c:pt>
                <c:pt idx="3">
                  <c:v>0.14260249554367202</c:v>
                </c:pt>
                <c:pt idx="4">
                  <c:v>0.11883541295306001</c:v>
                </c:pt>
                <c:pt idx="5">
                  <c:v>0.19013666072489599</c:v>
                </c:pt>
                <c:pt idx="6">
                  <c:v>0.21390374331550802</c:v>
                </c:pt>
                <c:pt idx="7">
                  <c:v>0.20202020202020202</c:v>
                </c:pt>
                <c:pt idx="8">
                  <c:v>0.24955436720142804</c:v>
                </c:pt>
                <c:pt idx="9">
                  <c:v>0.17825311942959002</c:v>
                </c:pt>
                <c:pt idx="10">
                  <c:v>0.15448603683898005</c:v>
                </c:pt>
                <c:pt idx="11">
                  <c:v>0.15448603683898005</c:v>
                </c:pt>
                <c:pt idx="12">
                  <c:v>0.17825311942959002</c:v>
                </c:pt>
                <c:pt idx="13">
                  <c:v>0.14260249554367202</c:v>
                </c:pt>
                <c:pt idx="14">
                  <c:v>0.14260249554367202</c:v>
                </c:pt>
                <c:pt idx="15">
                  <c:v>8.3184789067142023E-2</c:v>
                </c:pt>
                <c:pt idx="16">
                  <c:v>0.10695187165775399</c:v>
                </c:pt>
                <c:pt idx="17">
                  <c:v>9.5068330362449202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E-E0A3-40A5-9261-2323BFE7E4E5}"/>
            </c:ext>
          </c:extLst>
        </c:ser>
        <c:ser>
          <c:idx val="15"/>
          <c:order val="15"/>
          <c:tx>
            <c:strRef>
              <c:f>'6nt'!$A$217</c:f>
              <c:strCache>
                <c:ptCount val="1"/>
                <c:pt idx="0">
                  <c:v>UGUAAU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17:$S$217</c:f>
              <c:numCache>
                <c:formatCode>General</c:formatCode>
                <c:ptCount val="18"/>
                <c:pt idx="0">
                  <c:v>0.20202020202020202</c:v>
                </c:pt>
                <c:pt idx="1">
                  <c:v>0.16636957813428399</c:v>
                </c:pt>
                <c:pt idx="2">
                  <c:v>0.15448603683898005</c:v>
                </c:pt>
                <c:pt idx="3">
                  <c:v>0.19013666072489599</c:v>
                </c:pt>
                <c:pt idx="4">
                  <c:v>0.22578728461081402</c:v>
                </c:pt>
                <c:pt idx="5">
                  <c:v>0.19013666072489599</c:v>
                </c:pt>
                <c:pt idx="6">
                  <c:v>0.10695187165775399</c:v>
                </c:pt>
                <c:pt idx="7">
                  <c:v>0.15448603683898005</c:v>
                </c:pt>
                <c:pt idx="8">
                  <c:v>0.21390374331550802</c:v>
                </c:pt>
                <c:pt idx="9">
                  <c:v>0.22578728461081402</c:v>
                </c:pt>
                <c:pt idx="10">
                  <c:v>0.19013666072489599</c:v>
                </c:pt>
                <c:pt idx="11">
                  <c:v>0.16636957813428399</c:v>
                </c:pt>
                <c:pt idx="12">
                  <c:v>9.5068330362449202E-2</c:v>
                </c:pt>
                <c:pt idx="13">
                  <c:v>8.3184789067142023E-2</c:v>
                </c:pt>
                <c:pt idx="14">
                  <c:v>0.11883541295306001</c:v>
                </c:pt>
                <c:pt idx="15">
                  <c:v>7.1301247771836024E-2</c:v>
                </c:pt>
                <c:pt idx="16">
                  <c:v>0.10695187165775399</c:v>
                </c:pt>
                <c:pt idx="17">
                  <c:v>3.5650623885918012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F-E0A3-40A5-9261-2323BFE7E4E5}"/>
            </c:ext>
          </c:extLst>
        </c:ser>
        <c:ser>
          <c:idx val="16"/>
          <c:order val="16"/>
          <c:tx>
            <c:strRef>
              <c:f>'6nt'!$A$218</c:f>
              <c:strCache>
                <c:ptCount val="1"/>
                <c:pt idx="0">
                  <c:v>AUAUAU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18:$S$218</c:f>
              <c:numCache>
                <c:formatCode>General</c:formatCode>
                <c:ptCount val="18"/>
                <c:pt idx="0">
                  <c:v>9.5068330362449202E-2</c:v>
                </c:pt>
                <c:pt idx="1">
                  <c:v>0.13071895424836602</c:v>
                </c:pt>
                <c:pt idx="2">
                  <c:v>0.11883541295306001</c:v>
                </c:pt>
                <c:pt idx="3">
                  <c:v>7.1301247771836024E-2</c:v>
                </c:pt>
                <c:pt idx="4">
                  <c:v>0.23767082590611796</c:v>
                </c:pt>
                <c:pt idx="5">
                  <c:v>0.24955436720142804</c:v>
                </c:pt>
                <c:pt idx="6">
                  <c:v>9.5068330362449202E-2</c:v>
                </c:pt>
                <c:pt idx="7">
                  <c:v>7.1301247771836024E-2</c:v>
                </c:pt>
                <c:pt idx="8">
                  <c:v>0.14260249554367202</c:v>
                </c:pt>
                <c:pt idx="9">
                  <c:v>0.13071895424836602</c:v>
                </c:pt>
                <c:pt idx="10">
                  <c:v>0.24955436720142804</c:v>
                </c:pt>
                <c:pt idx="11">
                  <c:v>0.23767082590611796</c:v>
                </c:pt>
                <c:pt idx="12">
                  <c:v>0.20202020202020202</c:v>
                </c:pt>
                <c:pt idx="13">
                  <c:v>0.13071895424836602</c:v>
                </c:pt>
                <c:pt idx="14">
                  <c:v>2.3767082590611999E-2</c:v>
                </c:pt>
                <c:pt idx="15">
                  <c:v>0.10695187165775399</c:v>
                </c:pt>
                <c:pt idx="16">
                  <c:v>0.21390374331550802</c:v>
                </c:pt>
                <c:pt idx="17">
                  <c:v>0.1544860368389800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0-E0A3-40A5-9261-2323BFE7E4E5}"/>
            </c:ext>
          </c:extLst>
        </c:ser>
        <c:ser>
          <c:idx val="17"/>
          <c:order val="17"/>
          <c:tx>
            <c:strRef>
              <c:f>'6nt'!$A$219</c:f>
              <c:strCache>
                <c:ptCount val="1"/>
                <c:pt idx="0">
                  <c:v>UUAUUU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19:$S$219</c:f>
              <c:numCache>
                <c:formatCode>General</c:formatCode>
                <c:ptCount val="18"/>
                <c:pt idx="0">
                  <c:v>0.16636957813428399</c:v>
                </c:pt>
                <c:pt idx="1">
                  <c:v>0.17825311942959002</c:v>
                </c:pt>
                <c:pt idx="2">
                  <c:v>0.11883541295306001</c:v>
                </c:pt>
                <c:pt idx="3">
                  <c:v>0.10695187165775399</c:v>
                </c:pt>
                <c:pt idx="4">
                  <c:v>0.20202020202020202</c:v>
                </c:pt>
                <c:pt idx="5">
                  <c:v>0.20202020202020202</c:v>
                </c:pt>
                <c:pt idx="6">
                  <c:v>0.20202020202020202</c:v>
                </c:pt>
                <c:pt idx="7">
                  <c:v>0.14260249554367202</c:v>
                </c:pt>
                <c:pt idx="8">
                  <c:v>0.10695187165775399</c:v>
                </c:pt>
                <c:pt idx="9">
                  <c:v>0.13071895424836602</c:v>
                </c:pt>
                <c:pt idx="10">
                  <c:v>0.11883541295306001</c:v>
                </c:pt>
                <c:pt idx="11">
                  <c:v>0.10695187165775399</c:v>
                </c:pt>
                <c:pt idx="12">
                  <c:v>9.5068330362449202E-2</c:v>
                </c:pt>
                <c:pt idx="13">
                  <c:v>5.9417706476530496E-2</c:v>
                </c:pt>
                <c:pt idx="14">
                  <c:v>0.19013666072489599</c:v>
                </c:pt>
                <c:pt idx="15">
                  <c:v>0.11883541295306001</c:v>
                </c:pt>
                <c:pt idx="16">
                  <c:v>0.15448603683898005</c:v>
                </c:pt>
                <c:pt idx="17">
                  <c:v>0.225787284610814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1-E0A3-40A5-9261-2323BFE7E4E5}"/>
            </c:ext>
          </c:extLst>
        </c:ser>
        <c:ser>
          <c:idx val="18"/>
          <c:order val="18"/>
          <c:tx>
            <c:strRef>
              <c:f>'6nt'!$A$220</c:f>
              <c:strCache>
                <c:ptCount val="1"/>
                <c:pt idx="0">
                  <c:v>GAAUAA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20:$S$220</c:f>
              <c:numCache>
                <c:formatCode>General</c:formatCode>
                <c:ptCount val="18"/>
                <c:pt idx="0">
                  <c:v>0.13071895424836602</c:v>
                </c:pt>
                <c:pt idx="1">
                  <c:v>4.7534165181224004E-2</c:v>
                </c:pt>
                <c:pt idx="2">
                  <c:v>0.15448603683898005</c:v>
                </c:pt>
                <c:pt idx="3">
                  <c:v>0.10695187165775399</c:v>
                </c:pt>
                <c:pt idx="4">
                  <c:v>0.15448603683898005</c:v>
                </c:pt>
                <c:pt idx="5">
                  <c:v>0.21390374331550802</c:v>
                </c:pt>
                <c:pt idx="6">
                  <c:v>0.17825311942959002</c:v>
                </c:pt>
                <c:pt idx="7">
                  <c:v>0.24955436720142804</c:v>
                </c:pt>
                <c:pt idx="8">
                  <c:v>0.15448603683898005</c:v>
                </c:pt>
                <c:pt idx="9">
                  <c:v>0.21390374331550802</c:v>
                </c:pt>
                <c:pt idx="10">
                  <c:v>0.14260249554367202</c:v>
                </c:pt>
                <c:pt idx="11">
                  <c:v>0.14260249554367202</c:v>
                </c:pt>
                <c:pt idx="12">
                  <c:v>0.17825311942959002</c:v>
                </c:pt>
                <c:pt idx="13">
                  <c:v>0.15448603683898005</c:v>
                </c:pt>
                <c:pt idx="14">
                  <c:v>0.14260249554367202</c:v>
                </c:pt>
                <c:pt idx="15">
                  <c:v>0.13071895424836602</c:v>
                </c:pt>
                <c:pt idx="16">
                  <c:v>8.3184789067142023E-2</c:v>
                </c:pt>
                <c:pt idx="17">
                  <c:v>3.5650623885918012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2-E0A3-40A5-9261-2323BFE7E4E5}"/>
            </c:ext>
          </c:extLst>
        </c:ser>
        <c:ser>
          <c:idx val="19"/>
          <c:order val="19"/>
          <c:tx>
            <c:strRef>
              <c:f>'6nt'!$A$221</c:f>
              <c:strCache>
                <c:ptCount val="1"/>
                <c:pt idx="0">
                  <c:v>AAUACA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21:$S$221</c:f>
              <c:numCache>
                <c:formatCode>General</c:formatCode>
                <c:ptCount val="18"/>
                <c:pt idx="0">
                  <c:v>8.3184789067142023E-2</c:v>
                </c:pt>
                <c:pt idx="1">
                  <c:v>0.11883541295306001</c:v>
                </c:pt>
                <c:pt idx="2">
                  <c:v>0.15448603683898005</c:v>
                </c:pt>
                <c:pt idx="3">
                  <c:v>0.10695187165775399</c:v>
                </c:pt>
                <c:pt idx="4">
                  <c:v>0.11883541295306001</c:v>
                </c:pt>
                <c:pt idx="5">
                  <c:v>0.16636957813428399</c:v>
                </c:pt>
                <c:pt idx="6">
                  <c:v>0.17825311942959002</c:v>
                </c:pt>
                <c:pt idx="7">
                  <c:v>0.14260249554367202</c:v>
                </c:pt>
                <c:pt idx="8">
                  <c:v>0.11883541295306001</c:v>
                </c:pt>
                <c:pt idx="9">
                  <c:v>0.10695187165775399</c:v>
                </c:pt>
                <c:pt idx="10">
                  <c:v>0.16636957813428399</c:v>
                </c:pt>
                <c:pt idx="11">
                  <c:v>0.21390374331550802</c:v>
                </c:pt>
                <c:pt idx="12">
                  <c:v>0.16636957813428399</c:v>
                </c:pt>
                <c:pt idx="13">
                  <c:v>0.21390374331550802</c:v>
                </c:pt>
                <c:pt idx="14">
                  <c:v>0.20202020202020202</c:v>
                </c:pt>
                <c:pt idx="15">
                  <c:v>0.15448603683898005</c:v>
                </c:pt>
                <c:pt idx="16">
                  <c:v>0.15448603683898005</c:v>
                </c:pt>
                <c:pt idx="17">
                  <c:v>4.7534165181224004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3-E0A3-40A5-9261-2323BFE7E4E5}"/>
            </c:ext>
          </c:extLst>
        </c:ser>
        <c:ser>
          <c:idx val="20"/>
          <c:order val="20"/>
          <c:tx>
            <c:strRef>
              <c:f>'6nt'!$A$222</c:f>
              <c:strCache>
                <c:ptCount val="1"/>
                <c:pt idx="0">
                  <c:v>UUCAAU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22:$S$222</c:f>
              <c:numCache>
                <c:formatCode>General</c:formatCode>
                <c:ptCount val="18"/>
                <c:pt idx="0">
                  <c:v>7.1301247771836024E-2</c:v>
                </c:pt>
                <c:pt idx="1">
                  <c:v>0.21390374331550802</c:v>
                </c:pt>
                <c:pt idx="2">
                  <c:v>0.16636957813428399</c:v>
                </c:pt>
                <c:pt idx="3">
                  <c:v>0.19013666072489599</c:v>
                </c:pt>
                <c:pt idx="4">
                  <c:v>0.14260249554367202</c:v>
                </c:pt>
                <c:pt idx="5">
                  <c:v>0.15448603683898005</c:v>
                </c:pt>
                <c:pt idx="6">
                  <c:v>0.24955436720142804</c:v>
                </c:pt>
                <c:pt idx="7">
                  <c:v>0.14260249554367202</c:v>
                </c:pt>
                <c:pt idx="8">
                  <c:v>0.28520499108734909</c:v>
                </c:pt>
                <c:pt idx="9">
                  <c:v>0.15448603683898005</c:v>
                </c:pt>
                <c:pt idx="10">
                  <c:v>0.19013666072489599</c:v>
                </c:pt>
                <c:pt idx="11">
                  <c:v>0.10695187165775399</c:v>
                </c:pt>
                <c:pt idx="12">
                  <c:v>0.13071895424836602</c:v>
                </c:pt>
                <c:pt idx="13">
                  <c:v>9.5068330362449202E-2</c:v>
                </c:pt>
                <c:pt idx="14">
                  <c:v>0.10695187165775399</c:v>
                </c:pt>
                <c:pt idx="15">
                  <c:v>0.10695187165775399</c:v>
                </c:pt>
                <c:pt idx="16">
                  <c:v>7.1301247771836024E-2</c:v>
                </c:pt>
                <c:pt idx="17">
                  <c:v>3.5650623885918012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4-E0A3-40A5-9261-2323BFE7E4E5}"/>
            </c:ext>
          </c:extLst>
        </c:ser>
        <c:ser>
          <c:idx val="21"/>
          <c:order val="21"/>
          <c:tx>
            <c:strRef>
              <c:f>'6nt'!$A$223</c:f>
              <c:strCache>
                <c:ptCount val="1"/>
                <c:pt idx="0">
                  <c:v>UUGAAU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23:$S$223</c:f>
              <c:numCache>
                <c:formatCode>General</c:formatCode>
                <c:ptCount val="18"/>
                <c:pt idx="0">
                  <c:v>0.17825311942959002</c:v>
                </c:pt>
                <c:pt idx="1">
                  <c:v>0.16636957813428399</c:v>
                </c:pt>
                <c:pt idx="2">
                  <c:v>0.21390374331550802</c:v>
                </c:pt>
                <c:pt idx="3">
                  <c:v>0.22578728461081402</c:v>
                </c:pt>
                <c:pt idx="4">
                  <c:v>0.14260249554367202</c:v>
                </c:pt>
                <c:pt idx="5">
                  <c:v>0.17825311942959002</c:v>
                </c:pt>
                <c:pt idx="6">
                  <c:v>0.11883541295306001</c:v>
                </c:pt>
                <c:pt idx="7">
                  <c:v>0.14260249554367202</c:v>
                </c:pt>
                <c:pt idx="8">
                  <c:v>0.15448603683898005</c:v>
                </c:pt>
                <c:pt idx="9">
                  <c:v>0.17825311942959002</c:v>
                </c:pt>
                <c:pt idx="10">
                  <c:v>0.20202020202020202</c:v>
                </c:pt>
                <c:pt idx="11">
                  <c:v>0.14260249554367202</c:v>
                </c:pt>
                <c:pt idx="12">
                  <c:v>9.5068330362449202E-2</c:v>
                </c:pt>
                <c:pt idx="13">
                  <c:v>0.10695187165775399</c:v>
                </c:pt>
                <c:pt idx="14">
                  <c:v>5.9417706476530496E-2</c:v>
                </c:pt>
                <c:pt idx="15">
                  <c:v>0.13071895424836602</c:v>
                </c:pt>
                <c:pt idx="16">
                  <c:v>9.5068330362449202E-2</c:v>
                </c:pt>
                <c:pt idx="17">
                  <c:v>8.3184789067142023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5-E0A3-40A5-9261-2323BFE7E4E5}"/>
            </c:ext>
          </c:extLst>
        </c:ser>
        <c:ser>
          <c:idx val="22"/>
          <c:order val="22"/>
          <c:tx>
            <c:strRef>
              <c:f>'6nt'!$A$224</c:f>
              <c:strCache>
                <c:ptCount val="1"/>
                <c:pt idx="0">
                  <c:v>AUAAAG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24:$S$224</c:f>
              <c:numCache>
                <c:formatCode>General</c:formatCode>
                <c:ptCount val="18"/>
                <c:pt idx="0">
                  <c:v>8.3184789067142023E-2</c:v>
                </c:pt>
                <c:pt idx="1">
                  <c:v>4.7534165181224004E-2</c:v>
                </c:pt>
                <c:pt idx="2">
                  <c:v>5.9417706476530496E-2</c:v>
                </c:pt>
                <c:pt idx="3">
                  <c:v>0.10695187165775399</c:v>
                </c:pt>
                <c:pt idx="4">
                  <c:v>0.13071895424836602</c:v>
                </c:pt>
                <c:pt idx="5">
                  <c:v>5.9417706476530496E-2</c:v>
                </c:pt>
                <c:pt idx="6">
                  <c:v>0.15448603683898005</c:v>
                </c:pt>
                <c:pt idx="7">
                  <c:v>0.13071895424836602</c:v>
                </c:pt>
                <c:pt idx="8">
                  <c:v>0.15448603683898005</c:v>
                </c:pt>
                <c:pt idx="9">
                  <c:v>0.23767082590611796</c:v>
                </c:pt>
                <c:pt idx="10">
                  <c:v>0.15448603683898005</c:v>
                </c:pt>
                <c:pt idx="11">
                  <c:v>0.19013666072489599</c:v>
                </c:pt>
                <c:pt idx="12">
                  <c:v>0.16636957813428399</c:v>
                </c:pt>
                <c:pt idx="13">
                  <c:v>0.24955436720142804</c:v>
                </c:pt>
                <c:pt idx="14">
                  <c:v>0.22578728461081402</c:v>
                </c:pt>
                <c:pt idx="15">
                  <c:v>0.17825311942959002</c:v>
                </c:pt>
                <c:pt idx="16">
                  <c:v>0.19013666072489599</c:v>
                </c:pt>
                <c:pt idx="17">
                  <c:v>9.5068330362449202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6-E0A3-40A5-9261-2323BFE7E4E5}"/>
            </c:ext>
          </c:extLst>
        </c:ser>
        <c:ser>
          <c:idx val="23"/>
          <c:order val="23"/>
          <c:tx>
            <c:strRef>
              <c:f>'6nt'!$A$225</c:f>
              <c:strCache>
                <c:ptCount val="1"/>
                <c:pt idx="0">
                  <c:v>AAUUUA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25:$S$225</c:f>
              <c:numCache>
                <c:formatCode>General</c:formatCode>
                <c:ptCount val="18"/>
                <c:pt idx="0">
                  <c:v>0.11883541295306001</c:v>
                </c:pt>
                <c:pt idx="1">
                  <c:v>8.3184789067142023E-2</c:v>
                </c:pt>
                <c:pt idx="2">
                  <c:v>0.23767082590611796</c:v>
                </c:pt>
                <c:pt idx="3">
                  <c:v>0.19013666072489599</c:v>
                </c:pt>
                <c:pt idx="4">
                  <c:v>0.10695187165775399</c:v>
                </c:pt>
                <c:pt idx="5">
                  <c:v>0.16636957813428399</c:v>
                </c:pt>
                <c:pt idx="6">
                  <c:v>2.3767082590611999E-2</c:v>
                </c:pt>
                <c:pt idx="7">
                  <c:v>0.15448603683898005</c:v>
                </c:pt>
                <c:pt idx="8">
                  <c:v>0.23767082590611796</c:v>
                </c:pt>
                <c:pt idx="9">
                  <c:v>0.15448603683898005</c:v>
                </c:pt>
                <c:pt idx="10">
                  <c:v>0.15448603683898005</c:v>
                </c:pt>
                <c:pt idx="11">
                  <c:v>0.13071895424836602</c:v>
                </c:pt>
                <c:pt idx="12">
                  <c:v>0.20202020202020202</c:v>
                </c:pt>
                <c:pt idx="13">
                  <c:v>0.15448603683898005</c:v>
                </c:pt>
                <c:pt idx="14">
                  <c:v>0.15448603683898005</c:v>
                </c:pt>
                <c:pt idx="15">
                  <c:v>0.10695187165775399</c:v>
                </c:pt>
                <c:pt idx="16">
                  <c:v>0.10695187165775399</c:v>
                </c:pt>
                <c:pt idx="17">
                  <c:v>8.3184789067142023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7-E0A3-40A5-9261-2323BFE7E4E5}"/>
            </c:ext>
          </c:extLst>
        </c:ser>
        <c:ser>
          <c:idx val="24"/>
          <c:order val="24"/>
          <c:tx>
            <c:strRef>
              <c:f>'6nt'!$A$226</c:f>
              <c:strCache>
                <c:ptCount val="1"/>
                <c:pt idx="0">
                  <c:v>AUGAAA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26:$S$226</c:f>
              <c:numCache>
                <c:formatCode>General</c:formatCode>
                <c:ptCount val="18"/>
                <c:pt idx="0">
                  <c:v>8.3184789067142023E-2</c:v>
                </c:pt>
                <c:pt idx="1">
                  <c:v>0.10695187165775399</c:v>
                </c:pt>
                <c:pt idx="2">
                  <c:v>7.1301247771836024E-2</c:v>
                </c:pt>
                <c:pt idx="3">
                  <c:v>0.20202020202020202</c:v>
                </c:pt>
                <c:pt idx="4">
                  <c:v>9.5068330362449202E-2</c:v>
                </c:pt>
                <c:pt idx="5">
                  <c:v>8.3184789067142023E-2</c:v>
                </c:pt>
                <c:pt idx="6">
                  <c:v>0.15448603683898005</c:v>
                </c:pt>
                <c:pt idx="7">
                  <c:v>0.24955436720142804</c:v>
                </c:pt>
                <c:pt idx="8">
                  <c:v>0.24955436720142804</c:v>
                </c:pt>
                <c:pt idx="9">
                  <c:v>0.15448603683898005</c:v>
                </c:pt>
                <c:pt idx="10">
                  <c:v>0.15448603683898005</c:v>
                </c:pt>
                <c:pt idx="11">
                  <c:v>0.13071895424836602</c:v>
                </c:pt>
                <c:pt idx="12">
                  <c:v>0.13071895424836602</c:v>
                </c:pt>
                <c:pt idx="13">
                  <c:v>0.17825311942959002</c:v>
                </c:pt>
                <c:pt idx="14">
                  <c:v>0.19013666072489599</c:v>
                </c:pt>
                <c:pt idx="15">
                  <c:v>0.13071895424836602</c:v>
                </c:pt>
                <c:pt idx="16">
                  <c:v>7.1301247771836024E-2</c:v>
                </c:pt>
                <c:pt idx="17">
                  <c:v>0.130718954248366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8-E0A3-40A5-9261-2323BFE7E4E5}"/>
            </c:ext>
          </c:extLst>
        </c:ser>
        <c:ser>
          <c:idx val="25"/>
          <c:order val="25"/>
          <c:tx>
            <c:strRef>
              <c:f>'6nt'!$A$227</c:f>
              <c:strCache>
                <c:ptCount val="1"/>
                <c:pt idx="0">
                  <c:v>AAUUGA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27:$S$227</c:f>
              <c:numCache>
                <c:formatCode>General</c:formatCode>
                <c:ptCount val="18"/>
                <c:pt idx="0">
                  <c:v>0.13071895424836602</c:v>
                </c:pt>
                <c:pt idx="1">
                  <c:v>0.10695187165775399</c:v>
                </c:pt>
                <c:pt idx="2">
                  <c:v>0.15448603683898005</c:v>
                </c:pt>
                <c:pt idx="3">
                  <c:v>0.19013666072489599</c:v>
                </c:pt>
                <c:pt idx="4">
                  <c:v>0.14260249554367202</c:v>
                </c:pt>
                <c:pt idx="5">
                  <c:v>0.13071895424836602</c:v>
                </c:pt>
                <c:pt idx="6">
                  <c:v>0.15448603683898005</c:v>
                </c:pt>
                <c:pt idx="7">
                  <c:v>8.3184789067142023E-2</c:v>
                </c:pt>
                <c:pt idx="8">
                  <c:v>0.15448603683898005</c:v>
                </c:pt>
                <c:pt idx="9">
                  <c:v>0.11883541295306001</c:v>
                </c:pt>
                <c:pt idx="10">
                  <c:v>9.5068330362449202E-2</c:v>
                </c:pt>
                <c:pt idx="11">
                  <c:v>0.17825311942959002</c:v>
                </c:pt>
                <c:pt idx="12">
                  <c:v>0.21390374331550802</c:v>
                </c:pt>
                <c:pt idx="13">
                  <c:v>0.20202020202020202</c:v>
                </c:pt>
                <c:pt idx="14">
                  <c:v>9.5068330362449202E-2</c:v>
                </c:pt>
                <c:pt idx="15">
                  <c:v>0.22578728461081402</c:v>
                </c:pt>
                <c:pt idx="16">
                  <c:v>0.11883541295306001</c:v>
                </c:pt>
                <c:pt idx="17">
                  <c:v>5.9417706476530496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9-E0A3-40A5-9261-2323BFE7E4E5}"/>
            </c:ext>
          </c:extLst>
        </c:ser>
        <c:ser>
          <c:idx val="26"/>
          <c:order val="26"/>
          <c:tx>
            <c:strRef>
              <c:f>'6nt'!$A$228</c:f>
              <c:strCache>
                <c:ptCount val="1"/>
                <c:pt idx="0">
                  <c:v>AUUUUA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28:$S$228</c:f>
              <c:numCache>
                <c:formatCode>General</c:formatCode>
                <c:ptCount val="18"/>
                <c:pt idx="0">
                  <c:v>0.16636957813428399</c:v>
                </c:pt>
                <c:pt idx="1">
                  <c:v>0.22578728461081402</c:v>
                </c:pt>
                <c:pt idx="2">
                  <c:v>0.11883541295306001</c:v>
                </c:pt>
                <c:pt idx="3">
                  <c:v>0.19013666072489599</c:v>
                </c:pt>
                <c:pt idx="4">
                  <c:v>0.16636957813428399</c:v>
                </c:pt>
                <c:pt idx="5">
                  <c:v>0.19013666072489599</c:v>
                </c:pt>
                <c:pt idx="6">
                  <c:v>0.14260249554367202</c:v>
                </c:pt>
                <c:pt idx="7">
                  <c:v>0.14260249554367202</c:v>
                </c:pt>
                <c:pt idx="8">
                  <c:v>0.15448603683898005</c:v>
                </c:pt>
                <c:pt idx="9">
                  <c:v>0.13071895424836602</c:v>
                </c:pt>
                <c:pt idx="10">
                  <c:v>0.14260249554367202</c:v>
                </c:pt>
                <c:pt idx="11">
                  <c:v>0.14260249554367202</c:v>
                </c:pt>
                <c:pt idx="12">
                  <c:v>7.1301247771836024E-2</c:v>
                </c:pt>
                <c:pt idx="13">
                  <c:v>0.16636957813428399</c:v>
                </c:pt>
                <c:pt idx="14">
                  <c:v>0.10695187165775399</c:v>
                </c:pt>
                <c:pt idx="15">
                  <c:v>0.13071895424836602</c:v>
                </c:pt>
                <c:pt idx="16">
                  <c:v>0.11883541295306001</c:v>
                </c:pt>
                <c:pt idx="17">
                  <c:v>4.7534165181224004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A-E0A3-40A5-9261-2323BFE7E4E5}"/>
            </c:ext>
          </c:extLst>
        </c:ser>
        <c:ser>
          <c:idx val="27"/>
          <c:order val="27"/>
          <c:tx>
            <c:strRef>
              <c:f>'6nt'!$A$229</c:f>
              <c:strCache>
                <c:ptCount val="1"/>
                <c:pt idx="0">
                  <c:v>UUUAUU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29:$S$229</c:f>
              <c:numCache>
                <c:formatCode>General</c:formatCode>
                <c:ptCount val="18"/>
                <c:pt idx="0">
                  <c:v>0.16636957813428399</c:v>
                </c:pt>
                <c:pt idx="1">
                  <c:v>8.3184789067142023E-2</c:v>
                </c:pt>
                <c:pt idx="2">
                  <c:v>0.11883541295306001</c:v>
                </c:pt>
                <c:pt idx="3">
                  <c:v>0.24955436720142804</c:v>
                </c:pt>
                <c:pt idx="4">
                  <c:v>0.10695187165775399</c:v>
                </c:pt>
                <c:pt idx="5">
                  <c:v>0.24955436720142804</c:v>
                </c:pt>
                <c:pt idx="6">
                  <c:v>0.14260249554367202</c:v>
                </c:pt>
                <c:pt idx="7">
                  <c:v>9.5068330362449202E-2</c:v>
                </c:pt>
                <c:pt idx="8">
                  <c:v>8.3184789067142023E-2</c:v>
                </c:pt>
                <c:pt idx="9">
                  <c:v>0.24955436720142804</c:v>
                </c:pt>
                <c:pt idx="10">
                  <c:v>0.16636957813428399</c:v>
                </c:pt>
                <c:pt idx="11">
                  <c:v>0.14260249554367202</c:v>
                </c:pt>
                <c:pt idx="12">
                  <c:v>7.1301247771836024E-2</c:v>
                </c:pt>
                <c:pt idx="13">
                  <c:v>9.5068330362449202E-2</c:v>
                </c:pt>
                <c:pt idx="14">
                  <c:v>8.3184789067142023E-2</c:v>
                </c:pt>
                <c:pt idx="15">
                  <c:v>0.14260249554367202</c:v>
                </c:pt>
                <c:pt idx="16">
                  <c:v>0.14260249554367202</c:v>
                </c:pt>
                <c:pt idx="17">
                  <c:v>0.142602495543672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B-E0A3-40A5-9261-2323BFE7E4E5}"/>
            </c:ext>
          </c:extLst>
        </c:ser>
        <c:ser>
          <c:idx val="28"/>
          <c:order val="28"/>
          <c:tx>
            <c:strRef>
              <c:f>'6nt'!$A$230</c:f>
              <c:strCache>
                <c:ptCount val="1"/>
                <c:pt idx="0">
                  <c:v>UAAUUU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30:$S$230</c:f>
              <c:numCache>
                <c:formatCode>General</c:formatCode>
                <c:ptCount val="18"/>
                <c:pt idx="0">
                  <c:v>0.13071895424836602</c:v>
                </c:pt>
                <c:pt idx="1">
                  <c:v>0.21390374331550802</c:v>
                </c:pt>
                <c:pt idx="2">
                  <c:v>0.10695187165775399</c:v>
                </c:pt>
                <c:pt idx="3">
                  <c:v>0.17825311942959002</c:v>
                </c:pt>
                <c:pt idx="4">
                  <c:v>0.16636957813428399</c:v>
                </c:pt>
                <c:pt idx="5">
                  <c:v>0.15448603683898005</c:v>
                </c:pt>
                <c:pt idx="6">
                  <c:v>0.11883541295306001</c:v>
                </c:pt>
                <c:pt idx="7">
                  <c:v>0.13071895424836602</c:v>
                </c:pt>
                <c:pt idx="8">
                  <c:v>0.15448603683898005</c:v>
                </c:pt>
                <c:pt idx="9">
                  <c:v>0.13071895424836602</c:v>
                </c:pt>
                <c:pt idx="10">
                  <c:v>9.5068330362449202E-2</c:v>
                </c:pt>
                <c:pt idx="11">
                  <c:v>0.16636957813428399</c:v>
                </c:pt>
                <c:pt idx="12">
                  <c:v>0.10695187165775399</c:v>
                </c:pt>
                <c:pt idx="13">
                  <c:v>0.19013666072489599</c:v>
                </c:pt>
                <c:pt idx="14">
                  <c:v>7.1301247771836024E-2</c:v>
                </c:pt>
                <c:pt idx="15">
                  <c:v>0.13071895424836602</c:v>
                </c:pt>
                <c:pt idx="16">
                  <c:v>0.16636957813428399</c:v>
                </c:pt>
                <c:pt idx="17">
                  <c:v>8.3184789067142023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C-E0A3-40A5-9261-2323BFE7E4E5}"/>
            </c:ext>
          </c:extLst>
        </c:ser>
        <c:ser>
          <c:idx val="29"/>
          <c:order val="29"/>
          <c:tx>
            <c:strRef>
              <c:f>'6nt'!$A$231</c:f>
              <c:strCache>
                <c:ptCount val="1"/>
                <c:pt idx="0">
                  <c:v>UAAAUU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31:$S$231</c:f>
              <c:numCache>
                <c:formatCode>General</c:formatCode>
                <c:ptCount val="18"/>
                <c:pt idx="0">
                  <c:v>9.5068330362449202E-2</c:v>
                </c:pt>
                <c:pt idx="1">
                  <c:v>0.11883541295306001</c:v>
                </c:pt>
                <c:pt idx="2">
                  <c:v>9.5068330362449202E-2</c:v>
                </c:pt>
                <c:pt idx="3">
                  <c:v>9.5068330362449202E-2</c:v>
                </c:pt>
                <c:pt idx="4">
                  <c:v>8.3184789067142023E-2</c:v>
                </c:pt>
                <c:pt idx="5">
                  <c:v>0.20202020202020202</c:v>
                </c:pt>
                <c:pt idx="6">
                  <c:v>0.14260249554367202</c:v>
                </c:pt>
                <c:pt idx="7">
                  <c:v>0.11883541295306001</c:v>
                </c:pt>
                <c:pt idx="8">
                  <c:v>0.10695187165775399</c:v>
                </c:pt>
                <c:pt idx="9">
                  <c:v>5.9417706476530496E-2</c:v>
                </c:pt>
                <c:pt idx="10">
                  <c:v>0.28520499108734909</c:v>
                </c:pt>
                <c:pt idx="11">
                  <c:v>0.17825311942959002</c:v>
                </c:pt>
                <c:pt idx="12">
                  <c:v>0.14260249554367202</c:v>
                </c:pt>
                <c:pt idx="13">
                  <c:v>0.16636957813428399</c:v>
                </c:pt>
                <c:pt idx="14">
                  <c:v>0.13071895424836602</c:v>
                </c:pt>
                <c:pt idx="15">
                  <c:v>0.15448603683898005</c:v>
                </c:pt>
                <c:pt idx="16">
                  <c:v>0.13071895424836602</c:v>
                </c:pt>
                <c:pt idx="17">
                  <c:v>0.190136660724895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D-E0A3-40A5-9261-2323BFE7E4E5}"/>
            </c:ext>
          </c:extLst>
        </c:ser>
        <c:ser>
          <c:idx val="30"/>
          <c:order val="30"/>
          <c:tx>
            <c:strRef>
              <c:f>'6nt'!$A$232</c:f>
              <c:strCache>
                <c:ptCount val="1"/>
                <c:pt idx="0">
                  <c:v>UGAAUA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32:$S$232</c:f>
              <c:numCache>
                <c:formatCode>General</c:formatCode>
                <c:ptCount val="18"/>
                <c:pt idx="0">
                  <c:v>7.1301247771836024E-2</c:v>
                </c:pt>
                <c:pt idx="1">
                  <c:v>0.19013666072489599</c:v>
                </c:pt>
                <c:pt idx="2">
                  <c:v>0.11883541295306001</c:v>
                </c:pt>
                <c:pt idx="3">
                  <c:v>0.15448603683898005</c:v>
                </c:pt>
                <c:pt idx="4">
                  <c:v>0.20202020202020202</c:v>
                </c:pt>
                <c:pt idx="5">
                  <c:v>0.11883541295306001</c:v>
                </c:pt>
                <c:pt idx="6">
                  <c:v>0.16636957813428399</c:v>
                </c:pt>
                <c:pt idx="7">
                  <c:v>0.11883541295306001</c:v>
                </c:pt>
                <c:pt idx="8">
                  <c:v>0.20202020202020202</c:v>
                </c:pt>
                <c:pt idx="9">
                  <c:v>0.14260249554367202</c:v>
                </c:pt>
                <c:pt idx="10">
                  <c:v>0.13071895424836602</c:v>
                </c:pt>
                <c:pt idx="11">
                  <c:v>0.23767082590611796</c:v>
                </c:pt>
                <c:pt idx="12">
                  <c:v>0.11883541295306001</c:v>
                </c:pt>
                <c:pt idx="13">
                  <c:v>0.14260249554367202</c:v>
                </c:pt>
                <c:pt idx="14">
                  <c:v>0.10695187165775399</c:v>
                </c:pt>
                <c:pt idx="15">
                  <c:v>8.3184789067142023E-2</c:v>
                </c:pt>
                <c:pt idx="16">
                  <c:v>9.5068330362449202E-2</c:v>
                </c:pt>
                <c:pt idx="17">
                  <c:v>7.1301247771836024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E-E0A3-40A5-9261-2323BFE7E4E5}"/>
            </c:ext>
          </c:extLst>
        </c:ser>
        <c:ser>
          <c:idx val="31"/>
          <c:order val="31"/>
          <c:tx>
            <c:strRef>
              <c:f>'6nt'!$A$233</c:f>
              <c:strCache>
                <c:ptCount val="1"/>
                <c:pt idx="0">
                  <c:v>UUGUAA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33:$S$233</c:f>
              <c:numCache>
                <c:formatCode>General</c:formatCode>
                <c:ptCount val="18"/>
                <c:pt idx="0">
                  <c:v>0.14260249554367202</c:v>
                </c:pt>
                <c:pt idx="1">
                  <c:v>0.17825311942959002</c:v>
                </c:pt>
                <c:pt idx="2">
                  <c:v>0.11883541295306001</c:v>
                </c:pt>
                <c:pt idx="3">
                  <c:v>0.15448603683898005</c:v>
                </c:pt>
                <c:pt idx="4">
                  <c:v>0.19013666072489599</c:v>
                </c:pt>
                <c:pt idx="5">
                  <c:v>0.19013666072489599</c:v>
                </c:pt>
                <c:pt idx="6">
                  <c:v>0.14260249554367202</c:v>
                </c:pt>
                <c:pt idx="7">
                  <c:v>0.17825311942959002</c:v>
                </c:pt>
                <c:pt idx="8">
                  <c:v>0.24955436720142804</c:v>
                </c:pt>
                <c:pt idx="9">
                  <c:v>0.14260249554367202</c:v>
                </c:pt>
                <c:pt idx="10">
                  <c:v>0.10695187165775399</c:v>
                </c:pt>
                <c:pt idx="11">
                  <c:v>0.15448603683898005</c:v>
                </c:pt>
                <c:pt idx="12">
                  <c:v>0.14260249554367202</c:v>
                </c:pt>
                <c:pt idx="13">
                  <c:v>8.3184789067142023E-2</c:v>
                </c:pt>
                <c:pt idx="14">
                  <c:v>8.3184789067142023E-2</c:v>
                </c:pt>
                <c:pt idx="15">
                  <c:v>8.3184789067142023E-2</c:v>
                </c:pt>
                <c:pt idx="16">
                  <c:v>7.1301247771836024E-2</c:v>
                </c:pt>
                <c:pt idx="17">
                  <c:v>5.9417706476530496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F-E0A3-40A5-9261-2323BFE7E4E5}"/>
            </c:ext>
          </c:extLst>
        </c:ser>
        <c:ser>
          <c:idx val="32"/>
          <c:order val="32"/>
          <c:tx>
            <c:strRef>
              <c:f>'6nt'!$A$234</c:f>
              <c:strCache>
                <c:ptCount val="1"/>
                <c:pt idx="0">
                  <c:v>UAAAAU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34:$S$234</c:f>
              <c:numCache>
                <c:formatCode>General</c:formatCode>
                <c:ptCount val="18"/>
                <c:pt idx="0">
                  <c:v>0.15448603683898005</c:v>
                </c:pt>
                <c:pt idx="1">
                  <c:v>8.3184789067142023E-2</c:v>
                </c:pt>
                <c:pt idx="2">
                  <c:v>9.5068330362449202E-2</c:v>
                </c:pt>
                <c:pt idx="3">
                  <c:v>0.14260249554367202</c:v>
                </c:pt>
                <c:pt idx="4">
                  <c:v>0.15448603683898005</c:v>
                </c:pt>
                <c:pt idx="5">
                  <c:v>9.5068330362449202E-2</c:v>
                </c:pt>
                <c:pt idx="6">
                  <c:v>9.5068330362449202E-2</c:v>
                </c:pt>
                <c:pt idx="7">
                  <c:v>0.11883541295306001</c:v>
                </c:pt>
                <c:pt idx="8">
                  <c:v>0.11883541295306001</c:v>
                </c:pt>
                <c:pt idx="9">
                  <c:v>0.19013666072489599</c:v>
                </c:pt>
                <c:pt idx="10">
                  <c:v>0.11883541295306001</c:v>
                </c:pt>
                <c:pt idx="11">
                  <c:v>0.22578728461081402</c:v>
                </c:pt>
                <c:pt idx="12">
                  <c:v>0.17825311942959002</c:v>
                </c:pt>
                <c:pt idx="13">
                  <c:v>0.13071895424836602</c:v>
                </c:pt>
                <c:pt idx="14">
                  <c:v>0.17825311942959002</c:v>
                </c:pt>
                <c:pt idx="15">
                  <c:v>5.9417706476530496E-2</c:v>
                </c:pt>
                <c:pt idx="16">
                  <c:v>0.11883541295306001</c:v>
                </c:pt>
                <c:pt idx="17">
                  <c:v>0.17825311942959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0-E0A3-40A5-9261-2323BFE7E4E5}"/>
            </c:ext>
          </c:extLst>
        </c:ser>
        <c:ser>
          <c:idx val="33"/>
          <c:order val="33"/>
          <c:tx>
            <c:strRef>
              <c:f>'6nt'!$A$235</c:f>
              <c:strCache>
                <c:ptCount val="1"/>
                <c:pt idx="0">
                  <c:v>AUUUAU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35:$S$235</c:f>
              <c:numCache>
                <c:formatCode>General</c:formatCode>
                <c:ptCount val="18"/>
                <c:pt idx="0">
                  <c:v>0.17825311942959002</c:v>
                </c:pt>
                <c:pt idx="1">
                  <c:v>0.17825311942959002</c:v>
                </c:pt>
                <c:pt idx="2">
                  <c:v>0.10695187165775399</c:v>
                </c:pt>
                <c:pt idx="3">
                  <c:v>0.16636957813428399</c:v>
                </c:pt>
                <c:pt idx="4">
                  <c:v>0.17825311942959002</c:v>
                </c:pt>
                <c:pt idx="5">
                  <c:v>9.5068330362449202E-2</c:v>
                </c:pt>
                <c:pt idx="6">
                  <c:v>0.15448603683898005</c:v>
                </c:pt>
                <c:pt idx="7">
                  <c:v>5.9417706476530496E-2</c:v>
                </c:pt>
                <c:pt idx="8">
                  <c:v>9.5068330362449202E-2</c:v>
                </c:pt>
                <c:pt idx="9">
                  <c:v>0.16636957813428399</c:v>
                </c:pt>
                <c:pt idx="10">
                  <c:v>0.17825311942959002</c:v>
                </c:pt>
                <c:pt idx="11">
                  <c:v>8.3184789067142023E-2</c:v>
                </c:pt>
                <c:pt idx="12">
                  <c:v>0.17825311942959002</c:v>
                </c:pt>
                <c:pt idx="13">
                  <c:v>0.14260249554367202</c:v>
                </c:pt>
                <c:pt idx="14">
                  <c:v>0.11883541295306001</c:v>
                </c:pt>
                <c:pt idx="15">
                  <c:v>8.3184789067142023E-2</c:v>
                </c:pt>
                <c:pt idx="16">
                  <c:v>0.16636957813428399</c:v>
                </c:pt>
                <c:pt idx="17">
                  <c:v>0.106951871657753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1-E0A3-40A5-9261-2323BFE7E4E5}"/>
            </c:ext>
          </c:extLst>
        </c:ser>
        <c:ser>
          <c:idx val="34"/>
          <c:order val="34"/>
          <c:tx>
            <c:strRef>
              <c:f>'6nt'!$A$236</c:f>
              <c:strCache>
                <c:ptCount val="1"/>
                <c:pt idx="0">
                  <c:v>AUUGAA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36:$S$236</c:f>
              <c:numCache>
                <c:formatCode>General</c:formatCode>
                <c:ptCount val="18"/>
                <c:pt idx="0">
                  <c:v>8.3184789067142023E-2</c:v>
                </c:pt>
                <c:pt idx="1">
                  <c:v>0.11883541295306001</c:v>
                </c:pt>
                <c:pt idx="2">
                  <c:v>9.5068330362449202E-2</c:v>
                </c:pt>
                <c:pt idx="3">
                  <c:v>0.11883541295306001</c:v>
                </c:pt>
                <c:pt idx="4">
                  <c:v>0.14260249554367202</c:v>
                </c:pt>
                <c:pt idx="5">
                  <c:v>0.19013666072489599</c:v>
                </c:pt>
                <c:pt idx="6">
                  <c:v>0.14260249554367202</c:v>
                </c:pt>
                <c:pt idx="7">
                  <c:v>0.13071895424836602</c:v>
                </c:pt>
                <c:pt idx="8">
                  <c:v>0.11883541295306001</c:v>
                </c:pt>
                <c:pt idx="9">
                  <c:v>0.15448603683898005</c:v>
                </c:pt>
                <c:pt idx="10">
                  <c:v>0.15448603683898005</c:v>
                </c:pt>
                <c:pt idx="11">
                  <c:v>0.17825311942959002</c:v>
                </c:pt>
                <c:pt idx="12">
                  <c:v>0.14260249554367202</c:v>
                </c:pt>
                <c:pt idx="13">
                  <c:v>0.13071895424836602</c:v>
                </c:pt>
                <c:pt idx="14">
                  <c:v>0.14260249554367202</c:v>
                </c:pt>
                <c:pt idx="15">
                  <c:v>0.13071895424836602</c:v>
                </c:pt>
                <c:pt idx="16">
                  <c:v>0.13071895424836602</c:v>
                </c:pt>
                <c:pt idx="17">
                  <c:v>0.11883541295306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2-E0A3-40A5-9261-2323BFE7E4E5}"/>
            </c:ext>
          </c:extLst>
        </c:ser>
        <c:ser>
          <c:idx val="35"/>
          <c:order val="35"/>
          <c:tx>
            <c:strRef>
              <c:f>'6nt'!$A$237</c:f>
              <c:strCache>
                <c:ptCount val="1"/>
                <c:pt idx="0">
                  <c:v>AAUAUA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37:$S$237</c:f>
              <c:numCache>
                <c:formatCode>General</c:formatCode>
                <c:ptCount val="18"/>
                <c:pt idx="0">
                  <c:v>7.1301247771836024E-2</c:v>
                </c:pt>
                <c:pt idx="1">
                  <c:v>7.1301247771836024E-2</c:v>
                </c:pt>
                <c:pt idx="2">
                  <c:v>7.1301247771836024E-2</c:v>
                </c:pt>
                <c:pt idx="3">
                  <c:v>4.7534165181224004E-2</c:v>
                </c:pt>
                <c:pt idx="4">
                  <c:v>9.5068330362449202E-2</c:v>
                </c:pt>
                <c:pt idx="5">
                  <c:v>9.5068330362449202E-2</c:v>
                </c:pt>
                <c:pt idx="6">
                  <c:v>0.17825311942959002</c:v>
                </c:pt>
                <c:pt idx="7">
                  <c:v>0.26143790849672893</c:v>
                </c:pt>
                <c:pt idx="8">
                  <c:v>0.10695187165775399</c:v>
                </c:pt>
                <c:pt idx="9">
                  <c:v>0.13071895424836602</c:v>
                </c:pt>
                <c:pt idx="10">
                  <c:v>0.14260249554367202</c:v>
                </c:pt>
                <c:pt idx="11">
                  <c:v>0.22578728461081402</c:v>
                </c:pt>
                <c:pt idx="12">
                  <c:v>0.21390374331550802</c:v>
                </c:pt>
                <c:pt idx="13">
                  <c:v>0.19013666072489599</c:v>
                </c:pt>
                <c:pt idx="14">
                  <c:v>0.10695187165775399</c:v>
                </c:pt>
                <c:pt idx="15">
                  <c:v>0.20202020202020202</c:v>
                </c:pt>
                <c:pt idx="16">
                  <c:v>0.10695187165775399</c:v>
                </c:pt>
                <c:pt idx="17">
                  <c:v>8.3184789067142023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3-E0A3-40A5-9261-2323BFE7E4E5}"/>
            </c:ext>
          </c:extLst>
        </c:ser>
        <c:ser>
          <c:idx val="36"/>
          <c:order val="36"/>
          <c:tx>
            <c:strRef>
              <c:f>'6nt'!$A$238</c:f>
              <c:strCache>
                <c:ptCount val="1"/>
                <c:pt idx="0">
                  <c:v>UUUUUU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38:$S$238</c:f>
              <c:numCache>
                <c:formatCode>General</c:formatCode>
                <c:ptCount val="18"/>
                <c:pt idx="0">
                  <c:v>0.19013666072489599</c:v>
                </c:pt>
                <c:pt idx="1">
                  <c:v>0.10695187165775399</c:v>
                </c:pt>
                <c:pt idx="2">
                  <c:v>0.16636957813428399</c:v>
                </c:pt>
                <c:pt idx="3">
                  <c:v>0.17825311942959002</c:v>
                </c:pt>
                <c:pt idx="4">
                  <c:v>0.13071895424836602</c:v>
                </c:pt>
                <c:pt idx="5">
                  <c:v>0.22578728461081402</c:v>
                </c:pt>
                <c:pt idx="6">
                  <c:v>0.16636957813428399</c:v>
                </c:pt>
                <c:pt idx="7">
                  <c:v>0.14260249554367202</c:v>
                </c:pt>
                <c:pt idx="8">
                  <c:v>9.5068330362449202E-2</c:v>
                </c:pt>
                <c:pt idx="9">
                  <c:v>0.10695187165775399</c:v>
                </c:pt>
                <c:pt idx="10">
                  <c:v>4.7534165181224004E-2</c:v>
                </c:pt>
                <c:pt idx="11">
                  <c:v>8.3184789067142023E-2</c:v>
                </c:pt>
                <c:pt idx="12">
                  <c:v>5.9417706476530496E-2</c:v>
                </c:pt>
                <c:pt idx="13">
                  <c:v>8.3184789067142023E-2</c:v>
                </c:pt>
                <c:pt idx="14">
                  <c:v>0.11883541295306001</c:v>
                </c:pt>
                <c:pt idx="15">
                  <c:v>0.13071895424836602</c:v>
                </c:pt>
                <c:pt idx="16">
                  <c:v>9.5068330362449202E-2</c:v>
                </c:pt>
                <c:pt idx="17">
                  <c:v>0.2614379084967289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4-E0A3-40A5-9261-2323BFE7E4E5}"/>
            </c:ext>
          </c:extLst>
        </c:ser>
        <c:ser>
          <c:idx val="37"/>
          <c:order val="37"/>
          <c:tx>
            <c:strRef>
              <c:f>'6nt'!$A$239</c:f>
              <c:strCache>
                <c:ptCount val="1"/>
                <c:pt idx="0">
                  <c:v>AAAAUU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39:$S$239</c:f>
              <c:numCache>
                <c:formatCode>General</c:formatCode>
                <c:ptCount val="18"/>
                <c:pt idx="0">
                  <c:v>0.16636957813428399</c:v>
                </c:pt>
                <c:pt idx="1">
                  <c:v>0.10695187165775399</c:v>
                </c:pt>
                <c:pt idx="2">
                  <c:v>0.13071895424836602</c:v>
                </c:pt>
                <c:pt idx="3">
                  <c:v>4.7534165181224004E-2</c:v>
                </c:pt>
                <c:pt idx="4">
                  <c:v>0.17825311942959002</c:v>
                </c:pt>
                <c:pt idx="5">
                  <c:v>0.15448603683898005</c:v>
                </c:pt>
                <c:pt idx="6">
                  <c:v>0.13071895424836602</c:v>
                </c:pt>
                <c:pt idx="7">
                  <c:v>9.5068330362449202E-2</c:v>
                </c:pt>
                <c:pt idx="8">
                  <c:v>0.14260249554367202</c:v>
                </c:pt>
                <c:pt idx="9">
                  <c:v>0.13071895424836602</c:v>
                </c:pt>
                <c:pt idx="10">
                  <c:v>0.14260249554367202</c:v>
                </c:pt>
                <c:pt idx="11">
                  <c:v>0.13071895424836602</c:v>
                </c:pt>
                <c:pt idx="12">
                  <c:v>0.11883541295306001</c:v>
                </c:pt>
                <c:pt idx="13">
                  <c:v>0.20202020202020202</c:v>
                </c:pt>
                <c:pt idx="14">
                  <c:v>0.16636957813428399</c:v>
                </c:pt>
                <c:pt idx="15">
                  <c:v>9.5068330362449202E-2</c:v>
                </c:pt>
                <c:pt idx="16">
                  <c:v>0.10695187165775399</c:v>
                </c:pt>
                <c:pt idx="17">
                  <c:v>0.142602495543672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5-E0A3-40A5-9261-2323BFE7E4E5}"/>
            </c:ext>
          </c:extLst>
        </c:ser>
        <c:ser>
          <c:idx val="38"/>
          <c:order val="38"/>
          <c:tx>
            <c:strRef>
              <c:f>'6nt'!$A$240</c:f>
              <c:strCache>
                <c:ptCount val="1"/>
                <c:pt idx="0">
                  <c:v>AUUUAA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40:$S$240</c:f>
              <c:numCache>
                <c:formatCode>General</c:formatCode>
                <c:ptCount val="18"/>
                <c:pt idx="0">
                  <c:v>0.13071895424836602</c:v>
                </c:pt>
                <c:pt idx="1">
                  <c:v>0.11883541295306001</c:v>
                </c:pt>
                <c:pt idx="2">
                  <c:v>0.10695187165775399</c:v>
                </c:pt>
                <c:pt idx="3">
                  <c:v>0.16636957813428399</c:v>
                </c:pt>
                <c:pt idx="4">
                  <c:v>0.16636957813428399</c:v>
                </c:pt>
                <c:pt idx="5">
                  <c:v>0.13071895424836602</c:v>
                </c:pt>
                <c:pt idx="6">
                  <c:v>0.19013666072489599</c:v>
                </c:pt>
                <c:pt idx="7">
                  <c:v>9.5068330362449202E-2</c:v>
                </c:pt>
                <c:pt idx="8">
                  <c:v>0.15448603683898005</c:v>
                </c:pt>
                <c:pt idx="9">
                  <c:v>0.17825311942959002</c:v>
                </c:pt>
                <c:pt idx="10">
                  <c:v>0.15448603683898005</c:v>
                </c:pt>
                <c:pt idx="11">
                  <c:v>0.10695187165775399</c:v>
                </c:pt>
                <c:pt idx="12">
                  <c:v>0.11883541295306001</c:v>
                </c:pt>
                <c:pt idx="13">
                  <c:v>0.20202020202020202</c:v>
                </c:pt>
                <c:pt idx="14">
                  <c:v>8.3184789067142023E-2</c:v>
                </c:pt>
                <c:pt idx="15">
                  <c:v>9.5068330362449202E-2</c:v>
                </c:pt>
                <c:pt idx="16">
                  <c:v>9.5068330362449202E-2</c:v>
                </c:pt>
                <c:pt idx="17">
                  <c:v>5.9417706476530496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6-E0A3-40A5-9261-2323BFE7E4E5}"/>
            </c:ext>
          </c:extLst>
        </c:ser>
        <c:ser>
          <c:idx val="39"/>
          <c:order val="39"/>
          <c:tx>
            <c:strRef>
              <c:f>'6nt'!$A$241</c:f>
              <c:strCache>
                <c:ptCount val="1"/>
                <c:pt idx="0">
                  <c:v>UUUUUA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41:$S$241</c:f>
              <c:numCache>
                <c:formatCode>General</c:formatCode>
                <c:ptCount val="18"/>
                <c:pt idx="0">
                  <c:v>0.14260249554367202</c:v>
                </c:pt>
                <c:pt idx="1">
                  <c:v>0.20202020202020202</c:v>
                </c:pt>
                <c:pt idx="2">
                  <c:v>0.14260249554367202</c:v>
                </c:pt>
                <c:pt idx="3">
                  <c:v>0.10695187165775399</c:v>
                </c:pt>
                <c:pt idx="4">
                  <c:v>0.23767082590611796</c:v>
                </c:pt>
                <c:pt idx="5">
                  <c:v>0.17825311942959002</c:v>
                </c:pt>
                <c:pt idx="6">
                  <c:v>0.10695187165775399</c:v>
                </c:pt>
                <c:pt idx="7">
                  <c:v>0.21390374331550802</c:v>
                </c:pt>
                <c:pt idx="8">
                  <c:v>0.13071895424836602</c:v>
                </c:pt>
                <c:pt idx="9">
                  <c:v>0.14260249554367202</c:v>
                </c:pt>
                <c:pt idx="10">
                  <c:v>0.14260249554367202</c:v>
                </c:pt>
                <c:pt idx="11">
                  <c:v>8.3184789067142023E-2</c:v>
                </c:pt>
                <c:pt idx="12">
                  <c:v>0.14260249554367202</c:v>
                </c:pt>
                <c:pt idx="13">
                  <c:v>4.7534165181224004E-2</c:v>
                </c:pt>
                <c:pt idx="14">
                  <c:v>5.9417706476530496E-2</c:v>
                </c:pt>
                <c:pt idx="15">
                  <c:v>5.9417706476530496E-2</c:v>
                </c:pt>
                <c:pt idx="16">
                  <c:v>8.3184789067142023E-2</c:v>
                </c:pt>
                <c:pt idx="17">
                  <c:v>0.130718954248366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7-E0A3-40A5-9261-2323BFE7E4E5}"/>
            </c:ext>
          </c:extLst>
        </c:ser>
        <c:ser>
          <c:idx val="40"/>
          <c:order val="40"/>
          <c:tx>
            <c:strRef>
              <c:f>'6nt'!$A$242</c:f>
              <c:strCache>
                <c:ptCount val="1"/>
                <c:pt idx="0">
                  <c:v>UUUAAA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42:$S$242</c:f>
              <c:numCache>
                <c:formatCode>General</c:formatCode>
                <c:ptCount val="18"/>
                <c:pt idx="0">
                  <c:v>0.15448603683898005</c:v>
                </c:pt>
                <c:pt idx="1">
                  <c:v>0.15448603683898005</c:v>
                </c:pt>
                <c:pt idx="2">
                  <c:v>8.3184789067142023E-2</c:v>
                </c:pt>
                <c:pt idx="3">
                  <c:v>0.14260249554367202</c:v>
                </c:pt>
                <c:pt idx="4">
                  <c:v>0.11883541295306001</c:v>
                </c:pt>
                <c:pt idx="5">
                  <c:v>0.13071895424836602</c:v>
                </c:pt>
                <c:pt idx="6">
                  <c:v>0.20202020202020202</c:v>
                </c:pt>
                <c:pt idx="7">
                  <c:v>0.13071895424836602</c:v>
                </c:pt>
                <c:pt idx="8">
                  <c:v>9.5068330362449202E-2</c:v>
                </c:pt>
                <c:pt idx="9">
                  <c:v>0.11883541295306001</c:v>
                </c:pt>
                <c:pt idx="10">
                  <c:v>0.20202020202020202</c:v>
                </c:pt>
                <c:pt idx="11">
                  <c:v>0.19013666072489599</c:v>
                </c:pt>
                <c:pt idx="12">
                  <c:v>0.10695187165775399</c:v>
                </c:pt>
                <c:pt idx="13">
                  <c:v>0.11883541295306001</c:v>
                </c:pt>
                <c:pt idx="14">
                  <c:v>0.10695187165775399</c:v>
                </c:pt>
                <c:pt idx="15">
                  <c:v>9.5068330362449202E-2</c:v>
                </c:pt>
                <c:pt idx="16">
                  <c:v>8.3184789067142023E-2</c:v>
                </c:pt>
                <c:pt idx="17">
                  <c:v>0.11883541295306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8-E0A3-40A5-9261-2323BFE7E4E5}"/>
            </c:ext>
          </c:extLst>
        </c:ser>
        <c:ser>
          <c:idx val="41"/>
          <c:order val="41"/>
          <c:tx>
            <c:strRef>
              <c:f>'6nt'!$A$243</c:f>
              <c:strCache>
                <c:ptCount val="1"/>
                <c:pt idx="0">
                  <c:v>UAAAAA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43:$S$243</c:f>
              <c:numCache>
                <c:formatCode>General</c:formatCode>
                <c:ptCount val="18"/>
                <c:pt idx="0">
                  <c:v>0.10695187165775399</c:v>
                </c:pt>
                <c:pt idx="1">
                  <c:v>5.9417706476530496E-2</c:v>
                </c:pt>
                <c:pt idx="2">
                  <c:v>8.3184789067142023E-2</c:v>
                </c:pt>
                <c:pt idx="3">
                  <c:v>0.10695187165775399</c:v>
                </c:pt>
                <c:pt idx="4">
                  <c:v>0.11883541295306001</c:v>
                </c:pt>
                <c:pt idx="5">
                  <c:v>7.1301247771836024E-2</c:v>
                </c:pt>
                <c:pt idx="6">
                  <c:v>0.13071895424836602</c:v>
                </c:pt>
                <c:pt idx="7">
                  <c:v>0.11883541295306001</c:v>
                </c:pt>
                <c:pt idx="8">
                  <c:v>0.16636957813428399</c:v>
                </c:pt>
                <c:pt idx="9">
                  <c:v>0.15448603683898005</c:v>
                </c:pt>
                <c:pt idx="10">
                  <c:v>0.10695187165775399</c:v>
                </c:pt>
                <c:pt idx="11">
                  <c:v>0.20202020202020202</c:v>
                </c:pt>
                <c:pt idx="12">
                  <c:v>0.16636957813428399</c:v>
                </c:pt>
                <c:pt idx="13">
                  <c:v>0.11883541295306001</c:v>
                </c:pt>
                <c:pt idx="14">
                  <c:v>0.17825311942959002</c:v>
                </c:pt>
                <c:pt idx="15">
                  <c:v>0.14260249554367202</c:v>
                </c:pt>
                <c:pt idx="16">
                  <c:v>0.20202020202020202</c:v>
                </c:pt>
                <c:pt idx="17">
                  <c:v>9.5068330362449202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9-E0A3-40A5-9261-2323BFE7E4E5}"/>
            </c:ext>
          </c:extLst>
        </c:ser>
        <c:ser>
          <c:idx val="42"/>
          <c:order val="42"/>
          <c:tx>
            <c:strRef>
              <c:f>'6nt'!$A$244</c:f>
              <c:strCache>
                <c:ptCount val="1"/>
                <c:pt idx="0">
                  <c:v>AUAAUA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44:$S$244</c:f>
              <c:numCache>
                <c:formatCode>General</c:formatCode>
                <c:ptCount val="18"/>
                <c:pt idx="0">
                  <c:v>0.11883541295306001</c:v>
                </c:pt>
                <c:pt idx="1">
                  <c:v>7.1301247771836024E-2</c:v>
                </c:pt>
                <c:pt idx="2">
                  <c:v>9.5068330362449202E-2</c:v>
                </c:pt>
                <c:pt idx="3">
                  <c:v>7.1301247771836024E-2</c:v>
                </c:pt>
                <c:pt idx="4">
                  <c:v>0.16636957813428399</c:v>
                </c:pt>
                <c:pt idx="5">
                  <c:v>0.13071895424836602</c:v>
                </c:pt>
                <c:pt idx="6">
                  <c:v>5.9417706476530496E-2</c:v>
                </c:pt>
                <c:pt idx="7">
                  <c:v>0.13071895424836602</c:v>
                </c:pt>
                <c:pt idx="8">
                  <c:v>0.21390374331550802</c:v>
                </c:pt>
                <c:pt idx="9">
                  <c:v>0.19013666072489599</c:v>
                </c:pt>
                <c:pt idx="10">
                  <c:v>0.27332144979203804</c:v>
                </c:pt>
                <c:pt idx="11">
                  <c:v>0.11883541295306001</c:v>
                </c:pt>
                <c:pt idx="12">
                  <c:v>0.21390374331550802</c:v>
                </c:pt>
                <c:pt idx="13">
                  <c:v>0.17825311942959002</c:v>
                </c:pt>
                <c:pt idx="14">
                  <c:v>5.9417706476530496E-2</c:v>
                </c:pt>
                <c:pt idx="15">
                  <c:v>0.10695187165775399</c:v>
                </c:pt>
                <c:pt idx="16">
                  <c:v>5.9417706476530496E-2</c:v>
                </c:pt>
                <c:pt idx="17">
                  <c:v>5.9417706476530496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A-E0A3-40A5-9261-2323BFE7E4E5}"/>
            </c:ext>
          </c:extLst>
        </c:ser>
        <c:ser>
          <c:idx val="43"/>
          <c:order val="43"/>
          <c:tx>
            <c:strRef>
              <c:f>'6nt'!$A$245</c:f>
              <c:strCache>
                <c:ptCount val="1"/>
                <c:pt idx="0">
                  <c:v>AUCAAU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45:$S$245</c:f>
              <c:numCache>
                <c:formatCode>General</c:formatCode>
                <c:ptCount val="18"/>
                <c:pt idx="0">
                  <c:v>0.13071895424836602</c:v>
                </c:pt>
                <c:pt idx="1">
                  <c:v>8.3184789067142023E-2</c:v>
                </c:pt>
                <c:pt idx="2">
                  <c:v>0.10695187165775399</c:v>
                </c:pt>
                <c:pt idx="3">
                  <c:v>8.3184789067142023E-2</c:v>
                </c:pt>
                <c:pt idx="4">
                  <c:v>0.16636957813428399</c:v>
                </c:pt>
                <c:pt idx="5">
                  <c:v>0.16636957813428399</c:v>
                </c:pt>
                <c:pt idx="6">
                  <c:v>0.14260249554367202</c:v>
                </c:pt>
                <c:pt idx="7">
                  <c:v>0.11883541295306001</c:v>
                </c:pt>
                <c:pt idx="8">
                  <c:v>0.20202020202020202</c:v>
                </c:pt>
                <c:pt idx="9">
                  <c:v>0.21390374331550802</c:v>
                </c:pt>
                <c:pt idx="10">
                  <c:v>0.13071895424836602</c:v>
                </c:pt>
                <c:pt idx="11">
                  <c:v>0.20202020202020202</c:v>
                </c:pt>
                <c:pt idx="12">
                  <c:v>0.14260249554367202</c:v>
                </c:pt>
                <c:pt idx="13">
                  <c:v>0.10695187165775399</c:v>
                </c:pt>
                <c:pt idx="14">
                  <c:v>8.3184789067142023E-2</c:v>
                </c:pt>
                <c:pt idx="15">
                  <c:v>8.3184789067142023E-2</c:v>
                </c:pt>
                <c:pt idx="16">
                  <c:v>4.7534165181224004E-2</c:v>
                </c:pt>
                <c:pt idx="17">
                  <c:v>9.5068330362449202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B-E0A3-40A5-9261-2323BFE7E4E5}"/>
            </c:ext>
          </c:extLst>
        </c:ser>
        <c:ser>
          <c:idx val="44"/>
          <c:order val="44"/>
          <c:tx>
            <c:strRef>
              <c:f>'6nt'!$A$246</c:f>
              <c:strCache>
                <c:ptCount val="1"/>
                <c:pt idx="0">
                  <c:v>UUUUAU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46:$S$246</c:f>
              <c:numCache>
                <c:formatCode>General</c:formatCode>
                <c:ptCount val="18"/>
                <c:pt idx="0">
                  <c:v>9.5068330362449202E-2</c:v>
                </c:pt>
                <c:pt idx="1">
                  <c:v>0.15448603683898005</c:v>
                </c:pt>
                <c:pt idx="2">
                  <c:v>0.24955436720142804</c:v>
                </c:pt>
                <c:pt idx="3">
                  <c:v>0.10695187165775399</c:v>
                </c:pt>
                <c:pt idx="4">
                  <c:v>0.11883541295306001</c:v>
                </c:pt>
                <c:pt idx="5">
                  <c:v>0.21390374331550802</c:v>
                </c:pt>
                <c:pt idx="6">
                  <c:v>0.16636957813428399</c:v>
                </c:pt>
                <c:pt idx="7">
                  <c:v>0.11883541295306001</c:v>
                </c:pt>
                <c:pt idx="8">
                  <c:v>0.20202020202020202</c:v>
                </c:pt>
                <c:pt idx="9">
                  <c:v>9.5068330362449202E-2</c:v>
                </c:pt>
                <c:pt idx="10">
                  <c:v>0.14260249554367202</c:v>
                </c:pt>
                <c:pt idx="11">
                  <c:v>8.3184789067142023E-2</c:v>
                </c:pt>
                <c:pt idx="12">
                  <c:v>9.5068330362449202E-2</c:v>
                </c:pt>
                <c:pt idx="13">
                  <c:v>0.13071895424836602</c:v>
                </c:pt>
                <c:pt idx="14">
                  <c:v>0.11883541295306001</c:v>
                </c:pt>
                <c:pt idx="15">
                  <c:v>8.3184789067142023E-2</c:v>
                </c:pt>
                <c:pt idx="16">
                  <c:v>4.7534165181224004E-2</c:v>
                </c:pt>
                <c:pt idx="17">
                  <c:v>7.1301247771836024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C-E0A3-40A5-9261-2323BFE7E4E5}"/>
            </c:ext>
          </c:extLst>
        </c:ser>
        <c:ser>
          <c:idx val="45"/>
          <c:order val="45"/>
          <c:tx>
            <c:strRef>
              <c:f>'6nt'!$A$247</c:f>
              <c:strCache>
                <c:ptCount val="1"/>
                <c:pt idx="0">
                  <c:v>UUAAUU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47:$S$247</c:f>
              <c:numCache>
                <c:formatCode>General</c:formatCode>
                <c:ptCount val="18"/>
                <c:pt idx="0">
                  <c:v>0.20202020202020202</c:v>
                </c:pt>
                <c:pt idx="1">
                  <c:v>0.10695187165775399</c:v>
                </c:pt>
                <c:pt idx="2">
                  <c:v>0.11883541295306001</c:v>
                </c:pt>
                <c:pt idx="3">
                  <c:v>0.13071895424836602</c:v>
                </c:pt>
                <c:pt idx="4">
                  <c:v>8.3184789067142023E-2</c:v>
                </c:pt>
                <c:pt idx="5">
                  <c:v>0.15448603683898005</c:v>
                </c:pt>
                <c:pt idx="6">
                  <c:v>0.13071895424836602</c:v>
                </c:pt>
                <c:pt idx="7">
                  <c:v>0.11883541295306001</c:v>
                </c:pt>
                <c:pt idx="8">
                  <c:v>0.16636957813428399</c:v>
                </c:pt>
                <c:pt idx="9">
                  <c:v>0.14260249554367202</c:v>
                </c:pt>
                <c:pt idx="10">
                  <c:v>0.17825311942959002</c:v>
                </c:pt>
                <c:pt idx="11">
                  <c:v>0.17825311942959002</c:v>
                </c:pt>
                <c:pt idx="12">
                  <c:v>0.16636957813428399</c:v>
                </c:pt>
                <c:pt idx="13">
                  <c:v>0.16636957813428399</c:v>
                </c:pt>
                <c:pt idx="14">
                  <c:v>3.5650623885918012E-2</c:v>
                </c:pt>
                <c:pt idx="15">
                  <c:v>0.13071895424836602</c:v>
                </c:pt>
                <c:pt idx="16">
                  <c:v>3.5650623885918012E-2</c:v>
                </c:pt>
                <c:pt idx="17">
                  <c:v>3.5650623885918012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D-E0A3-40A5-9261-2323BFE7E4E5}"/>
            </c:ext>
          </c:extLst>
        </c:ser>
        <c:ser>
          <c:idx val="46"/>
          <c:order val="46"/>
          <c:tx>
            <c:strRef>
              <c:f>'6nt'!$A$248</c:f>
              <c:strCache>
                <c:ptCount val="1"/>
                <c:pt idx="0">
                  <c:v>UAUAAA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48:$S$248</c:f>
              <c:numCache>
                <c:formatCode>General</c:formatCode>
                <c:ptCount val="18"/>
                <c:pt idx="0">
                  <c:v>7.1301247771836024E-2</c:v>
                </c:pt>
                <c:pt idx="1">
                  <c:v>2.3767082590611999E-2</c:v>
                </c:pt>
                <c:pt idx="2">
                  <c:v>0.11883541295306001</c:v>
                </c:pt>
                <c:pt idx="3">
                  <c:v>0.14260249554367202</c:v>
                </c:pt>
                <c:pt idx="4">
                  <c:v>0.10695187165775399</c:v>
                </c:pt>
                <c:pt idx="5">
                  <c:v>9.5068330362449202E-2</c:v>
                </c:pt>
                <c:pt idx="6">
                  <c:v>4.7534165181224004E-2</c:v>
                </c:pt>
                <c:pt idx="7">
                  <c:v>0.14260249554367202</c:v>
                </c:pt>
                <c:pt idx="8">
                  <c:v>0.16636957813428399</c:v>
                </c:pt>
                <c:pt idx="9">
                  <c:v>0.26143790849672893</c:v>
                </c:pt>
                <c:pt idx="10">
                  <c:v>0.11883541295306001</c:v>
                </c:pt>
                <c:pt idx="11">
                  <c:v>9.5068330362449202E-2</c:v>
                </c:pt>
                <c:pt idx="12">
                  <c:v>0.19013666072489599</c:v>
                </c:pt>
                <c:pt idx="13">
                  <c:v>0.17825311942959002</c:v>
                </c:pt>
                <c:pt idx="14">
                  <c:v>0.17825311942959002</c:v>
                </c:pt>
                <c:pt idx="15">
                  <c:v>0.15448603683898005</c:v>
                </c:pt>
                <c:pt idx="16">
                  <c:v>0.13071895424836602</c:v>
                </c:pt>
                <c:pt idx="17">
                  <c:v>5.9417706476530496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E-E0A3-40A5-9261-2323BFE7E4E5}"/>
            </c:ext>
          </c:extLst>
        </c:ser>
        <c:ser>
          <c:idx val="47"/>
          <c:order val="47"/>
          <c:tx>
            <c:strRef>
              <c:f>'6nt'!$A$249</c:f>
              <c:strCache>
                <c:ptCount val="1"/>
                <c:pt idx="0">
                  <c:v>UUAAUA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49:$S$249</c:f>
              <c:numCache>
                <c:formatCode>General</c:formatCode>
                <c:ptCount val="18"/>
                <c:pt idx="0">
                  <c:v>7.1301247771836024E-2</c:v>
                </c:pt>
                <c:pt idx="1">
                  <c:v>0.11883541295306001</c:v>
                </c:pt>
                <c:pt idx="2">
                  <c:v>9.5068330362449202E-2</c:v>
                </c:pt>
                <c:pt idx="3">
                  <c:v>0.11883541295306001</c:v>
                </c:pt>
                <c:pt idx="4">
                  <c:v>0.16636957813428399</c:v>
                </c:pt>
                <c:pt idx="5">
                  <c:v>0.17825311942959002</c:v>
                </c:pt>
                <c:pt idx="6">
                  <c:v>0.19013666072489599</c:v>
                </c:pt>
                <c:pt idx="7">
                  <c:v>0.21390374331550802</c:v>
                </c:pt>
                <c:pt idx="8">
                  <c:v>0.14260249554367202</c:v>
                </c:pt>
                <c:pt idx="9">
                  <c:v>0.17825311942959002</c:v>
                </c:pt>
                <c:pt idx="10">
                  <c:v>0.20202020202020202</c:v>
                </c:pt>
                <c:pt idx="11">
                  <c:v>0.16636957813428399</c:v>
                </c:pt>
                <c:pt idx="12">
                  <c:v>0.10695187165775399</c:v>
                </c:pt>
                <c:pt idx="13">
                  <c:v>0.10695187165775399</c:v>
                </c:pt>
                <c:pt idx="14">
                  <c:v>8.3184789067142023E-2</c:v>
                </c:pt>
                <c:pt idx="15">
                  <c:v>8.3184789067142023E-2</c:v>
                </c:pt>
                <c:pt idx="16">
                  <c:v>1.1883541295306303E-2</c:v>
                </c:pt>
                <c:pt idx="17">
                  <c:v>2.3767082590611999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F-E0A3-40A5-9261-2323BFE7E4E5}"/>
            </c:ext>
          </c:extLst>
        </c:ser>
        <c:ser>
          <c:idx val="48"/>
          <c:order val="48"/>
          <c:tx>
            <c:strRef>
              <c:f>'6nt'!$A$250</c:f>
              <c:strCache>
                <c:ptCount val="1"/>
                <c:pt idx="0">
                  <c:v>AAAAAU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50:$S$250</c:f>
              <c:numCache>
                <c:formatCode>General</c:formatCode>
                <c:ptCount val="18"/>
                <c:pt idx="0">
                  <c:v>5.9417706476530496E-2</c:v>
                </c:pt>
                <c:pt idx="1">
                  <c:v>0.20202020202020202</c:v>
                </c:pt>
                <c:pt idx="2">
                  <c:v>0.11883541295306001</c:v>
                </c:pt>
                <c:pt idx="3">
                  <c:v>0.10695187165775399</c:v>
                </c:pt>
                <c:pt idx="4">
                  <c:v>4.7534165181224004E-2</c:v>
                </c:pt>
                <c:pt idx="5">
                  <c:v>8.3184789067142023E-2</c:v>
                </c:pt>
                <c:pt idx="6">
                  <c:v>9.5068330362449202E-2</c:v>
                </c:pt>
                <c:pt idx="7">
                  <c:v>0.19013666072489599</c:v>
                </c:pt>
                <c:pt idx="8">
                  <c:v>0.14260249554367202</c:v>
                </c:pt>
                <c:pt idx="9">
                  <c:v>0.15448603683898005</c:v>
                </c:pt>
                <c:pt idx="10">
                  <c:v>0.10695187165775399</c:v>
                </c:pt>
                <c:pt idx="11">
                  <c:v>9.5068330362449202E-2</c:v>
                </c:pt>
                <c:pt idx="12">
                  <c:v>0.20202020202020202</c:v>
                </c:pt>
                <c:pt idx="13">
                  <c:v>0.14260249554367202</c:v>
                </c:pt>
                <c:pt idx="14">
                  <c:v>5.9417706476530496E-2</c:v>
                </c:pt>
                <c:pt idx="15">
                  <c:v>0.14260249554367202</c:v>
                </c:pt>
                <c:pt idx="16">
                  <c:v>0.17825311942959002</c:v>
                </c:pt>
                <c:pt idx="17">
                  <c:v>0.130718954248366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0-E0A3-40A5-9261-2323BFE7E4E5}"/>
            </c:ext>
          </c:extLst>
        </c:ser>
        <c:ser>
          <c:idx val="49"/>
          <c:order val="49"/>
          <c:tx>
            <c:strRef>
              <c:f>'6nt'!$A$251</c:f>
              <c:strCache>
                <c:ptCount val="1"/>
                <c:pt idx="0">
                  <c:v>UAAUAU</c:v>
                </c:pt>
              </c:strCache>
            </c:strRef>
          </c:tx>
          <c:marker>
            <c:symbol val="none"/>
          </c:marker>
          <c:cat>
            <c:numRef>
              <c:f>'6nt'!$B$201:$S$201</c:f>
              <c:numCache>
                <c:formatCode>General</c:formatCode>
                <c:ptCount val="18"/>
                <c:pt idx="0">
                  <c:v>-35</c:v>
                </c:pt>
                <c:pt idx="1">
                  <c:v>-34</c:v>
                </c:pt>
                <c:pt idx="2">
                  <c:v>-33</c:v>
                </c:pt>
                <c:pt idx="3">
                  <c:v>-32</c:v>
                </c:pt>
                <c:pt idx="4">
                  <c:v>-31</c:v>
                </c:pt>
                <c:pt idx="5">
                  <c:v>-30</c:v>
                </c:pt>
                <c:pt idx="6">
                  <c:v>-29</c:v>
                </c:pt>
                <c:pt idx="7">
                  <c:v>-28</c:v>
                </c:pt>
                <c:pt idx="8">
                  <c:v>-27</c:v>
                </c:pt>
                <c:pt idx="9">
                  <c:v>-26</c:v>
                </c:pt>
                <c:pt idx="10">
                  <c:v>-25</c:v>
                </c:pt>
                <c:pt idx="11">
                  <c:v>-24</c:v>
                </c:pt>
                <c:pt idx="12">
                  <c:v>-23</c:v>
                </c:pt>
                <c:pt idx="13">
                  <c:v>-22</c:v>
                </c:pt>
                <c:pt idx="14">
                  <c:v>-21</c:v>
                </c:pt>
                <c:pt idx="15">
                  <c:v>-20</c:v>
                </c:pt>
                <c:pt idx="16">
                  <c:v>-19</c:v>
                </c:pt>
                <c:pt idx="17">
                  <c:v>-18</c:v>
                </c:pt>
              </c:numCache>
            </c:numRef>
          </c:cat>
          <c:val>
            <c:numRef>
              <c:f>'6nt'!$B$251:$S$251</c:f>
              <c:numCache>
                <c:formatCode>General</c:formatCode>
                <c:ptCount val="18"/>
                <c:pt idx="0">
                  <c:v>3.5650623885918012E-2</c:v>
                </c:pt>
                <c:pt idx="1">
                  <c:v>0.13071895424836602</c:v>
                </c:pt>
                <c:pt idx="2">
                  <c:v>8.3184789067142023E-2</c:v>
                </c:pt>
                <c:pt idx="3">
                  <c:v>8.3184789067142023E-2</c:v>
                </c:pt>
                <c:pt idx="4">
                  <c:v>0.11883541295306001</c:v>
                </c:pt>
                <c:pt idx="5">
                  <c:v>0.13071895424836602</c:v>
                </c:pt>
                <c:pt idx="6">
                  <c:v>0.19013666072489599</c:v>
                </c:pt>
                <c:pt idx="7">
                  <c:v>9.5068330362449202E-2</c:v>
                </c:pt>
                <c:pt idx="8">
                  <c:v>0.13071895424836602</c:v>
                </c:pt>
                <c:pt idx="9">
                  <c:v>0.15448603683898005</c:v>
                </c:pt>
                <c:pt idx="10">
                  <c:v>0.15448603683898005</c:v>
                </c:pt>
                <c:pt idx="11">
                  <c:v>0.23767082590611796</c:v>
                </c:pt>
                <c:pt idx="12">
                  <c:v>9.5068330362449202E-2</c:v>
                </c:pt>
                <c:pt idx="13">
                  <c:v>0.14260249554367202</c:v>
                </c:pt>
                <c:pt idx="14">
                  <c:v>0.19013666072489599</c:v>
                </c:pt>
                <c:pt idx="15">
                  <c:v>9.5068330362449202E-2</c:v>
                </c:pt>
                <c:pt idx="16">
                  <c:v>0.11883541295306001</c:v>
                </c:pt>
                <c:pt idx="17">
                  <c:v>4.7534165181224004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1-E0A3-40A5-9261-2323BFE7E4E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89800064"/>
        <c:axId val="89822336"/>
      </c:lineChart>
      <c:catAx>
        <c:axId val="898000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zh-CN"/>
            </a:pPr>
            <a:endParaRPr lang="en-US"/>
          </a:p>
        </c:txPr>
        <c:crossAx val="89822336"/>
        <c:crosses val="autoZero"/>
        <c:auto val="1"/>
        <c:lblAlgn val="ctr"/>
        <c:lblOffset val="100"/>
        <c:noMultiLvlLbl val="0"/>
      </c:catAx>
      <c:valAx>
        <c:axId val="898223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zh-CN"/>
            </a:pPr>
            <a:endParaRPr lang="en-US"/>
          </a:p>
        </c:txPr>
        <c:crossAx val="8980006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1.5094339622641504E-3"/>
          <c:y val="0.59899288157162189"/>
          <c:w val="0.99130278526503879"/>
          <c:h val="0.39859918078422107"/>
        </c:manualLayout>
      </c:layout>
      <c:overlay val="0"/>
      <c:txPr>
        <a:bodyPr/>
        <a:lstStyle/>
        <a:p>
          <a:pPr>
            <a:defRPr lang="zh-CN" sz="600" baseline="0"/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9027</cdr:x>
      <cdr:y>0.02625</cdr:y>
    </cdr:from>
    <cdr:to>
      <cdr:x>0.75604</cdr:x>
      <cdr:y>0.21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576064" y="72008"/>
          <a:ext cx="4248472" cy="50405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zh-CN" altLang="en-US" sz="1100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2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2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2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2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2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2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21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21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21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2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2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2/2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400" dirty="0" smtClean="0"/>
              <a:t>Zhao et al., Supplemental file 1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25917495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内容占位符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91902549"/>
              </p:ext>
            </p:extLst>
          </p:nvPr>
        </p:nvGraphicFramePr>
        <p:xfrm>
          <a:off x="304800" y="103311"/>
          <a:ext cx="6264696" cy="12682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内容占位符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64916536"/>
              </p:ext>
            </p:extLst>
          </p:nvPr>
        </p:nvGraphicFramePr>
        <p:xfrm>
          <a:off x="304800" y="1371599"/>
          <a:ext cx="6263640" cy="1267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3" name="矩形 12"/>
          <p:cNvSpPr/>
          <p:nvPr/>
        </p:nvSpPr>
        <p:spPr>
          <a:xfrm>
            <a:off x="0" y="2623591"/>
            <a:ext cx="400110" cy="4392488"/>
          </a:xfrm>
          <a:prstGeom prst="rect">
            <a:avLst/>
          </a:prstGeom>
          <a:scene3d>
            <a:camera prst="orthographicFront">
              <a:rot lat="0" lon="21299999" rev="0"/>
            </a:camera>
            <a:lightRig rig="threePt" dir="t"/>
          </a:scene3d>
        </p:spPr>
        <p:txBody>
          <a:bodyPr vert="vert270" wrap="square">
            <a:spAutoFit/>
          </a:bodyPr>
          <a:lstStyle/>
          <a:p>
            <a:pPr algn="ctr">
              <a:defRPr sz="1175" b="0" i="0" u="none" strike="noStrike" kern="1200" baseline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</a:defRPr>
            </a:pPr>
            <a:r>
              <a:rPr lang="en-US" altLang="en-US" sz="1400" dirty="0" smtClean="0"/>
              <a:t>Signal frequency %</a:t>
            </a:r>
            <a:endParaRPr lang="en-US" altLang="en-US" sz="1400" dirty="0"/>
          </a:p>
        </p:txBody>
      </p:sp>
      <p:sp>
        <p:nvSpPr>
          <p:cNvPr id="9" name="TextBox 8"/>
          <p:cNvSpPr txBox="1"/>
          <p:nvPr/>
        </p:nvSpPr>
        <p:spPr>
          <a:xfrm>
            <a:off x="3048000" y="8913168"/>
            <a:ext cx="6858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smtClean="0">
                <a:latin typeface="Times New Roman" pitchFamily="18" charset="0"/>
                <a:cs typeface="Times New Roman" pitchFamily="18" charset="0"/>
              </a:rPr>
              <a:t>Position</a:t>
            </a:r>
            <a:endParaRPr lang="zh-CN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10" name="Chart 9"/>
          <p:cNvGraphicFramePr/>
          <p:nvPr>
            <p:extLst>
              <p:ext uri="{D42A27DB-BD31-4B8C-83A1-F6EECF244321}">
                <p14:modId xmlns:p14="http://schemas.microsoft.com/office/powerpoint/2010/main" val="2804247378"/>
              </p:ext>
            </p:extLst>
          </p:nvPr>
        </p:nvGraphicFramePr>
        <p:xfrm>
          <a:off x="304800" y="2590799"/>
          <a:ext cx="6263640" cy="1267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4" name="图表 8"/>
          <p:cNvGraphicFramePr/>
          <p:nvPr>
            <p:extLst>
              <p:ext uri="{D42A27DB-BD31-4B8C-83A1-F6EECF244321}">
                <p14:modId xmlns:p14="http://schemas.microsoft.com/office/powerpoint/2010/main" val="4129653234"/>
              </p:ext>
            </p:extLst>
          </p:nvPr>
        </p:nvGraphicFramePr>
        <p:xfrm>
          <a:off x="304800" y="3886199"/>
          <a:ext cx="6263640" cy="1267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Chart 7"/>
          <p:cNvGraphicFramePr/>
          <p:nvPr>
            <p:extLst>
              <p:ext uri="{D42A27DB-BD31-4B8C-83A1-F6EECF244321}">
                <p14:modId xmlns:p14="http://schemas.microsoft.com/office/powerpoint/2010/main" val="2201149038"/>
              </p:ext>
            </p:extLst>
          </p:nvPr>
        </p:nvGraphicFramePr>
        <p:xfrm>
          <a:off x="304800" y="5181599"/>
          <a:ext cx="6263640" cy="1267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1" name="内容占位符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65407866"/>
              </p:ext>
            </p:extLst>
          </p:nvPr>
        </p:nvGraphicFramePr>
        <p:xfrm>
          <a:off x="304800" y="6400799"/>
          <a:ext cx="6264696" cy="1267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2" name="内容占位符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84689819"/>
              </p:ext>
            </p:extLst>
          </p:nvPr>
        </p:nvGraphicFramePr>
        <p:xfrm>
          <a:off x="304800" y="7696199"/>
          <a:ext cx="6264696" cy="1267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15" name="TextBox 14"/>
          <p:cNvSpPr txBox="1"/>
          <p:nvPr/>
        </p:nvSpPr>
        <p:spPr>
          <a:xfrm>
            <a:off x="2133600" y="76200"/>
            <a:ext cx="2438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    </a:t>
            </a:r>
            <a:r>
              <a:rPr lang="en-US" sz="1000" i="1" dirty="0" err="1" smtClean="0">
                <a:latin typeface="Times New Roman" pitchFamily="18" charset="0"/>
                <a:cs typeface="Times New Roman" pitchFamily="18" charset="0"/>
              </a:rPr>
              <a:t>Thalassiosira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000" i="1" dirty="0" err="1" smtClean="0">
                <a:latin typeface="Times New Roman" pitchFamily="18" charset="0"/>
                <a:cs typeface="Times New Roman" pitchFamily="18" charset="0"/>
              </a:rPr>
              <a:t>pseudonana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(T diatom)</a:t>
            </a:r>
            <a:endParaRPr 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2133600" y="1371599"/>
            <a:ext cx="2590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    </a:t>
            </a:r>
            <a:r>
              <a:rPr lang="en-US" sz="1000" i="1" dirty="0" err="1" smtClean="0">
                <a:latin typeface="Times New Roman" pitchFamily="18" charset="0"/>
                <a:cs typeface="Times New Roman" pitchFamily="18" charset="0"/>
              </a:rPr>
              <a:t>Phaeodactylum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000" i="1" dirty="0" err="1" smtClean="0">
                <a:latin typeface="Times New Roman" pitchFamily="18" charset="0"/>
                <a:cs typeface="Times New Roman" pitchFamily="18" charset="0"/>
              </a:rPr>
              <a:t>tricornutum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(P diatom)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2133600" y="2590799"/>
            <a:ext cx="2438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C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    </a:t>
            </a:r>
            <a:r>
              <a:rPr lang="en-US" sz="1000" i="1" dirty="0" err="1" smtClean="0">
                <a:latin typeface="Times New Roman" pitchFamily="18" charset="0"/>
                <a:cs typeface="Times New Roman" pitchFamily="18" charset="0"/>
              </a:rPr>
              <a:t>Tetrahymena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000" i="1" dirty="0" err="1" smtClean="0">
                <a:latin typeface="Times New Roman" pitchFamily="18" charset="0"/>
                <a:cs typeface="Times New Roman" pitchFamily="18" charset="0"/>
              </a:rPr>
              <a:t>thermophila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(Ciliate)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2133600" y="3886199"/>
            <a:ext cx="2667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D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    </a:t>
            </a:r>
            <a:r>
              <a:rPr lang="en-US" sz="1000" i="1" dirty="0" err="1" smtClean="0">
                <a:latin typeface="Times New Roman" pitchFamily="18" charset="0"/>
                <a:cs typeface="Times New Roman" pitchFamily="18" charset="0"/>
              </a:rPr>
              <a:t>Ostreococcus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000" i="1" dirty="0" err="1" smtClean="0">
                <a:latin typeface="Times New Roman" pitchFamily="18" charset="0"/>
                <a:cs typeface="Times New Roman" pitchFamily="18" charset="0"/>
              </a:rPr>
              <a:t>lucimarinus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(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Ostreococcus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2133600" y="5105399"/>
            <a:ext cx="2362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>
                <a:latin typeface="Times New Roman" pitchFamily="18" charset="0"/>
                <a:cs typeface="Times New Roman" pitchFamily="18" charset="0"/>
              </a:rPr>
              <a:t>E</a:t>
            </a:r>
            <a:r>
              <a:rPr lang="es-ES" sz="1000" dirty="0" smtClean="0">
                <a:latin typeface="Times New Roman" pitchFamily="18" charset="0"/>
                <a:cs typeface="Times New Roman" pitchFamily="18" charset="0"/>
              </a:rPr>
              <a:t>     </a:t>
            </a:r>
            <a:r>
              <a:rPr lang="es-ES" sz="1000" i="1" dirty="0" err="1" smtClean="0">
                <a:latin typeface="Times New Roman" pitchFamily="18" charset="0"/>
                <a:cs typeface="Times New Roman" pitchFamily="18" charset="0"/>
              </a:rPr>
              <a:t>Cyanidioschyzon</a:t>
            </a:r>
            <a:r>
              <a:rPr lang="es-ES" sz="10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000" i="1" dirty="0" err="1" smtClean="0">
                <a:latin typeface="Times New Roman" pitchFamily="18" charset="0"/>
                <a:cs typeface="Times New Roman" pitchFamily="18" charset="0"/>
              </a:rPr>
              <a:t>merolae</a:t>
            </a:r>
            <a:r>
              <a:rPr lang="es-ES" sz="1000" dirty="0" smtClean="0">
                <a:latin typeface="Times New Roman" pitchFamily="18" charset="0"/>
                <a:cs typeface="Times New Roman" pitchFamily="18" charset="0"/>
              </a:rPr>
              <a:t> (Red alga)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2133600" y="6400799"/>
            <a:ext cx="2438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F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    </a:t>
            </a:r>
            <a:r>
              <a:rPr lang="en-US" sz="1000" i="1" dirty="0" err="1" smtClean="0">
                <a:latin typeface="Times New Roman" pitchFamily="18" charset="0"/>
                <a:cs typeface="Times New Roman" pitchFamily="18" charset="0"/>
              </a:rPr>
              <a:t>Selaginella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000" i="1" dirty="0" err="1" smtClean="0">
                <a:latin typeface="Times New Roman" pitchFamily="18" charset="0"/>
                <a:cs typeface="Times New Roman" pitchFamily="18" charset="0"/>
              </a:rPr>
              <a:t>moellendorffii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(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spikemoss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2133600" y="7619999"/>
            <a:ext cx="1981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G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     </a:t>
            </a:r>
            <a:r>
              <a:rPr lang="en-US" sz="1000" i="1" dirty="0" err="1" smtClean="0">
                <a:latin typeface="Times New Roman" pitchFamily="18" charset="0"/>
                <a:cs typeface="Times New Roman" pitchFamily="18" charset="0"/>
              </a:rPr>
              <a:t>Physcomitrella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 patens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(moss)</a:t>
            </a:r>
            <a:endParaRPr lang="zh-CN" altLang="en-US" sz="1000" dirty="0" smtClean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762000" y="762000"/>
            <a:ext cx="54102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Figure </a:t>
            </a:r>
            <a:r>
              <a:rPr lang="en-US" b="1" dirty="0"/>
              <a:t>S</a:t>
            </a:r>
            <a:r>
              <a:rPr lang="en-US" b="1" dirty="0" smtClean="0"/>
              <a:t>1</a:t>
            </a:r>
            <a:r>
              <a:rPr lang="en-US" b="1" dirty="0" smtClean="0"/>
              <a:t>. </a:t>
            </a:r>
            <a:r>
              <a:rPr lang="en-US" b="1" dirty="0"/>
              <a:t>The distributions of 50 top-ranked poly(A) signals in the NUE regions of the 7</a:t>
            </a:r>
            <a:r>
              <a:rPr lang="en-US" b="1" dirty="0" smtClean="0"/>
              <a:t> species. 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071713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6</TotalTime>
  <Words>76</Words>
  <Application>Microsoft Office PowerPoint</Application>
  <PresentationFormat>On-screen Show (4:3)</PresentationFormat>
  <Paragraphs>11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宋体</vt:lpstr>
      <vt:lpstr>Arial</vt:lpstr>
      <vt:lpstr>Calibri</vt:lpstr>
      <vt:lpstr>Times New Roman</vt:lpstr>
      <vt:lpstr>Office Theme</vt:lpstr>
      <vt:lpstr>Zhao et al., Supplemental file 1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walter</dc:creator>
  <cp:lastModifiedBy>MDPI</cp:lastModifiedBy>
  <cp:revision>100</cp:revision>
  <cp:lastPrinted>2013-10-25T20:00:54Z</cp:lastPrinted>
  <dcterms:created xsi:type="dcterms:W3CDTF">2013-10-25T19:59:36Z</dcterms:created>
  <dcterms:modified xsi:type="dcterms:W3CDTF">2019-02-21T02:36:40Z</dcterms:modified>
</cp:coreProperties>
</file>